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0" r:id="rId2"/>
    <p:sldId id="270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FF33"/>
    <a:srgbClr val="00B050"/>
    <a:srgbClr val="8FAADC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67" autoAdjust="0"/>
  </p:normalViewPr>
  <p:slideViewPr>
    <p:cSldViewPr snapToGrid="0">
      <p:cViewPr varScale="1">
        <p:scale>
          <a:sx n="102" d="100"/>
          <a:sy n="102" d="100"/>
        </p:scale>
        <p:origin x="54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吉武 和敏" userId="e4825ba96748af9c" providerId="LiveId" clId="{0CB8545E-49B2-1B49-92F2-063C827FA5AF}"/>
    <pc:docChg chg="delSld modSld sldOrd">
      <pc:chgData name="吉武 和敏" userId="e4825ba96748af9c" providerId="LiveId" clId="{0CB8545E-49B2-1B49-92F2-063C827FA5AF}" dt="2022-03-22T14:22:14.487" v="588" actId="20577"/>
      <pc:docMkLst>
        <pc:docMk/>
      </pc:docMkLst>
      <pc:sldChg chg="del">
        <pc:chgData name="吉武 和敏" userId="e4825ba96748af9c" providerId="LiveId" clId="{0CB8545E-49B2-1B49-92F2-063C827FA5AF}" dt="2022-03-14T14:43:57.185" v="19" actId="2696"/>
        <pc:sldMkLst>
          <pc:docMk/>
          <pc:sldMk cId="1991318276" sldId="258"/>
        </pc:sldMkLst>
      </pc:sldChg>
      <pc:sldChg chg="modSp mod">
        <pc:chgData name="吉武 和敏" userId="e4825ba96748af9c" providerId="LiveId" clId="{0CB8545E-49B2-1B49-92F2-063C827FA5AF}" dt="2022-03-22T14:20:03.276" v="582" actId="20577"/>
        <pc:sldMkLst>
          <pc:docMk/>
          <pc:sldMk cId="1542364386" sldId="260"/>
        </pc:sldMkLst>
        <pc:spChg chg="mod">
          <ac:chgData name="吉武 和敏" userId="e4825ba96748af9c" providerId="LiveId" clId="{0CB8545E-49B2-1B49-92F2-063C827FA5AF}" dt="2022-03-22T14:20:03.276" v="582" actId="20577"/>
          <ac:spMkLst>
            <pc:docMk/>
            <pc:sldMk cId="1542364386" sldId="260"/>
            <ac:spMk id="14" creationId="{A75E551B-345E-4D00-A4F1-F961C99F3B6F}"/>
          </ac:spMkLst>
        </pc:spChg>
      </pc:sldChg>
      <pc:sldChg chg="addSp modSp mod ord">
        <pc:chgData name="吉武 和敏" userId="e4825ba96748af9c" providerId="LiveId" clId="{0CB8545E-49B2-1B49-92F2-063C827FA5AF}" dt="2022-03-14T15:30:12.367" v="556" actId="20577"/>
        <pc:sldMkLst>
          <pc:docMk/>
          <pc:sldMk cId="2806979806" sldId="262"/>
        </pc:sldMkLst>
        <pc:spChg chg="add mod">
          <ac:chgData name="吉武 和敏" userId="e4825ba96748af9c" providerId="LiveId" clId="{0CB8545E-49B2-1B49-92F2-063C827FA5AF}" dt="2022-03-14T15:30:12.367" v="556" actId="20577"/>
          <ac:spMkLst>
            <pc:docMk/>
            <pc:sldMk cId="2806979806" sldId="262"/>
            <ac:spMk id="4" creationId="{511C915F-66A0-D349-8612-850522C1B5EF}"/>
          </ac:spMkLst>
        </pc:spChg>
        <pc:picChg chg="mod modCrop">
          <ac:chgData name="吉武 和敏" userId="e4825ba96748af9c" providerId="LiveId" clId="{0CB8545E-49B2-1B49-92F2-063C827FA5AF}" dt="2022-03-14T15:29:54.127" v="510" actId="1076"/>
          <ac:picMkLst>
            <pc:docMk/>
            <pc:sldMk cId="2806979806" sldId="262"/>
            <ac:picMk id="7" creationId="{1CACE172-1607-4966-8E1D-A997A63CD4CA}"/>
          </ac:picMkLst>
        </pc:picChg>
      </pc:sldChg>
      <pc:sldChg chg="ord">
        <pc:chgData name="吉武 和敏" userId="e4825ba96748af9c" providerId="LiveId" clId="{0CB8545E-49B2-1B49-92F2-063C827FA5AF}" dt="2022-03-14T15:31:22.710" v="558" actId="20578"/>
        <pc:sldMkLst>
          <pc:docMk/>
          <pc:sldMk cId="2928055407" sldId="263"/>
        </pc:sldMkLst>
      </pc:sldChg>
      <pc:sldChg chg="ord">
        <pc:chgData name="吉武 和敏" userId="e4825ba96748af9c" providerId="LiveId" clId="{0CB8545E-49B2-1B49-92F2-063C827FA5AF}" dt="2022-03-14T15:31:50.115" v="559" actId="20578"/>
        <pc:sldMkLst>
          <pc:docMk/>
          <pc:sldMk cId="1214924586" sldId="264"/>
        </pc:sldMkLst>
      </pc:sldChg>
      <pc:sldChg chg="ord">
        <pc:chgData name="吉武 和敏" userId="e4825ba96748af9c" providerId="LiveId" clId="{0CB8545E-49B2-1B49-92F2-063C827FA5AF}" dt="2022-03-14T15:31:52.957" v="560" actId="20578"/>
        <pc:sldMkLst>
          <pc:docMk/>
          <pc:sldMk cId="3293758939" sldId="265"/>
        </pc:sldMkLst>
      </pc:sldChg>
      <pc:sldChg chg="del">
        <pc:chgData name="吉武 和敏" userId="e4825ba96748af9c" providerId="LiveId" clId="{0CB8545E-49B2-1B49-92F2-063C827FA5AF}" dt="2022-03-14T15:32:44.097" v="561" actId="2696"/>
        <pc:sldMkLst>
          <pc:docMk/>
          <pc:sldMk cId="2676106001" sldId="269"/>
        </pc:sldMkLst>
      </pc:sldChg>
      <pc:sldChg chg="addSp modSp mod ord">
        <pc:chgData name="吉武 和敏" userId="e4825ba96748af9c" providerId="LiveId" clId="{0CB8545E-49B2-1B49-92F2-063C827FA5AF}" dt="2022-03-22T14:22:14.487" v="588" actId="20577"/>
        <pc:sldMkLst>
          <pc:docMk/>
          <pc:sldMk cId="549526029" sldId="270"/>
        </pc:sldMkLst>
        <pc:spChg chg="add mod">
          <ac:chgData name="吉武 和敏" userId="e4825ba96748af9c" providerId="LiveId" clId="{0CB8545E-49B2-1B49-92F2-063C827FA5AF}" dt="2022-03-14T15:28:14.243" v="507" actId="20577"/>
          <ac:spMkLst>
            <pc:docMk/>
            <pc:sldMk cId="549526029" sldId="270"/>
            <ac:spMk id="36" creationId="{9B68D934-5BD7-B74E-B7C8-1DEB66CE07C4}"/>
          </ac:spMkLst>
        </pc:spChg>
        <pc:spChg chg="mod">
          <ac:chgData name="吉武 和敏" userId="e4825ba96748af9c" providerId="LiveId" clId="{0CB8545E-49B2-1B49-92F2-063C827FA5AF}" dt="2022-03-22T14:22:11.538" v="585" actId="20577"/>
          <ac:spMkLst>
            <pc:docMk/>
            <pc:sldMk cId="549526029" sldId="270"/>
            <ac:spMk id="37" creationId="{D6133BAF-5153-457F-A4E1-591BDABB5F99}"/>
          </ac:spMkLst>
        </pc:spChg>
        <pc:spChg chg="mod">
          <ac:chgData name="吉武 和敏" userId="e4825ba96748af9c" providerId="LiveId" clId="{0CB8545E-49B2-1B49-92F2-063C827FA5AF}" dt="2022-03-22T14:22:14.487" v="588" actId="20577"/>
          <ac:spMkLst>
            <pc:docMk/>
            <pc:sldMk cId="549526029" sldId="270"/>
            <ac:spMk id="38" creationId="{BC80D470-3D00-401A-BE04-F4E3B5EC0A75}"/>
          </ac:spMkLst>
        </pc:spChg>
      </pc:sldChg>
      <pc:sldChg chg="addSp modSp mod">
        <pc:chgData name="吉武 和敏" userId="e4825ba96748af9c" providerId="LiveId" clId="{0CB8545E-49B2-1B49-92F2-063C827FA5AF}" dt="2022-03-22T02:55:52.208" v="574" actId="14100"/>
        <pc:sldMkLst>
          <pc:docMk/>
          <pc:sldMk cId="1801781158" sldId="276"/>
        </pc:sldMkLst>
        <pc:spChg chg="add mod">
          <ac:chgData name="吉武 和敏" userId="e4825ba96748af9c" providerId="LiveId" clId="{0CB8545E-49B2-1B49-92F2-063C827FA5AF}" dt="2022-03-14T14:09:44.576" v="17" actId="20577"/>
          <ac:spMkLst>
            <pc:docMk/>
            <pc:sldMk cId="1801781158" sldId="276"/>
            <ac:spMk id="63" creationId="{EF2511F3-ED4D-0A40-8C20-D4F0E89E88FC}"/>
          </ac:spMkLst>
        </pc:spChg>
        <pc:spChg chg="add mod">
          <ac:chgData name="吉武 和敏" userId="e4825ba96748af9c" providerId="LiveId" clId="{0CB8545E-49B2-1B49-92F2-063C827FA5AF}" dt="2022-03-14T14:09:32.954" v="10" actId="20577"/>
          <ac:spMkLst>
            <pc:docMk/>
            <pc:sldMk cId="1801781158" sldId="276"/>
            <ac:spMk id="64" creationId="{D4922FBE-274A-5249-86EC-8C823F60DE4D}"/>
          </ac:spMkLst>
        </pc:spChg>
        <pc:spChg chg="add mod">
          <ac:chgData name="吉武 和敏" userId="e4825ba96748af9c" providerId="LiveId" clId="{0CB8545E-49B2-1B49-92F2-063C827FA5AF}" dt="2022-03-22T02:55:44.543" v="573" actId="14100"/>
          <ac:spMkLst>
            <pc:docMk/>
            <pc:sldMk cId="1801781158" sldId="276"/>
            <ac:spMk id="73" creationId="{1621162D-4AE2-1048-8671-F9043E47A5EB}"/>
          </ac:spMkLst>
        </pc:spChg>
        <pc:cxnChg chg="add">
          <ac:chgData name="吉武 和敏" userId="e4825ba96748af9c" providerId="LiveId" clId="{0CB8545E-49B2-1B49-92F2-063C827FA5AF}" dt="2022-03-14T14:09:02.280" v="0" actId="11529"/>
          <ac:cxnSpMkLst>
            <pc:docMk/>
            <pc:sldMk cId="1801781158" sldId="276"/>
            <ac:cxnSpMk id="24" creationId="{3A870D4F-8ED4-714F-AC1D-ABD9026A987B}"/>
          </ac:cxnSpMkLst>
        </pc:cxnChg>
        <pc:cxnChg chg="add">
          <ac:chgData name="吉武 和敏" userId="e4825ba96748af9c" providerId="LiveId" clId="{0CB8545E-49B2-1B49-92F2-063C827FA5AF}" dt="2022-03-22T02:54:44.257" v="562" actId="11529"/>
          <ac:cxnSpMkLst>
            <pc:docMk/>
            <pc:sldMk cId="1801781158" sldId="276"/>
            <ac:cxnSpMk id="25" creationId="{D4323DD4-E98D-DA49-BEE8-CFB756E0ED46}"/>
          </ac:cxnSpMkLst>
        </pc:cxnChg>
        <pc:cxnChg chg="add mod">
          <ac:chgData name="吉武 和敏" userId="e4825ba96748af9c" providerId="LiveId" clId="{0CB8545E-49B2-1B49-92F2-063C827FA5AF}" dt="2022-03-14T14:09:09.743" v="2" actId="14100"/>
          <ac:cxnSpMkLst>
            <pc:docMk/>
            <pc:sldMk cId="1801781158" sldId="276"/>
            <ac:cxnSpMk id="62" creationId="{3EF21EC9-1594-404E-9348-BAFA4710893A}"/>
          </ac:cxnSpMkLst>
        </pc:cxnChg>
        <pc:cxnChg chg="add mod">
          <ac:chgData name="吉武 和敏" userId="e4825ba96748af9c" providerId="LiveId" clId="{0CB8545E-49B2-1B49-92F2-063C827FA5AF}" dt="2022-03-22T02:54:57.325" v="565" actId="14100"/>
          <ac:cxnSpMkLst>
            <pc:docMk/>
            <pc:sldMk cId="1801781158" sldId="276"/>
            <ac:cxnSpMk id="69" creationId="{5DFBCD9A-B9C7-844D-AAFA-F1B2B8CF7F0D}"/>
          </ac:cxnSpMkLst>
        </pc:cxnChg>
        <pc:cxnChg chg="add mod">
          <ac:chgData name="吉武 和敏" userId="e4825ba96748af9c" providerId="LiveId" clId="{0CB8545E-49B2-1B49-92F2-063C827FA5AF}" dt="2022-03-22T02:55:10.178" v="567" actId="14100"/>
          <ac:cxnSpMkLst>
            <pc:docMk/>
            <pc:sldMk cId="1801781158" sldId="276"/>
            <ac:cxnSpMk id="70" creationId="{C465EFBC-0493-3242-BDAE-01D0FD04AF56}"/>
          </ac:cxnSpMkLst>
        </pc:cxnChg>
        <pc:cxnChg chg="add mod">
          <ac:chgData name="吉武 和敏" userId="e4825ba96748af9c" providerId="LiveId" clId="{0CB8545E-49B2-1B49-92F2-063C827FA5AF}" dt="2022-03-22T02:55:20.228" v="570" actId="14100"/>
          <ac:cxnSpMkLst>
            <pc:docMk/>
            <pc:sldMk cId="1801781158" sldId="276"/>
            <ac:cxnSpMk id="71" creationId="{335D5671-49CA-FC41-BEA1-5E6569B1C571}"/>
          </ac:cxnSpMkLst>
        </pc:cxnChg>
        <pc:cxnChg chg="add mod">
          <ac:chgData name="吉武 和敏" userId="e4825ba96748af9c" providerId="LiveId" clId="{0CB8545E-49B2-1B49-92F2-063C827FA5AF}" dt="2022-03-22T02:55:52.208" v="574" actId="14100"/>
          <ac:cxnSpMkLst>
            <pc:docMk/>
            <pc:sldMk cId="1801781158" sldId="276"/>
            <ac:cxnSpMk id="72" creationId="{9338DB2D-00A6-7040-839F-360855509E4A}"/>
          </ac:cxnSpMkLst>
        </pc:cxnChg>
      </pc:sldChg>
      <pc:sldChg chg="del">
        <pc:chgData name="吉武 和敏" userId="e4825ba96748af9c" providerId="LiveId" clId="{0CB8545E-49B2-1B49-92F2-063C827FA5AF}" dt="2022-03-14T14:43:56.378" v="18" actId="2696"/>
        <pc:sldMkLst>
          <pc:docMk/>
          <pc:sldMk cId="49459081" sldId="277"/>
        </pc:sldMkLst>
      </pc:sldChg>
      <pc:sldChg chg="modSp mod">
        <pc:chgData name="吉武 和敏" userId="e4825ba96748af9c" providerId="LiveId" clId="{0CB8545E-49B2-1B49-92F2-063C827FA5AF}" dt="2022-03-14T14:53:58.524" v="483" actId="20577"/>
        <pc:sldMkLst>
          <pc:docMk/>
          <pc:sldMk cId="2753622518" sldId="278"/>
        </pc:sldMkLst>
        <pc:spChg chg="mod">
          <ac:chgData name="吉武 和敏" userId="e4825ba96748af9c" providerId="LiveId" clId="{0CB8545E-49B2-1B49-92F2-063C827FA5AF}" dt="2022-03-14T14:53:58.524" v="483" actId="20577"/>
          <ac:spMkLst>
            <pc:docMk/>
            <pc:sldMk cId="2753622518" sldId="278"/>
            <ac:spMk id="5" creationId="{7F157F4B-724B-4DC6-B394-EA4EB26E75A4}"/>
          </ac:spMkLst>
        </pc:spChg>
        <pc:spChg chg="mod">
          <ac:chgData name="吉武 和敏" userId="e4825ba96748af9c" providerId="LiveId" clId="{0CB8545E-49B2-1B49-92F2-063C827FA5AF}" dt="2022-03-14T14:48:31.145" v="44" actId="1038"/>
          <ac:spMkLst>
            <pc:docMk/>
            <pc:sldMk cId="2753622518" sldId="278"/>
            <ac:spMk id="7" creationId="{AA34A617-FB96-41A7-B2A0-6C317647BC5E}"/>
          </ac:spMkLst>
        </pc:spChg>
        <pc:spChg chg="mod">
          <ac:chgData name="吉武 和敏" userId="e4825ba96748af9c" providerId="LiveId" clId="{0CB8545E-49B2-1B49-92F2-063C827FA5AF}" dt="2022-03-14T14:48:31.145" v="44" actId="1038"/>
          <ac:spMkLst>
            <pc:docMk/>
            <pc:sldMk cId="2753622518" sldId="278"/>
            <ac:spMk id="8" creationId="{56555404-CC4A-4442-A2AA-693806D5A6A9}"/>
          </ac:spMkLst>
        </pc:spChg>
      </pc:sldChg>
      <pc:sldChg chg="ord">
        <pc:chgData name="吉武 和敏" userId="e4825ba96748af9c" providerId="LiveId" clId="{0CB8545E-49B2-1B49-92F2-063C827FA5AF}" dt="2022-03-14T15:30:57.634" v="557" actId="20578"/>
        <pc:sldMkLst>
          <pc:docMk/>
          <pc:sldMk cId="731570627" sldId="849"/>
        </pc:sldMkLst>
      </pc:sldChg>
      <pc:sldChg chg="ord">
        <pc:chgData name="吉武 和敏" userId="e4825ba96748af9c" providerId="LiveId" clId="{0CB8545E-49B2-1B49-92F2-063C827FA5AF}" dt="2022-03-14T15:30:57.634" v="557" actId="20578"/>
        <pc:sldMkLst>
          <pc:docMk/>
          <pc:sldMk cId="2300418936" sldId="850"/>
        </pc:sldMkLst>
      </pc:sldChg>
    </pc:docChg>
  </pc:docChgLst>
  <pc:docChgLst>
    <pc:chgData name="吉武 和敏" userId="e4825ba96748af9c" providerId="LiveId" clId="{F9D40476-436E-48E8-A5D6-204A0E704A88}"/>
    <pc:docChg chg="undo redo custSel addSld delSld modSld sldOrd">
      <pc:chgData name="吉武 和敏" userId="e4825ba96748af9c" providerId="LiveId" clId="{F9D40476-436E-48E8-A5D6-204A0E704A88}" dt="2020-06-25T08:06:51.837" v="3155" actId="20577"/>
      <pc:docMkLst>
        <pc:docMk/>
      </pc:docMkLst>
      <pc:sldChg chg="del">
        <pc:chgData name="吉武 和敏" userId="e4825ba96748af9c" providerId="LiveId" clId="{F9D40476-436E-48E8-A5D6-204A0E704A88}" dt="2020-06-19T08:54:54.184" v="2132" actId="47"/>
        <pc:sldMkLst>
          <pc:docMk/>
          <pc:sldMk cId="947865464" sldId="256"/>
        </pc:sldMkLst>
      </pc:sldChg>
      <pc:sldChg chg="addSp delSp modSp mod">
        <pc:chgData name="吉武 和敏" userId="e4825ba96748af9c" providerId="LiveId" clId="{F9D40476-436E-48E8-A5D6-204A0E704A88}" dt="2020-06-19T09:08:43.677" v="2160" actId="20577"/>
        <pc:sldMkLst>
          <pc:docMk/>
          <pc:sldMk cId="1744819178" sldId="257"/>
        </pc:sldMkLst>
        <pc:spChg chg="del">
          <ac:chgData name="吉武 和敏" userId="e4825ba96748af9c" providerId="LiveId" clId="{F9D40476-436E-48E8-A5D6-204A0E704A88}" dt="2020-06-19T06:52:49.566" v="1254" actId="478"/>
          <ac:spMkLst>
            <pc:docMk/>
            <pc:sldMk cId="1744819178" sldId="257"/>
            <ac:spMk id="2" creationId="{8C5E9E0B-DAA4-344D-B53B-B4E5D875579D}"/>
          </ac:spMkLst>
        </pc:spChg>
        <pc:spChg chg="add mod">
          <ac:chgData name="吉武 和敏" userId="e4825ba96748af9c" providerId="LiveId" clId="{F9D40476-436E-48E8-A5D6-204A0E704A88}" dt="2020-06-19T07:00:25.105" v="1519" actId="1076"/>
          <ac:spMkLst>
            <pc:docMk/>
            <pc:sldMk cId="1744819178" sldId="257"/>
            <ac:spMk id="9" creationId="{1B91C58E-3ABA-48EF-A0FC-FD5433F797C2}"/>
          </ac:spMkLst>
        </pc:spChg>
        <pc:spChg chg="del">
          <ac:chgData name="吉武 和敏" userId="e4825ba96748af9c" providerId="LiveId" clId="{F9D40476-436E-48E8-A5D6-204A0E704A88}" dt="2020-06-19T06:52:49.566" v="1254" actId="478"/>
          <ac:spMkLst>
            <pc:docMk/>
            <pc:sldMk cId="1744819178" sldId="257"/>
            <ac:spMk id="10" creationId="{192E88E9-BF57-4C42-A91F-EC22F2ED5525}"/>
          </ac:spMkLst>
        </pc:spChg>
        <pc:spChg chg="mod">
          <ac:chgData name="吉武 和敏" userId="e4825ba96748af9c" providerId="LiveId" clId="{F9D40476-436E-48E8-A5D6-204A0E704A88}" dt="2020-06-19T09:08:43.677" v="2160" actId="20577"/>
          <ac:spMkLst>
            <pc:docMk/>
            <pc:sldMk cId="1744819178" sldId="257"/>
            <ac:spMk id="11" creationId="{00000000-0000-0000-0000-000000000000}"/>
          </ac:spMkLst>
        </pc:spChg>
        <pc:spChg chg="del">
          <ac:chgData name="吉武 和敏" userId="e4825ba96748af9c" providerId="LiveId" clId="{F9D40476-436E-48E8-A5D6-204A0E704A88}" dt="2020-06-19T06:52:49.566" v="1254" actId="478"/>
          <ac:spMkLst>
            <pc:docMk/>
            <pc:sldMk cId="1744819178" sldId="257"/>
            <ac:spMk id="12" creationId="{DE1E9486-B856-9F4E-8C0E-A9D5FA3A6B28}"/>
          </ac:spMkLst>
        </pc:spChg>
        <pc:spChg chg="del">
          <ac:chgData name="吉武 和敏" userId="e4825ba96748af9c" providerId="LiveId" clId="{F9D40476-436E-48E8-A5D6-204A0E704A88}" dt="2020-06-19T06:52:50.430" v="1255" actId="478"/>
          <ac:spMkLst>
            <pc:docMk/>
            <pc:sldMk cId="1744819178" sldId="257"/>
            <ac:spMk id="13" creationId="{B135A94E-CA15-8F4D-BC26-4E0889DA5448}"/>
          </ac:spMkLst>
        </pc:spChg>
        <pc:spChg chg="add del mod">
          <ac:chgData name="吉武 和敏" userId="e4825ba96748af9c" providerId="LiveId" clId="{F9D40476-436E-48E8-A5D6-204A0E704A88}" dt="2020-06-19T06:52:51.374" v="1256" actId="478"/>
          <ac:spMkLst>
            <pc:docMk/>
            <pc:sldMk cId="1744819178" sldId="257"/>
            <ac:spMk id="16" creationId="{8388E8C5-118A-4E45-B826-4FB4465ADC63}"/>
          </ac:spMkLst>
        </pc:spChg>
        <pc:spChg chg="add del mod">
          <ac:chgData name="吉武 和敏" userId="e4825ba96748af9c" providerId="LiveId" clId="{F9D40476-436E-48E8-A5D6-204A0E704A88}" dt="2020-06-19T06:52:51.374" v="1256" actId="478"/>
          <ac:spMkLst>
            <pc:docMk/>
            <pc:sldMk cId="1744819178" sldId="257"/>
            <ac:spMk id="17" creationId="{B307299D-5E5D-4D05-8DCC-E453C67097D7}"/>
          </ac:spMkLst>
        </pc:spChg>
        <pc:spChg chg="add del mod">
          <ac:chgData name="吉武 和敏" userId="e4825ba96748af9c" providerId="LiveId" clId="{F9D40476-436E-48E8-A5D6-204A0E704A88}" dt="2020-06-19T06:52:51.374" v="1256" actId="478"/>
          <ac:spMkLst>
            <pc:docMk/>
            <pc:sldMk cId="1744819178" sldId="257"/>
            <ac:spMk id="19" creationId="{D3938583-7E03-402E-BE64-470F2079B5A3}"/>
          </ac:spMkLst>
        </pc:spChg>
        <pc:spChg chg="add mod">
          <ac:chgData name="吉武 和敏" userId="e4825ba96748af9c" providerId="LiveId" clId="{F9D40476-436E-48E8-A5D6-204A0E704A88}" dt="2020-06-19T07:00:25.105" v="1519" actId="1076"/>
          <ac:spMkLst>
            <pc:docMk/>
            <pc:sldMk cId="1744819178" sldId="257"/>
            <ac:spMk id="30" creationId="{889C4CE0-175C-4B66-9EF0-EF336551A3AE}"/>
          </ac:spMkLst>
        </pc:spChg>
        <pc:grpChg chg="add mod">
          <ac:chgData name="吉武 和敏" userId="e4825ba96748af9c" providerId="LiveId" clId="{F9D40476-436E-48E8-A5D6-204A0E704A88}" dt="2020-06-19T07:00:25.105" v="1519" actId="1076"/>
          <ac:grpSpMkLst>
            <pc:docMk/>
            <pc:sldMk cId="1744819178" sldId="257"/>
            <ac:grpSpMk id="8" creationId="{8CC0BA1B-9D0D-4D7C-986F-D15F2E747002}"/>
          </ac:grpSpMkLst>
        </pc:grpChg>
        <pc:graphicFrameChg chg="del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4" creationId="{00000000-0000-0000-0000-000000000000}"/>
          </ac:graphicFrameMkLst>
        </pc:graphicFrameChg>
        <pc:graphicFrameChg chg="del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5" creationId="{00000000-0000-0000-0000-000000000000}"/>
          </ac:graphicFrameMkLst>
        </pc:graphicFrameChg>
        <pc:graphicFrameChg chg="del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6" creationId="{00000000-0000-0000-0000-000000000000}"/>
          </ac:graphicFrameMkLst>
        </pc:graphicFrameChg>
        <pc:graphicFrameChg chg="del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7" creationId="{00000000-0000-0000-0000-000000000000}"/>
          </ac:graphicFrameMkLst>
        </pc:graphicFrameChg>
        <pc:graphicFrameChg chg="add del mod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14" creationId="{735B423F-B002-42AF-8C56-8B6A4535D9F1}"/>
          </ac:graphicFrameMkLst>
        </pc:graphicFrameChg>
        <pc:graphicFrameChg chg="add del mod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15" creationId="{44F18B7B-7A07-4DFF-BEB7-3B8BC876530F}"/>
          </ac:graphicFrameMkLst>
        </pc:graphicFrameChg>
        <pc:graphicFrameChg chg="add del mod">
          <ac:chgData name="吉武 和敏" userId="e4825ba96748af9c" providerId="LiveId" clId="{F9D40476-436E-48E8-A5D6-204A0E704A88}" dt="2020-06-19T06:52:46.575" v="1253" actId="478"/>
          <ac:graphicFrameMkLst>
            <pc:docMk/>
            <pc:sldMk cId="1744819178" sldId="257"/>
            <ac:graphicFrameMk id="18" creationId="{24CB4ADD-AADD-41B7-83ED-CFD775136A3D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0" creationId="{00000000-0008-0000-0000-000004000000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1" creationId="{00000000-0008-0000-0000-000005000000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2" creationId="{00000000-0008-0000-0000-000006000000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3" creationId="{00000000-0008-0000-0000-000007000000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4" creationId="{00000000-0008-0000-0000-000008000000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5" creationId="{00000000-0008-0000-0000-000009000000}"/>
          </ac:graphicFrameMkLst>
        </pc:graphicFrameChg>
        <pc:graphicFrameChg chg="add mod">
          <ac:chgData name="吉武 和敏" userId="e4825ba96748af9c" providerId="LiveId" clId="{F9D40476-436E-48E8-A5D6-204A0E704A88}" dt="2020-06-19T07:00:25.105" v="1519" actId="1076"/>
          <ac:graphicFrameMkLst>
            <pc:docMk/>
            <pc:sldMk cId="1744819178" sldId="257"/>
            <ac:graphicFrameMk id="26" creationId="{00000000-0008-0000-0000-00000A000000}"/>
          </ac:graphicFrameMkLst>
        </pc:graphicFrameChg>
        <pc:graphicFrameChg chg="add del mod">
          <ac:chgData name="吉武 和敏" userId="e4825ba96748af9c" providerId="LiveId" clId="{F9D40476-436E-48E8-A5D6-204A0E704A88}" dt="2020-06-19T06:55:27.140" v="1453" actId="478"/>
          <ac:graphicFrameMkLst>
            <pc:docMk/>
            <pc:sldMk cId="1744819178" sldId="257"/>
            <ac:graphicFrameMk id="27" creationId="{E3D54547-AE99-4407-B3F9-442D43926AB4}"/>
          </ac:graphicFrameMkLst>
        </pc:graphicFrameChg>
        <pc:graphicFrameChg chg="add del mod">
          <ac:chgData name="吉武 和敏" userId="e4825ba96748af9c" providerId="LiveId" clId="{F9D40476-436E-48E8-A5D6-204A0E704A88}" dt="2020-06-19T06:56:55.955" v="1474" actId="478"/>
          <ac:graphicFrameMkLst>
            <pc:docMk/>
            <pc:sldMk cId="1744819178" sldId="257"/>
            <ac:graphicFrameMk id="29" creationId="{7417D4C9-B7B5-4BA1-B117-FF356536DCE9}"/>
          </ac:graphicFrameMkLst>
        </pc:graphicFrameChg>
        <pc:picChg chg="add mod modCrop">
          <ac:chgData name="吉武 和敏" userId="e4825ba96748af9c" providerId="LiveId" clId="{F9D40476-436E-48E8-A5D6-204A0E704A88}" dt="2020-06-19T06:56:28.188" v="1468" actId="164"/>
          <ac:picMkLst>
            <pc:docMk/>
            <pc:sldMk cId="1744819178" sldId="257"/>
            <ac:picMk id="3" creationId="{C4099FB8-8067-4D31-9196-F6656ECACD57}"/>
          </ac:picMkLst>
        </pc:picChg>
        <pc:picChg chg="add mod modCrop">
          <ac:chgData name="吉武 和敏" userId="e4825ba96748af9c" providerId="LiveId" clId="{F9D40476-436E-48E8-A5D6-204A0E704A88}" dt="2020-06-19T06:56:28.188" v="1468" actId="164"/>
          <ac:picMkLst>
            <pc:docMk/>
            <pc:sldMk cId="1744819178" sldId="257"/>
            <ac:picMk id="28" creationId="{7EAE7EC0-1C42-4709-9FA7-48B5504F9BF7}"/>
          </ac:picMkLst>
        </pc:picChg>
      </pc:sldChg>
      <pc:sldChg chg="addSp delSp modSp mod">
        <pc:chgData name="吉武 和敏" userId="e4825ba96748af9c" providerId="LiveId" clId="{F9D40476-436E-48E8-A5D6-204A0E704A88}" dt="2020-06-19T09:08:46.795" v="2161" actId="20577"/>
        <pc:sldMkLst>
          <pc:docMk/>
          <pc:sldMk cId="1279635173" sldId="258"/>
        </pc:sldMkLst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2" creationId="{E53D8DD9-11AB-482A-A594-D5B2C6DB1733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9" creationId="{C871ADAF-F0D2-415F-ADB0-2DB162BC2858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10" creationId="{7DE08F2E-D003-4355-8233-8C25E2922F6D}"/>
          </ac:spMkLst>
        </pc:spChg>
        <pc:spChg chg="del">
          <ac:chgData name="吉武 和敏" userId="e4825ba96748af9c" providerId="LiveId" clId="{F9D40476-436E-48E8-A5D6-204A0E704A88}" dt="2020-06-19T08:39:01.871" v="1644" actId="478"/>
          <ac:spMkLst>
            <pc:docMk/>
            <pc:sldMk cId="1279635173" sldId="258"/>
            <ac:spMk id="11" creationId="{DC3BC33B-21EC-42AC-8D69-D40CE84678FB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16" creationId="{8D9C783F-FC6C-4BB0-A617-AC6428B36DDA}"/>
          </ac:spMkLst>
        </pc:spChg>
        <pc:spChg chg="add mod">
          <ac:chgData name="吉武 和敏" userId="e4825ba96748af9c" providerId="LiveId" clId="{F9D40476-436E-48E8-A5D6-204A0E704A88}" dt="2020-06-19T09:08:46.795" v="2161" actId="20577"/>
          <ac:spMkLst>
            <pc:docMk/>
            <pc:sldMk cId="1279635173" sldId="258"/>
            <ac:spMk id="17" creationId="{B2D68AC7-1A9E-486E-8E8C-4E418A7A418D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19" creationId="{8F0457B7-BC6D-40C5-84C3-28F9E45F09D4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20" creationId="{4A7CB688-03EB-49D7-9368-717070822765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25" creationId="{021332A7-2B3E-481E-9201-0AA1142573F9}"/>
          </ac:spMkLst>
        </pc:spChg>
        <pc:spChg chg="del">
          <ac:chgData name="吉武 和敏" userId="e4825ba96748af9c" providerId="LiveId" clId="{F9D40476-436E-48E8-A5D6-204A0E704A88}" dt="2020-06-19T08:39:53.535" v="1650" actId="478"/>
          <ac:spMkLst>
            <pc:docMk/>
            <pc:sldMk cId="1279635173" sldId="258"/>
            <ac:spMk id="26" creationId="{1070F505-21A4-44DA-ACAE-60634A7A20A3}"/>
          </ac:spMkLst>
        </pc:spChg>
        <pc:graphicFrameChg chg="del">
          <ac:chgData name="吉武 和敏" userId="e4825ba96748af9c" providerId="LiveId" clId="{F9D40476-436E-48E8-A5D6-204A0E704A88}" dt="2020-06-19T08:39:01.871" v="1644" actId="478"/>
          <ac:graphicFrameMkLst>
            <pc:docMk/>
            <pc:sldMk cId="1279635173" sldId="258"/>
            <ac:graphicFrameMk id="8" creationId="{7EC5F59D-F4C7-4C8E-B216-749B4E2664DA}"/>
          </ac:graphicFrameMkLst>
        </pc:graphicFrameChg>
        <pc:graphicFrameChg chg="del">
          <ac:chgData name="吉武 和敏" userId="e4825ba96748af9c" providerId="LiveId" clId="{F9D40476-436E-48E8-A5D6-204A0E704A88}" dt="2020-06-19T08:39:53.535" v="1650" actId="478"/>
          <ac:graphicFrameMkLst>
            <pc:docMk/>
            <pc:sldMk cId="1279635173" sldId="258"/>
            <ac:graphicFrameMk id="13" creationId="{DB2ADC17-AE43-4232-A8B4-E2AB7F83C20B}"/>
          </ac:graphicFrameMkLst>
        </pc:graphicFrameChg>
        <pc:graphicFrameChg chg="del">
          <ac:chgData name="吉武 和敏" userId="e4825ba96748af9c" providerId="LiveId" clId="{F9D40476-436E-48E8-A5D6-204A0E704A88}" dt="2020-06-19T08:39:53.535" v="1650" actId="478"/>
          <ac:graphicFrameMkLst>
            <pc:docMk/>
            <pc:sldMk cId="1279635173" sldId="258"/>
            <ac:graphicFrameMk id="14" creationId="{04FBCF37-4AED-45AA-B398-B923EE3B9CB0}"/>
          </ac:graphicFrameMkLst>
        </pc:graphicFrameChg>
        <pc:graphicFrameChg chg="add mod">
          <ac:chgData name="吉武 和敏" userId="e4825ba96748af9c" providerId="LiveId" clId="{F9D40476-436E-48E8-A5D6-204A0E704A88}" dt="2020-06-19T08:53:08.419" v="2131" actId="1076"/>
          <ac:graphicFrameMkLst>
            <pc:docMk/>
            <pc:sldMk cId="1279635173" sldId="258"/>
            <ac:graphicFrameMk id="15" creationId="{00000000-0008-0000-0000-000003000000}"/>
          </ac:graphicFrameMkLst>
        </pc:graphicFrameChg>
      </pc:sldChg>
      <pc:sldChg chg="del">
        <pc:chgData name="吉武 和敏" userId="e4825ba96748af9c" providerId="LiveId" clId="{F9D40476-436E-48E8-A5D6-204A0E704A88}" dt="2020-06-22T08:34:10.910" v="2162" actId="47"/>
        <pc:sldMkLst>
          <pc:docMk/>
          <pc:sldMk cId="269046186" sldId="259"/>
        </pc:sldMkLst>
      </pc:sldChg>
      <pc:sldChg chg="del">
        <pc:chgData name="吉武 和敏" userId="e4825ba96748af9c" providerId="LiveId" clId="{F9D40476-436E-48E8-A5D6-204A0E704A88}" dt="2020-06-19T08:54:56.245" v="2133" actId="47"/>
        <pc:sldMkLst>
          <pc:docMk/>
          <pc:sldMk cId="3017545617" sldId="260"/>
        </pc:sldMkLst>
      </pc:sldChg>
      <pc:sldChg chg="del">
        <pc:chgData name="吉武 和敏" userId="e4825ba96748af9c" providerId="LiveId" clId="{F9D40476-436E-48E8-A5D6-204A0E704A88}" dt="2020-06-19T08:54:57.113" v="2134" actId="47"/>
        <pc:sldMkLst>
          <pc:docMk/>
          <pc:sldMk cId="3696140831" sldId="261"/>
        </pc:sldMkLst>
      </pc:sldChg>
      <pc:sldChg chg="del">
        <pc:chgData name="吉武 和敏" userId="e4825ba96748af9c" providerId="LiveId" clId="{F9D40476-436E-48E8-A5D6-204A0E704A88}" dt="2020-06-19T08:54:58.362" v="2135" actId="47"/>
        <pc:sldMkLst>
          <pc:docMk/>
          <pc:sldMk cId="636513443" sldId="263"/>
        </pc:sldMkLst>
      </pc:sldChg>
      <pc:sldChg chg="del">
        <pc:chgData name="吉武 和敏" userId="e4825ba96748af9c" providerId="LiveId" clId="{F9D40476-436E-48E8-A5D6-204A0E704A88}" dt="2020-06-18T16:53:54.492" v="1" actId="47"/>
        <pc:sldMkLst>
          <pc:docMk/>
          <pc:sldMk cId="1485698774" sldId="265"/>
        </pc:sldMkLst>
      </pc:sldChg>
      <pc:sldChg chg="del">
        <pc:chgData name="吉武 和敏" userId="e4825ba96748af9c" providerId="LiveId" clId="{F9D40476-436E-48E8-A5D6-204A0E704A88}" dt="2020-06-22T08:34:10.910" v="2162" actId="47"/>
        <pc:sldMkLst>
          <pc:docMk/>
          <pc:sldMk cId="626345740" sldId="267"/>
        </pc:sldMkLst>
      </pc:sldChg>
      <pc:sldChg chg="addSp delSp modSp mod ord">
        <pc:chgData name="吉武 和敏" userId="e4825ba96748af9c" providerId="LiveId" clId="{F9D40476-436E-48E8-A5D6-204A0E704A88}" dt="2020-06-25T08:06:51.837" v="3155" actId="20577"/>
        <pc:sldMkLst>
          <pc:docMk/>
          <pc:sldMk cId="2704609531" sldId="268"/>
        </pc:sldMkLst>
        <pc:spChg chg="mod">
          <ac:chgData name="吉武 和敏" userId="e4825ba96748af9c" providerId="LiveId" clId="{F9D40476-436E-48E8-A5D6-204A0E704A88}" dt="2020-06-25T07:52:04.949" v="2832" actId="1076"/>
          <ac:spMkLst>
            <pc:docMk/>
            <pc:sldMk cId="2704609531" sldId="268"/>
            <ac:spMk id="16" creationId="{7BCD9ADA-C363-44AB-986C-4A86D045145B}"/>
          </ac:spMkLst>
        </pc:spChg>
        <pc:spChg chg="mod">
          <ac:chgData name="吉武 和敏" userId="e4825ba96748af9c" providerId="LiveId" clId="{F9D40476-436E-48E8-A5D6-204A0E704A88}" dt="2020-06-25T07:52:04.949" v="2832" actId="1076"/>
          <ac:spMkLst>
            <pc:docMk/>
            <pc:sldMk cId="2704609531" sldId="268"/>
            <ac:spMk id="17" creationId="{C01C5D12-5A10-4587-A12B-1035FEEBF04C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9" creationId="{C1AB3248-BC88-4C67-9617-62F1D9866D89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1" creationId="{5C7B10A9-76D5-4862-B0B9-A3294F4E9F1F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2" creationId="{2AA9FA06-BDF8-4CA1-B8B2-FFB2995842B6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3" creationId="{FC8184EB-F5C7-449D-843D-9D2574A883B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5" creationId="{76576770-6F70-4DA2-B7F6-42FB365AD76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6" creationId="{C63EB485-5C3D-4FFF-A7B3-47394E9FE200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7" creationId="{38C41209-430D-45D4-8565-A768F2FF086C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0" creationId="{25B1462B-A3C6-46A6-806C-8F0DB5A8C3FC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1" creationId="{08B7F3A2-19CB-47B1-B182-D92139425174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98" creationId="{DF513214-1548-4A72-9209-EE27F649DA0A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99" creationId="{F287C267-ACEF-4F01-810F-58D4D5A0B958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43" creationId="{938BDC4F-B134-4F18-88D4-D86165B08E93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44" creationId="{CC884790-F988-478B-B6CB-5A7BC0CBEFA8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45" creationId="{E4171464-44CF-4FAF-966E-2103F82E3957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46" creationId="{84807937-221A-4F8E-943E-631C9BC9B603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47" creationId="{D827FFBB-50E1-42B6-91C6-8588BC38D82F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48" creationId="{6093F1B5-7EE0-4EF1-873B-92E31E3BC15C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53" creationId="{F806988C-6604-4B9B-A963-B73A2F04B90E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04" creationId="{84BAC722-9CC4-4EAE-82BB-333FBA97F377}"/>
          </ac:spMkLst>
        </pc:spChg>
        <pc:spChg chg="mod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08" creationId="{815ED7E2-3095-481F-9E69-F93E970C27DB}"/>
          </ac:spMkLst>
        </pc:spChg>
        <pc:spChg chg="mod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09" creationId="{A5998FF5-D549-42A7-BF06-D0C29E80C558}"/>
          </ac:spMkLst>
        </pc:spChg>
        <pc:spChg chg="mod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10" creationId="{B54E1EC1-EE94-4156-A57D-EE157B4BBB7A}"/>
          </ac:spMkLst>
        </pc:spChg>
        <pc:spChg chg="mod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11" creationId="{A57BADDF-B439-46E3-B6C4-8DE247994176}"/>
          </ac:spMkLst>
        </pc:spChg>
        <pc:spChg chg="mod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12" creationId="{0C4EFD7D-EB4B-497E-974C-DF74EF29BDFD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53" creationId="{95E3CB9A-9ADC-4971-9AD9-99EE5A15EBA9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60" creationId="{62E17AB0-9CD5-4D65-B127-E0316520B97F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61" creationId="{CEC2680B-39A9-4E11-AC5D-79EA6DAD7BA9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268" creationId="{50B42C45-7333-4ED1-8C94-2C09964C4666}"/>
          </ac:spMkLst>
        </pc:spChg>
        <pc:spChg chg="del mod">
          <ac:chgData name="吉武 和敏" userId="e4825ba96748af9c" providerId="LiveId" clId="{F9D40476-436E-48E8-A5D6-204A0E704A88}" dt="2020-06-25T07:56:15.807" v="2893"/>
          <ac:spMkLst>
            <pc:docMk/>
            <pc:sldMk cId="2704609531" sldId="268"/>
            <ac:spMk id="269" creationId="{0B22F5FF-E2C0-4913-BF27-A58ADDA9CC4C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70" creationId="{598935E1-46FE-4292-9839-776458C26A7A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71" creationId="{2EC336BA-8682-426B-809B-0B3F3D25BDEA}"/>
          </ac:spMkLst>
        </pc:spChg>
        <pc:spChg chg="mod">
          <ac:chgData name="吉武 和敏" userId="e4825ba96748af9c" providerId="LiveId" clId="{F9D40476-436E-48E8-A5D6-204A0E704A88}" dt="2020-06-25T07:56:10.366" v="2890" actId="14100"/>
          <ac:spMkLst>
            <pc:docMk/>
            <pc:sldMk cId="2704609531" sldId="268"/>
            <ac:spMk id="272" creationId="{3DDD0C33-4381-4DEF-A6C2-C3CB234FD623}"/>
          </ac:spMkLst>
        </pc:spChg>
        <pc:spChg chg="del">
          <ac:chgData name="吉武 和敏" userId="e4825ba96748af9c" providerId="LiveId" clId="{F9D40476-436E-48E8-A5D6-204A0E704A88}" dt="2020-06-25T07:51:14.284" v="2823" actId="478"/>
          <ac:spMkLst>
            <pc:docMk/>
            <pc:sldMk cId="2704609531" sldId="268"/>
            <ac:spMk id="274" creationId="{14F6A7C9-50BA-47CD-9DB6-C1C9FF086540}"/>
          </ac:spMkLst>
        </pc:spChg>
        <pc:spChg chg="mod">
          <ac:chgData name="吉武 和敏" userId="e4825ba96748af9c" providerId="LiveId" clId="{F9D40476-436E-48E8-A5D6-204A0E704A88}" dt="2020-06-25T07:52:23.629" v="2845" actId="20577"/>
          <ac:spMkLst>
            <pc:docMk/>
            <pc:sldMk cId="2704609531" sldId="268"/>
            <ac:spMk id="275" creationId="{52F45436-A5A4-4E8A-8889-54E25BDDADCB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77" creationId="{2AD5A4D5-5138-4656-A5E6-271E3977DDDD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78" creationId="{28B5EBA9-FF92-453A-914D-6B6E479CFB96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81" creationId="{740B5ACB-3B38-4F96-A58E-157EF942D04F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82" creationId="{7F80167F-87A7-4F1C-A8C2-D41F5B5430F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83" creationId="{5A58F105-F9A2-4C13-AB04-B0A336913D8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84" creationId="{8A9E8578-EF85-42D7-AA96-78603C6404DA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285" creationId="{D6123B56-6A50-4AC5-AB52-167D86FE0BD4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25" creationId="{7D3668B3-7D72-4BBA-9826-0E23EB18096E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26" creationId="{6623FD20-178C-4EB6-892C-B6A7256529CB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28" creationId="{DBB60115-54E0-449C-9F4A-DD54A9E0FB4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31" creationId="{5907E8F1-4C0B-45C7-A9D3-C6DF12B2393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35" creationId="{3F3E8436-4470-46F8-AB41-CEFABA8C86DE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338" creationId="{13D9BFE2-3F27-4424-9F12-F45F5A2EDD65}"/>
          </ac:spMkLst>
        </pc:spChg>
        <pc:spChg chg="add mod">
          <ac:chgData name="吉武 和敏" userId="e4825ba96748af9c" providerId="LiveId" clId="{F9D40476-436E-48E8-A5D6-204A0E704A88}" dt="2020-06-25T07:54:24.493" v="2860" actId="1076"/>
          <ac:spMkLst>
            <pc:docMk/>
            <pc:sldMk cId="2704609531" sldId="268"/>
            <ac:spMk id="339" creationId="{99C6B893-12DB-4AB4-A5DA-F70B135D26F8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40" creationId="{72B8202D-FCA7-4BE9-AEB5-4C627237077B}"/>
          </ac:spMkLst>
        </pc:spChg>
        <pc:spChg chg="add mod">
          <ac:chgData name="吉武 和敏" userId="e4825ba96748af9c" providerId="LiveId" clId="{F9D40476-436E-48E8-A5D6-204A0E704A88}" dt="2020-06-25T07:54:47.404" v="2862" actId="1076"/>
          <ac:spMkLst>
            <pc:docMk/>
            <pc:sldMk cId="2704609531" sldId="268"/>
            <ac:spMk id="342" creationId="{81BD39A7-ED16-4508-A739-D706E239A977}"/>
          </ac:spMkLst>
        </pc:spChg>
        <pc:spChg chg="add mod">
          <ac:chgData name="吉武 和敏" userId="e4825ba96748af9c" providerId="LiveId" clId="{F9D40476-436E-48E8-A5D6-204A0E704A88}" dt="2020-06-25T07:54:47.404" v="2862" actId="1076"/>
          <ac:spMkLst>
            <pc:docMk/>
            <pc:sldMk cId="2704609531" sldId="268"/>
            <ac:spMk id="343" creationId="{B16C3CB0-07D6-448F-8C51-6AF1EEB4A4C5}"/>
          </ac:spMkLst>
        </pc:spChg>
        <pc:spChg chg="add mod">
          <ac:chgData name="吉武 和敏" userId="e4825ba96748af9c" providerId="LiveId" clId="{F9D40476-436E-48E8-A5D6-204A0E704A88}" dt="2020-06-25T07:54:47.404" v="2862" actId="1076"/>
          <ac:spMkLst>
            <pc:docMk/>
            <pc:sldMk cId="2704609531" sldId="268"/>
            <ac:spMk id="345" creationId="{846FD827-DE05-4BFD-B403-F5E6F4245237}"/>
          </ac:spMkLst>
        </pc:spChg>
        <pc:spChg chg="add del mod">
          <ac:chgData name="吉武 和敏" userId="e4825ba96748af9c" providerId="LiveId" clId="{F9D40476-436E-48E8-A5D6-204A0E704A88}" dt="2020-06-25T07:54:09.565" v="2858" actId="478"/>
          <ac:spMkLst>
            <pc:docMk/>
            <pc:sldMk cId="2704609531" sldId="268"/>
            <ac:spMk id="346" creationId="{70599804-AE50-4CEC-AD0C-942280CCCF9A}"/>
          </ac:spMkLst>
        </pc:spChg>
        <pc:spChg chg="add mod">
          <ac:chgData name="吉武 和敏" userId="e4825ba96748af9c" providerId="LiveId" clId="{F9D40476-436E-48E8-A5D6-204A0E704A88}" dt="2020-06-25T07:54:56.205" v="2864" actId="571"/>
          <ac:spMkLst>
            <pc:docMk/>
            <pc:sldMk cId="2704609531" sldId="268"/>
            <ac:spMk id="348" creationId="{851D2F5C-25E3-4E67-B647-D08CDAA008C0}"/>
          </ac:spMkLst>
        </pc:spChg>
        <pc:spChg chg="add mod">
          <ac:chgData name="吉武 和敏" userId="e4825ba96748af9c" providerId="LiveId" clId="{F9D40476-436E-48E8-A5D6-204A0E704A88}" dt="2020-06-25T07:54:56.205" v="2864" actId="571"/>
          <ac:spMkLst>
            <pc:docMk/>
            <pc:sldMk cId="2704609531" sldId="268"/>
            <ac:spMk id="350" creationId="{02833A28-99A8-4D05-AB54-80B1E74C2E31}"/>
          </ac:spMkLst>
        </pc:spChg>
        <pc:spChg chg="add mod">
          <ac:chgData name="吉武 和敏" userId="e4825ba96748af9c" providerId="LiveId" clId="{F9D40476-436E-48E8-A5D6-204A0E704A88}" dt="2020-06-25T07:54:56.205" v="2864" actId="571"/>
          <ac:spMkLst>
            <pc:docMk/>
            <pc:sldMk cId="2704609531" sldId="268"/>
            <ac:spMk id="351" creationId="{63E37109-C6D4-46FC-A3B4-8CAEDEA21049}"/>
          </ac:spMkLst>
        </pc:spChg>
        <pc:spChg chg="add mod">
          <ac:chgData name="吉武 和敏" userId="e4825ba96748af9c" providerId="LiveId" clId="{F9D40476-436E-48E8-A5D6-204A0E704A88}" dt="2020-06-25T07:54:56.205" v="2864" actId="571"/>
          <ac:spMkLst>
            <pc:docMk/>
            <pc:sldMk cId="2704609531" sldId="268"/>
            <ac:spMk id="352" creationId="{229C6664-F192-4F4B-93B5-168D0CAB9B39}"/>
          </ac:spMkLst>
        </pc:spChg>
        <pc:spChg chg="add mod">
          <ac:chgData name="吉武 和敏" userId="e4825ba96748af9c" providerId="LiveId" clId="{F9D40476-436E-48E8-A5D6-204A0E704A88}" dt="2020-06-25T07:55:02.724" v="2865" actId="571"/>
          <ac:spMkLst>
            <pc:docMk/>
            <pc:sldMk cId="2704609531" sldId="268"/>
            <ac:spMk id="353" creationId="{B142EDAD-A3FF-4524-A038-58665311DF58}"/>
          </ac:spMkLst>
        </pc:spChg>
        <pc:spChg chg="add mod">
          <ac:chgData name="吉武 和敏" userId="e4825ba96748af9c" providerId="LiveId" clId="{F9D40476-436E-48E8-A5D6-204A0E704A88}" dt="2020-06-25T07:55:02.724" v="2865" actId="571"/>
          <ac:spMkLst>
            <pc:docMk/>
            <pc:sldMk cId="2704609531" sldId="268"/>
            <ac:spMk id="355" creationId="{78433BDD-6D9F-4A46-983E-68534FC811AB}"/>
          </ac:spMkLst>
        </pc:spChg>
        <pc:spChg chg="add mod">
          <ac:chgData name="吉武 和敏" userId="e4825ba96748af9c" providerId="LiveId" clId="{F9D40476-436E-48E8-A5D6-204A0E704A88}" dt="2020-06-25T07:55:21.931" v="2867" actId="207"/>
          <ac:spMkLst>
            <pc:docMk/>
            <pc:sldMk cId="2704609531" sldId="268"/>
            <ac:spMk id="356" creationId="{A1FCDCFE-0E8B-4E21-AC86-418DD0B3FBF6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58" creationId="{833B5CC8-1100-4A4F-A5C5-99F14D4BE9C1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59" creationId="{EB013EAB-A959-478C-B54B-938056513CF6}"/>
          </ac:spMkLst>
        </pc:spChg>
        <pc:spChg chg="add mod">
          <ac:chgData name="吉武 和敏" userId="e4825ba96748af9c" providerId="LiveId" clId="{F9D40476-436E-48E8-A5D6-204A0E704A88}" dt="2020-06-25T07:55:02.724" v="2865" actId="571"/>
          <ac:spMkLst>
            <pc:docMk/>
            <pc:sldMk cId="2704609531" sldId="268"/>
            <ac:spMk id="360" creationId="{9C50F1D7-C40B-4787-9935-38905A83F827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62" creationId="{469F7847-758D-4E29-BDF4-ABA42C203CA0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63" creationId="{A3830F12-BF99-4781-B646-038417F41E9D}"/>
          </ac:spMkLst>
        </pc:spChg>
        <pc:spChg chg="add mod">
          <ac:chgData name="吉武 和敏" userId="e4825ba96748af9c" providerId="LiveId" clId="{F9D40476-436E-48E8-A5D6-204A0E704A88}" dt="2020-06-25T07:55:07.774" v="2866" actId="571"/>
          <ac:spMkLst>
            <pc:docMk/>
            <pc:sldMk cId="2704609531" sldId="268"/>
            <ac:spMk id="364" creationId="{E9F7F570-8836-4D6D-B035-66903CD3AE54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66" creationId="{5CBAFE80-0640-4A70-B115-481C2189CE98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67" creationId="{585ABDCF-88EE-4391-A0CB-0EE82B6F51AA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70" creationId="{BEF545F3-4CB5-489D-8EF5-64080C0BA258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371" creationId="{8B8CC97B-94AF-44F4-802A-1BD8807FBE65}"/>
          </ac:spMkLst>
        </pc:spChg>
        <pc:spChg chg="add mod">
          <ac:chgData name="吉武 和敏" userId="e4825ba96748af9c" providerId="LiveId" clId="{F9D40476-436E-48E8-A5D6-204A0E704A88}" dt="2020-06-25T07:55:07.774" v="2866" actId="571"/>
          <ac:spMkLst>
            <pc:docMk/>
            <pc:sldMk cId="2704609531" sldId="268"/>
            <ac:spMk id="372" creationId="{1EFB2F54-B668-4592-8F6D-79209BE29975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74" creationId="{4772426F-9D9B-42E1-B47E-1D4C771FD413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75" creationId="{0CEA017C-8F9F-4848-B555-A5E5EA1333BA}"/>
          </ac:spMkLst>
        </pc:spChg>
        <pc:spChg chg="add mod">
          <ac:chgData name="吉武 和敏" userId="e4825ba96748af9c" providerId="LiveId" clId="{F9D40476-436E-48E8-A5D6-204A0E704A88}" dt="2020-06-25T07:55:32.017" v="2868" actId="207"/>
          <ac:spMkLst>
            <pc:docMk/>
            <pc:sldMk cId="2704609531" sldId="268"/>
            <ac:spMk id="376" creationId="{1E2796FB-ED5F-47CB-9EE1-71C6F0A1221A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78" creationId="{8F3D495C-C4A8-4B9E-8C45-0A03A4F14E0B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79" creationId="{5DF279F6-E491-44C5-8B60-3984245203C4}"/>
          </ac:spMkLst>
        </pc:spChg>
        <pc:spChg chg="add mod">
          <ac:chgData name="吉武 和敏" userId="e4825ba96748af9c" providerId="LiveId" clId="{F9D40476-436E-48E8-A5D6-204A0E704A88}" dt="2020-06-25T07:55:07.774" v="2866" actId="571"/>
          <ac:spMkLst>
            <pc:docMk/>
            <pc:sldMk cId="2704609531" sldId="268"/>
            <ac:spMk id="380" creationId="{D990E3AE-4B8F-4865-80C5-9527DBAF6318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82" creationId="{377C6F55-39A0-48F3-A789-4DBC77783A52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83" creationId="{EF3E4B55-2956-49D5-A711-3C673D151030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86" creationId="{2B4D8C4B-6E11-4449-BC48-E21452A34070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387" creationId="{A587B11B-2C70-4513-8294-C8935BFEFA10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390" creationId="{1664D78D-A092-4B16-8BFA-F800ADC3368C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391" creationId="{5A607E87-07EF-4005-897E-48109A2AFE01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394" creationId="{54B4CC42-D19E-4E38-90A9-434BF10349F6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395" creationId="{5303268A-064F-4F44-AD8B-569F4FBF666C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398" creationId="{F5196095-D820-4F37-9767-CB5C383218E0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399" creationId="{81C77510-93DC-4949-B167-B3C53DEE8C6F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02" creationId="{E0A7F8F0-7A9C-4C51-934F-E782ED4E0DE5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03" creationId="{792112C7-8A50-47F7-970B-786524C56A22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06" creationId="{D79711CD-67D0-4BF5-A832-10F4B7BAB328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07" creationId="{2390849D-6CDA-410A-8814-CB163E9508BE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10" creationId="{5C587C39-84EE-416F-AC17-6A2F462B4BF4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11" creationId="{56EC11D4-DF5F-44C3-9A1C-05F19BDACAE0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13" creationId="{416107C2-CA0F-4701-A7AB-C1BCE30C3D32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14" creationId="{4AE528A3-5131-4AF0-8D4B-9DEFBD9A135F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15" creationId="{4AA0AE50-D153-4F5C-9A97-1EDDE00A820A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16" creationId="{A62F3C0E-9377-41C7-8235-8E670C55C0D1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417" creationId="{6ED106AC-859A-4F5C-B585-14963D2167C4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418" creationId="{D0CF6245-8083-4435-8FF4-E122B87FF37E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419" creationId="{F4D2F69A-EA28-41A0-B0F7-986674D50937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420" creationId="{EABC3C07-8482-4AC8-97B9-FA77571C520A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21" creationId="{6434E1C5-5B94-404F-A074-603209ABFDF0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22" creationId="{3441F6B3-9A4A-4355-8E5C-CF6B17D6E4CF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23" creationId="{C093F5FA-A025-4707-AD70-BE4A2E64F853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24" creationId="{17FF84B6-75BF-4D08-9ACB-4DE993A99FA2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25" creationId="{25EC392E-3411-4B80-B314-6CF73A3F1379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26" creationId="{D7144B30-717A-4738-B391-B78D9D32DECD}"/>
          </ac:spMkLst>
        </pc:spChg>
        <pc:spChg chg="mod">
          <ac:chgData name="吉武 和敏" userId="e4825ba96748af9c" providerId="LiveId" clId="{F9D40476-436E-48E8-A5D6-204A0E704A88}" dt="2020-06-25T07:52:04.949" v="2832" actId="1076"/>
          <ac:spMkLst>
            <pc:docMk/>
            <pc:sldMk cId="2704609531" sldId="268"/>
            <ac:spMk id="437" creationId="{CBD17CFB-FF32-407C-991A-C4B4C467BE83}"/>
          </ac:spMkLst>
        </pc:spChg>
        <pc:spChg chg="del mod">
          <ac:chgData name="吉武 和敏" userId="e4825ba96748af9c" providerId="LiveId" clId="{F9D40476-436E-48E8-A5D6-204A0E704A88}" dt="2020-06-25T07:52:58.220" v="2846" actId="478"/>
          <ac:spMkLst>
            <pc:docMk/>
            <pc:sldMk cId="2704609531" sldId="268"/>
            <ac:spMk id="438" creationId="{D7070B48-5CD7-473E-8E2C-61047F4F1FF1}"/>
          </ac:spMkLst>
        </pc:spChg>
        <pc:spChg chg="del mod">
          <ac:chgData name="吉武 和敏" userId="e4825ba96748af9c" providerId="LiveId" clId="{F9D40476-436E-48E8-A5D6-204A0E704A88}" dt="2020-06-25T07:52:58.220" v="2846" actId="478"/>
          <ac:spMkLst>
            <pc:docMk/>
            <pc:sldMk cId="2704609531" sldId="268"/>
            <ac:spMk id="439" creationId="{3E53E53B-698F-4E0D-B539-EC0CC4DE5E67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46" creationId="{640FC2AB-861A-45CD-B442-DFC8FF3FBC39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47" creationId="{81B06913-721F-4081-B32D-955FD6CB4E9D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48" creationId="{EA28CBE6-A97A-4882-A318-6A0E862950DB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49" creationId="{BE424FA7-9F75-4870-A8BA-494E1187D537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450" creationId="{91620531-110B-468D-B105-E9A6469585BF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51" creationId="{562D90A0-6181-4F5A-AB92-155366B747D5}"/>
          </ac:spMkLst>
        </pc:spChg>
        <pc:spChg chg="mod topLvl">
          <ac:chgData name="吉武 和敏" userId="e4825ba96748af9c" providerId="LiveId" clId="{F9D40476-436E-48E8-A5D6-204A0E704A88}" dt="2020-06-25T07:53:27.991" v="2850" actId="1076"/>
          <ac:spMkLst>
            <pc:docMk/>
            <pc:sldMk cId="2704609531" sldId="268"/>
            <ac:spMk id="453" creationId="{037633A4-6C55-4179-9FFD-9D275389E961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54" creationId="{0E4F2274-1E4D-41F9-95CC-2C877EE024E4}"/>
          </ac:spMkLst>
        </pc:spChg>
        <pc:spChg chg="mod topLvl">
          <ac:chgData name="吉武 和敏" userId="e4825ba96748af9c" providerId="LiveId" clId="{F9D40476-436E-48E8-A5D6-204A0E704A88}" dt="2020-06-25T07:53:34.062" v="2851" actId="1076"/>
          <ac:spMkLst>
            <pc:docMk/>
            <pc:sldMk cId="2704609531" sldId="268"/>
            <ac:spMk id="458" creationId="{8BB434D5-F34A-4BED-B723-1170A00FE3AC}"/>
          </ac:spMkLst>
        </pc:spChg>
        <pc:spChg chg="del">
          <ac:chgData name="吉武 和敏" userId="e4825ba96748af9c" providerId="LiveId" clId="{F9D40476-436E-48E8-A5D6-204A0E704A88}" dt="2020-06-25T07:51:52.061" v="2830" actId="478"/>
          <ac:spMkLst>
            <pc:docMk/>
            <pc:sldMk cId="2704609531" sldId="268"/>
            <ac:spMk id="463" creationId="{660BB367-776A-4013-812B-B91137B61F6F}"/>
          </ac:spMkLst>
        </pc:spChg>
        <pc:spChg chg="mod">
          <ac:chgData name="吉武 和敏" userId="e4825ba96748af9c" providerId="LiveId" clId="{F9D40476-436E-48E8-A5D6-204A0E704A88}" dt="2020-06-25T08:06:51.837" v="3155" actId="20577"/>
          <ac:spMkLst>
            <pc:docMk/>
            <pc:sldMk cId="2704609531" sldId="268"/>
            <ac:spMk id="464" creationId="{34EBC69B-984F-4718-B389-24BE132528C5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039" creationId="{234E0A24-BABF-425C-8E9D-21599868ACD9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040" creationId="{9DE9D2CC-232B-4D7B-99F8-8A82CC3DA390}"/>
          </ac:spMkLst>
        </pc:spChg>
        <pc:spChg chg="mod topLvl">
          <ac:chgData name="吉武 和敏" userId="e4825ba96748af9c" providerId="LiveId" clId="{F9D40476-436E-48E8-A5D6-204A0E704A88}" dt="2020-06-25T08:01:47.838" v="2991" actId="165"/>
          <ac:spMkLst>
            <pc:docMk/>
            <pc:sldMk cId="2704609531" sldId="268"/>
            <ac:spMk id="1043" creationId="{2DD8AD13-6C07-4E61-939D-DCFDE6E61648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1044" creationId="{1C5B1876-1108-46C2-9A19-18FEC16A341C}"/>
          </ac:spMkLst>
        </pc:spChg>
        <pc:spChg chg="mod topLvl">
          <ac:chgData name="吉武 和敏" userId="e4825ba96748af9c" providerId="LiveId" clId="{F9D40476-436E-48E8-A5D6-204A0E704A88}" dt="2020-06-25T07:53:20.828" v="2849" actId="1076"/>
          <ac:spMkLst>
            <pc:docMk/>
            <pc:sldMk cId="2704609531" sldId="268"/>
            <ac:spMk id="1048" creationId="{47501306-EDA9-4495-85FC-B94E23223926}"/>
          </ac:spMkLst>
        </pc:spChg>
        <pc:spChg chg="del mod">
          <ac:chgData name="吉武 和敏" userId="e4825ba96748af9c" providerId="LiveId" clId="{F9D40476-436E-48E8-A5D6-204A0E704A88}" dt="2020-06-25T07:52:58.220" v="2846" actId="478"/>
          <ac:spMkLst>
            <pc:docMk/>
            <pc:sldMk cId="2704609531" sldId="268"/>
            <ac:spMk id="1050" creationId="{1043B6D6-AA18-43EE-9EDC-8C4C5DD47F3B}"/>
          </ac:spMkLst>
        </pc:spChg>
        <pc:spChg chg="del mod">
          <ac:chgData name="吉武 和敏" userId="e4825ba96748af9c" providerId="LiveId" clId="{F9D40476-436E-48E8-A5D6-204A0E704A88}" dt="2020-06-25T07:52:58.220" v="2846" actId="478"/>
          <ac:spMkLst>
            <pc:docMk/>
            <pc:sldMk cId="2704609531" sldId="268"/>
            <ac:spMk id="1051" creationId="{D56D6A0F-ACBD-4C86-8556-9ECE86BAB4B8}"/>
          </ac:spMkLst>
        </pc:spChg>
        <pc:spChg chg="del mod">
          <ac:chgData name="吉武 和敏" userId="e4825ba96748af9c" providerId="LiveId" clId="{F9D40476-436E-48E8-A5D6-204A0E704A88}" dt="2020-06-25T07:52:58.220" v="2846" actId="478"/>
          <ac:spMkLst>
            <pc:docMk/>
            <pc:sldMk cId="2704609531" sldId="268"/>
            <ac:spMk id="1052" creationId="{0D1B7D8F-19AF-44E0-B279-E33FEFBB3A10}"/>
          </ac:spMkLst>
        </pc:spChg>
        <pc:spChg chg="mod">
          <ac:chgData name="吉武 和敏" userId="e4825ba96748af9c" providerId="LiveId" clId="{F9D40476-436E-48E8-A5D6-204A0E704A88}" dt="2020-06-25T07:52:04.949" v="2832" actId="1076"/>
          <ac:spMkLst>
            <pc:docMk/>
            <pc:sldMk cId="2704609531" sldId="268"/>
            <ac:spMk id="1053" creationId="{564C88ED-76A2-4F94-BB79-744EC060F481}"/>
          </ac:spMkLst>
        </pc:spChg>
        <pc:spChg chg="mod">
          <ac:chgData name="吉武 和敏" userId="e4825ba96748af9c" providerId="LiveId" clId="{F9D40476-436E-48E8-A5D6-204A0E704A88}" dt="2020-06-25T07:52:04.949" v="2832" actId="1076"/>
          <ac:spMkLst>
            <pc:docMk/>
            <pc:sldMk cId="2704609531" sldId="268"/>
            <ac:spMk id="1054" creationId="{50417159-E717-48F8-8E9A-EE39A7B0009E}"/>
          </ac:spMkLst>
        </pc:spChg>
        <pc:spChg chg="mod">
          <ac:chgData name="吉武 和敏" userId="e4825ba96748af9c" providerId="LiveId" clId="{F9D40476-436E-48E8-A5D6-204A0E704A88}" dt="2020-06-25T07:52:04.949" v="2832" actId="1076"/>
          <ac:spMkLst>
            <pc:docMk/>
            <pc:sldMk cId="2704609531" sldId="268"/>
            <ac:spMk id="1055" creationId="{C8FDCCA0-C5AB-463D-8003-D861C8273E96}"/>
          </ac:spMkLst>
        </pc:spChg>
        <pc:grpChg chg="mod">
          <ac:chgData name="吉武 和敏" userId="e4825ba96748af9c" providerId="LiveId" clId="{F9D40476-436E-48E8-A5D6-204A0E704A88}" dt="2020-06-25T07:52:04.949" v="2832" actId="1076"/>
          <ac:grpSpMkLst>
            <pc:docMk/>
            <pc:sldMk cId="2704609531" sldId="268"/>
            <ac:grpSpMk id="2" creationId="{665E1805-4BF1-4D56-A203-2C9D756D85A4}"/>
          </ac:grpSpMkLst>
        </pc:grpChg>
        <pc:grpChg chg="mod">
          <ac:chgData name="吉武 和敏" userId="e4825ba96748af9c" providerId="LiveId" clId="{F9D40476-436E-48E8-A5D6-204A0E704A88}" dt="2020-06-25T07:52:04.949" v="2832" actId="1076"/>
          <ac:grpSpMkLst>
            <pc:docMk/>
            <pc:sldMk cId="2704609531" sldId="268"/>
            <ac:grpSpMk id="15" creationId="{9749FD00-5C1A-4576-8CE6-8BE9786CA8DB}"/>
          </ac:grpSpMkLst>
        </pc:grpChg>
        <pc:grpChg chg="del mod">
          <ac:chgData name="吉武 和敏" userId="e4825ba96748af9c" providerId="LiveId" clId="{F9D40476-436E-48E8-A5D6-204A0E704A88}" dt="2020-06-25T07:53:09.629" v="2847" actId="165"/>
          <ac:grpSpMkLst>
            <pc:docMk/>
            <pc:sldMk cId="2704609531" sldId="268"/>
            <ac:grpSpMk id="18" creationId="{CE07F219-15E7-41D1-9F45-32E3BE0BF82A}"/>
          </ac:grpSpMkLst>
        </pc:grpChg>
        <pc:grpChg chg="del mod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20" creationId="{49680207-5E7F-4E5E-849B-89DEF36B0BAE}"/>
          </ac:grpSpMkLst>
        </pc:grpChg>
        <pc:grpChg chg="mod topLvl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97" creationId="{2625A12B-2875-4602-B5B6-ED703EA83C7B}"/>
          </ac:grpSpMkLst>
        </pc:grpChg>
        <pc:grpChg chg="mod topLvl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102" creationId="{EA48411C-1529-4DAC-9278-2496458725F4}"/>
          </ac:grpSpMkLst>
        </pc:grpChg>
        <pc:grpChg chg="mod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206" creationId="{3369C3CE-10E6-4573-BBEC-FB31ACC1A2FD}"/>
          </ac:grpSpMkLst>
        </pc:grpChg>
        <pc:grpChg chg="mod topLvl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280" creationId="{2CC40E0B-76CA-4646-B409-F36CF13AEFE6}"/>
          </ac:grpSpMkLst>
        </pc:grpChg>
        <pc:grpChg chg="mod topLvl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1030" creationId="{F79B10AA-4DC7-4A1B-AF12-F763280B599D}"/>
          </ac:grpSpMkLst>
        </pc:grpChg>
        <pc:grpChg chg="mod topLvl">
          <ac:chgData name="吉武 和敏" userId="e4825ba96748af9c" providerId="LiveId" clId="{F9D40476-436E-48E8-A5D6-204A0E704A88}" dt="2020-06-25T08:01:47.838" v="2991" actId="165"/>
          <ac:grpSpMkLst>
            <pc:docMk/>
            <pc:sldMk cId="2704609531" sldId="268"/>
            <ac:grpSpMk id="1037" creationId="{35571A21-6248-4F1A-B2A2-FF0C910B75C3}"/>
          </ac:grpSpMkLst>
        </pc:grpChg>
        <pc:grpChg chg="del mod topLvl">
          <ac:chgData name="吉武 和敏" userId="e4825ba96748af9c" providerId="LiveId" clId="{F9D40476-436E-48E8-A5D6-204A0E704A88}" dt="2020-06-25T07:53:14.383" v="2848" actId="165"/>
          <ac:grpSpMkLst>
            <pc:docMk/>
            <pc:sldMk cId="2704609531" sldId="268"/>
            <ac:grpSpMk id="1049" creationId="{F216A254-5CD2-4EFF-B517-1D3C1377CD26}"/>
          </ac:grpSpMkLst>
        </pc:grp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3" creationId="{C201429F-6929-4F3F-B785-EC4D0EF59B79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4" creationId="{CF8302DF-DF7A-41C8-A5BE-BBDB08288EED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5" creationId="{CC035038-C7B5-44AF-90F9-D86028F4923B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6" creationId="{ADA88C4F-7ABE-4DFB-AE74-BB6386FB2D50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7" creationId="{F90EC730-CFB0-4B46-8722-A8D8F8382C90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8" creationId="{37A4E642-D186-478D-9451-E848CE88EF7C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9" creationId="{28ED03F8-3934-4A50-A2EE-784042BFAA0D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10" creationId="{72682CC4-0084-4C4F-A9BD-A0212C4F85DF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11" creationId="{33F2E214-7F6D-4842-95FA-DB53FB367B26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12" creationId="{CFF058E9-6C0C-4092-90BA-FD19A5856D4F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13" creationId="{5385831C-5418-4899-8E87-4A276BFD50CC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14" creationId="{5BB596AF-5EEE-4B4A-9A13-5EA8BF4AD9A4}"/>
          </ac:picMkLst>
        </pc:picChg>
        <pc:picChg chg="mod">
          <ac:chgData name="吉武 和敏" userId="e4825ba96748af9c" providerId="LiveId" clId="{F9D40476-436E-48E8-A5D6-204A0E704A88}" dt="2020-06-25T07:52:04.949" v="2832" actId="1076"/>
          <ac:picMkLst>
            <pc:docMk/>
            <pc:sldMk cId="2704609531" sldId="268"/>
            <ac:picMk id="1026" creationId="{65186306-FA30-4FEF-9E45-AD78CED01C5D}"/>
          </ac:picMkLst>
        </pc:pic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3" creationId="{2D2A81D1-9D4F-489C-A386-6B96251AF431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5" creationId="{40C0A4C3-B881-4E29-A5FC-0499B769D888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6" creationId="{402584B5-DC59-4CE1-B9D7-37608EECAEE1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7" creationId="{55D73373-0B4F-4555-BC2D-54762EF2383F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8" creationId="{5F415D1E-62E5-49E0-AE7C-8C2A74EF3419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9" creationId="{61642AA5-8F6F-43D0-B729-BEA6FA91DDFF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0" creationId="{53A7A953-51A2-4B5A-9529-EB15F5CFD4FB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3" creationId="{E5092B58-2DE4-45ED-90AF-E4C78F6EFCD7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4" creationId="{1DB8EA55-F8E8-41C3-A74D-7DB62D971D3F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5" creationId="{144C47CB-1FE3-4375-9F78-9B37C525F63A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6" creationId="{42933D94-B69B-44E7-BD8B-E330ABEE2A15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7" creationId="{4F116DAC-99E2-451E-8BC1-E9341E84C579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8" creationId="{FA52145A-B0D1-415E-B0AA-D5253E6C92C8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49" creationId="{2CC0AB3C-384F-4100-9434-9DF5D538D88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56" creationId="{921E7018-C44A-4F0B-AF21-6A1F18DC34E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59" creationId="{D4209669-30FB-46D4-8934-BAEC651AE6A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0" creationId="{0E34483D-9187-47B3-9429-9D662F109AB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1" creationId="{B7C041A3-3650-4016-B04B-ED9C202090A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2" creationId="{482BA695-3DDF-442B-ABCC-7D8AB387F79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3" creationId="{A4B000F8-5FA2-497D-8A3A-38B973B2919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4" creationId="{0A2F9ACC-59D8-4063-A417-175D2D6FE19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5" creationId="{03711504-3E16-474E-BF47-0A392DB1810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6" creationId="{A98D158D-E2C1-405B-8059-77DEE053959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7" creationId="{15C4EB13-EBBD-4DBB-B01B-E77A0406489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8" creationId="{DEDB5E5B-5432-4F44-9799-081919315DA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69" creationId="{7CBB98DB-A590-4133-BEBA-42C31BADAEEC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0" creationId="{C2729567-3E78-4161-822C-86AED5FE11D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1" creationId="{55002943-EBDA-4FF0-993D-0C4D809D867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2" creationId="{A0D8346D-A3D7-4115-B7AB-326F3B4A4DB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3" creationId="{350815D4-2D78-4AE1-BBB0-9E9E59D526A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4" creationId="{4C9BFF62-24A0-405B-8A77-A132EA52BC0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5" creationId="{262027EF-F56C-40DB-943B-6B1570069C1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6" creationId="{2D27C451-0C04-497B-99BD-0BB3EA5E0B78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7" creationId="{1BA63FC6-63DE-45FF-B496-0DC0A44DFDB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8" creationId="{D1CD0844-EAAA-4150-859D-18F8B1D5C0A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79" creationId="{014142B3-7606-4F2B-B557-0208F2138DBC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0" creationId="{F42AFB3E-2A58-49E0-ABBD-4A0EB5FF897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1" creationId="{0EAEDB30-1476-4D66-B391-284BC8C026F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2" creationId="{78F3DA01-8626-4283-A846-F16ACE1B6F3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3" creationId="{8872E4ED-89FD-4147-B759-8D5532AD029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4" creationId="{6BD1B127-1CCE-4CE7-8704-D9F41B01267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5" creationId="{B02559BA-6EFB-4883-8800-E8C9647D769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6" creationId="{B2FE9F92-1E30-4519-B9F8-9CC30A691438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7" creationId="{23290D55-EFB7-4B38-83FE-EB556D4D5EB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8" creationId="{A9890CB5-924C-48BF-8DB3-41962B3BC0B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89" creationId="{D95EDC44-0408-4325-8C63-296E5B58F92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0" creationId="{E6E31346-C494-496C-98BE-282A9AB83E4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1" creationId="{44A0E351-979E-4810-8800-2DFC5CB5A60C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2" creationId="{F9FFF64E-2736-4CE6-87BE-C2F897002EB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3" creationId="{17C3DB46-43E5-41DF-A3A6-748705FB4FF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4" creationId="{80A9BBB7-213E-49BB-9BA3-769B5AB4688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5" creationId="{2752284B-73B2-46E8-AAC2-8F37FA5D979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96" creationId="{F24BE78D-048F-45B5-95EC-7878B3651DD8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3" creationId="{DCA2935A-9055-4F48-A88B-78170B2E769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4" creationId="{DA4B89E8-E8FC-4453-90EE-7BA18FB8255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5" creationId="{9EDB0197-7A34-4C79-8904-60E7B252952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6" creationId="{8B2BA974-8D77-4FDD-820D-1A3F57A9B54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7" creationId="{9FD5CC28-4EAD-40CF-B0F8-26450437F16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8" creationId="{D47BEC9A-C34B-4AD7-9649-57379912543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9" creationId="{EC4BF574-4EE4-46BC-A660-A69BD10F89A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0" creationId="{33E3C0B8-B64F-4644-AEB1-7DB289BC5CD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1" creationId="{CAD44E99-63C8-495F-9BC6-F5DE195B74C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2" creationId="{A07E7582-9D3E-487A-ACE0-EF96A893101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3" creationId="{84C37609-C33C-4094-8B5D-03C2CF09BD8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4" creationId="{B5287C04-D17A-43B7-BBC0-9AF200390E3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5" creationId="{C026B63A-90B1-4FFC-BA97-254CB292AA5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6" creationId="{823569A1-72CD-47A3-A751-6B56FAC527C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7" creationId="{A83D77D8-5C76-45C7-9661-E1FFB6FC065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8" creationId="{1D0E3A77-95C1-48C1-B4F5-8F0ED60D55C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19" creationId="{C7B0D04D-4635-48CD-8F25-2D382E2E400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0" creationId="{2BF298C4-E928-46EF-B95A-76A2488A32A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1" creationId="{D62BCA3F-6572-46FF-B67F-F0A16300369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2" creationId="{CE9B3733-DBAA-4BB7-AA24-6AA7843F355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3" creationId="{1E94865B-30DC-4621-B4C7-E6085731E5C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4" creationId="{5AAE774E-CFBC-44AA-84F5-1307E04B9E0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5" creationId="{EDF71834-401E-4A12-8C3A-EDEF0FF8D1B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6" creationId="{E48BED60-100E-4C34-9E19-3856FB9F3B4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7" creationId="{CD231D13-F80A-4097-81B7-D5357401B2D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8" creationId="{9FF1E21E-E743-4A56-B18A-70057E07D16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29" creationId="{758FCDEA-26B9-4DFC-A779-07AA290F0A6C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0" creationId="{EC5175B4-6BBA-4B56-BD9C-684D93318F6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1" creationId="{D5F053AF-97EE-43B9-9E85-B2D25C23CA5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2" creationId="{628EC738-1309-4B54-859F-AB75577DA80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3" creationId="{A66C1575-F05C-420C-A660-9F5BDD3A3F1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4" creationId="{F766704C-16CF-4B06-A484-D0F41E6064B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5" creationId="{5E40C319-EFBE-4223-A180-E01644998F7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6" creationId="{92592A1F-3C72-44C2-8B26-C345312E78F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7" creationId="{0F17690A-94E0-4F8E-8250-A4EDA65FEDD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8" creationId="{08CC6725-0A49-4E0C-ACE8-40C04B082B6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39" creationId="{5AC1D00D-735A-4757-9B78-1DA259537AB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40" creationId="{30F015E7-E598-491A-89CC-8E899757457C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41" creationId="{8D88DAEB-E05C-4BDC-B2DB-215F4B97847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3" creationId="{3203609D-1F97-4760-A812-662246C7DAE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4" creationId="{FB66070D-D7B9-4B51-BCE5-DC8ACD21BAF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5" creationId="{BD9E50AA-1535-4E17-A2BD-3C7E71EBAB5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6" creationId="{AA025CC2-934C-407A-B755-502D9D33C5A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7" creationId="{A386A291-DC95-4DA4-9643-24A4243FF6B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8" creationId="{3FE99682-0215-4A2B-9B87-6E4997C99B0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19" creationId="{4D070272-538A-405B-8FE5-2319F06EAB4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0" creationId="{FC9D1D7E-0FFB-42C2-BC14-CB27F7E7F82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1" creationId="{582FE9B9-935A-4342-A355-064157F8BA8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2" creationId="{604E208C-37F0-4C5A-A281-F93323693A0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3" creationId="{874A04AD-4E67-40F3-ADE9-517AAA1EF78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4" creationId="{EBAFE828-8CB3-412C-BF48-FC9713F5A93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5" creationId="{462A0ADA-2812-43A0-9A72-478A780D471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6" creationId="{CAA9A4D2-9F84-40D9-A958-DBE28D913F0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7" creationId="{E2D9FFF6-3E74-4DA3-AAB5-67A8F909A52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8" creationId="{26AF0804-1B83-42AF-ABE0-1C3C24D08B3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29" creationId="{B7886C72-FDF4-4D4F-AEBE-A7F2F73369F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0" creationId="{021D0451-A35B-4198-A021-1DC6AD4799B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1" creationId="{923777FB-8279-4AA5-93C6-C9BEAAC4473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2" creationId="{E2CF2B28-DBE1-4157-8616-F0252DD6FCB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3" creationId="{63D5E119-66E3-48D8-A851-4CB6B1D45F1D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4" creationId="{AA8EC7B7-A82E-4791-A4BA-A58EAB072DF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5" creationId="{0F9A138C-4C16-4CD9-AD07-D1811017CE6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6" creationId="{873FDC4E-877F-4A5D-8F10-5E5B1B3183A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7" creationId="{8BB7AEA3-A283-4112-922C-9C387AEEEB4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8" creationId="{08A45EAC-8346-4C38-8E03-CA0000E74B6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39" creationId="{B94E528F-AFAE-4907-A2B4-377FC2FE5F0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0" creationId="{A532E313-D777-4520-B168-E4189D922B6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1" creationId="{CA933B1B-3381-4B48-B270-D23EA66586F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2" creationId="{669774CB-726C-493E-8A99-4C8D7B56830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3" creationId="{89AA4344-3421-4843-B43C-4DDE4041F40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4" creationId="{BFF8C8B6-D2B5-4AB9-AF04-127293DC03A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5" creationId="{41540DAA-389D-420B-8498-B9E9BA2E23A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6" creationId="{BBCFF366-79F3-40D6-B733-F7AFAD97BE2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7" creationId="{BBF97032-B4B9-4D1A-BF66-976BF419F18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8" creationId="{3B4706F3-8FAA-4724-90EC-5856365620F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49" creationId="{B5B8E74F-F758-4194-BC80-AAE8D62E75E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50" creationId="{43D741D9-8132-486B-A347-E3EA1AD56AD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51" creationId="{AAF45D4A-7BE3-4498-928F-C2C323DE8E3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54" creationId="{6A6C5312-9052-4F1D-BD04-2FDA6B9B6BCD}"/>
          </ac:cxnSpMkLst>
        </pc:cxnChg>
        <pc:cxnChg chg="mod">
          <ac:chgData name="吉武 和敏" userId="e4825ba96748af9c" providerId="LiveId" clId="{F9D40476-436E-48E8-A5D6-204A0E704A88}" dt="2020-06-25T07:52:04.949" v="2832" actId="1076"/>
          <ac:cxnSpMkLst>
            <pc:docMk/>
            <pc:sldMk cId="2704609531" sldId="268"/>
            <ac:cxnSpMk id="258" creationId="{623A3FD8-CFD2-41B9-A372-038BD4934284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65" creationId="{AD8D49BB-1125-471B-8B58-1FB81B602955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66" creationId="{A3875A23-465E-47F2-9667-B72BF44A1D06}"/>
          </ac:cxnSpMkLst>
        </pc:cxnChg>
        <pc:cxnChg chg="mod topLvl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67" creationId="{24D63007-BF65-4946-94BB-0E73023EA7A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86" creationId="{76AC0556-D070-4B7E-85AF-A3F53347CB5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87" creationId="{1DDE0A93-DBF2-4990-8965-DB68DCCF9FE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88" creationId="{533CFE8B-978A-4668-BA71-EA52D1AB5D3A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89" creationId="{661F2415-AC72-469D-928A-8F78BF6ED2A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0" creationId="{23097728-D634-4E71-9A2C-7C75F9D8795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1" creationId="{8D84A834-8E59-4BAF-B31B-899A8A545DE8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2" creationId="{EF349EA4-24AB-4AF7-947D-951D2BF044F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3" creationId="{AC9FB791-2669-484D-B1B7-88EF4FEE9EB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4" creationId="{3EA67EA4-30AD-4771-87E3-86D9701C246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5" creationId="{D4388C74-335E-4E0D-8AD7-00F1731163D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6" creationId="{3CA19095-863E-4A13-B6CC-2460CEEF75F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7" creationId="{05454026-4993-4874-9BB4-04D3D9AA2EB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8" creationId="{5091EBD1-ED9D-4352-A521-2AC901A050C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299" creationId="{8A83A425-CF5B-49A4-871D-492A6E0D211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0" creationId="{8B5B6523-D5B0-4FFA-9B23-70AAAF00E6E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1" creationId="{AB52A95A-A3D2-40EC-B531-DC30018CA4C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2" creationId="{859EB1CE-70E4-48A6-A57A-EEE2A2A5742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3" creationId="{8A5B15E3-51F1-4E51-AA02-BEC4D7BCFC17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4" creationId="{3D626AC1-8AED-4CE3-95C2-8A74FAE50452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5" creationId="{FC75CB8B-B234-4AF1-BAC1-61A01BF04E8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6" creationId="{D84C5433-1378-4ED3-BF5A-E15D28536DB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7" creationId="{7FE15C54-A41F-403F-B086-7BCDB8BA005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8" creationId="{B3869D16-02B8-4F3E-A86C-CC3B064898D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09" creationId="{39FCA42A-C4D1-46F2-8B7A-9BF6097CD85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0" creationId="{8358EE02-399A-40A8-815C-86D6B1825BD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1" creationId="{6413BADC-FCD8-4F87-BBB8-7C5B8FAC2AE1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2" creationId="{8840EB6A-15F6-422F-8D12-10335C51BB5E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3" creationId="{5BE91DA2-F319-4ED1-AD97-2558C0F0DEB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4" creationId="{A32DE51E-DAB2-4A55-B240-0DDDBC69EBEB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5" creationId="{957D0ABB-D0F6-4F9E-BAD3-4B6512AF08A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6" creationId="{37E43B01-9781-48CA-9273-54D10A3FC8E0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7" creationId="{AEBB665C-7CB3-4EBA-9170-21500669800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8" creationId="{80EA0D5F-28AD-443C-BF50-1035DD528B8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19" creationId="{50C722A6-27F3-4749-9159-9AE53417B91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20" creationId="{27858120-6EA8-4B43-B94B-B1E156583813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21" creationId="{92C20599-82F9-4308-996C-7D1714BE0D4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22" creationId="{3EE6F605-FAA1-4B07-B740-B74DDB814494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23" creationId="{43EF9553-B086-417E-8061-47C061E14A15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324" creationId="{44B6BFDC-AACA-4F32-AB16-C7AF9293B8CE}"/>
          </ac:cxnSpMkLst>
        </pc:cxnChg>
        <pc:cxnChg chg="add mod">
          <ac:chgData name="吉武 和敏" userId="e4825ba96748af9c" providerId="LiveId" clId="{F9D40476-436E-48E8-A5D6-204A0E704A88}" dt="2020-06-25T07:54:47.404" v="2862" actId="1076"/>
          <ac:cxnSpMkLst>
            <pc:docMk/>
            <pc:sldMk cId="2704609531" sldId="268"/>
            <ac:cxnSpMk id="341" creationId="{BADB434E-D523-4882-AE15-08ADC08D829C}"/>
          </ac:cxnSpMkLst>
        </pc:cxnChg>
        <pc:cxnChg chg="add del mod">
          <ac:chgData name="吉武 和敏" userId="e4825ba96748af9c" providerId="LiveId" clId="{F9D40476-436E-48E8-A5D6-204A0E704A88}" dt="2020-06-25T07:54:07.952" v="2857" actId="478"/>
          <ac:cxnSpMkLst>
            <pc:docMk/>
            <pc:sldMk cId="2704609531" sldId="268"/>
            <ac:cxnSpMk id="344" creationId="{FB901203-B9F9-4288-A5DE-EFE55C3128C2}"/>
          </ac:cxnSpMkLst>
        </pc:cxnChg>
        <pc:cxnChg chg="add mod">
          <ac:chgData name="吉武 和敏" userId="e4825ba96748af9c" providerId="LiveId" clId="{F9D40476-436E-48E8-A5D6-204A0E704A88}" dt="2020-06-25T07:54:56.205" v="2864" actId="571"/>
          <ac:cxnSpMkLst>
            <pc:docMk/>
            <pc:sldMk cId="2704609531" sldId="268"/>
            <ac:cxnSpMk id="347" creationId="{E5A10AF9-B077-4223-96FD-1D1DF277DEAD}"/>
          </ac:cxnSpMkLst>
        </pc:cxnChg>
        <pc:cxnChg chg="add mod">
          <ac:chgData name="吉武 和敏" userId="e4825ba96748af9c" providerId="LiveId" clId="{F9D40476-436E-48E8-A5D6-204A0E704A88}" dt="2020-06-25T07:54:56.205" v="2864" actId="571"/>
          <ac:cxnSpMkLst>
            <pc:docMk/>
            <pc:sldMk cId="2704609531" sldId="268"/>
            <ac:cxnSpMk id="349" creationId="{64DEF639-7517-47B5-95A0-6C27750CE652}"/>
          </ac:cxnSpMkLst>
        </pc:cxnChg>
        <pc:cxnChg chg="add mod">
          <ac:chgData name="吉武 和敏" userId="e4825ba96748af9c" providerId="LiveId" clId="{F9D40476-436E-48E8-A5D6-204A0E704A88}" dt="2020-06-25T07:55:02.724" v="2865" actId="571"/>
          <ac:cxnSpMkLst>
            <pc:docMk/>
            <pc:sldMk cId="2704609531" sldId="268"/>
            <ac:cxnSpMk id="354" creationId="{5798D086-CCC6-4D96-B701-A9C8CC6C5902}"/>
          </ac:cxnSpMkLst>
        </pc:cxnChg>
        <pc:cxnChg chg="mod topLvl">
          <ac:chgData name="吉武 和敏" userId="e4825ba96748af9c" providerId="LiveId" clId="{F9D40476-436E-48E8-A5D6-204A0E704A88}" dt="2020-06-25T07:53:20.828" v="2849" actId="1076"/>
          <ac:cxnSpMkLst>
            <pc:docMk/>
            <pc:sldMk cId="2704609531" sldId="268"/>
            <ac:cxnSpMk id="357" creationId="{86854BF8-40BB-44E6-9E4D-BD95CA468379}"/>
          </ac:cxnSpMkLst>
        </pc:cxnChg>
        <pc:cxnChg chg="mod topLvl">
          <ac:chgData name="吉武 和敏" userId="e4825ba96748af9c" providerId="LiveId" clId="{F9D40476-436E-48E8-A5D6-204A0E704A88}" dt="2020-06-25T07:53:20.828" v="2849" actId="1076"/>
          <ac:cxnSpMkLst>
            <pc:docMk/>
            <pc:sldMk cId="2704609531" sldId="268"/>
            <ac:cxnSpMk id="361" creationId="{F107AB22-EE09-4AFF-B99C-7AF450E69F54}"/>
          </ac:cxnSpMkLst>
        </pc:cxnChg>
        <pc:cxnChg chg="mod topLvl">
          <ac:chgData name="吉武 和敏" userId="e4825ba96748af9c" providerId="LiveId" clId="{F9D40476-436E-48E8-A5D6-204A0E704A88}" dt="2020-06-25T07:53:20.828" v="2849" actId="1076"/>
          <ac:cxnSpMkLst>
            <pc:docMk/>
            <pc:sldMk cId="2704609531" sldId="268"/>
            <ac:cxnSpMk id="365" creationId="{B1820D45-5EC2-496B-92F0-739F5AE8FED2}"/>
          </ac:cxnSpMkLst>
        </pc:cxnChg>
        <pc:cxnChg chg="add mod">
          <ac:chgData name="吉武 和敏" userId="e4825ba96748af9c" providerId="LiveId" clId="{F9D40476-436E-48E8-A5D6-204A0E704A88}" dt="2020-06-25T07:55:07.774" v="2866" actId="571"/>
          <ac:cxnSpMkLst>
            <pc:docMk/>
            <pc:sldMk cId="2704609531" sldId="268"/>
            <ac:cxnSpMk id="368" creationId="{CBF09BC6-CD9F-4C70-8032-44ED7DDF7992}"/>
          </ac:cxnSpMkLst>
        </pc:cxnChg>
        <pc:cxnChg chg="mod topLvl">
          <ac:chgData name="吉武 和敏" userId="e4825ba96748af9c" providerId="LiveId" clId="{F9D40476-436E-48E8-A5D6-204A0E704A88}" dt="2020-06-25T07:53:20.828" v="2849" actId="1076"/>
          <ac:cxnSpMkLst>
            <pc:docMk/>
            <pc:sldMk cId="2704609531" sldId="268"/>
            <ac:cxnSpMk id="369" creationId="{51A6E31C-FBDA-4BA9-A40B-3EB788D296E1}"/>
          </ac:cxnSpMkLst>
        </pc:cxnChg>
        <pc:cxnChg chg="mod topLvl">
          <ac:chgData name="吉武 和敏" userId="e4825ba96748af9c" providerId="LiveId" clId="{F9D40476-436E-48E8-A5D6-204A0E704A88}" dt="2020-06-25T07:53:27.991" v="2850" actId="1076"/>
          <ac:cxnSpMkLst>
            <pc:docMk/>
            <pc:sldMk cId="2704609531" sldId="268"/>
            <ac:cxnSpMk id="373" creationId="{E2E4E78C-CACA-4052-8F47-D34E246B6795}"/>
          </ac:cxnSpMkLst>
        </pc:cxnChg>
        <pc:cxnChg chg="mod topLvl">
          <ac:chgData name="吉武 和敏" userId="e4825ba96748af9c" providerId="LiveId" clId="{F9D40476-436E-48E8-A5D6-204A0E704A88}" dt="2020-06-25T07:53:27.991" v="2850" actId="1076"/>
          <ac:cxnSpMkLst>
            <pc:docMk/>
            <pc:sldMk cId="2704609531" sldId="268"/>
            <ac:cxnSpMk id="377" creationId="{573A5710-E89D-4FE5-888E-FD5531369C21}"/>
          </ac:cxnSpMkLst>
        </pc:cxnChg>
        <pc:cxnChg chg="mod topLvl">
          <ac:chgData name="吉武 和敏" userId="e4825ba96748af9c" providerId="LiveId" clId="{F9D40476-436E-48E8-A5D6-204A0E704A88}" dt="2020-06-25T07:53:27.991" v="2850" actId="1076"/>
          <ac:cxnSpMkLst>
            <pc:docMk/>
            <pc:sldMk cId="2704609531" sldId="268"/>
            <ac:cxnSpMk id="381" creationId="{EA09A7E6-88C6-4BCC-A808-F70355B642C2}"/>
          </ac:cxnSpMkLst>
        </pc:cxnChg>
        <pc:cxnChg chg="mod topLvl">
          <ac:chgData name="吉武 和敏" userId="e4825ba96748af9c" providerId="LiveId" clId="{F9D40476-436E-48E8-A5D6-204A0E704A88}" dt="2020-06-25T07:53:27.991" v="2850" actId="1076"/>
          <ac:cxnSpMkLst>
            <pc:docMk/>
            <pc:sldMk cId="2704609531" sldId="268"/>
            <ac:cxnSpMk id="385" creationId="{39712E4E-9D7C-47D9-A9B2-22C8446AA370}"/>
          </ac:cxnSpMkLst>
        </pc:cxnChg>
        <pc:cxnChg chg="mod topLvl">
          <ac:chgData name="吉武 和敏" userId="e4825ba96748af9c" providerId="LiveId" clId="{F9D40476-436E-48E8-A5D6-204A0E704A88}" dt="2020-06-25T07:53:34.062" v="2851" actId="1076"/>
          <ac:cxnSpMkLst>
            <pc:docMk/>
            <pc:sldMk cId="2704609531" sldId="268"/>
            <ac:cxnSpMk id="389" creationId="{6B808040-67F4-47A3-8D36-FE4A5D61F323}"/>
          </ac:cxnSpMkLst>
        </pc:cxnChg>
        <pc:cxnChg chg="mod topLvl">
          <ac:chgData name="吉武 和敏" userId="e4825ba96748af9c" providerId="LiveId" clId="{F9D40476-436E-48E8-A5D6-204A0E704A88}" dt="2020-06-25T07:53:34.062" v="2851" actId="1076"/>
          <ac:cxnSpMkLst>
            <pc:docMk/>
            <pc:sldMk cId="2704609531" sldId="268"/>
            <ac:cxnSpMk id="393" creationId="{F035CA95-1248-472A-8B26-95D3F6A04BB0}"/>
          </ac:cxnSpMkLst>
        </pc:cxnChg>
        <pc:cxnChg chg="mod topLvl">
          <ac:chgData name="吉武 和敏" userId="e4825ba96748af9c" providerId="LiveId" clId="{F9D40476-436E-48E8-A5D6-204A0E704A88}" dt="2020-06-25T07:53:34.062" v="2851" actId="1076"/>
          <ac:cxnSpMkLst>
            <pc:docMk/>
            <pc:sldMk cId="2704609531" sldId="268"/>
            <ac:cxnSpMk id="397" creationId="{75444F60-E3C2-424C-B129-FA991445A287}"/>
          </ac:cxnSpMkLst>
        </pc:cxnChg>
        <pc:cxnChg chg="mod topLvl">
          <ac:chgData name="吉武 和敏" userId="e4825ba96748af9c" providerId="LiveId" clId="{F9D40476-436E-48E8-A5D6-204A0E704A88}" dt="2020-06-25T07:53:34.062" v="2851" actId="1076"/>
          <ac:cxnSpMkLst>
            <pc:docMk/>
            <pc:sldMk cId="2704609531" sldId="268"/>
            <ac:cxnSpMk id="401" creationId="{6C8EB4D6-74C6-437B-8954-29952EE83E9D}"/>
          </ac:cxnSpMkLst>
        </pc:cxnChg>
        <pc:cxnChg chg="mod topLvl">
          <ac:chgData name="吉武 和敏" userId="e4825ba96748af9c" providerId="LiveId" clId="{F9D40476-436E-48E8-A5D6-204A0E704A88}" dt="2020-06-25T07:53:34.062" v="2851" actId="1076"/>
          <ac:cxnSpMkLst>
            <pc:docMk/>
            <pc:sldMk cId="2704609531" sldId="268"/>
            <ac:cxnSpMk id="405" creationId="{899569A9-CECF-40EF-AA3C-3BBBCE94C0E3}"/>
          </ac:cxnSpMkLst>
        </pc:cxnChg>
        <pc:cxnChg chg="mod topLvl">
          <ac:chgData name="吉武 和敏" userId="e4825ba96748af9c" providerId="LiveId" clId="{F9D40476-436E-48E8-A5D6-204A0E704A88}" dt="2020-06-25T07:53:34.062" v="2851" actId="1076"/>
          <ac:cxnSpMkLst>
            <pc:docMk/>
            <pc:sldMk cId="2704609531" sldId="268"/>
            <ac:cxnSpMk id="409" creationId="{17F305C5-ADCA-4D15-9ED0-AD33CA3B8FAF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24" creationId="{8CEFC986-BD1B-437D-ABFE-59AF0F4C1379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27" creationId="{009D61A5-C3FB-41FE-A0B3-F1DAFD3445F6}"/>
          </ac:cxnSpMkLst>
        </pc:cxnChg>
        <pc:cxnChg chg="mod">
          <ac:chgData name="吉武 和敏" userId="e4825ba96748af9c" providerId="LiveId" clId="{F9D40476-436E-48E8-A5D6-204A0E704A88}" dt="2020-06-25T08:01:47.838" v="2991" actId="165"/>
          <ac:cxnSpMkLst>
            <pc:docMk/>
            <pc:sldMk cId="2704609531" sldId="268"/>
            <ac:cxnSpMk id="1029" creationId="{091B9006-106A-45E1-9982-0DDC99A016BC}"/>
          </ac:cxnSpMkLst>
        </pc:cxnChg>
        <pc:cxnChg chg="mod topLvl">
          <ac:chgData name="吉武 和敏" userId="e4825ba96748af9c" providerId="LiveId" clId="{F9D40476-436E-48E8-A5D6-204A0E704A88}" dt="2020-06-25T07:53:20.828" v="2849" actId="1076"/>
          <ac:cxnSpMkLst>
            <pc:docMk/>
            <pc:sldMk cId="2704609531" sldId="268"/>
            <ac:cxnSpMk id="1046" creationId="{33A587C8-8BB1-4F70-BEAC-82839B57043C}"/>
          </ac:cxnSpMkLst>
        </pc:cxnChg>
      </pc:sldChg>
      <pc:sldChg chg="addSp delSp modSp mod">
        <pc:chgData name="吉武 和敏" userId="e4825ba96748af9c" providerId="LiveId" clId="{F9D40476-436E-48E8-A5D6-204A0E704A88}" dt="2020-06-25T08:05:57.837" v="3114" actId="20577"/>
        <pc:sldMkLst>
          <pc:docMk/>
          <pc:sldMk cId="3600490621" sldId="269"/>
        </pc:sldMkLst>
        <pc:spChg chg="mod ord">
          <ac:chgData name="吉武 和敏" userId="e4825ba96748af9c" providerId="LiveId" clId="{F9D40476-436E-48E8-A5D6-204A0E704A88}" dt="2020-06-25T06:37:31.155" v="2711" actId="166"/>
          <ac:spMkLst>
            <pc:docMk/>
            <pc:sldMk cId="3600490621" sldId="269"/>
            <ac:spMk id="7" creationId="{8BCFB491-CC8D-4B38-86FB-FD962F62841E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3" creationId="{E3A2AFBB-D4CD-497C-9290-867EED99EA56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25" creationId="{B891CB40-D755-4F7D-B43B-FF2FE48C6849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34" creationId="{54A14456-2909-408D-A173-0D39580BAA6F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36" creationId="{BD5DA0C0-0BB7-4801-B432-3A5985CD9AA6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39" creationId="{CBCDE0BA-21FD-4F46-8624-37EB5AB473B5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43" creationId="{EBFA25FB-F771-48F4-813D-7C618FB7AD47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53" creationId="{D3F44535-9ECF-419D-92A6-6ACBE23EB024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54" creationId="{F58C9D88-1738-43D0-91BA-E680AE232662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55" creationId="{74BA2DED-2485-4D8E-8D8A-60208E47CBFF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58" creationId="{843EBD7F-F4CE-442D-9EA6-E84F9F778925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59" creationId="{B27533F2-3389-4C70-8282-9031981DC756}"/>
          </ac:spMkLst>
        </pc:spChg>
        <pc:spChg chg="mod topLvl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60" creationId="{DA35C147-B146-4D3E-9594-DF7CCA1C7041}"/>
          </ac:spMkLst>
        </pc:spChg>
        <pc:spChg chg="mod">
          <ac:chgData name="吉武 和敏" userId="e4825ba96748af9c" providerId="LiveId" clId="{F9D40476-436E-48E8-A5D6-204A0E704A88}" dt="2020-06-25T06:35:02.140" v="2680" actId="1076"/>
          <ac:spMkLst>
            <pc:docMk/>
            <pc:sldMk cId="3600490621" sldId="269"/>
            <ac:spMk id="61" creationId="{4CFC19BD-CE52-4F4B-9457-6050B58AFDA4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67" creationId="{D9D16605-3A82-429A-8FC9-03BA11C3ADDF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68" creationId="{6C7B8194-3FCE-46A0-AD2E-F683ACEDD2CF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69" creationId="{1E658857-8E93-4141-BE74-560923DD29C2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70" creationId="{5AE95BB0-3431-49F9-A3D3-4713E4018D91}"/>
          </ac:spMkLst>
        </pc:spChg>
        <pc:spChg chg="del mod">
          <ac:chgData name="吉武 和敏" userId="e4825ba96748af9c" providerId="LiveId" clId="{F9D40476-436E-48E8-A5D6-204A0E704A88}" dt="2020-06-25T06:29:53.542" v="2496" actId="478"/>
          <ac:spMkLst>
            <pc:docMk/>
            <pc:sldMk cId="3600490621" sldId="269"/>
            <ac:spMk id="71" creationId="{0B304BFF-4CB4-4CC9-85E8-3CDC9C5A8258}"/>
          </ac:spMkLst>
        </pc:spChg>
        <pc:spChg chg="del mod">
          <ac:chgData name="吉武 和敏" userId="e4825ba96748af9c" providerId="LiveId" clId="{F9D40476-436E-48E8-A5D6-204A0E704A88}" dt="2020-06-25T06:29:53.542" v="2496" actId="478"/>
          <ac:spMkLst>
            <pc:docMk/>
            <pc:sldMk cId="3600490621" sldId="269"/>
            <ac:spMk id="73" creationId="{26FCCA6F-5CC0-4741-9B99-CB4EDC779CB7}"/>
          </ac:spMkLst>
        </pc:spChg>
        <pc:spChg chg="mod">
          <ac:chgData name="吉武 和敏" userId="e4825ba96748af9c" providerId="LiveId" clId="{F9D40476-436E-48E8-A5D6-204A0E704A88}" dt="2020-06-25T06:35:02.140" v="2680" actId="1076"/>
          <ac:spMkLst>
            <pc:docMk/>
            <pc:sldMk cId="3600490621" sldId="269"/>
            <ac:spMk id="75" creationId="{9992828A-99AF-46FE-BB7A-4E5FE133A7AA}"/>
          </ac:spMkLst>
        </pc:spChg>
        <pc:spChg chg="mod">
          <ac:chgData name="吉武 和敏" userId="e4825ba96748af9c" providerId="LiveId" clId="{F9D40476-436E-48E8-A5D6-204A0E704A88}" dt="2020-06-25T06:39:18.043" v="2724" actId="1076"/>
          <ac:spMkLst>
            <pc:docMk/>
            <pc:sldMk cId="3600490621" sldId="269"/>
            <ac:spMk id="76" creationId="{FA057F1D-002D-467D-825D-E0FACC3F702E}"/>
          </ac:spMkLst>
        </pc:spChg>
        <pc:spChg chg="del mod">
          <ac:chgData name="吉武 和敏" userId="e4825ba96748af9c" providerId="LiveId" clId="{F9D40476-436E-48E8-A5D6-204A0E704A88}" dt="2020-06-25T06:29:53.542" v="2496" actId="478"/>
          <ac:spMkLst>
            <pc:docMk/>
            <pc:sldMk cId="3600490621" sldId="269"/>
            <ac:spMk id="78" creationId="{22072707-308B-4F1E-8BF6-58F8EDCF83A8}"/>
          </ac:spMkLst>
        </pc:spChg>
        <pc:spChg chg="del mod">
          <ac:chgData name="吉武 和敏" userId="e4825ba96748af9c" providerId="LiveId" clId="{F9D40476-436E-48E8-A5D6-204A0E704A88}" dt="2020-06-25T06:29:53.542" v="2496" actId="478"/>
          <ac:spMkLst>
            <pc:docMk/>
            <pc:sldMk cId="3600490621" sldId="269"/>
            <ac:spMk id="79" creationId="{D5F369DF-6883-493F-BAB8-61ACED8CE570}"/>
          </ac:spMkLst>
        </pc:spChg>
        <pc:spChg chg="mod">
          <ac:chgData name="吉武 和敏" userId="e4825ba96748af9c" providerId="LiveId" clId="{F9D40476-436E-48E8-A5D6-204A0E704A88}" dt="2020-06-25T06:35:02.140" v="2680" actId="1076"/>
          <ac:spMkLst>
            <pc:docMk/>
            <pc:sldMk cId="3600490621" sldId="269"/>
            <ac:spMk id="81" creationId="{DC14642C-AA4A-44A9-9771-365EA3DA7DD4}"/>
          </ac:spMkLst>
        </pc:spChg>
        <pc:spChg chg="mod">
          <ac:chgData name="吉武 和敏" userId="e4825ba96748af9c" providerId="LiveId" clId="{F9D40476-436E-48E8-A5D6-204A0E704A88}" dt="2020-06-25T06:35:16.897" v="2683" actId="14100"/>
          <ac:spMkLst>
            <pc:docMk/>
            <pc:sldMk cId="3600490621" sldId="269"/>
            <ac:spMk id="82" creationId="{7E0D8C86-A409-4577-ACA0-21773029AD8A}"/>
          </ac:spMkLst>
        </pc:spChg>
        <pc:spChg chg="mod">
          <ac:chgData name="吉武 和敏" userId="e4825ba96748af9c" providerId="LiveId" clId="{F9D40476-436E-48E8-A5D6-204A0E704A88}" dt="2020-06-25T06:38:36.394" v="2714" actId="1076"/>
          <ac:spMkLst>
            <pc:docMk/>
            <pc:sldMk cId="3600490621" sldId="269"/>
            <ac:spMk id="83" creationId="{73D40766-4BD6-4831-B9F8-A364FBEBCB82}"/>
          </ac:spMkLst>
        </pc:spChg>
        <pc:spChg chg="del mod">
          <ac:chgData name="吉武 和敏" userId="e4825ba96748af9c" providerId="LiveId" clId="{F9D40476-436E-48E8-A5D6-204A0E704A88}" dt="2020-06-25T06:29:53.542" v="2496" actId="478"/>
          <ac:spMkLst>
            <pc:docMk/>
            <pc:sldMk cId="3600490621" sldId="269"/>
            <ac:spMk id="84" creationId="{88CE5C0A-EBD7-440B-94DA-4AB731807D43}"/>
          </ac:spMkLst>
        </pc:spChg>
        <pc:spChg chg="del mod">
          <ac:chgData name="吉武 和敏" userId="e4825ba96748af9c" providerId="LiveId" clId="{F9D40476-436E-48E8-A5D6-204A0E704A88}" dt="2020-06-25T06:31:52.422" v="2564" actId="478"/>
          <ac:spMkLst>
            <pc:docMk/>
            <pc:sldMk cId="3600490621" sldId="269"/>
            <ac:spMk id="85" creationId="{26A7A009-B167-422C-BF5D-A7481CC956E8}"/>
          </ac:spMkLst>
        </pc:spChg>
        <pc:spChg chg="mod">
          <ac:chgData name="吉武 和敏" userId="e4825ba96748af9c" providerId="LiveId" clId="{F9D40476-436E-48E8-A5D6-204A0E704A88}" dt="2020-06-25T08:03:55.071" v="3056" actId="14100"/>
          <ac:spMkLst>
            <pc:docMk/>
            <pc:sldMk cId="3600490621" sldId="269"/>
            <ac:spMk id="89" creationId="{B1194E59-3657-4B23-B386-B2C2380FA42A}"/>
          </ac:spMkLst>
        </pc:spChg>
        <pc:spChg chg="mod">
          <ac:chgData name="吉武 和敏" userId="e4825ba96748af9c" providerId="LiveId" clId="{F9D40476-436E-48E8-A5D6-204A0E704A88}" dt="2020-06-25T08:00:27.575" v="2986" actId="14100"/>
          <ac:spMkLst>
            <pc:docMk/>
            <pc:sldMk cId="3600490621" sldId="269"/>
            <ac:spMk id="90" creationId="{6DC85691-1F6A-42E6-BC42-14DFCE3CB5FA}"/>
          </ac:spMkLst>
        </pc:spChg>
        <pc:spChg chg="mod">
          <ac:chgData name="吉武 和敏" userId="e4825ba96748af9c" providerId="LiveId" clId="{F9D40476-436E-48E8-A5D6-204A0E704A88}" dt="2020-06-25T08:00:07.307" v="2977" actId="164"/>
          <ac:spMkLst>
            <pc:docMk/>
            <pc:sldMk cId="3600490621" sldId="269"/>
            <ac:spMk id="92" creationId="{D5C7E194-6FA3-4882-8058-CDF46552242E}"/>
          </ac:spMkLst>
        </pc:spChg>
        <pc:spChg chg="mod">
          <ac:chgData name="吉武 和敏" userId="e4825ba96748af9c" providerId="LiveId" clId="{F9D40476-436E-48E8-A5D6-204A0E704A88}" dt="2020-06-25T08:00:07.307" v="2977" actId="164"/>
          <ac:spMkLst>
            <pc:docMk/>
            <pc:sldMk cId="3600490621" sldId="269"/>
            <ac:spMk id="93" creationId="{722EEC41-8E6F-4732-9211-41B8D8EB86A1}"/>
          </ac:spMkLst>
        </pc:spChg>
        <pc:spChg chg="mod">
          <ac:chgData name="吉武 和敏" userId="e4825ba96748af9c" providerId="LiveId" clId="{F9D40476-436E-48E8-A5D6-204A0E704A88}" dt="2020-06-25T08:00:24.740" v="2985" actId="1076"/>
          <ac:spMkLst>
            <pc:docMk/>
            <pc:sldMk cId="3600490621" sldId="269"/>
            <ac:spMk id="94" creationId="{82D96BE6-8EF6-4316-B74B-D0DAE128D0B5}"/>
          </ac:spMkLst>
        </pc:spChg>
        <pc:spChg chg="del mod">
          <ac:chgData name="吉武 和敏" userId="e4825ba96748af9c" providerId="LiveId" clId="{F9D40476-436E-48E8-A5D6-204A0E704A88}" dt="2020-06-25T07:57:53.356" v="2954" actId="478"/>
          <ac:spMkLst>
            <pc:docMk/>
            <pc:sldMk cId="3600490621" sldId="269"/>
            <ac:spMk id="95" creationId="{D8A227D5-27AC-4EC4-9D6F-487C8A759080}"/>
          </ac:spMkLst>
        </pc:spChg>
        <pc:spChg chg="del mod">
          <ac:chgData name="吉武 和敏" userId="e4825ba96748af9c" providerId="LiveId" clId="{F9D40476-436E-48E8-A5D6-204A0E704A88}" dt="2020-06-25T07:57:54.204" v="2955" actId="478"/>
          <ac:spMkLst>
            <pc:docMk/>
            <pc:sldMk cId="3600490621" sldId="269"/>
            <ac:spMk id="96" creationId="{5F3D0E75-B89D-460D-961F-202491B3B0DF}"/>
          </ac:spMkLst>
        </pc:spChg>
        <pc:spChg chg="del mod">
          <ac:chgData name="吉武 和敏" userId="e4825ba96748af9c" providerId="LiveId" clId="{F9D40476-436E-48E8-A5D6-204A0E704A88}" dt="2020-06-25T07:58:53.916" v="2967" actId="478"/>
          <ac:spMkLst>
            <pc:docMk/>
            <pc:sldMk cId="3600490621" sldId="269"/>
            <ac:spMk id="97" creationId="{0FB102F8-0C3C-42FF-B84C-5213BACA1250}"/>
          </ac:spMkLst>
        </pc:spChg>
        <pc:spChg chg="del mod">
          <ac:chgData name="吉武 和敏" userId="e4825ba96748af9c" providerId="LiveId" clId="{F9D40476-436E-48E8-A5D6-204A0E704A88}" dt="2020-06-25T07:58:53.916" v="2967" actId="478"/>
          <ac:spMkLst>
            <pc:docMk/>
            <pc:sldMk cId="3600490621" sldId="269"/>
            <ac:spMk id="99" creationId="{DF3B7B6F-CBCC-4B8B-86C0-C6B452758C94}"/>
          </ac:spMkLst>
        </pc:spChg>
        <pc:spChg chg="del mod">
          <ac:chgData name="吉武 和敏" userId="e4825ba96748af9c" providerId="LiveId" clId="{F9D40476-436E-48E8-A5D6-204A0E704A88}" dt="2020-06-25T07:57:56.444" v="2956" actId="478"/>
          <ac:spMkLst>
            <pc:docMk/>
            <pc:sldMk cId="3600490621" sldId="269"/>
            <ac:spMk id="100" creationId="{2AD68585-8E1B-473C-9372-4DB5F51250FB}"/>
          </ac:spMkLst>
        </pc:spChg>
        <pc:spChg chg="mod">
          <ac:chgData name="吉武 和敏" userId="e4825ba96748af9c" providerId="LiveId" clId="{F9D40476-436E-48E8-A5D6-204A0E704A88}" dt="2020-06-25T07:59:47.908" v="2970" actId="403"/>
          <ac:spMkLst>
            <pc:docMk/>
            <pc:sldMk cId="3600490621" sldId="269"/>
            <ac:spMk id="101" creationId="{29A92198-243E-4C6E-B2BF-068A88449DFD}"/>
          </ac:spMkLst>
        </pc:spChg>
        <pc:spChg chg="del mod">
          <ac:chgData name="吉武 和敏" userId="e4825ba96748af9c" providerId="LiveId" clId="{F9D40476-436E-48E8-A5D6-204A0E704A88}" dt="2020-06-25T07:57:59.308" v="2957" actId="478"/>
          <ac:spMkLst>
            <pc:docMk/>
            <pc:sldMk cId="3600490621" sldId="269"/>
            <ac:spMk id="102" creationId="{F660BE29-2D68-4D24-A58E-70E8C50B084D}"/>
          </ac:spMkLst>
        </pc:spChg>
        <pc:spChg chg="mod">
          <ac:chgData name="吉武 和敏" userId="e4825ba96748af9c" providerId="LiveId" clId="{F9D40476-436E-48E8-A5D6-204A0E704A88}" dt="2020-06-25T06:40:37.892" v="2744" actId="1076"/>
          <ac:spMkLst>
            <pc:docMk/>
            <pc:sldMk cId="3600490621" sldId="269"/>
            <ac:spMk id="103" creationId="{FE34D225-3901-4F1B-9F83-631A84AE7AA0}"/>
          </ac:spMkLst>
        </pc:spChg>
        <pc:spChg chg="mod">
          <ac:chgData name="吉武 和敏" userId="e4825ba96748af9c" providerId="LiveId" clId="{F9D40476-436E-48E8-A5D6-204A0E704A88}" dt="2020-06-25T08:04:44.492" v="3080" actId="14100"/>
          <ac:spMkLst>
            <pc:docMk/>
            <pc:sldMk cId="3600490621" sldId="269"/>
            <ac:spMk id="104" creationId="{7D574AC1-95D8-4671-AEA5-707F1C079F12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05" creationId="{6CECF3CA-D2C4-40E1-8789-69B366E56CEC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11" creationId="{50001D3A-9D9D-4A57-B55B-A2B4629DF47C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12" creationId="{EC6A976C-1F5D-4B03-85FD-EDC24E0DC6FE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13" creationId="{5FFE7E16-8FEB-4795-8BCA-C63754BEA01C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14" creationId="{20A58F89-DAE7-400E-84A0-B13082614BDB}"/>
          </ac:spMkLst>
        </pc:spChg>
        <pc:spChg chg="mod">
          <ac:chgData name="吉武 和敏" userId="e4825ba96748af9c" providerId="LiveId" clId="{F9D40476-436E-48E8-A5D6-204A0E704A88}" dt="2020-06-25T08:04:00.829" v="3057" actId="14100"/>
          <ac:spMkLst>
            <pc:docMk/>
            <pc:sldMk cId="3600490621" sldId="269"/>
            <ac:spMk id="115" creationId="{CBED4EAB-5279-4B64-8A3F-0CF792E06049}"/>
          </ac:spMkLst>
        </pc:spChg>
        <pc:spChg chg="del mod">
          <ac:chgData name="吉武 和敏" userId="e4825ba96748af9c" providerId="LiveId" clId="{F9D40476-436E-48E8-A5D6-204A0E704A88}" dt="2020-06-25T06:40:24.117" v="2740" actId="478"/>
          <ac:spMkLst>
            <pc:docMk/>
            <pc:sldMk cId="3600490621" sldId="269"/>
            <ac:spMk id="116" creationId="{02C7D3ED-76B0-4591-ABEF-9DC00FBC4529}"/>
          </ac:spMkLst>
        </pc:spChg>
        <pc:spChg chg="del mod">
          <ac:chgData name="吉武 和敏" userId="e4825ba96748af9c" providerId="LiveId" clId="{F9D40476-436E-48E8-A5D6-204A0E704A88}" dt="2020-06-25T06:40:24.117" v="2740" actId="478"/>
          <ac:spMkLst>
            <pc:docMk/>
            <pc:sldMk cId="3600490621" sldId="269"/>
            <ac:spMk id="117" creationId="{6F19271B-76C3-4B7B-8BF5-ADBB0C6C71AE}"/>
          </ac:spMkLst>
        </pc:spChg>
        <pc:spChg chg="mod">
          <ac:chgData name="吉武 和敏" userId="e4825ba96748af9c" providerId="LiveId" clId="{F9D40476-436E-48E8-A5D6-204A0E704A88}" dt="2020-06-25T08:03:50.428" v="3055" actId="14100"/>
          <ac:spMkLst>
            <pc:docMk/>
            <pc:sldMk cId="3600490621" sldId="269"/>
            <ac:spMk id="119" creationId="{2EEAF96D-A78B-42DC-8C8D-DA421E6E52A4}"/>
          </ac:spMkLst>
        </pc:spChg>
        <pc:spChg chg="mod">
          <ac:chgData name="吉武 和敏" userId="e4825ba96748af9c" providerId="LiveId" clId="{F9D40476-436E-48E8-A5D6-204A0E704A88}" dt="2020-06-25T08:04:29.030" v="3059" actId="1076"/>
          <ac:spMkLst>
            <pc:docMk/>
            <pc:sldMk cId="3600490621" sldId="269"/>
            <ac:spMk id="126" creationId="{A7E8D0CE-C520-4C56-A5BF-9A6C570C4358}"/>
          </ac:spMkLst>
        </pc:spChg>
        <pc:spChg chg="del mod">
          <ac:chgData name="吉武 和敏" userId="e4825ba96748af9c" providerId="LiveId" clId="{F9D40476-436E-48E8-A5D6-204A0E704A88}" dt="2020-06-25T08:03:47.243" v="3054" actId="478"/>
          <ac:spMkLst>
            <pc:docMk/>
            <pc:sldMk cId="3600490621" sldId="269"/>
            <ac:spMk id="127" creationId="{1CAE4D79-B31F-46B0-AD03-DFFFA7D26967}"/>
          </ac:spMkLst>
        </pc:spChg>
        <pc:spChg chg="del mod">
          <ac:chgData name="吉武 和敏" userId="e4825ba96748af9c" providerId="LiveId" clId="{F9D40476-436E-48E8-A5D6-204A0E704A88}" dt="2020-06-25T06:34:27.509" v="2678" actId="478"/>
          <ac:spMkLst>
            <pc:docMk/>
            <pc:sldMk cId="3600490621" sldId="269"/>
            <ac:spMk id="134" creationId="{80DC5995-1C89-47CC-BC93-1676E029E1FC}"/>
          </ac:spMkLst>
        </pc:spChg>
        <pc:spChg chg="del mod">
          <ac:chgData name="吉武 和敏" userId="e4825ba96748af9c" providerId="LiveId" clId="{F9D40476-436E-48E8-A5D6-204A0E704A88}" dt="2020-06-25T06:34:27.509" v="2678" actId="478"/>
          <ac:spMkLst>
            <pc:docMk/>
            <pc:sldMk cId="3600490621" sldId="269"/>
            <ac:spMk id="135" creationId="{40A2AA1C-D513-4BBE-9EA5-CACEDDBF90F2}"/>
          </ac:spMkLst>
        </pc:spChg>
        <pc:spChg chg="add 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36" creationId="{47222D92-120A-4B11-B69B-65A2A4DF9924}"/>
          </ac:spMkLst>
        </pc:spChg>
        <pc:spChg chg="add 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37" creationId="{FC7ACBFD-BBA1-488F-9897-DBBA93C0136B}"/>
          </ac:spMkLst>
        </pc:spChg>
        <pc:spChg chg="mod">
          <ac:chgData name="吉武 和敏" userId="e4825ba96748af9c" providerId="LiveId" clId="{F9D40476-436E-48E8-A5D6-204A0E704A88}" dt="2020-06-25T06:34:16.945" v="2677" actId="14100"/>
          <ac:spMkLst>
            <pc:docMk/>
            <pc:sldMk cId="3600490621" sldId="269"/>
            <ac:spMk id="139" creationId="{B6DF0637-210D-43AA-908F-A655DAB6B85B}"/>
          </ac:spMkLst>
        </pc:spChg>
        <pc:spChg chg="del">
          <ac:chgData name="吉武 和敏" userId="e4825ba96748af9c" providerId="LiveId" clId="{F9D40476-436E-48E8-A5D6-204A0E704A88}" dt="2020-06-25T05:27:23.918" v="2488" actId="478"/>
          <ac:spMkLst>
            <pc:docMk/>
            <pc:sldMk cId="3600490621" sldId="269"/>
            <ac:spMk id="141" creationId="{4DC90414-684E-4359-853D-1CEE3750270E}"/>
          </ac:spMkLst>
        </pc:spChg>
        <pc:spChg chg="del mod">
          <ac:chgData name="吉武 和敏" userId="e4825ba96748af9c" providerId="LiveId" clId="{F9D40476-436E-48E8-A5D6-204A0E704A88}" dt="2020-06-25T05:27:22.460" v="2487"/>
          <ac:spMkLst>
            <pc:docMk/>
            <pc:sldMk cId="3600490621" sldId="269"/>
            <ac:spMk id="142" creationId="{969C0E33-79FC-4D66-B724-CF589C8AEBDC}"/>
          </ac:spMkLst>
        </pc:spChg>
        <pc:spChg chg="del mod">
          <ac:chgData name="吉武 和敏" userId="e4825ba96748af9c" providerId="LiveId" clId="{F9D40476-436E-48E8-A5D6-204A0E704A88}" dt="2020-06-25T06:34:27.509" v="2678" actId="478"/>
          <ac:spMkLst>
            <pc:docMk/>
            <pc:sldMk cId="3600490621" sldId="269"/>
            <ac:spMk id="143" creationId="{6C1AEB7E-7935-4B13-BCE8-19E1BEEFDF39}"/>
          </ac:spMkLst>
        </pc:spChg>
        <pc:spChg chg="del mod">
          <ac:chgData name="吉武 和敏" userId="e4825ba96748af9c" providerId="LiveId" clId="{F9D40476-436E-48E8-A5D6-204A0E704A88}" dt="2020-06-25T06:34:27.509" v="2678" actId="478"/>
          <ac:spMkLst>
            <pc:docMk/>
            <pc:sldMk cId="3600490621" sldId="269"/>
            <ac:spMk id="144" creationId="{D5BAA878-7776-4FF0-81DA-5C744661EC23}"/>
          </ac:spMkLst>
        </pc:spChg>
        <pc:spChg chg="add del">
          <ac:chgData name="吉武 和敏" userId="e4825ba96748af9c" providerId="LiveId" clId="{F9D40476-436E-48E8-A5D6-204A0E704A88}" dt="2020-06-25T05:27:27.120" v="2490" actId="22"/>
          <ac:spMkLst>
            <pc:docMk/>
            <pc:sldMk cId="3600490621" sldId="269"/>
            <ac:spMk id="147" creationId="{79C6C204-EA2C-44AD-9D62-9D3456CDDB9E}"/>
          </ac:spMkLst>
        </pc:spChg>
        <pc:spChg chg="add mod">
          <ac:chgData name="吉武 和敏" userId="e4825ba96748af9c" providerId="LiveId" clId="{F9D40476-436E-48E8-A5D6-204A0E704A88}" dt="2020-06-25T08:05:57.837" v="3114" actId="20577"/>
          <ac:spMkLst>
            <pc:docMk/>
            <pc:sldMk cId="3600490621" sldId="269"/>
            <ac:spMk id="148" creationId="{8EA9CF68-ACDA-455B-97C7-59AF4AF6EAD8}"/>
          </ac:spMkLst>
        </pc:spChg>
        <pc:spChg chg="add mod">
          <ac:chgData name="吉武 和敏" userId="e4825ba96748af9c" providerId="LiveId" clId="{F9D40476-436E-48E8-A5D6-204A0E704A88}" dt="2020-06-25T06:35:33.127" v="2687" actId="571"/>
          <ac:spMkLst>
            <pc:docMk/>
            <pc:sldMk cId="3600490621" sldId="269"/>
            <ac:spMk id="150" creationId="{36B19890-9324-4F5C-9834-F29D41DF2213}"/>
          </ac:spMkLst>
        </pc:spChg>
        <pc:spChg chg="add mod">
          <ac:chgData name="吉武 和敏" userId="e4825ba96748af9c" providerId="LiveId" clId="{F9D40476-436E-48E8-A5D6-204A0E704A88}" dt="2020-06-25T06:36:16.253" v="2707" actId="1076"/>
          <ac:spMkLst>
            <pc:docMk/>
            <pc:sldMk cId="3600490621" sldId="269"/>
            <ac:spMk id="153" creationId="{DAEEA99D-F267-4A6F-B1E2-E4C972AC8E74}"/>
          </ac:spMkLst>
        </pc:spChg>
        <pc:spChg chg="add del mod">
          <ac:chgData name="吉武 和敏" userId="e4825ba96748af9c" providerId="LiveId" clId="{F9D40476-436E-48E8-A5D6-204A0E704A88}" dt="2020-06-25T06:41:31.958" v="2750" actId="478"/>
          <ac:spMkLst>
            <pc:docMk/>
            <pc:sldMk cId="3600490621" sldId="269"/>
            <ac:spMk id="164" creationId="{E05CF70E-BC44-4507-9E37-43F024D8497B}"/>
          </ac:spMkLst>
        </pc:spChg>
        <pc:spChg chg="add del mod">
          <ac:chgData name="吉武 和敏" userId="e4825ba96748af9c" providerId="LiveId" clId="{F9D40476-436E-48E8-A5D6-204A0E704A88}" dt="2020-06-25T06:41:34.054" v="2751" actId="478"/>
          <ac:spMkLst>
            <pc:docMk/>
            <pc:sldMk cId="3600490621" sldId="269"/>
            <ac:spMk id="165" creationId="{DF85FFBA-4E8B-477B-9E5D-A02131D04AEB}"/>
          </ac:spMkLst>
        </pc:spChg>
        <pc:spChg chg="add mod">
          <ac:chgData name="吉武 和敏" userId="e4825ba96748af9c" providerId="LiveId" clId="{F9D40476-436E-48E8-A5D6-204A0E704A88}" dt="2020-06-25T08:01:03.838" v="2990" actId="14100"/>
          <ac:spMkLst>
            <pc:docMk/>
            <pc:sldMk cId="3600490621" sldId="269"/>
            <ac:spMk id="166" creationId="{F986F84C-3CA5-4E40-A919-B9F85BF4FE0E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67" creationId="{F6E9CB0D-F82C-4272-A08E-12B1A74488B4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68" creationId="{716E4E25-2D61-4A69-A017-1B521A217B2C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76" creationId="{21155259-889E-4AFD-9FF0-49C000C943A2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77" creationId="{BA38AF65-652F-4A26-AEEE-006B5EB5F2C6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78" creationId="{EA36E852-9A09-46A5-88CB-3C94713B8F9D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86" creationId="{2A6065F9-5E5E-4F0C-B390-A173E77BF1EF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87" creationId="{42791C1F-F1F8-4C08-A4A4-F6FDACD7DF6A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88" creationId="{E0A8A2A4-386F-42C4-9AA9-9DB36DDB8D48}"/>
          </ac:spMkLst>
        </pc:spChg>
        <pc:spChg chg="add del mod">
          <ac:chgData name="吉武 和敏" userId="e4825ba96748af9c" providerId="LiveId" clId="{F9D40476-436E-48E8-A5D6-204A0E704A88}" dt="2020-06-25T08:01:56.955" v="2995"/>
          <ac:spMkLst>
            <pc:docMk/>
            <pc:sldMk cId="3600490621" sldId="269"/>
            <ac:spMk id="189" creationId="{9074317A-0C59-49D5-8806-4094B6E7FF46}"/>
          </ac:spMkLst>
        </pc:spChg>
        <pc:spChg chg="add del mod">
          <ac:chgData name="吉武 和敏" userId="e4825ba96748af9c" providerId="LiveId" clId="{F9D40476-436E-48E8-A5D6-204A0E704A88}" dt="2020-06-25T08:02:13.595" v="2999" actId="478"/>
          <ac:spMkLst>
            <pc:docMk/>
            <pc:sldMk cId="3600490621" sldId="269"/>
            <ac:spMk id="190" creationId="{7CE2DDF4-B046-425D-85AF-BF005E847F9D}"/>
          </ac:spMkLst>
        </pc:spChg>
        <pc:spChg chg="add del mod">
          <ac:chgData name="吉武 和敏" userId="e4825ba96748af9c" providerId="LiveId" clId="{F9D40476-436E-48E8-A5D6-204A0E704A88}" dt="2020-06-25T08:02:14.939" v="3000" actId="478"/>
          <ac:spMkLst>
            <pc:docMk/>
            <pc:sldMk cId="3600490621" sldId="269"/>
            <ac:spMk id="191" creationId="{8141BDBD-8062-42EB-BAE8-36791E86C324}"/>
          </ac:spMkLst>
        </pc:spChg>
        <pc:spChg chg="add mod">
          <ac:chgData name="吉武 和敏" userId="e4825ba96748af9c" providerId="LiveId" clId="{F9D40476-436E-48E8-A5D6-204A0E704A88}" dt="2020-06-25T08:02:20.155" v="3002" actId="164"/>
          <ac:spMkLst>
            <pc:docMk/>
            <pc:sldMk cId="3600490621" sldId="269"/>
            <ac:spMk id="199" creationId="{42E042E6-2668-4DBE-BAE0-D1D581F02F6A}"/>
          </ac:spMkLst>
        </pc:spChg>
        <pc:spChg chg="add mod">
          <ac:chgData name="吉武 和敏" userId="e4825ba96748af9c" providerId="LiveId" clId="{F9D40476-436E-48E8-A5D6-204A0E704A88}" dt="2020-06-25T08:02:20.155" v="3002" actId="164"/>
          <ac:spMkLst>
            <pc:docMk/>
            <pc:sldMk cId="3600490621" sldId="269"/>
            <ac:spMk id="200" creationId="{C73F06C6-B248-46AD-AD0E-0179C75B6C05}"/>
          </ac:spMkLst>
        </pc:spChg>
        <pc:spChg chg="add mod">
          <ac:chgData name="吉武 和敏" userId="e4825ba96748af9c" providerId="LiveId" clId="{F9D40476-436E-48E8-A5D6-204A0E704A88}" dt="2020-06-25T08:02:20.155" v="3002" actId="164"/>
          <ac:spMkLst>
            <pc:docMk/>
            <pc:sldMk cId="3600490621" sldId="269"/>
            <ac:spMk id="201" creationId="{E353E058-F45B-4681-A66C-2B1E467156B1}"/>
          </ac:spMkLst>
        </pc:spChg>
        <pc:spChg chg="add mod">
          <ac:chgData name="吉武 和敏" userId="e4825ba96748af9c" providerId="LiveId" clId="{F9D40476-436E-48E8-A5D6-204A0E704A88}" dt="2020-06-25T08:02:20.155" v="3002" actId="164"/>
          <ac:spMkLst>
            <pc:docMk/>
            <pc:sldMk cId="3600490621" sldId="269"/>
            <ac:spMk id="209" creationId="{CBB6CDFC-2884-4CEC-BD34-A1D48192FCA4}"/>
          </ac:spMkLst>
        </pc:spChg>
        <pc:spChg chg="add mod">
          <ac:chgData name="吉武 和敏" userId="e4825ba96748af9c" providerId="LiveId" clId="{F9D40476-436E-48E8-A5D6-204A0E704A88}" dt="2020-06-25T08:02:20.155" v="3002" actId="164"/>
          <ac:spMkLst>
            <pc:docMk/>
            <pc:sldMk cId="3600490621" sldId="269"/>
            <ac:spMk id="210" creationId="{6582DD14-49D2-4E13-8B41-8D4BF28DFD8F}"/>
          </ac:spMkLst>
        </pc:spChg>
        <pc:spChg chg="add del mod">
          <ac:chgData name="吉武 和敏" userId="e4825ba96748af9c" providerId="LiveId" clId="{F9D40476-436E-48E8-A5D6-204A0E704A88}" dt="2020-06-25T08:02:11.820" v="2998" actId="478"/>
          <ac:spMkLst>
            <pc:docMk/>
            <pc:sldMk cId="3600490621" sldId="269"/>
            <ac:spMk id="211" creationId="{B14D4F05-EA47-470E-A1A4-F34EE56D2656}"/>
          </ac:spMkLst>
        </pc:spChg>
        <pc:spChg chg="add del mod">
          <ac:chgData name="吉武 和敏" userId="e4825ba96748af9c" providerId="LiveId" clId="{F9D40476-436E-48E8-A5D6-204A0E704A88}" dt="2020-06-25T08:02:15.724" v="3001" actId="478"/>
          <ac:spMkLst>
            <pc:docMk/>
            <pc:sldMk cId="3600490621" sldId="269"/>
            <ac:spMk id="212" creationId="{D675B3FA-56B7-4B7D-AB51-877CB2CFC799}"/>
          </ac:spMkLst>
        </pc:spChg>
        <pc:spChg chg="add mod">
          <ac:chgData name="吉武 和敏" userId="e4825ba96748af9c" providerId="LiveId" clId="{F9D40476-436E-48E8-A5D6-204A0E704A88}" dt="2020-06-25T08:03:06.037" v="3029" actId="1076"/>
          <ac:spMkLst>
            <pc:docMk/>
            <pc:sldMk cId="3600490621" sldId="269"/>
            <ac:spMk id="213" creationId="{F71E78BA-32B1-453C-948F-583BED51A639}"/>
          </ac:spMkLst>
        </pc:spChg>
        <pc:spChg chg="mod ord">
          <ac:chgData name="吉武 和敏" userId="e4825ba96748af9c" providerId="LiveId" clId="{F9D40476-436E-48E8-A5D6-204A0E704A88}" dt="2020-06-25T06:37:48.581" v="2713" actId="1076"/>
          <ac:spMkLst>
            <pc:docMk/>
            <pc:sldMk cId="3600490621" sldId="269"/>
            <ac:spMk id="1029" creationId="{DC024F5A-1540-487B-9337-8C13FE995FF6}"/>
          </ac:spMkLst>
        </pc:spChg>
        <pc:spChg chg="del mod">
          <ac:chgData name="吉武 和敏" userId="e4825ba96748af9c" providerId="LiveId" clId="{F9D40476-436E-48E8-A5D6-204A0E704A88}" dt="2020-06-25T06:32:56.871" v="2602" actId="478"/>
          <ac:spMkLst>
            <pc:docMk/>
            <pc:sldMk cId="3600490621" sldId="269"/>
            <ac:spMk id="1037" creationId="{C7F55A80-CA93-4FE2-B328-AF6354A1F8FB}"/>
          </ac:spMkLst>
        </pc:spChg>
        <pc:spChg chg="mod">
          <ac:chgData name="吉武 和敏" userId="e4825ba96748af9c" providerId="LiveId" clId="{F9D40476-436E-48E8-A5D6-204A0E704A88}" dt="2020-06-25T06:31:39.351" v="2558" actId="20577"/>
          <ac:spMkLst>
            <pc:docMk/>
            <pc:sldMk cId="3600490621" sldId="269"/>
            <ac:spMk id="1041" creationId="{3E16F35A-5418-45C8-B92D-E7075961D7F3}"/>
          </ac:spMkLst>
        </pc:spChg>
        <pc:spChg chg="mod">
          <ac:chgData name="吉武 和敏" userId="e4825ba96748af9c" providerId="LiveId" clId="{F9D40476-436E-48E8-A5D6-204A0E704A88}" dt="2020-06-25T05:27:36.809" v="2493" actId="1076"/>
          <ac:spMkLst>
            <pc:docMk/>
            <pc:sldMk cId="3600490621" sldId="269"/>
            <ac:spMk id="1043" creationId="{BFA1E1B3-2C66-4079-9EC6-82077426ACE6}"/>
          </ac:spMkLst>
        </pc:spChg>
        <pc:spChg chg="mod">
          <ac:chgData name="吉武 和敏" userId="e4825ba96748af9c" providerId="LiveId" clId="{F9D40476-436E-48E8-A5D6-204A0E704A88}" dt="2020-06-25T08:05:12.606" v="3082" actId="1076"/>
          <ac:spMkLst>
            <pc:docMk/>
            <pc:sldMk cId="3600490621" sldId="269"/>
            <ac:spMk id="1046" creationId="{DF883BB1-7F7A-4855-9842-00C0E897A37A}"/>
          </ac:spMkLst>
        </pc:spChg>
        <pc:grpChg chg="mod">
          <ac:chgData name="吉武 和敏" userId="e4825ba96748af9c" providerId="LiveId" clId="{F9D40476-436E-48E8-A5D6-204A0E704A88}" dt="2020-06-25T05:27:36.809" v="2493" actId="1076"/>
          <ac:grpSpMkLst>
            <pc:docMk/>
            <pc:sldMk cId="3600490621" sldId="269"/>
            <ac:grpSpMk id="4" creationId="{FEA417CA-249B-478E-B05C-CD6794EACFE8}"/>
          </ac:grpSpMkLst>
        </pc:grpChg>
        <pc:grpChg chg="mod">
          <ac:chgData name="吉武 和敏" userId="e4825ba96748af9c" providerId="LiveId" clId="{F9D40476-436E-48E8-A5D6-204A0E704A88}" dt="2020-06-25T05:27:36.809" v="2493" actId="1076"/>
          <ac:grpSpMkLst>
            <pc:docMk/>
            <pc:sldMk cId="3600490621" sldId="269"/>
            <ac:grpSpMk id="24" creationId="{E3A9B85A-E2BD-44FC-BE8F-D34A7A6F530F}"/>
          </ac:grpSpMkLst>
        </pc:grpChg>
        <pc:grpChg chg="add del mod">
          <ac:chgData name="吉武 和敏" userId="e4825ba96748af9c" providerId="LiveId" clId="{F9D40476-436E-48E8-A5D6-204A0E704A88}" dt="2020-06-25T07:59:15.932" v="2969" actId="478"/>
          <ac:grpSpMkLst>
            <pc:docMk/>
            <pc:sldMk cId="3600490621" sldId="269"/>
            <ac:grpSpMk id="40" creationId="{7CC621B8-D01B-44B5-AC50-E23EB0E5564D}"/>
          </ac:grpSpMkLst>
        </pc:grpChg>
        <pc:grpChg chg="mod topLvl">
          <ac:chgData name="吉武 和敏" userId="e4825ba96748af9c" providerId="LiveId" clId="{F9D40476-436E-48E8-A5D6-204A0E704A88}" dt="2020-06-25T05:27:36.809" v="2493" actId="1076"/>
          <ac:grpSpMkLst>
            <pc:docMk/>
            <pc:sldMk cId="3600490621" sldId="269"/>
            <ac:grpSpMk id="41" creationId="{297253A3-1AB7-4519-8109-828B519A55A2}"/>
          </ac:grpSpMkLst>
        </pc:grpChg>
        <pc:grpChg chg="mod topLvl">
          <ac:chgData name="吉武 和敏" userId="e4825ba96748af9c" providerId="LiveId" clId="{F9D40476-436E-48E8-A5D6-204A0E704A88}" dt="2020-06-25T05:27:36.809" v="2493" actId="1076"/>
          <ac:grpSpMkLst>
            <pc:docMk/>
            <pc:sldMk cId="3600490621" sldId="269"/>
            <ac:grpSpMk id="42" creationId="{B8BE5D18-ABF7-4E36-8307-FB6BB9CD6B37}"/>
          </ac:grpSpMkLst>
        </pc:grpChg>
        <pc:grpChg chg="add mod">
          <ac:chgData name="吉武 和敏" userId="e4825ba96748af9c" providerId="LiveId" clId="{F9D40476-436E-48E8-A5D6-204A0E704A88}" dt="2020-06-25T08:04:20.218" v="3058" actId="1076"/>
          <ac:grpSpMkLst>
            <pc:docMk/>
            <pc:sldMk cId="3600490621" sldId="269"/>
            <ac:grpSpMk id="50" creationId="{876E339A-A5D8-487F-AED1-FEAFD9A78B8B}"/>
          </ac:grpSpMkLst>
        </pc:grpChg>
        <pc:grpChg chg="add mod">
          <ac:chgData name="吉武 和敏" userId="e4825ba96748af9c" providerId="LiveId" clId="{F9D40476-436E-48E8-A5D6-204A0E704A88}" dt="2020-06-25T08:03:02.558" v="3028" actId="1076"/>
          <ac:grpSpMkLst>
            <pc:docMk/>
            <pc:sldMk cId="3600490621" sldId="269"/>
            <ac:grpSpMk id="51" creationId="{BA5E6B8F-7A0C-4912-AF23-F51E6A855242}"/>
          </ac:grpSpMkLst>
        </pc:grpChg>
        <pc:grpChg chg="mod">
          <ac:chgData name="吉武 和敏" userId="e4825ba96748af9c" providerId="LiveId" clId="{F9D40476-436E-48E8-A5D6-204A0E704A88}" dt="2020-06-25T06:35:02.140" v="2680" actId="1076"/>
          <ac:grpSpMkLst>
            <pc:docMk/>
            <pc:sldMk cId="3600490621" sldId="269"/>
            <ac:grpSpMk id="62" creationId="{0750F7C4-6F19-4538-9D6D-C298580E6A62}"/>
          </ac:grpSpMkLst>
        </pc:grpChg>
        <pc:grpChg chg="mod">
          <ac:chgData name="吉武 和敏" userId="e4825ba96748af9c" providerId="LiveId" clId="{F9D40476-436E-48E8-A5D6-204A0E704A88}" dt="2020-06-25T05:27:36.809" v="2493" actId="1076"/>
          <ac:grpSpMkLst>
            <pc:docMk/>
            <pc:sldMk cId="3600490621" sldId="269"/>
            <ac:grpSpMk id="106" creationId="{288A2D67-88E1-4D07-B849-C86231B3C7D6}"/>
          </ac:grpSpMkLst>
        </pc:grpChg>
        <pc:grpChg chg="del">
          <ac:chgData name="吉武 和敏" userId="e4825ba96748af9c" providerId="LiveId" clId="{F9D40476-436E-48E8-A5D6-204A0E704A88}" dt="2020-06-25T05:18:28.784" v="2358" actId="165"/>
          <ac:grpSpMkLst>
            <pc:docMk/>
            <pc:sldMk cId="3600490621" sldId="269"/>
            <ac:grpSpMk id="1042" creationId="{2CFD438D-D198-4537-AC08-2D25869C4DA4}"/>
          </ac:grpSpMkLst>
        </pc:grp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4" creationId="{F152491A-B099-4540-A32C-5C9CCDCC9DE6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5" creationId="{BBEC991E-F125-4025-B737-D2B124EE7858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6" creationId="{C2CB2B9C-08C4-4489-B917-474BE00EDFC1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7" creationId="{11B40381-3D2A-40FE-8796-B96A0407780C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8" creationId="{D2EB1D94-8E3F-416A-96DD-9CBCB04A9A0A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9" creationId="{A6FCFD92-FCEE-4413-80AE-D53E36E156DA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20" creationId="{14198F7A-6E68-4FE2-8BB4-C2CAB3C3F60A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21" creationId="{909712B4-92DC-4F7E-9074-039AD5405AB2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26" creationId="{45133F30-F5E5-4E2B-95F1-5350D6F0A09E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27" creationId="{8D6E897F-E933-4D98-9DF2-4803E8936BC4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28" creationId="{96538CAA-6AB0-481D-9E12-79F4BA48568A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29" creationId="{8D8D3EDA-80DD-4AFE-8A72-D2BAB88730C6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30" creationId="{F45B5AE9-EF64-4057-BF78-834A31D98718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31" creationId="{8C342A21-216A-46FF-8284-4B502F05B77C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32" creationId="{45FC24E3-28F8-4B9E-860D-7C0E9D33A307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33" creationId="{5EE4D5DF-0EDE-4BFA-A29B-2597D23959C4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44" creationId="{275D86BF-F78B-42FE-9A5A-BDE10EFB6694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45" creationId="{23B21659-7E7D-4B5C-B628-1F31F07DD69C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46" creationId="{F538A6FF-19AE-43BA-9B7F-D7DD601660C0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47" creationId="{E909B0CE-E475-4A0C-BFD5-C6E7ACCC1A55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48" creationId="{96929E93-E4E1-43E6-B0BD-80A73EBA3891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49" creationId="{04F1B0DE-435F-4375-9E79-502A7CFF463B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63" creationId="{89933E1A-3CA8-4F6F-A274-E3C18B03E47C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64" creationId="{FDFA9C69-B1C9-46C5-96AF-3B3ACCE39221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65" creationId="{2EDEB58C-3112-4C82-BD70-21C2AC88F0BE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66" creationId="{0C57ECD8-49F1-4857-9A03-0E1F18572250}"/>
          </ac:picMkLst>
        </pc:picChg>
        <pc:picChg chg="del mod">
          <ac:chgData name="吉武 和敏" userId="e4825ba96748af9c" providerId="LiveId" clId="{F9D40476-436E-48E8-A5D6-204A0E704A88}" dt="2020-06-25T06:29:53.542" v="2496" actId="478"/>
          <ac:picMkLst>
            <pc:docMk/>
            <pc:sldMk cId="3600490621" sldId="269"/>
            <ac:picMk id="72" creationId="{B84A8F56-753D-411B-8957-5BFBD5C731D9}"/>
          </ac:picMkLst>
        </pc:picChg>
        <pc:picChg chg="mod">
          <ac:chgData name="吉武 和敏" userId="e4825ba96748af9c" providerId="LiveId" clId="{F9D40476-436E-48E8-A5D6-204A0E704A88}" dt="2020-06-25T06:35:02.140" v="2680" actId="1076"/>
          <ac:picMkLst>
            <pc:docMk/>
            <pc:sldMk cId="3600490621" sldId="269"/>
            <ac:picMk id="74" creationId="{F34C211D-9272-4B39-82AF-332462C3BBC2}"/>
          </ac:picMkLst>
        </pc:picChg>
        <pc:picChg chg="del mod">
          <ac:chgData name="吉武 和敏" userId="e4825ba96748af9c" providerId="LiveId" clId="{F9D40476-436E-48E8-A5D6-204A0E704A88}" dt="2020-06-25T07:57:52.076" v="2953" actId="478"/>
          <ac:picMkLst>
            <pc:docMk/>
            <pc:sldMk cId="3600490621" sldId="269"/>
            <ac:picMk id="91" creationId="{7BCC4C0B-9602-4F63-AB13-3C30965148A9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07" creationId="{0233C684-C9EE-4084-AD62-C6B73674CA59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08" creationId="{C8759C96-001D-4969-A991-743963F6C62D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09" creationId="{E894889A-F52C-4CED-91F9-F030C8077387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10" creationId="{E39716F4-B2E0-45B9-9A8D-749810636B12}"/>
          </ac:picMkLst>
        </pc:picChg>
        <pc:picChg chg="mod">
          <ac:chgData name="吉武 和敏" userId="e4825ba96748af9c" providerId="LiveId" clId="{F9D40476-436E-48E8-A5D6-204A0E704A88}" dt="2020-06-25T06:40:28.144" v="2741" actId="1076"/>
          <ac:picMkLst>
            <pc:docMk/>
            <pc:sldMk cId="3600490621" sldId="269"/>
            <ac:picMk id="118" creationId="{2C482492-B76F-4D2A-99AC-428F6CAD5D93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28" creationId="{08038D2C-85A0-488E-9800-F5A7DF481075}"/>
          </ac:picMkLst>
        </pc:picChg>
        <pc:picChg chg="del mod">
          <ac:chgData name="吉武 和敏" userId="e4825ba96748af9c" providerId="LiveId" clId="{F9D40476-436E-48E8-A5D6-204A0E704A88}" dt="2020-06-25T06:34:27.509" v="2678" actId="478"/>
          <ac:picMkLst>
            <pc:docMk/>
            <pc:sldMk cId="3600490621" sldId="269"/>
            <ac:picMk id="138" creationId="{F2BB0311-D82C-497F-B286-34A964755D02}"/>
          </ac:picMkLst>
        </pc:picChg>
        <pc:picChg chg="del mod">
          <ac:chgData name="吉武 和敏" userId="e4825ba96748af9c" providerId="LiveId" clId="{F9D40476-436E-48E8-A5D6-204A0E704A88}" dt="2020-06-25T06:34:27.509" v="2678" actId="478"/>
          <ac:picMkLst>
            <pc:docMk/>
            <pc:sldMk cId="3600490621" sldId="269"/>
            <ac:picMk id="145" creationId="{9AB14D59-5A83-4BA7-846E-516F12FEF10E}"/>
          </ac:picMkLst>
        </pc:picChg>
        <pc:picChg chg="mod">
          <ac:chgData name="吉武 和敏" userId="e4825ba96748af9c" providerId="LiveId" clId="{F9D40476-436E-48E8-A5D6-204A0E704A88}" dt="2020-06-25T06:35:20.297" v="2684" actId="1076"/>
          <ac:picMkLst>
            <pc:docMk/>
            <pc:sldMk cId="3600490621" sldId="269"/>
            <ac:picMk id="146" creationId="{A03A1D51-4DBB-48DF-A200-1CBA5B9E086A}"/>
          </ac:picMkLst>
        </pc:picChg>
        <pc:picChg chg="add mod">
          <ac:chgData name="吉武 和敏" userId="e4825ba96748af9c" providerId="LiveId" clId="{F9D40476-436E-48E8-A5D6-204A0E704A88}" dt="2020-06-25T06:35:28.897" v="2685" actId="571"/>
          <ac:picMkLst>
            <pc:docMk/>
            <pc:sldMk cId="3600490621" sldId="269"/>
            <ac:picMk id="149" creationId="{CA3E02D7-91B2-4506-BEB2-CCFB6C5EED15}"/>
          </ac:picMkLst>
        </pc:picChg>
        <pc:picChg chg="add mod">
          <ac:chgData name="吉武 和敏" userId="e4825ba96748af9c" providerId="LiveId" clId="{F9D40476-436E-48E8-A5D6-204A0E704A88}" dt="2020-06-25T06:35:44.358" v="2690" actId="571"/>
          <ac:picMkLst>
            <pc:docMk/>
            <pc:sldMk cId="3600490621" sldId="269"/>
            <ac:picMk id="152" creationId="{D878E678-E795-4655-9934-93FC8B6BD985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54" creationId="{80612015-0EDB-4630-849B-FCE7108DA1CF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55" creationId="{4DF3E39C-96A6-4A6E-8AC5-427EAE77620D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56" creationId="{90D4B646-116D-496C-B0A9-8208C67675B1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57" creationId="{17AC205F-3B91-439E-AF65-1CC8AD93D356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58" creationId="{382F1CB0-511D-463A-8C13-FB67CD325EE3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59" creationId="{696DF33C-43E4-4EE7-B58E-D7CD47CF2442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60" creationId="{9EB5F098-5C62-4888-9F68-56DB5DFA7B9A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61" creationId="{DE21054B-2B66-4A1F-9B21-904C46FE3A1F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62" creationId="{6A30F2B8-71D2-448C-8836-875325E5718A}"/>
          </ac:picMkLst>
        </pc:picChg>
        <pc:picChg chg="add mod">
          <ac:chgData name="吉武 和敏" userId="e4825ba96748af9c" providerId="LiveId" clId="{F9D40476-436E-48E8-A5D6-204A0E704A88}" dt="2020-06-25T06:41:28.197" v="2748" actId="164"/>
          <ac:picMkLst>
            <pc:docMk/>
            <pc:sldMk cId="3600490621" sldId="269"/>
            <ac:picMk id="163" creationId="{049472A7-5116-4E9B-8AE2-5C2A3BBFCED6}"/>
          </ac:picMkLst>
        </pc:picChg>
        <pc:picChg chg="mod">
          <ac:chgData name="吉武 和敏" userId="e4825ba96748af9c" providerId="LiveId" clId="{F9D40476-436E-48E8-A5D6-204A0E704A88}" dt="2020-06-25T05:27:36.809" v="2493" actId="1076"/>
          <ac:picMkLst>
            <pc:docMk/>
            <pc:sldMk cId="3600490621" sldId="269"/>
            <ac:picMk id="1030" creationId="{D8BAC99E-2EBC-41B7-91BC-761CEC1C3296}"/>
          </ac:picMkLst>
        </pc:picChg>
        <pc:cxnChg chg="mod">
          <ac:chgData name="吉武 和敏" userId="e4825ba96748af9c" providerId="LiveId" clId="{F9D40476-436E-48E8-A5D6-204A0E704A88}" dt="2020-06-25T06:40:41.737" v="2745" actId="14100"/>
          <ac:cxnSpMkLst>
            <pc:docMk/>
            <pc:sldMk cId="3600490621" sldId="269"/>
            <ac:cxnSpMk id="11" creationId="{D32D435B-49B8-4C66-8A64-A7612425FE7E}"/>
          </ac:cxnSpMkLst>
        </pc:cxnChg>
        <pc:cxnChg chg="del mod">
          <ac:chgData name="吉武 和敏" userId="e4825ba96748af9c" providerId="LiveId" clId="{F9D40476-436E-48E8-A5D6-204A0E704A88}" dt="2020-06-25T06:29:56.263" v="2497" actId="478"/>
          <ac:cxnSpMkLst>
            <pc:docMk/>
            <pc:sldMk cId="3600490621" sldId="269"/>
            <ac:cxnSpMk id="77" creationId="{AE9A2B53-114B-4488-A092-599EC3CEBACC}"/>
          </ac:cxnSpMkLst>
        </pc:cxnChg>
        <pc:cxnChg chg="mod">
          <ac:chgData name="吉武 和敏" userId="e4825ba96748af9c" providerId="LiveId" clId="{F9D40476-436E-48E8-A5D6-204A0E704A88}" dt="2020-06-25T06:35:02.140" v="2680" actId="1076"/>
          <ac:cxnSpMkLst>
            <pc:docMk/>
            <pc:sldMk cId="3600490621" sldId="269"/>
            <ac:cxnSpMk id="80" creationId="{F1F3E733-06DD-4EFB-AE3A-E67EAB82EF58}"/>
          </ac:cxnSpMkLst>
        </pc:cxnChg>
        <pc:cxnChg chg="del mod">
          <ac:chgData name="吉武 和敏" userId="e4825ba96748af9c" providerId="LiveId" clId="{F9D40476-436E-48E8-A5D6-204A0E704A88}" dt="2020-06-25T07:58:57.019" v="2968" actId="478"/>
          <ac:cxnSpMkLst>
            <pc:docMk/>
            <pc:sldMk cId="3600490621" sldId="269"/>
            <ac:cxnSpMk id="98" creationId="{2166C27B-6370-4121-B9D7-4A5E4F604F8B}"/>
          </ac:cxnSpMkLst>
        </pc:cxnChg>
        <pc:cxnChg chg="add mod">
          <ac:chgData name="吉武 和敏" userId="e4825ba96748af9c" providerId="LiveId" clId="{F9D40476-436E-48E8-A5D6-204A0E704A88}" dt="2020-06-25T08:01:55.147" v="2994" actId="1076"/>
          <ac:cxnSpMkLst>
            <pc:docMk/>
            <pc:sldMk cId="3600490621" sldId="269"/>
            <ac:cxnSpMk id="129" creationId="{803EE3C9-9CC8-4BB6-AD49-BFF40C055D0C}"/>
          </ac:cxnSpMkLst>
        </pc:cxnChg>
        <pc:cxnChg chg="mod">
          <ac:chgData name="吉武 和敏" userId="e4825ba96748af9c" providerId="LiveId" clId="{F9D40476-436E-48E8-A5D6-204A0E704A88}" dt="2020-06-25T05:27:36.809" v="2493" actId="1076"/>
          <ac:cxnSpMkLst>
            <pc:docMk/>
            <pc:sldMk cId="3600490621" sldId="269"/>
            <ac:cxnSpMk id="130" creationId="{ACEF69F4-BF92-4882-B5B6-D24F2D4C9CAA}"/>
          </ac:cxnSpMkLst>
        </pc:cxnChg>
        <pc:cxnChg chg="del mod">
          <ac:chgData name="吉武 和敏" userId="e4825ba96748af9c" providerId="LiveId" clId="{F9D40476-436E-48E8-A5D6-204A0E704A88}" dt="2020-06-25T06:34:30.727" v="2679" actId="478"/>
          <ac:cxnSpMkLst>
            <pc:docMk/>
            <pc:sldMk cId="3600490621" sldId="269"/>
            <ac:cxnSpMk id="131" creationId="{DC306518-E14D-497B-91F1-5A26533F45C4}"/>
          </ac:cxnSpMkLst>
        </pc:cxnChg>
        <pc:cxnChg chg="mod">
          <ac:chgData name="吉武 和敏" userId="e4825ba96748af9c" providerId="LiveId" clId="{F9D40476-436E-48E8-A5D6-204A0E704A88}" dt="2020-06-25T05:27:36.809" v="2493" actId="1076"/>
          <ac:cxnSpMkLst>
            <pc:docMk/>
            <pc:sldMk cId="3600490621" sldId="269"/>
            <ac:cxnSpMk id="132" creationId="{52547D9F-9327-4E63-BAA0-2EAC3FD406F5}"/>
          </ac:cxnSpMkLst>
        </pc:cxnChg>
        <pc:cxnChg chg="mod">
          <ac:chgData name="吉武 和敏" userId="e4825ba96748af9c" providerId="LiveId" clId="{F9D40476-436E-48E8-A5D6-204A0E704A88}" dt="2020-06-25T08:00:35.806" v="2987" actId="1076"/>
          <ac:cxnSpMkLst>
            <pc:docMk/>
            <pc:sldMk cId="3600490621" sldId="269"/>
            <ac:cxnSpMk id="133" creationId="{8422D867-76CB-4DEC-AD32-F6895A6CDB2A}"/>
          </ac:cxnSpMkLst>
        </pc:cxnChg>
        <pc:cxnChg chg="mod">
          <ac:chgData name="吉武 和敏" userId="e4825ba96748af9c" providerId="LiveId" clId="{F9D40476-436E-48E8-A5D6-204A0E704A88}" dt="2020-06-25T05:27:36.809" v="2493" actId="1076"/>
          <ac:cxnSpMkLst>
            <pc:docMk/>
            <pc:sldMk cId="3600490621" sldId="269"/>
            <ac:cxnSpMk id="140" creationId="{1E956F70-20A1-4454-909C-ECBCC610E34F}"/>
          </ac:cxnSpMkLst>
        </pc:cxnChg>
        <pc:cxnChg chg="add mod">
          <ac:chgData name="吉武 和敏" userId="e4825ba96748af9c" providerId="LiveId" clId="{F9D40476-436E-48E8-A5D6-204A0E704A88}" dt="2020-06-25T06:35:37.808" v="2688" actId="571"/>
          <ac:cxnSpMkLst>
            <pc:docMk/>
            <pc:sldMk cId="3600490621" sldId="269"/>
            <ac:cxnSpMk id="151" creationId="{E4B86359-5519-495B-A5B0-68D39EFCD38F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69" creationId="{57FAEDD2-46AE-4613-9954-7E5DDC970E5C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0" creationId="{53411596-5EDA-4D4A-9BB3-2BC33953D7BE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1" creationId="{8A9A9819-59F5-4B9B-855E-F472992AEAE6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2" creationId="{4BCB1B5F-D085-4DB8-B844-6D503113301C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3" creationId="{9CA2399D-C6A1-4A5C-9F58-60DB0137BDE6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4" creationId="{C63123C2-3D50-465F-92C3-0A024BC18590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5" creationId="{E058AB82-9230-4ABF-805C-B2F623D692DE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79" creationId="{9465C90F-1233-4972-9058-C9077F60FCE5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80" creationId="{F276922E-6A04-4CF3-BAC4-F9242886A6F5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81" creationId="{242A9970-F759-4C8A-A0AC-E04C1840B9A1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82" creationId="{CD942939-053E-4265-9CF5-902C74858719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83" creationId="{CD4AA2B0-6A35-4BC8-A5DD-0BC5B70E6EB9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84" creationId="{543EDCE2-4FDC-4EA1-A583-51B8A1771F77}"/>
          </ac:cxnSpMkLst>
        </pc:cxnChg>
        <pc:cxnChg chg="add del mod">
          <ac:chgData name="吉武 和敏" userId="e4825ba96748af9c" providerId="LiveId" clId="{F9D40476-436E-48E8-A5D6-204A0E704A88}" dt="2020-06-25T08:01:56.955" v="2995"/>
          <ac:cxnSpMkLst>
            <pc:docMk/>
            <pc:sldMk cId="3600490621" sldId="269"/>
            <ac:cxnSpMk id="185" creationId="{CA596253-BBBE-4957-9102-7ECC472EBE92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2" creationId="{E50B9A02-008C-4239-B100-0A91F3D35413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3" creationId="{00F089B9-ACC0-4B3E-8069-5F9B43675009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4" creationId="{4A2FA0D4-61EA-48EC-A20D-948CCE0C6D33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5" creationId="{C88D87A6-53CD-4155-B5FE-6534DCC5837E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6" creationId="{0D647087-311A-4D01-9774-E9B658AD4AD5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7" creationId="{31289CE6-6846-4E5B-8314-67224ACB764B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198" creationId="{FBDB4678-382D-4612-930E-CB6A0C60C474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2" creationId="{B3B8518A-3FD4-4CE9-B3B2-392188E56A45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3" creationId="{F112F996-13D4-4DDA-93DD-56A0EC34B59D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4" creationId="{27FA686B-34FD-480B-B206-80BF13A2D65C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5" creationId="{99B54EF7-273D-4312-90AC-732253DAA862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6" creationId="{B7FDFC38-E4C6-43BB-8ACD-ECA090F8052A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7" creationId="{1C7E8B20-D04D-49DC-A092-4BCF53BA1A4C}"/>
          </ac:cxnSpMkLst>
        </pc:cxnChg>
        <pc:cxnChg chg="add mod">
          <ac:chgData name="吉武 和敏" userId="e4825ba96748af9c" providerId="LiveId" clId="{F9D40476-436E-48E8-A5D6-204A0E704A88}" dt="2020-06-25T08:02:20.155" v="3002" actId="164"/>
          <ac:cxnSpMkLst>
            <pc:docMk/>
            <pc:sldMk cId="3600490621" sldId="269"/>
            <ac:cxnSpMk id="208" creationId="{8D93BF08-CBA1-4B08-9490-FAB99C5C1D8E}"/>
          </ac:cxnSpMkLst>
        </pc:cxnChg>
        <pc:cxnChg chg="add mod">
          <ac:chgData name="吉武 和敏" userId="e4825ba96748af9c" providerId="LiveId" clId="{F9D40476-436E-48E8-A5D6-204A0E704A88}" dt="2020-06-25T08:03:11.209" v="3030" actId="571"/>
          <ac:cxnSpMkLst>
            <pc:docMk/>
            <pc:sldMk cId="3600490621" sldId="269"/>
            <ac:cxnSpMk id="214" creationId="{05DF31C5-0D20-4F52-92B7-DF9B48413003}"/>
          </ac:cxnSpMkLst>
        </pc:cxnChg>
        <pc:cxnChg chg="mod ord">
          <ac:chgData name="吉武 和敏" userId="e4825ba96748af9c" providerId="LiveId" clId="{F9D40476-436E-48E8-A5D6-204A0E704A88}" dt="2020-06-25T06:37:24.396" v="2710" actId="166"/>
          <ac:cxnSpMkLst>
            <pc:docMk/>
            <pc:sldMk cId="3600490621" sldId="269"/>
            <ac:cxnSpMk id="1033" creationId="{EDB24211-0E1B-4713-949E-5C138728DBC4}"/>
          </ac:cxnSpMkLst>
        </pc:cxnChg>
        <pc:cxnChg chg="mod">
          <ac:chgData name="吉武 和敏" userId="e4825ba96748af9c" providerId="LiveId" clId="{F9D40476-436E-48E8-A5D6-204A0E704A88}" dt="2020-06-25T05:27:36.809" v="2493" actId="1076"/>
          <ac:cxnSpMkLst>
            <pc:docMk/>
            <pc:sldMk cId="3600490621" sldId="269"/>
            <ac:cxnSpMk id="1040" creationId="{4D092222-F98B-4A4D-A282-31B8FAB29090}"/>
          </ac:cxnSpMkLst>
        </pc:cxnChg>
        <pc:cxnChg chg="mod">
          <ac:chgData name="吉武 和敏" userId="e4825ba96748af9c" providerId="LiveId" clId="{F9D40476-436E-48E8-A5D6-204A0E704A88}" dt="2020-06-25T05:27:36.809" v="2493" actId="1076"/>
          <ac:cxnSpMkLst>
            <pc:docMk/>
            <pc:sldMk cId="3600490621" sldId="269"/>
            <ac:cxnSpMk id="1045" creationId="{C9A30389-8AB0-4D87-B44E-3838CE1C4797}"/>
          </ac:cxnSpMkLst>
        </pc:cxnChg>
        <pc:cxnChg chg="mod">
          <ac:chgData name="吉武 和敏" userId="e4825ba96748af9c" providerId="LiveId" clId="{F9D40476-436E-48E8-A5D6-204A0E704A88}" dt="2020-06-25T05:27:36.809" v="2493" actId="1076"/>
          <ac:cxnSpMkLst>
            <pc:docMk/>
            <pc:sldMk cId="3600490621" sldId="269"/>
            <ac:cxnSpMk id="1055" creationId="{BA90F666-9436-4D3C-A898-C77274B2A9EF}"/>
          </ac:cxnSpMkLst>
        </pc:cxnChg>
      </pc:sldChg>
      <pc:sldChg chg="del">
        <pc:chgData name="吉武 和敏" userId="e4825ba96748af9c" providerId="LiveId" clId="{F9D40476-436E-48E8-A5D6-204A0E704A88}" dt="2020-06-18T16:52:25.751" v="0" actId="47"/>
        <pc:sldMkLst>
          <pc:docMk/>
          <pc:sldMk cId="3159242479" sldId="271"/>
        </pc:sldMkLst>
      </pc:sldChg>
      <pc:sldChg chg="del">
        <pc:chgData name="吉武 和敏" userId="e4825ba96748af9c" providerId="LiveId" clId="{F9D40476-436E-48E8-A5D6-204A0E704A88}" dt="2020-06-19T05:57:44.453" v="998" actId="47"/>
        <pc:sldMkLst>
          <pc:docMk/>
          <pc:sldMk cId="2987232527" sldId="272"/>
        </pc:sldMkLst>
      </pc:sldChg>
      <pc:sldChg chg="delSp del mod">
        <pc:chgData name="吉武 和敏" userId="e4825ba96748af9c" providerId="LiveId" clId="{F9D40476-436E-48E8-A5D6-204A0E704A88}" dt="2020-06-19T06:45:12.038" v="1039" actId="47"/>
        <pc:sldMkLst>
          <pc:docMk/>
          <pc:sldMk cId="3371264791" sldId="273"/>
        </pc:sldMkLst>
        <pc:spChg chg="del">
          <ac:chgData name="吉武 和敏" userId="e4825ba96748af9c" providerId="LiveId" clId="{F9D40476-436E-48E8-A5D6-204A0E704A88}" dt="2020-06-19T06:45:02.591" v="1035" actId="21"/>
          <ac:spMkLst>
            <pc:docMk/>
            <pc:sldMk cId="3371264791" sldId="273"/>
            <ac:spMk id="4" creationId="{B00D0AF0-42F6-4300-95E8-3E1A57B62954}"/>
          </ac:spMkLst>
        </pc:spChg>
        <pc:spChg chg="del">
          <ac:chgData name="吉武 和敏" userId="e4825ba96748af9c" providerId="LiveId" clId="{F9D40476-436E-48E8-A5D6-204A0E704A88}" dt="2020-06-19T06:45:02.591" v="1035" actId="21"/>
          <ac:spMkLst>
            <pc:docMk/>
            <pc:sldMk cId="3371264791" sldId="273"/>
            <ac:spMk id="5" creationId="{6666208D-BAA0-4895-BF4C-BCE73C519F22}"/>
          </ac:spMkLst>
        </pc:spChg>
        <pc:spChg chg="del">
          <ac:chgData name="吉武 和敏" userId="e4825ba96748af9c" providerId="LiveId" clId="{F9D40476-436E-48E8-A5D6-204A0E704A88}" dt="2020-06-19T06:45:02.591" v="1035" actId="21"/>
          <ac:spMkLst>
            <pc:docMk/>
            <pc:sldMk cId="3371264791" sldId="273"/>
            <ac:spMk id="7" creationId="{2574C463-CDEF-451C-8651-0840FFF397CA}"/>
          </ac:spMkLst>
        </pc:spChg>
        <pc:graphicFrameChg chg="del">
          <ac:chgData name="吉武 和敏" userId="e4825ba96748af9c" providerId="LiveId" clId="{F9D40476-436E-48E8-A5D6-204A0E704A88}" dt="2020-06-19T06:45:02.591" v="1035" actId="21"/>
          <ac:graphicFrameMkLst>
            <pc:docMk/>
            <pc:sldMk cId="3371264791" sldId="273"/>
            <ac:graphicFrameMk id="2" creationId="{6EE86D08-E3E5-47A2-A08B-FCF97BCFC701}"/>
          </ac:graphicFrameMkLst>
        </pc:graphicFrameChg>
        <pc:graphicFrameChg chg="del">
          <ac:chgData name="吉武 和敏" userId="e4825ba96748af9c" providerId="LiveId" clId="{F9D40476-436E-48E8-A5D6-204A0E704A88}" dt="2020-06-19T06:45:02.591" v="1035" actId="21"/>
          <ac:graphicFrameMkLst>
            <pc:docMk/>
            <pc:sldMk cId="3371264791" sldId="273"/>
            <ac:graphicFrameMk id="3" creationId="{BB348E8E-C754-4719-AD5D-DBF13B5F20E2}"/>
          </ac:graphicFrameMkLst>
        </pc:graphicFrameChg>
        <pc:graphicFrameChg chg="del">
          <ac:chgData name="吉武 和敏" userId="e4825ba96748af9c" providerId="LiveId" clId="{F9D40476-436E-48E8-A5D6-204A0E704A88}" dt="2020-06-19T06:45:02.591" v="1035" actId="21"/>
          <ac:graphicFrameMkLst>
            <pc:docMk/>
            <pc:sldMk cId="3371264791" sldId="273"/>
            <ac:graphicFrameMk id="6" creationId="{EAC9ED4A-D428-4E4D-BF7C-250664AB7206}"/>
          </ac:graphicFrameMkLst>
        </pc:graphicFrameChg>
      </pc:sldChg>
      <pc:sldChg chg="del">
        <pc:chgData name="吉武 和敏" userId="e4825ba96748af9c" providerId="LiveId" clId="{F9D40476-436E-48E8-A5D6-204A0E704A88}" dt="2020-06-22T08:34:10.910" v="2162" actId="47"/>
        <pc:sldMkLst>
          <pc:docMk/>
          <pc:sldMk cId="1287841559" sldId="274"/>
        </pc:sldMkLst>
      </pc:sldChg>
      <pc:sldChg chg="del">
        <pc:chgData name="吉武 和敏" userId="e4825ba96748af9c" providerId="LiveId" clId="{F9D40476-436E-48E8-A5D6-204A0E704A88}" dt="2020-06-22T08:34:10.910" v="2162" actId="47"/>
        <pc:sldMkLst>
          <pc:docMk/>
          <pc:sldMk cId="1920743463" sldId="275"/>
        </pc:sldMkLst>
      </pc:sldChg>
      <pc:sldChg chg="del">
        <pc:chgData name="吉武 和敏" userId="e4825ba96748af9c" providerId="LiveId" clId="{F9D40476-436E-48E8-A5D6-204A0E704A88}" dt="2020-06-22T08:34:10.910" v="2162" actId="47"/>
        <pc:sldMkLst>
          <pc:docMk/>
          <pc:sldMk cId="491749897" sldId="276"/>
        </pc:sldMkLst>
      </pc:sldChg>
      <pc:sldChg chg="addSp delSp modSp new mod">
        <pc:chgData name="吉武 和敏" userId="e4825ba96748af9c" providerId="LiveId" clId="{F9D40476-436E-48E8-A5D6-204A0E704A88}" dt="2020-06-19T05:56:57.950" v="997" actId="20577"/>
        <pc:sldMkLst>
          <pc:docMk/>
          <pc:sldMk cId="664468651" sldId="277"/>
        </pc:sldMkLst>
        <pc:spChg chg="add mod">
          <ac:chgData name="吉武 和敏" userId="e4825ba96748af9c" providerId="LiveId" clId="{F9D40476-436E-48E8-A5D6-204A0E704A88}" dt="2020-06-19T05:54:31.554" v="918" actId="20577"/>
          <ac:spMkLst>
            <pc:docMk/>
            <pc:sldMk cId="664468651" sldId="277"/>
            <ac:spMk id="7" creationId="{F72334D3-2C6D-4958-B3FA-0EE2C20DE506}"/>
          </ac:spMkLst>
        </pc:spChg>
        <pc:graphicFrameChg chg="add del mod">
          <ac:chgData name="吉武 和敏" userId="e4825ba96748af9c" providerId="LiveId" clId="{F9D40476-436E-48E8-A5D6-204A0E704A88}" dt="2020-06-19T05:50:26.754" v="828" actId="478"/>
          <ac:graphicFrameMkLst>
            <pc:docMk/>
            <pc:sldMk cId="664468651" sldId="277"/>
            <ac:graphicFrameMk id="2" creationId="{B9809098-DEA2-453C-96D2-D10088BCEB05}"/>
          </ac:graphicFrameMkLst>
        </pc:graphicFrameChg>
        <pc:graphicFrameChg chg="add del mod modGraphic">
          <ac:chgData name="吉武 和敏" userId="e4825ba96748af9c" providerId="LiveId" clId="{F9D40476-436E-48E8-A5D6-204A0E704A88}" dt="2020-06-18T17:12:01.342" v="20" actId="478"/>
          <ac:graphicFrameMkLst>
            <pc:docMk/>
            <pc:sldMk cId="664468651" sldId="277"/>
            <ac:graphicFrameMk id="2" creationId="{D89FC39E-AF9A-4415-BDF6-34ED3B5FFDD5}"/>
          </ac:graphicFrameMkLst>
        </pc:graphicFrameChg>
        <pc:graphicFrameChg chg="add mod modGraphic">
          <ac:chgData name="吉武 和敏" userId="e4825ba96748af9c" providerId="LiveId" clId="{F9D40476-436E-48E8-A5D6-204A0E704A88}" dt="2020-06-19T05:56:43.150" v="972" actId="20577"/>
          <ac:graphicFrameMkLst>
            <pc:docMk/>
            <pc:sldMk cId="664468651" sldId="277"/>
            <ac:graphicFrameMk id="3" creationId="{1A0145B6-3B56-4B20-9992-5A6A84270D2F}"/>
          </ac:graphicFrameMkLst>
        </pc:graphicFrameChg>
        <pc:graphicFrameChg chg="add del mod modGraphic">
          <ac:chgData name="吉武 和敏" userId="e4825ba96748af9c" providerId="LiveId" clId="{F9D40476-436E-48E8-A5D6-204A0E704A88}" dt="2020-06-18T17:12:01.342" v="20" actId="478"/>
          <ac:graphicFrameMkLst>
            <pc:docMk/>
            <pc:sldMk cId="664468651" sldId="277"/>
            <ac:graphicFrameMk id="3" creationId="{B1EFE857-E506-475D-9A19-6DF6004CE8F7}"/>
          </ac:graphicFrameMkLst>
        </pc:graphicFrameChg>
        <pc:graphicFrameChg chg="add del mod modGraphic">
          <ac:chgData name="吉武 和敏" userId="e4825ba96748af9c" providerId="LiveId" clId="{F9D40476-436E-48E8-A5D6-204A0E704A88}" dt="2020-06-19T05:51:13.251" v="832" actId="478"/>
          <ac:graphicFrameMkLst>
            <pc:docMk/>
            <pc:sldMk cId="664468651" sldId="277"/>
            <ac:graphicFrameMk id="4" creationId="{AF6459B5-BD7C-414C-8B65-67B161683E27}"/>
          </ac:graphicFrameMkLst>
        </pc:graphicFrameChg>
        <pc:graphicFrameChg chg="add del mod modGraphic">
          <ac:chgData name="吉武 和敏" userId="e4825ba96748af9c" providerId="LiveId" clId="{F9D40476-436E-48E8-A5D6-204A0E704A88}" dt="2020-06-19T05:51:13.251" v="832" actId="478"/>
          <ac:graphicFrameMkLst>
            <pc:docMk/>
            <pc:sldMk cId="664468651" sldId="277"/>
            <ac:graphicFrameMk id="5" creationId="{F8B5E1FC-BF27-4089-AED8-FBFD1BFDE87D}"/>
          </ac:graphicFrameMkLst>
        </pc:graphicFrameChg>
        <pc:graphicFrameChg chg="add mod modGraphic">
          <ac:chgData name="吉武 和敏" userId="e4825ba96748af9c" providerId="LiveId" clId="{F9D40476-436E-48E8-A5D6-204A0E704A88}" dt="2020-06-19T05:56:57.950" v="997" actId="20577"/>
          <ac:graphicFrameMkLst>
            <pc:docMk/>
            <pc:sldMk cId="664468651" sldId="277"/>
            <ac:graphicFrameMk id="6" creationId="{EB9129B0-C9CB-472F-AFA8-F14E689CB913}"/>
          </ac:graphicFrameMkLst>
        </pc:graphicFrameChg>
      </pc:sldChg>
      <pc:sldChg chg="addSp delSp modSp add mod">
        <pc:chgData name="吉武 和敏" userId="e4825ba96748af9c" providerId="LiveId" clId="{F9D40476-436E-48E8-A5D6-204A0E704A88}" dt="2020-06-19T09:08:40.092" v="2159" actId="20577"/>
        <pc:sldMkLst>
          <pc:docMk/>
          <pc:sldMk cId="370389737" sldId="278"/>
        </pc:sldMkLst>
        <pc:spChg chg="add mod">
          <ac:chgData name="吉武 和敏" userId="e4825ba96748af9c" providerId="LiveId" clId="{F9D40476-436E-48E8-A5D6-204A0E704A88}" dt="2020-06-19T05:44:13.378" v="495" actId="164"/>
          <ac:spMkLst>
            <pc:docMk/>
            <pc:sldMk cId="370389737" sldId="278"/>
            <ac:spMk id="6" creationId="{2B1D1877-3479-40F2-8519-331983E9E6A9}"/>
          </ac:spMkLst>
        </pc:spChg>
        <pc:spChg chg="add mod">
          <ac:chgData name="吉武 和敏" userId="e4825ba96748af9c" providerId="LiveId" clId="{F9D40476-436E-48E8-A5D6-204A0E704A88}" dt="2020-06-19T05:44:16.433" v="496" actId="164"/>
          <ac:spMkLst>
            <pc:docMk/>
            <pc:sldMk cId="370389737" sldId="278"/>
            <ac:spMk id="7" creationId="{474D52EB-0B0A-402B-A206-9B89E2776BE0}"/>
          </ac:spMkLst>
        </pc:spChg>
        <pc:spChg chg="add mod">
          <ac:chgData name="吉武 和敏" userId="e4825ba96748af9c" providerId="LiveId" clId="{F9D40476-436E-48E8-A5D6-204A0E704A88}" dt="2020-06-19T05:44:13.378" v="495" actId="164"/>
          <ac:spMkLst>
            <pc:docMk/>
            <pc:sldMk cId="370389737" sldId="278"/>
            <ac:spMk id="8" creationId="{B94A3975-539F-431C-B416-033D1CB6DBD9}"/>
          </ac:spMkLst>
        </pc:spChg>
        <pc:spChg chg="add mod">
          <ac:chgData name="吉武 和敏" userId="e4825ba96748af9c" providerId="LiveId" clId="{F9D40476-436E-48E8-A5D6-204A0E704A88}" dt="2020-06-19T05:44:16.433" v="496" actId="164"/>
          <ac:spMkLst>
            <pc:docMk/>
            <pc:sldMk cId="370389737" sldId="278"/>
            <ac:spMk id="9" creationId="{CF4F23F9-F589-4410-A73A-264236DA14A2}"/>
          </ac:spMkLst>
        </pc:spChg>
        <pc:spChg chg="add mod">
          <ac:chgData name="吉武 和敏" userId="e4825ba96748af9c" providerId="LiveId" clId="{F9D40476-436E-48E8-A5D6-204A0E704A88}" dt="2020-06-19T09:08:40.092" v="2159" actId="20577"/>
          <ac:spMkLst>
            <pc:docMk/>
            <pc:sldMk cId="370389737" sldId="278"/>
            <ac:spMk id="10" creationId="{03EB489A-2754-4EF8-B046-85DE05011559}"/>
          </ac:spMkLst>
        </pc:spChg>
        <pc:spChg chg="add mod">
          <ac:chgData name="吉武 和敏" userId="e4825ba96748af9c" providerId="LiveId" clId="{F9D40476-436E-48E8-A5D6-204A0E704A88}" dt="2020-06-19T06:26:47.572" v="1030" actId="1076"/>
          <ac:spMkLst>
            <pc:docMk/>
            <pc:sldMk cId="370389737" sldId="278"/>
            <ac:spMk id="13" creationId="{FCFE6DDB-741E-432E-8287-876BDCF0213D}"/>
          </ac:spMkLst>
        </pc:spChg>
        <pc:spChg chg="mod">
          <ac:chgData name="吉武 和敏" userId="e4825ba96748af9c" providerId="LiveId" clId="{F9D40476-436E-48E8-A5D6-204A0E704A88}" dt="2020-06-19T06:26:49.917" v="1032" actId="571"/>
          <ac:spMkLst>
            <pc:docMk/>
            <pc:sldMk cId="370389737" sldId="278"/>
            <ac:spMk id="16" creationId="{9A53E6FC-5C74-42AD-8876-F20874CE06F4}"/>
          </ac:spMkLst>
        </pc:spChg>
        <pc:spChg chg="mod">
          <ac:chgData name="吉武 和敏" userId="e4825ba96748af9c" providerId="LiveId" clId="{F9D40476-436E-48E8-A5D6-204A0E704A88}" dt="2020-06-19T06:26:49.917" v="1032" actId="571"/>
          <ac:spMkLst>
            <pc:docMk/>
            <pc:sldMk cId="370389737" sldId="278"/>
            <ac:spMk id="17" creationId="{DC24ACD7-39D3-4D44-B535-E1F5DA342BD7}"/>
          </ac:spMkLst>
        </pc:spChg>
        <pc:spChg chg="add mod">
          <ac:chgData name="吉武 和敏" userId="e4825ba96748af9c" providerId="LiveId" clId="{F9D40476-436E-48E8-A5D6-204A0E704A88}" dt="2020-06-19T06:26:54.613" v="1034" actId="20577"/>
          <ac:spMkLst>
            <pc:docMk/>
            <pc:sldMk cId="370389737" sldId="278"/>
            <ac:spMk id="18" creationId="{84DC98AF-C168-44AA-B451-BF9F5B5406D8}"/>
          </ac:spMkLst>
        </pc:spChg>
        <pc:grpChg chg="add mod">
          <ac:chgData name="吉武 和敏" userId="e4825ba96748af9c" providerId="LiveId" clId="{F9D40476-436E-48E8-A5D6-204A0E704A88}" dt="2020-06-19T05:44:26.189" v="498" actId="1076"/>
          <ac:grpSpMkLst>
            <pc:docMk/>
            <pc:sldMk cId="370389737" sldId="278"/>
            <ac:grpSpMk id="11" creationId="{583066E0-1316-4A80-99A2-A3851EFCC5C5}"/>
          </ac:grpSpMkLst>
        </pc:grpChg>
        <pc:grpChg chg="add mod">
          <ac:chgData name="吉武 和敏" userId="e4825ba96748af9c" providerId="LiveId" clId="{F9D40476-436E-48E8-A5D6-204A0E704A88}" dt="2020-06-19T05:44:31.684" v="499" actId="1076"/>
          <ac:grpSpMkLst>
            <pc:docMk/>
            <pc:sldMk cId="370389737" sldId="278"/>
            <ac:grpSpMk id="12" creationId="{59923182-BDD9-47A5-9412-778C146C7A2D}"/>
          </ac:grpSpMkLst>
        </pc:grpChg>
        <pc:grpChg chg="add mod">
          <ac:chgData name="吉武 和敏" userId="e4825ba96748af9c" providerId="LiveId" clId="{F9D40476-436E-48E8-A5D6-204A0E704A88}" dt="2020-06-19T06:26:49.917" v="1032" actId="571"/>
          <ac:grpSpMkLst>
            <pc:docMk/>
            <pc:sldMk cId="370389737" sldId="278"/>
            <ac:grpSpMk id="14" creationId="{33AD2AB7-21E1-463E-BEA5-69BBDF685699}"/>
          </ac:grpSpMkLst>
        </pc:grpChg>
        <pc:picChg chg="add del mod">
          <ac:chgData name="吉武 和敏" userId="e4825ba96748af9c" providerId="LiveId" clId="{F9D40476-436E-48E8-A5D6-204A0E704A88}" dt="2020-06-19T05:44:16.433" v="496" actId="164"/>
          <ac:picMkLst>
            <pc:docMk/>
            <pc:sldMk cId="370389737" sldId="278"/>
            <ac:picMk id="3" creationId="{3BA2E872-0799-432D-B17F-F9E7177C215F}"/>
          </ac:picMkLst>
        </pc:picChg>
        <pc:picChg chg="add del mod">
          <ac:chgData name="吉武 和敏" userId="e4825ba96748af9c" providerId="LiveId" clId="{F9D40476-436E-48E8-A5D6-204A0E704A88}" dt="2020-06-19T05:44:13.378" v="495" actId="164"/>
          <ac:picMkLst>
            <pc:docMk/>
            <pc:sldMk cId="370389737" sldId="278"/>
            <ac:picMk id="5" creationId="{07F36C09-D5FE-43E9-B673-F8D4A94A0899}"/>
          </ac:picMkLst>
        </pc:picChg>
        <pc:picChg chg="mod">
          <ac:chgData name="吉武 和敏" userId="e4825ba96748af9c" providerId="LiveId" clId="{F9D40476-436E-48E8-A5D6-204A0E704A88}" dt="2020-06-19T06:26:49.917" v="1032" actId="571"/>
          <ac:picMkLst>
            <pc:docMk/>
            <pc:sldMk cId="370389737" sldId="278"/>
            <ac:picMk id="15" creationId="{5FCC0FB3-7471-421C-B36B-546F36820A94}"/>
          </ac:picMkLst>
        </pc:picChg>
      </pc:sldChg>
    </pc:docChg>
  </pc:docChgLst>
  <pc:docChgLst>
    <pc:chgData name="吉武 和敏" userId="e4825ba96748af9c" providerId="LiveId" clId="{522C4D81-2F64-48E1-952E-BE8506DF25DD}"/>
    <pc:docChg chg="modSld">
      <pc:chgData name="吉武 和敏" userId="e4825ba96748af9c" providerId="LiveId" clId="{522C4D81-2F64-48E1-952E-BE8506DF25DD}" dt="2022-07-29T05:35:28.937" v="29"/>
      <pc:docMkLst>
        <pc:docMk/>
      </pc:docMkLst>
      <pc:sldChg chg="addSp delSp modSp mod">
        <pc:chgData name="吉武 和敏" userId="e4825ba96748af9c" providerId="LiveId" clId="{522C4D81-2F64-48E1-952E-BE8506DF25DD}" dt="2022-07-29T05:35:28.937" v="29"/>
        <pc:sldMkLst>
          <pc:docMk/>
          <pc:sldMk cId="1542364386" sldId="260"/>
        </pc:sldMkLst>
        <pc:spChg chg="add del mod">
          <ac:chgData name="吉武 和敏" userId="e4825ba96748af9c" providerId="LiveId" clId="{522C4D81-2F64-48E1-952E-BE8506DF25DD}" dt="2022-07-29T05:31:00.343" v="6"/>
          <ac:spMkLst>
            <pc:docMk/>
            <pc:sldMk cId="1542364386" sldId="260"/>
            <ac:spMk id="9" creationId="{2EEA9475-81E4-6B5E-CCFC-4A4E683DD147}"/>
          </ac:spMkLst>
        </pc:spChg>
        <pc:spChg chg="add del mod">
          <ac:chgData name="吉武 和敏" userId="e4825ba96748af9c" providerId="LiveId" clId="{522C4D81-2F64-48E1-952E-BE8506DF25DD}" dt="2022-07-29T05:31:04.906" v="9"/>
          <ac:spMkLst>
            <pc:docMk/>
            <pc:sldMk cId="1542364386" sldId="260"/>
            <ac:spMk id="11" creationId="{B7721205-4428-82B7-6CB3-2E6C68BE5761}"/>
          </ac:spMkLst>
        </pc:spChg>
        <pc:spChg chg="add mod">
          <ac:chgData name="吉武 和敏" userId="e4825ba96748af9c" providerId="LiveId" clId="{522C4D81-2F64-48E1-952E-BE8506DF25DD}" dt="2022-07-29T05:35:28.937" v="29"/>
          <ac:spMkLst>
            <pc:docMk/>
            <pc:sldMk cId="1542364386" sldId="260"/>
            <ac:spMk id="21" creationId="{902FF8B9-7044-43E5-D9BD-33B729BA46A0}"/>
          </ac:spMkLst>
        </pc:spChg>
        <pc:spChg chg="add mod">
          <ac:chgData name="吉武 和敏" userId="e4825ba96748af9c" providerId="LiveId" clId="{522C4D81-2F64-48E1-952E-BE8506DF25DD}" dt="2022-07-29T05:33:44.355" v="28" actId="20577"/>
          <ac:spMkLst>
            <pc:docMk/>
            <pc:sldMk cId="1542364386" sldId="260"/>
            <ac:spMk id="22" creationId="{EF2E27DF-9EE9-2804-3871-6D6EEACA8C88}"/>
          </ac:spMkLst>
        </pc:spChg>
        <pc:spChg chg="add mod">
          <ac:chgData name="吉武 和敏" userId="e4825ba96748af9c" providerId="LiveId" clId="{522C4D81-2F64-48E1-952E-BE8506DF25DD}" dt="2022-07-29T05:33:01.936" v="25" actId="1076"/>
          <ac:spMkLst>
            <pc:docMk/>
            <pc:sldMk cId="1542364386" sldId="260"/>
            <ac:spMk id="25" creationId="{00D7ABE3-4059-B4BC-EBCA-2387421283DF}"/>
          </ac:spMkLst>
        </pc:spChg>
        <pc:cxnChg chg="add mod">
          <ac:chgData name="吉武 和敏" userId="e4825ba96748af9c" providerId="LiveId" clId="{522C4D81-2F64-48E1-952E-BE8506DF25DD}" dt="2022-07-29T05:29:59.099" v="1" actId="208"/>
          <ac:cxnSpMkLst>
            <pc:docMk/>
            <pc:sldMk cId="1542364386" sldId="260"/>
            <ac:cxnSpMk id="5" creationId="{8DB3D441-48C5-FE38-D1A7-DF5960F71C07}"/>
          </ac:cxnSpMkLst>
        </pc:cxnChg>
        <pc:cxnChg chg="add mod">
          <ac:chgData name="吉武 和敏" userId="e4825ba96748af9c" providerId="LiveId" clId="{522C4D81-2F64-48E1-952E-BE8506DF25DD}" dt="2022-07-29T05:32:09.880" v="18" actId="14100"/>
          <ac:cxnSpMkLst>
            <pc:docMk/>
            <pc:sldMk cId="1542364386" sldId="260"/>
            <ac:cxnSpMk id="23" creationId="{D6896F92-6BCC-5126-2988-7850C728775A}"/>
          </ac:cxnSpMkLst>
        </pc:cxnChg>
        <pc:cxnChg chg="add mod">
          <ac:chgData name="吉武 和敏" userId="e4825ba96748af9c" providerId="LiveId" clId="{522C4D81-2F64-48E1-952E-BE8506DF25DD}" dt="2022-07-29T05:32:19.060" v="20" actId="571"/>
          <ac:cxnSpMkLst>
            <pc:docMk/>
            <pc:sldMk cId="1542364386" sldId="260"/>
            <ac:cxnSpMk id="24" creationId="{7DD54C5C-E5B8-3431-A0F3-04C7A8C221E3}"/>
          </ac:cxnSpMkLst>
        </pc:cxnChg>
      </pc:sldChg>
    </pc:docChg>
  </pc:docChgLst>
  <pc:docChgLst>
    <pc:chgData name="吉武 和敏" userId="e4825ba96748af9c" providerId="LiveId" clId="{E74B9FEE-F61C-4A9F-84D5-57235532D7C9}"/>
    <pc:docChg chg="custSel modSld">
      <pc:chgData name="吉武 和敏" userId="e4825ba96748af9c" providerId="LiveId" clId="{E74B9FEE-F61C-4A9F-84D5-57235532D7C9}" dt="2020-08-06T03:47:18.427" v="148" actId="571"/>
      <pc:docMkLst>
        <pc:docMk/>
      </pc:docMkLst>
      <pc:sldChg chg="addSp modSp mod">
        <pc:chgData name="吉武 和敏" userId="e4825ba96748af9c" providerId="LiveId" clId="{E74B9FEE-F61C-4A9F-84D5-57235532D7C9}" dt="2020-08-06T03:47:18.427" v="148" actId="571"/>
        <pc:sldMkLst>
          <pc:docMk/>
          <pc:sldMk cId="370389737" sldId="278"/>
        </pc:sldMkLst>
        <pc:spChg chg="add mod">
          <ac:chgData name="吉武 和敏" userId="e4825ba96748af9c" providerId="LiveId" clId="{E74B9FEE-F61C-4A9F-84D5-57235532D7C9}" dt="2020-08-06T03:47:16.330" v="147" actId="1076"/>
          <ac:spMkLst>
            <pc:docMk/>
            <pc:sldMk cId="370389737" sldId="278"/>
            <ac:spMk id="2" creationId="{A3481CA7-64F8-4BA4-A202-4F3C47995B73}"/>
          </ac:spMkLst>
        </pc:spChg>
        <pc:spChg chg="mod">
          <ac:chgData name="吉武 和敏" userId="e4825ba96748af9c" providerId="LiveId" clId="{E74B9FEE-F61C-4A9F-84D5-57235532D7C9}" dt="2020-08-06T03:35:39.405" v="116" actId="20577"/>
          <ac:spMkLst>
            <pc:docMk/>
            <pc:sldMk cId="370389737" sldId="278"/>
            <ac:spMk id="10" creationId="{03EB489A-2754-4EF8-B046-85DE05011559}"/>
          </ac:spMkLst>
        </pc:spChg>
        <pc:spChg chg="add mod">
          <ac:chgData name="吉武 和敏" userId="e4825ba96748af9c" providerId="LiveId" clId="{E74B9FEE-F61C-4A9F-84D5-57235532D7C9}" dt="2020-08-06T03:47:18.427" v="148" actId="571"/>
          <ac:spMkLst>
            <pc:docMk/>
            <pc:sldMk cId="370389737" sldId="278"/>
            <ac:spMk id="14" creationId="{70034490-71C5-4EE3-8747-DCBB15FAD6AE}"/>
          </ac:spMkLst>
        </pc:spChg>
      </pc:sldChg>
    </pc:docChg>
  </pc:docChgLst>
  <pc:docChgLst>
    <pc:chgData name="吉武 和敏" userId="e4825ba96748af9c" providerId="LiveId" clId="{D2FE407E-229C-4037-87FB-4983F9E9D7B4}"/>
    <pc:docChg chg="undo custSel delSld modSld sldOrd">
      <pc:chgData name="吉武 和敏" userId="e4825ba96748af9c" providerId="LiveId" clId="{D2FE407E-229C-4037-87FB-4983F9E9D7B4}" dt="2022-03-25T03:47:55.674" v="167" actId="1076"/>
      <pc:docMkLst>
        <pc:docMk/>
      </pc:docMkLst>
      <pc:sldChg chg="delSp modSp mod">
        <pc:chgData name="吉武 和敏" userId="e4825ba96748af9c" providerId="LiveId" clId="{D2FE407E-229C-4037-87FB-4983F9E9D7B4}" dt="2021-12-30T07:28:57.481" v="156" actId="1076"/>
        <pc:sldMkLst>
          <pc:docMk/>
          <pc:sldMk cId="2806979806" sldId="262"/>
        </pc:sldMkLst>
        <pc:spChg chg="del">
          <ac:chgData name="吉武 和敏" userId="e4825ba96748af9c" providerId="LiveId" clId="{D2FE407E-229C-4037-87FB-4983F9E9D7B4}" dt="2021-12-30T07:28:47.725" v="152" actId="478"/>
          <ac:spMkLst>
            <pc:docMk/>
            <pc:sldMk cId="2806979806" sldId="262"/>
            <ac:spMk id="3" creationId="{974B97DD-F0D2-461A-929B-22D1DEB06DCA}"/>
          </ac:spMkLst>
        </pc:spChg>
        <pc:spChg chg="del">
          <ac:chgData name="吉武 和敏" userId="e4825ba96748af9c" providerId="LiveId" clId="{D2FE407E-229C-4037-87FB-4983F9E9D7B4}" dt="2021-12-30T07:28:47.725" v="152" actId="478"/>
          <ac:spMkLst>
            <pc:docMk/>
            <pc:sldMk cId="2806979806" sldId="262"/>
            <ac:spMk id="5" creationId="{E38F2233-6C68-48EF-AF3D-A8D0A7043C32}"/>
          </ac:spMkLst>
        </pc:spChg>
        <pc:graphicFrameChg chg="mod">
          <ac:chgData name="吉武 和敏" userId="e4825ba96748af9c" providerId="LiveId" clId="{D2FE407E-229C-4037-87FB-4983F9E9D7B4}" dt="2021-12-30T07:28:57.481" v="156" actId="1076"/>
          <ac:graphicFrameMkLst>
            <pc:docMk/>
            <pc:sldMk cId="2806979806" sldId="262"/>
            <ac:graphicFrameMk id="8" creationId="{6EF45101-230B-4BC4-8CA5-FF20480C115F}"/>
          </ac:graphicFrameMkLst>
        </pc:graphicFrameChg>
        <pc:graphicFrameChg chg="del">
          <ac:chgData name="吉武 和敏" userId="e4825ba96748af9c" providerId="LiveId" clId="{D2FE407E-229C-4037-87FB-4983F9E9D7B4}" dt="2021-12-30T07:28:33.797" v="149" actId="478"/>
          <ac:graphicFrameMkLst>
            <pc:docMk/>
            <pc:sldMk cId="2806979806" sldId="262"/>
            <ac:graphicFrameMk id="10" creationId="{24F41B01-3CD9-8148-801D-F56737EC36F4}"/>
          </ac:graphicFrameMkLst>
        </pc:graphicFrameChg>
        <pc:picChg chg="del">
          <ac:chgData name="吉武 和敏" userId="e4825ba96748af9c" providerId="LiveId" clId="{D2FE407E-229C-4037-87FB-4983F9E9D7B4}" dt="2021-12-30T07:28:35.580" v="150" actId="478"/>
          <ac:picMkLst>
            <pc:docMk/>
            <pc:sldMk cId="2806979806" sldId="262"/>
            <ac:picMk id="2" creationId="{FF4ED084-102B-F547-9AB4-0EC15F9D7EE4}"/>
          </ac:picMkLst>
        </pc:picChg>
        <pc:picChg chg="mod">
          <ac:chgData name="吉武 和敏" userId="e4825ba96748af9c" providerId="LiveId" clId="{D2FE407E-229C-4037-87FB-4983F9E9D7B4}" dt="2021-12-30T07:28:57.481" v="156" actId="1076"/>
          <ac:picMkLst>
            <pc:docMk/>
            <pc:sldMk cId="2806979806" sldId="262"/>
            <ac:picMk id="7" creationId="{1CACE172-1607-4966-8E1D-A997A63CD4CA}"/>
          </ac:picMkLst>
        </pc:picChg>
        <pc:picChg chg="del">
          <ac:chgData name="吉武 和敏" userId="e4825ba96748af9c" providerId="LiveId" clId="{D2FE407E-229C-4037-87FB-4983F9E9D7B4}" dt="2021-12-30T07:28:33.797" v="149" actId="478"/>
          <ac:picMkLst>
            <pc:docMk/>
            <pc:sldMk cId="2806979806" sldId="262"/>
            <ac:picMk id="9" creationId="{C4CB12EA-75AA-464F-A734-C60823C372F0}"/>
          </ac:picMkLst>
        </pc:picChg>
      </pc:sldChg>
      <pc:sldChg chg="addSp delSp modSp mod ord">
        <pc:chgData name="吉武 和敏" userId="e4825ba96748af9c" providerId="LiveId" clId="{D2FE407E-229C-4037-87FB-4983F9E9D7B4}" dt="2021-12-14T07:17:35.642" v="138"/>
        <pc:sldMkLst>
          <pc:docMk/>
          <pc:sldMk cId="549526029" sldId="270"/>
        </pc:sldMkLst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15" creationId="{14C90151-FE65-47E2-A011-A5ABC036A431}"/>
          </ac:spMkLst>
        </pc:spChg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16" creationId="{BC9BBE92-BF58-4A10-81F0-B694204EAD9A}"/>
          </ac:spMkLst>
        </pc:spChg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17" creationId="{4C7B0BD2-DAD4-4367-85B7-BC19BB77F192}"/>
          </ac:spMkLst>
        </pc:spChg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18" creationId="{3312C2DC-7835-403C-A3C9-C0C31DDCA916}"/>
          </ac:spMkLst>
        </pc:spChg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19" creationId="{49AF99EF-0ECE-4953-A58D-7586138946EC}"/>
          </ac:spMkLst>
        </pc:spChg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20" creationId="{1CAA7D10-F6A7-4B50-A9D0-8072D220EE49}"/>
          </ac:spMkLst>
        </pc:spChg>
        <pc:spChg chg="add mod">
          <ac:chgData name="吉武 和敏" userId="e4825ba96748af9c" providerId="LiveId" clId="{D2FE407E-229C-4037-87FB-4983F9E9D7B4}" dt="2021-12-14T07:15:58.856" v="94" actId="207"/>
          <ac:spMkLst>
            <pc:docMk/>
            <pc:sldMk cId="549526029" sldId="270"/>
            <ac:spMk id="21" creationId="{55E6D484-0EE8-4FC9-AC52-300982BCF67A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29" creationId="{1C0D539E-DBB4-47F2-BC07-FC0E1DDDECA1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30" creationId="{D14FA8E3-B9E8-4FE8-A009-47D4C205766C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31" creationId="{5E5647CA-8E4C-4A70-BA57-7C7E5D2CE5D7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32" creationId="{D18E7BF0-E70D-48F1-B34B-6D39421DCACE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33" creationId="{2BF1A2DB-BFF5-43E0-BA14-FC601F79BEC8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34" creationId="{A954818D-EF86-4443-B00E-EEE3C46514CE}"/>
          </ac:spMkLst>
        </pc:spChg>
        <pc:spChg chg="add mod topLvl">
          <ac:chgData name="吉武 和敏" userId="e4825ba96748af9c" providerId="LiveId" clId="{D2FE407E-229C-4037-87FB-4983F9E9D7B4}" dt="2021-12-14T07:15:49.807" v="91" actId="165"/>
          <ac:spMkLst>
            <pc:docMk/>
            <pc:sldMk cId="549526029" sldId="270"/>
            <ac:spMk id="35" creationId="{CDCAAA5C-3D14-4FC4-A913-249A3471B53F}"/>
          </ac:spMkLst>
        </pc:spChg>
        <pc:spChg chg="add mod">
          <ac:chgData name="吉武 和敏" userId="e4825ba96748af9c" providerId="LiveId" clId="{D2FE407E-229C-4037-87FB-4983F9E9D7B4}" dt="2021-12-14T07:16:46.750" v="119" actId="1076"/>
          <ac:spMkLst>
            <pc:docMk/>
            <pc:sldMk cId="549526029" sldId="270"/>
            <ac:spMk id="37" creationId="{D6133BAF-5153-457F-A4E1-591BDABB5F99}"/>
          </ac:spMkLst>
        </pc:spChg>
        <pc:spChg chg="add mod">
          <ac:chgData name="吉武 和敏" userId="e4825ba96748af9c" providerId="LiveId" clId="{D2FE407E-229C-4037-87FB-4983F9E9D7B4}" dt="2021-12-14T07:16:55.679" v="128" actId="20577"/>
          <ac:spMkLst>
            <pc:docMk/>
            <pc:sldMk cId="549526029" sldId="270"/>
            <ac:spMk id="38" creationId="{BC80D470-3D00-401A-BE04-F4E3B5EC0A75}"/>
          </ac:spMkLst>
        </pc:spChg>
        <pc:grpChg chg="add del mod">
          <ac:chgData name="吉武 和敏" userId="e4825ba96748af9c" providerId="LiveId" clId="{D2FE407E-229C-4037-87FB-4983F9E9D7B4}" dt="2021-12-14T07:15:49.807" v="91" actId="165"/>
          <ac:grpSpMkLst>
            <pc:docMk/>
            <pc:sldMk cId="549526029" sldId="270"/>
            <ac:grpSpMk id="36" creationId="{CD3DC5B8-3694-4B0A-ABA3-E48C6D6A73AC}"/>
          </ac:grpSpMkLst>
        </pc:grpChg>
        <pc:picChg chg="add mod modCrop">
          <ac:chgData name="吉武 和敏" userId="e4825ba96748af9c" providerId="LiveId" clId="{D2FE407E-229C-4037-87FB-4983F9E9D7B4}" dt="2021-12-14T07:12:40.534" v="17" actId="1076"/>
          <ac:picMkLst>
            <pc:docMk/>
            <pc:sldMk cId="549526029" sldId="270"/>
            <ac:picMk id="3" creationId="{412B2D32-B0C7-45ED-8587-7D4EE4FC5DCA}"/>
          </ac:picMkLst>
        </pc:picChg>
        <pc:picChg chg="add mod modCrop">
          <ac:chgData name="吉武 和敏" userId="e4825ba96748af9c" providerId="LiveId" clId="{D2FE407E-229C-4037-87FB-4983F9E9D7B4}" dt="2021-12-14T07:12:39.265" v="16" actId="1076"/>
          <ac:picMkLst>
            <pc:docMk/>
            <pc:sldMk cId="549526029" sldId="270"/>
            <ac:picMk id="4" creationId="{3E731FC4-5B4E-483A-B273-E32BAAC7EB3A}"/>
          </ac:picMkLst>
        </pc:pic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6" creationId="{75B6111D-3A68-4F7D-9B6B-EFC429EC7C47}"/>
          </ac:cxnSpMkLst>
        </pc:cxn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9" creationId="{DDFDA90B-F622-45F8-90D0-41D389C85843}"/>
          </ac:cxnSpMkLst>
        </pc:cxn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10" creationId="{C0E99A34-CE09-4E96-812C-1C3AD28E8F56}"/>
          </ac:cxnSpMkLst>
        </pc:cxn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11" creationId="{9671955D-B1D3-4DA6-8856-C53C8F764057}"/>
          </ac:cxnSpMkLst>
        </pc:cxn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12" creationId="{C2A54EB0-9C15-4C5D-818D-C04E04D3F4C3}"/>
          </ac:cxnSpMkLst>
        </pc:cxn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13" creationId="{EDAF7941-A96E-4AA3-AE62-BE142EE3AB8C}"/>
          </ac:cxnSpMkLst>
        </pc:cxnChg>
        <pc:cxnChg chg="add mod">
          <ac:chgData name="吉武 和敏" userId="e4825ba96748af9c" providerId="LiveId" clId="{D2FE407E-229C-4037-87FB-4983F9E9D7B4}" dt="2021-12-14T07:15:56.148" v="93" actId="208"/>
          <ac:cxnSpMkLst>
            <pc:docMk/>
            <pc:sldMk cId="549526029" sldId="270"/>
            <ac:cxnSpMk id="14" creationId="{0119B606-FB1F-4911-820A-04C9E5F35252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2" creationId="{FF99138F-8B33-4C65-9D20-63595C38AA97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3" creationId="{0102FFD8-465A-44AF-989E-6D54A6A2F175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4" creationId="{80186D92-8A84-4496-AA6C-79012ACEBB69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5" creationId="{EDDB0627-B36D-4154-99F4-6CB70B34F7FD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6" creationId="{8241671F-B955-4EA2-B4CD-613F826A0F4B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7" creationId="{CAF98E57-D148-4A08-951B-63953576FC17}"/>
          </ac:cxnSpMkLst>
        </pc:cxnChg>
        <pc:cxnChg chg="add mod topLvl">
          <ac:chgData name="吉武 和敏" userId="e4825ba96748af9c" providerId="LiveId" clId="{D2FE407E-229C-4037-87FB-4983F9E9D7B4}" dt="2021-12-14T07:15:52.762" v="92" actId="208"/>
          <ac:cxnSpMkLst>
            <pc:docMk/>
            <pc:sldMk cId="549526029" sldId="270"/>
            <ac:cxnSpMk id="28" creationId="{8165324B-E17D-4B45-9559-3281837264EE}"/>
          </ac:cxnSpMkLst>
        </pc:cxnChg>
      </pc:sldChg>
      <pc:sldChg chg="addSp delSp modSp del mod ord">
        <pc:chgData name="吉武 和敏" userId="e4825ba96748af9c" providerId="LiveId" clId="{D2FE407E-229C-4037-87FB-4983F9E9D7B4}" dt="2021-12-30T07:29:01.116" v="157" actId="47"/>
        <pc:sldMkLst>
          <pc:docMk/>
          <pc:sldMk cId="2345565979" sldId="272"/>
        </pc:sldMkLst>
        <pc:picChg chg="add del mod">
          <ac:chgData name="吉武 和敏" userId="e4825ba96748af9c" providerId="LiveId" clId="{D2FE407E-229C-4037-87FB-4983F9E9D7B4}" dt="2021-12-14T07:12:00.728" v="10" actId="21"/>
          <ac:picMkLst>
            <pc:docMk/>
            <pc:sldMk cId="2345565979" sldId="272"/>
            <ac:picMk id="3" creationId="{50FB4A4B-863D-410B-AAFD-5DA27A744DDC}"/>
          </ac:picMkLst>
        </pc:picChg>
        <pc:picChg chg="add mod">
          <ac:chgData name="吉武 和敏" userId="e4825ba96748af9c" providerId="LiveId" clId="{D2FE407E-229C-4037-87FB-4983F9E9D7B4}" dt="2021-12-30T07:26:38.798" v="140" actId="27614"/>
          <ac:picMkLst>
            <pc:docMk/>
            <pc:sldMk cId="2345565979" sldId="272"/>
            <ac:picMk id="3" creationId="{F4F9072C-4EE3-45D3-BD03-1A4BE176568D}"/>
          </ac:picMkLst>
        </pc:picChg>
      </pc:sldChg>
      <pc:sldChg chg="addSp delSp modSp mod">
        <pc:chgData name="吉武 和敏" userId="e4825ba96748af9c" providerId="LiveId" clId="{D2FE407E-229C-4037-87FB-4983F9E9D7B4}" dt="2022-03-25T03:47:55.674" v="167" actId="1076"/>
        <pc:sldMkLst>
          <pc:docMk/>
          <pc:sldMk cId="1801781158" sldId="276"/>
        </pc:sldMkLst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3" creationId="{F8240C55-48B7-4F38-AF8C-2C987B10E89A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" creationId="{F33501D9-4A03-4976-A54E-BE855E935BBA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5" creationId="{1ABA4B7E-D139-4B4B-88DC-DA4AAAA73436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" creationId="{21C3DACB-70B7-4A80-BBFD-84C2DCBA92E0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13" creationId="{F85FFFF0-2103-4D3D-AFB0-C6DB98D86EAF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14" creationId="{7CB3ACA1-CF1C-4DD7-82EE-8D46BF98C232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15" creationId="{CE03A854-A46C-48FE-AFA4-B36BB4BFA394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22" creationId="{672643A1-391C-4F61-9000-5A1EE34A4607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39" creationId="{1C0FEDCB-3362-489E-9782-2996FDD610AF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0" creationId="{40214D6C-801C-4CE1-A951-9280C580394B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1" creationId="{56901C6A-B8AD-4ED6-804C-3A1026EA8C9D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2" creationId="{7419A43C-7FC7-48BD-B4BB-E637C08E6974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3" creationId="{CD60431F-4837-4630-ABF0-6C5C7BAD1804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4" creationId="{0E00EF14-A266-4AA8-854F-32F153C631EC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5" creationId="{1A62A78B-355B-4376-827F-BB4E530798D2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46" creationId="{B79398A3-9F8D-455B-91FC-68D88DECEBEB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57" creationId="{A3D4012E-541D-4ACF-BB87-3882EDBCB796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58" creationId="{A0D6428E-E0A9-4F87-A810-F942DC2B3B9E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59" creationId="{64E18347-9B67-4CA1-BDE9-C7130653F6BF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0" creationId="{B9B4A422-335E-4B02-917D-C57977D0348A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1" creationId="{7E7EFE70-1534-4982-A21A-328251FBCE7F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3" creationId="{EF2511F3-ED4D-0A40-8C20-D4F0E89E88FC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4" creationId="{D4922FBE-274A-5249-86EC-8C823F60DE4D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5" creationId="{B94FC8F5-3559-4F17-9CB5-90007785C336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6" creationId="{723970A6-CC40-420A-889E-2BC2F8274D76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7" creationId="{4470E73B-62A0-4BFC-B2AB-31AF50E28765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68" creationId="{04B94BC0-AAEF-4D5C-9562-F3FA61E7F5DB}"/>
          </ac:spMkLst>
        </pc:spChg>
        <pc:spChg chg="del">
          <ac:chgData name="吉武 和敏" userId="e4825ba96748af9c" providerId="LiveId" clId="{D2FE407E-229C-4037-87FB-4983F9E9D7B4}" dt="2022-03-25T03:47:27.290" v="160" actId="478"/>
          <ac:spMkLst>
            <pc:docMk/>
            <pc:sldMk cId="1801781158" sldId="276"/>
            <ac:spMk id="73" creationId="{1621162D-4AE2-1048-8671-F9043E47A5EB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76" creationId="{9559733F-EA28-4DD4-95C1-66A92DFB9E79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77" creationId="{FCA4177E-A0DC-4C8E-9F8E-4A453C62394B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78" creationId="{1AED206B-B936-460B-8222-FDD061B63307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79" creationId="{C3A8203A-5B1F-4C5C-A549-CBCDB8053BA1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81" creationId="{C6A77BFD-CE17-48E4-9B67-710601AC0862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82" creationId="{C157C3D6-1896-4AE2-A4A9-06050A8C0334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83" creationId="{2BF46C91-0726-4CDB-A4BE-44DB4DF79D27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84" creationId="{7A43A773-D796-46C0-9567-D34DF1001350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86" creationId="{8B54BCE2-2CF6-4A08-94C9-0C376C535CAC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87" creationId="{B862F9DD-6447-429C-8952-559EB8BE619D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88" creationId="{8A36E97E-057D-4B47-9CC5-5379BA11A056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89" creationId="{47661CCE-863A-41F9-8587-9C4C1F69C42E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90" creationId="{3DE6CE39-139F-4E68-B213-E7E3AB3EF52B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91" creationId="{0B8D4CE6-0CEF-468A-BCD4-850397405C8B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92" creationId="{AEC4BA30-7253-428B-8214-02E3EC8DE984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93" creationId="{9A74D1FE-224A-4D81-873A-0DF42720601F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95" creationId="{99311B52-E27D-49A8-8C2B-56C16253E9D2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96" creationId="{06BA72F4-B0A5-46F1-8888-DE3A9E61FAD2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97" creationId="{560D92D5-2E93-48E2-B039-2704BCC35CFE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98" creationId="{0E6C9E42-B86C-4D9D-B050-B1E1705CE291}"/>
          </ac:spMkLst>
        </pc:spChg>
        <pc:spChg chg="mod">
          <ac:chgData name="吉武 和敏" userId="e4825ba96748af9c" providerId="LiveId" clId="{D2FE407E-229C-4037-87FB-4983F9E9D7B4}" dt="2022-03-25T03:47:24.996" v="158"/>
          <ac:spMkLst>
            <pc:docMk/>
            <pc:sldMk cId="1801781158" sldId="276"/>
            <ac:spMk id="99" creationId="{AE4EE921-C16C-4DC4-8B4E-F8111C59D216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00" creationId="{EA11EDBC-D452-4A85-8FBC-6B239B35256F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01" creationId="{DFA2FE21-FC53-48B1-9936-9E6BDA10A8DA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02" creationId="{4A9C5302-C040-4EE4-A9F0-C9855EC44238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03" creationId="{632F9CD8-A12E-4C4D-A11A-9A9BDFCFD1B4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04" creationId="{2E56A4C3-A082-4CCB-87DA-B896FAA3EDD5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14" creationId="{EC963AD3-CC39-4E97-AD00-0CDC246CC59D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15" creationId="{7DD00F81-70C6-46DD-80C2-C431A9024014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16" creationId="{108F4806-0FA5-4C78-A691-16DECB3BAAFE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17" creationId="{06F5A846-0CD4-40C2-8D98-770C0CD8CA62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18" creationId="{875FF741-DB24-4E5B-96C8-8A970B488020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19" creationId="{FB013CF4-1E38-45CB-BD92-8E74DDE4AD42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20" creationId="{89DE14DE-FA7B-4D6D-BAB3-E15B912C9DF9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21" creationId="{0CEFB8A5-0290-48AE-96C6-656F366799E8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22" creationId="{91D88990-8FF6-4370-AAE0-1CF95DC5E574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23" creationId="{FF8C1AA8-39ED-4983-B381-17AF7B671207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24" creationId="{9DFA0E12-11B3-4855-9248-2BCAAB0784C0}"/>
          </ac:spMkLst>
        </pc:spChg>
        <pc:spChg chg="add del mod">
          <ac:chgData name="吉武 和敏" userId="e4825ba96748af9c" providerId="LiveId" clId="{D2FE407E-229C-4037-87FB-4983F9E9D7B4}" dt="2022-03-25T03:47:26.270" v="159"/>
          <ac:spMkLst>
            <pc:docMk/>
            <pc:sldMk cId="1801781158" sldId="276"/>
            <ac:spMk id="130" creationId="{0D80DC49-1EF9-43D0-AF3D-C0B0F54FE66E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33" creationId="{82FB00B5-D625-498B-900D-5C8608CC7104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34" creationId="{F33D7786-894E-4336-AFE2-08A3AA577998}"/>
          </ac:spMkLst>
        </pc:spChg>
        <pc:spChg chg="add mod">
          <ac:chgData name="吉武 和敏" userId="e4825ba96748af9c" providerId="LiveId" clId="{D2FE407E-229C-4037-87FB-4983F9E9D7B4}" dt="2022-03-25T03:47:55.674" v="167" actId="1076"/>
          <ac:spMkLst>
            <pc:docMk/>
            <pc:sldMk cId="1801781158" sldId="276"/>
            <ac:spMk id="135" creationId="{1D0ABAEF-3984-454A-86F3-3B0DDB5E52F8}"/>
          </ac:spMkLst>
        </pc:spChg>
        <pc:spChg chg="add mod">
          <ac:chgData name="吉武 和敏" userId="e4825ba96748af9c" providerId="LiveId" clId="{D2FE407E-229C-4037-87FB-4983F9E9D7B4}" dt="2022-03-25T03:47:55.674" v="167" actId="1076"/>
          <ac:spMkLst>
            <pc:docMk/>
            <pc:sldMk cId="1801781158" sldId="276"/>
            <ac:spMk id="136" creationId="{E2B5A034-0262-44CB-8BA7-E8B423E4F198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38" creationId="{11FF698B-F8DB-481B-9C59-6D72A00D9CF3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39" creationId="{BD96449B-A802-4954-A154-71AEECB96297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0" creationId="{95CE1A66-B7B5-4E5B-858F-925807FFAB90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1" creationId="{F45D0294-DE9B-49E5-BF52-CDCA73551EB6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3" creationId="{369BB812-9A24-4023-8CF8-ADB828FDC1C9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4" creationId="{EBF54CF1-8573-4D79-9BA5-8D564729C43F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5" creationId="{027E2719-8D8D-457E-9C19-79349C72F8DA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6" creationId="{6DCA375F-4019-4121-B77A-4EA9256C15D8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7" creationId="{47B0ADE1-3FE0-473D-82AC-CA44562D4DA8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8" creationId="{F3BA8252-3A97-4DDB-A721-A7BDC1263F67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49" creationId="{9E729119-C4F3-460A-BF04-09CF5256D902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0" creationId="{C183F0C1-2F17-4EAA-AF8A-DEA7640F336E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2" creationId="{219E8449-60F7-4ED5-A3A9-9014D25CC3AB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3" creationId="{0EB6F97B-5A89-41A0-AE74-FF89F3C70301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4" creationId="{9AB105F9-0F13-422A-94F7-EF8F7ECD2546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5" creationId="{D6423DE5-7E93-42A1-8F16-29380ADD8C31}"/>
          </ac:spMkLst>
        </pc:spChg>
        <pc:spChg chg="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6" creationId="{1ABF2F5D-9B0D-43F5-A8FA-042C625144CE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7" creationId="{B5D44FB6-2169-4D27-902B-0C82934A361D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8" creationId="{DF0A16DE-BBB7-4D01-8F51-6347D5624A4B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59" creationId="{BFF3B753-F377-4D4C-A21E-4ED05B7769DF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60" creationId="{921BD71D-083F-444D-A5B6-D16ADD355D4F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61" creationId="{456EDE17-0BEB-4FD6-B2BF-CBC644F484F6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1" creationId="{7FDDE4DF-38E3-469C-87AC-17F37EE6C4D9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2" creationId="{F445CC41-5451-4D89-AABA-47434DA86D0E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3" creationId="{2E062E6D-08E1-4C43-A281-F77015C3E22F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4" creationId="{6E5A503D-858D-4E02-8905-14636F362771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5" creationId="{C56DE13D-05A8-4605-A40D-6A7F550037CB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6" creationId="{3F69BF02-CB5C-47FF-9B94-60E977F94814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7" creationId="{EA15BA34-50B2-4189-BD6C-2DE711AEAA25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8" creationId="{23FDB3CA-67AA-47CB-A302-E0401DB80423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79" creationId="{6EB05808-F5A4-408D-96BC-86FB5BDC6223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80" creationId="{BB7C322D-A523-4888-A765-2CCCD2A43234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81" creationId="{28F79B98-6E6D-4E30-8EB6-4A2BC00E8D28}"/>
          </ac:spMkLst>
        </pc:spChg>
        <pc:spChg chg="add mod">
          <ac:chgData name="吉武 和敏" userId="e4825ba96748af9c" providerId="LiveId" clId="{D2FE407E-229C-4037-87FB-4983F9E9D7B4}" dt="2022-03-25T03:47:49.689" v="166" actId="255"/>
          <ac:spMkLst>
            <pc:docMk/>
            <pc:sldMk cId="1801781158" sldId="276"/>
            <ac:spMk id="187" creationId="{BAE869FB-CACC-4D1C-B781-89AA83F228B8}"/>
          </ac:spMkLst>
        </pc:spChg>
        <pc:grpChg chg="del">
          <ac:chgData name="吉武 和敏" userId="e4825ba96748af9c" providerId="LiveId" clId="{D2FE407E-229C-4037-87FB-4983F9E9D7B4}" dt="2022-03-25T03:47:27.290" v="160" actId="478"/>
          <ac:grpSpMkLst>
            <pc:docMk/>
            <pc:sldMk cId="1801781158" sldId="276"/>
            <ac:grpSpMk id="7" creationId="{A966122F-78ED-4B9D-8C74-266BB20E1D84}"/>
          </ac:grpSpMkLst>
        </pc:grpChg>
        <pc:grpChg chg="del">
          <ac:chgData name="吉武 和敏" userId="e4825ba96748af9c" providerId="LiveId" clId="{D2FE407E-229C-4037-87FB-4983F9E9D7B4}" dt="2022-03-25T03:47:27.290" v="160" actId="478"/>
          <ac:grpSpMkLst>
            <pc:docMk/>
            <pc:sldMk cId="1801781158" sldId="276"/>
            <ac:grpSpMk id="16" creationId="{C5549054-6AEF-40F0-8D85-70D99D1E3DD7}"/>
          </ac:grpSpMkLst>
        </pc:grpChg>
        <pc:grpChg chg="add mod">
          <ac:chgData name="吉武 和敏" userId="e4825ba96748af9c" providerId="LiveId" clId="{D2FE407E-229C-4037-87FB-4983F9E9D7B4}" dt="2022-03-25T03:47:49.689" v="166" actId="255"/>
          <ac:grpSpMkLst>
            <pc:docMk/>
            <pc:sldMk cId="1801781158" sldId="276"/>
            <ac:grpSpMk id="23" creationId="{C46D59B5-E620-4190-AA70-9841255DFD95}"/>
          </ac:grpSpMkLst>
        </pc:grpChg>
        <pc:grpChg chg="add del mod">
          <ac:chgData name="吉武 和敏" userId="e4825ba96748af9c" providerId="LiveId" clId="{D2FE407E-229C-4037-87FB-4983F9E9D7B4}" dt="2022-03-25T03:47:26.270" v="159"/>
          <ac:grpSpMkLst>
            <pc:docMk/>
            <pc:sldMk cId="1801781158" sldId="276"/>
            <ac:grpSpMk id="85" creationId="{298EDC00-7473-4812-937C-ED1B388E8E5B}"/>
          </ac:grpSpMkLst>
        </pc:grpChg>
        <pc:grpChg chg="add del mod">
          <ac:chgData name="吉武 和敏" userId="e4825ba96748af9c" providerId="LiveId" clId="{D2FE407E-229C-4037-87FB-4983F9E9D7B4}" dt="2022-03-25T03:47:26.270" v="159"/>
          <ac:grpSpMkLst>
            <pc:docMk/>
            <pc:sldMk cId="1801781158" sldId="276"/>
            <ac:grpSpMk id="94" creationId="{7F31CA00-CF17-44D5-980A-FF2A5A2C7F2A}"/>
          </ac:grpSpMkLst>
        </pc:grpChg>
        <pc:grpChg chg="add mod">
          <ac:chgData name="吉武 和敏" userId="e4825ba96748af9c" providerId="LiveId" clId="{D2FE407E-229C-4037-87FB-4983F9E9D7B4}" dt="2022-03-25T03:47:49.689" v="166" actId="255"/>
          <ac:grpSpMkLst>
            <pc:docMk/>
            <pc:sldMk cId="1801781158" sldId="276"/>
            <ac:grpSpMk id="142" creationId="{93E04830-B4C2-4EB7-9934-1D6440F064C1}"/>
          </ac:grpSpMkLst>
        </pc:grpChg>
        <pc:grpChg chg="add mod">
          <ac:chgData name="吉武 和敏" userId="e4825ba96748af9c" providerId="LiveId" clId="{D2FE407E-229C-4037-87FB-4983F9E9D7B4}" dt="2022-03-25T03:47:49.689" v="166" actId="255"/>
          <ac:grpSpMkLst>
            <pc:docMk/>
            <pc:sldMk cId="1801781158" sldId="276"/>
            <ac:grpSpMk id="151" creationId="{3CA8B676-31F6-4D16-B87D-241898043E57}"/>
          </ac:grpSpMkLst>
        </pc:grpChg>
        <pc:picChg chg="del">
          <ac:chgData name="吉武 和敏" userId="e4825ba96748af9c" providerId="LiveId" clId="{D2FE407E-229C-4037-87FB-4983F9E9D7B4}" dt="2022-03-25T03:47:27.290" v="160" actId="478"/>
          <ac:picMkLst>
            <pc:docMk/>
            <pc:sldMk cId="1801781158" sldId="276"/>
            <ac:picMk id="47" creationId="{67417B17-7F98-4E54-BD6B-29FE9C9540FF}"/>
          </ac:picMkLst>
        </pc:picChg>
        <pc:picChg chg="del">
          <ac:chgData name="吉武 和敏" userId="e4825ba96748af9c" providerId="LiveId" clId="{D2FE407E-229C-4037-87FB-4983F9E9D7B4}" dt="2022-03-25T03:47:27.290" v="160" actId="478"/>
          <ac:picMkLst>
            <pc:docMk/>
            <pc:sldMk cId="1801781158" sldId="276"/>
            <ac:picMk id="48" creationId="{20C1B741-9EA4-49DF-BB2F-3ACF3370A9D0}"/>
          </ac:picMkLst>
        </pc:picChg>
        <pc:picChg chg="del">
          <ac:chgData name="吉武 和敏" userId="e4825ba96748af9c" providerId="LiveId" clId="{D2FE407E-229C-4037-87FB-4983F9E9D7B4}" dt="2022-03-25T03:47:27.290" v="160" actId="478"/>
          <ac:picMkLst>
            <pc:docMk/>
            <pc:sldMk cId="1801781158" sldId="276"/>
            <ac:picMk id="49" creationId="{7635A0AE-A756-4AC6-B66C-CEA0C815787E}"/>
          </ac:picMkLst>
        </pc:picChg>
        <pc:picChg chg="add del mod">
          <ac:chgData name="吉武 和敏" userId="e4825ba96748af9c" providerId="LiveId" clId="{D2FE407E-229C-4037-87FB-4983F9E9D7B4}" dt="2022-03-25T03:47:26.270" v="159"/>
          <ac:picMkLst>
            <pc:docMk/>
            <pc:sldMk cId="1801781158" sldId="276"/>
            <ac:picMk id="105" creationId="{9E41DD4E-2AAD-4166-A29B-4FE378C9654B}"/>
          </ac:picMkLst>
        </pc:picChg>
        <pc:picChg chg="add del mod">
          <ac:chgData name="吉武 和敏" userId="e4825ba96748af9c" providerId="LiveId" clId="{D2FE407E-229C-4037-87FB-4983F9E9D7B4}" dt="2022-03-25T03:47:26.270" v="159"/>
          <ac:picMkLst>
            <pc:docMk/>
            <pc:sldMk cId="1801781158" sldId="276"/>
            <ac:picMk id="106" creationId="{C8FC8454-589F-4F9E-BEE9-7808EB768D8A}"/>
          </ac:picMkLst>
        </pc:picChg>
        <pc:picChg chg="add del mod">
          <ac:chgData name="吉武 和敏" userId="e4825ba96748af9c" providerId="LiveId" clId="{D2FE407E-229C-4037-87FB-4983F9E9D7B4}" dt="2022-03-25T03:47:26.270" v="159"/>
          <ac:picMkLst>
            <pc:docMk/>
            <pc:sldMk cId="1801781158" sldId="276"/>
            <ac:picMk id="107" creationId="{C3ADC99B-F8A1-4F7E-891B-D49306AF88F5}"/>
          </ac:picMkLst>
        </pc:picChg>
        <pc:picChg chg="add mod">
          <ac:chgData name="吉武 和敏" userId="e4825ba96748af9c" providerId="LiveId" clId="{D2FE407E-229C-4037-87FB-4983F9E9D7B4}" dt="2022-03-25T03:47:49.689" v="166" actId="255"/>
          <ac:picMkLst>
            <pc:docMk/>
            <pc:sldMk cId="1801781158" sldId="276"/>
            <ac:picMk id="162" creationId="{8136D439-923F-4F99-B500-ED11224E7908}"/>
          </ac:picMkLst>
        </pc:picChg>
        <pc:picChg chg="add mod">
          <ac:chgData name="吉武 和敏" userId="e4825ba96748af9c" providerId="LiveId" clId="{D2FE407E-229C-4037-87FB-4983F9E9D7B4}" dt="2022-03-25T03:47:49.689" v="166" actId="255"/>
          <ac:picMkLst>
            <pc:docMk/>
            <pc:sldMk cId="1801781158" sldId="276"/>
            <ac:picMk id="163" creationId="{6224FAE0-03E6-4A57-802B-DBECA44C13FE}"/>
          </ac:picMkLst>
        </pc:picChg>
        <pc:picChg chg="add mod">
          <ac:chgData name="吉武 和敏" userId="e4825ba96748af9c" providerId="LiveId" clId="{D2FE407E-229C-4037-87FB-4983F9E9D7B4}" dt="2022-03-25T03:47:49.689" v="166" actId="255"/>
          <ac:picMkLst>
            <pc:docMk/>
            <pc:sldMk cId="1801781158" sldId="276"/>
            <ac:picMk id="164" creationId="{76E9F69D-64B1-4CD7-8AE4-EC35905D1BB9}"/>
          </ac:picMkLst>
        </pc:pic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2" creationId="{F1DEAC02-A837-4C3B-B18E-9A965A909FC3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24" creationId="{3A870D4F-8ED4-714F-AC1D-ABD9026A987B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25" creationId="{D4323DD4-E98D-DA49-BEE8-CFB756E0ED46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51" creationId="{FADDA0DA-4332-4D2D-BA7A-DC71C678BA4C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52" creationId="{AD439C5F-7971-46C6-A2A1-9F747B0BC057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53" creationId="{AB51DDD2-91D0-40AE-8473-1EC7A3DA79B1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54" creationId="{99329787-9CB5-4F98-8B40-ACD91DEE0A39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55" creationId="{8D98788D-AA60-446A-A236-0754ED6903A5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56" creationId="{6CDA478C-687B-48D1-9EE0-526B92E23E40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62" creationId="{3EF21EC9-1594-404E-9348-BAFA4710893A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69" creationId="{5DFBCD9A-B9C7-844D-AAFA-F1B2B8CF7F0D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70" creationId="{C465EFBC-0493-3242-BDAE-01D0FD04AF56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71" creationId="{335D5671-49CA-FC41-BEA1-5E6569B1C571}"/>
          </ac:cxnSpMkLst>
        </pc:cxnChg>
        <pc:cxnChg chg="del">
          <ac:chgData name="吉武 和敏" userId="e4825ba96748af9c" providerId="LiveId" clId="{D2FE407E-229C-4037-87FB-4983F9E9D7B4}" dt="2022-03-25T03:47:27.290" v="160" actId="478"/>
          <ac:cxnSpMkLst>
            <pc:docMk/>
            <pc:sldMk cId="1801781158" sldId="276"/>
            <ac:cxnSpMk id="72" creationId="{9338DB2D-00A6-7040-839F-360855509E4A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74" creationId="{30D47C9A-37F5-49D1-ACD6-CAB112086EC8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75" creationId="{9FEBEA6C-4742-42A5-A369-47B1B34B35D2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80" creationId="{63080DF1-797F-4794-833D-D1611C482CD0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08" creationId="{FC8E07CD-BAF5-4655-85FC-BBF63186E006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09" creationId="{3B81C2F5-7993-4DE2-821D-54A433CA0CDE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10" creationId="{7A7E4421-426A-472D-B3D6-1F63D3996D69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11" creationId="{DB099391-C4B2-4058-80BA-83D9D16D68E0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12" creationId="{03A3C1E2-D72B-4175-99DE-B0986468D25A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13" creationId="{C7B75C0C-6C35-4D5B-972B-58B25676C8A0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25" creationId="{E677A15C-DEC8-4F93-AA3E-ADDE005E108A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26" creationId="{1497CEE5-5E2B-42B4-B198-F37EE5280601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27" creationId="{4ED3661F-FEE3-411C-819B-5E0DE66A2D5B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28" creationId="{AC1927AE-2D51-4227-A198-76CD1A2255C6}"/>
          </ac:cxnSpMkLst>
        </pc:cxnChg>
        <pc:cxnChg chg="add del mod">
          <ac:chgData name="吉武 和敏" userId="e4825ba96748af9c" providerId="LiveId" clId="{D2FE407E-229C-4037-87FB-4983F9E9D7B4}" dt="2022-03-25T03:47:26.270" v="159"/>
          <ac:cxnSpMkLst>
            <pc:docMk/>
            <pc:sldMk cId="1801781158" sldId="276"/>
            <ac:cxnSpMk id="129" creationId="{1F1A687C-1D9F-4F08-91AF-04B74750983C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31" creationId="{8ACC601B-614A-464F-9927-DAB717E1B501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32" creationId="{A7D99360-283D-428A-9BA6-AD866DED1EEC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37" creationId="{EB710813-8EFF-4F60-923A-ED5B477BBBB0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65" creationId="{4C951DB4-DA8B-4585-B945-1E356CF557A8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66" creationId="{475D3CBE-77FE-4813-A1F9-30C193C7B5EC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67" creationId="{A646F50F-EF52-4046-91F2-CECAA63C7773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68" creationId="{873548B1-576C-4100-8EA4-2695968FAD72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69" creationId="{224311A3-0252-49EA-9D58-57223911ABFC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70" creationId="{B340C186-43EE-4030-A088-FA72954C1675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82" creationId="{54685350-1355-47FA-869D-1B70B0C9F84A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83" creationId="{E7ACECF8-C8FB-4EEB-90D3-EB44109BE816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84" creationId="{0A0B0A57-EC80-444E-B46B-C8B7227F5CB2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85" creationId="{E5F47915-62CB-4307-9CF0-373C42B40C25}"/>
          </ac:cxnSpMkLst>
        </pc:cxnChg>
        <pc:cxnChg chg="add mod">
          <ac:chgData name="吉武 和敏" userId="e4825ba96748af9c" providerId="LiveId" clId="{D2FE407E-229C-4037-87FB-4983F9E9D7B4}" dt="2022-03-25T03:47:49.689" v="166" actId="255"/>
          <ac:cxnSpMkLst>
            <pc:docMk/>
            <pc:sldMk cId="1801781158" sldId="276"/>
            <ac:cxnSpMk id="186" creationId="{B8C1FB6C-1E06-4E59-95B1-3B206C4ADDB4}"/>
          </ac:cxnSpMkLst>
        </pc:cxnChg>
      </pc:sldChg>
    </pc:docChg>
  </pc:docChgLst>
  <pc:docChgLst>
    <pc:chgData name="吉武 和敏" userId="e4825ba96748af9c" providerId="LiveId" clId="{B646EDF2-F982-4404-8692-3140A042F270}"/>
    <pc:docChg chg="modSld sldOrd">
      <pc:chgData name="吉武 和敏" userId="e4825ba96748af9c" providerId="LiveId" clId="{B646EDF2-F982-4404-8692-3140A042F270}" dt="2020-09-16T04:30:35.367" v="3"/>
      <pc:docMkLst>
        <pc:docMk/>
      </pc:docMkLst>
      <pc:sldChg chg="ord">
        <pc:chgData name="吉武 和敏" userId="e4825ba96748af9c" providerId="LiveId" clId="{B646EDF2-F982-4404-8692-3140A042F270}" dt="2020-09-16T04:30:35.367" v="3"/>
        <pc:sldMkLst>
          <pc:docMk/>
          <pc:sldMk cId="3600490621" sldId="269"/>
        </pc:sldMkLst>
      </pc:sldChg>
    </pc:docChg>
  </pc:docChgLst>
  <pc:docChgLst>
    <pc:chgData name="吉武 和敏" userId="e4825ba96748af9c" providerId="LiveId" clId="{535808C7-081B-4693-8F85-8231CF06CA29}"/>
    <pc:docChg chg="custSel addSld delSld modSld">
      <pc:chgData name="吉武 和敏" userId="e4825ba96748af9c" providerId="LiveId" clId="{535808C7-081B-4693-8F85-8231CF06CA29}" dt="2021-10-19T09:40:00.442" v="53"/>
      <pc:docMkLst>
        <pc:docMk/>
      </pc:docMkLst>
      <pc:sldChg chg="del">
        <pc:chgData name="吉武 和敏" userId="e4825ba96748af9c" providerId="LiveId" clId="{535808C7-081B-4693-8F85-8231CF06CA29}" dt="2021-09-13T08:30:44.898" v="0" actId="47"/>
        <pc:sldMkLst>
          <pc:docMk/>
          <pc:sldMk cId="1744819178" sldId="257"/>
        </pc:sldMkLst>
      </pc:sldChg>
      <pc:sldChg chg="add">
        <pc:chgData name="吉武 和敏" userId="e4825ba96748af9c" providerId="LiveId" clId="{535808C7-081B-4693-8F85-8231CF06CA29}" dt="2021-09-13T08:38:40.418" v="12"/>
        <pc:sldMkLst>
          <pc:docMk/>
          <pc:sldMk cId="2737082793" sldId="257"/>
        </pc:sldMkLst>
      </pc:sldChg>
      <pc:sldChg chg="del">
        <pc:chgData name="吉武 和敏" userId="e4825ba96748af9c" providerId="LiveId" clId="{535808C7-081B-4693-8F85-8231CF06CA29}" dt="2021-09-13T08:30:44.898" v="0" actId="47"/>
        <pc:sldMkLst>
          <pc:docMk/>
          <pc:sldMk cId="1279635173" sldId="258"/>
        </pc:sldMkLst>
      </pc:sldChg>
      <pc:sldChg chg="add">
        <pc:chgData name="吉武 和敏" userId="e4825ba96748af9c" providerId="LiveId" clId="{535808C7-081B-4693-8F85-8231CF06CA29}" dt="2021-10-19T09:40:00.442" v="53"/>
        <pc:sldMkLst>
          <pc:docMk/>
          <pc:sldMk cId="1991318276" sldId="258"/>
        </pc:sldMkLst>
      </pc:sldChg>
      <pc:sldChg chg="add">
        <pc:chgData name="吉武 和敏" userId="e4825ba96748af9c" providerId="LiveId" clId="{535808C7-081B-4693-8F85-8231CF06CA29}" dt="2021-09-13T08:38:46.836" v="13"/>
        <pc:sldMkLst>
          <pc:docMk/>
          <pc:sldMk cId="1542364386" sldId="260"/>
        </pc:sldMkLst>
      </pc:sldChg>
      <pc:sldChg chg="add del">
        <pc:chgData name="吉武 和敏" userId="e4825ba96748af9c" providerId="LiveId" clId="{535808C7-081B-4693-8F85-8231CF06CA29}" dt="2021-09-13T08:39:26.132" v="16" actId="47"/>
        <pc:sldMkLst>
          <pc:docMk/>
          <pc:sldMk cId="4240152337" sldId="261"/>
        </pc:sldMkLst>
      </pc:sldChg>
      <pc:sldChg chg="addSp delSp modSp add mod">
        <pc:chgData name="吉武 和敏" userId="e4825ba96748af9c" providerId="LiveId" clId="{535808C7-081B-4693-8F85-8231CF06CA29}" dt="2021-09-14T06:46:51.002" v="31" actId="1076"/>
        <pc:sldMkLst>
          <pc:docMk/>
          <pc:sldMk cId="2806979806" sldId="262"/>
        </pc:sldMkLst>
        <pc:spChg chg="add del mod">
          <ac:chgData name="吉武 和敏" userId="e4825ba96748af9c" providerId="LiveId" clId="{535808C7-081B-4693-8F85-8231CF06CA29}" dt="2021-09-14T06:46:27.141" v="27" actId="478"/>
          <ac:spMkLst>
            <pc:docMk/>
            <pc:sldMk cId="2806979806" sldId="262"/>
            <ac:spMk id="4" creationId="{F2D0DE9F-49F8-4F7A-A69A-EFBE9266173C}"/>
          </ac:spMkLst>
        </pc:spChg>
        <pc:graphicFrameChg chg="add mod">
          <ac:chgData name="吉武 和敏" userId="e4825ba96748af9c" providerId="LiveId" clId="{535808C7-081B-4693-8F85-8231CF06CA29}" dt="2021-09-14T06:46:51.002" v="31" actId="1076"/>
          <ac:graphicFrameMkLst>
            <pc:docMk/>
            <pc:sldMk cId="2806979806" sldId="262"/>
            <ac:graphicFrameMk id="8" creationId="{6EF45101-230B-4BC4-8CA5-FF20480C115F}"/>
          </ac:graphicFrameMkLst>
        </pc:graphicFrameChg>
        <pc:picChg chg="add mod">
          <ac:chgData name="吉武 和敏" userId="e4825ba96748af9c" providerId="LiveId" clId="{535808C7-081B-4693-8F85-8231CF06CA29}" dt="2021-09-14T06:46:46.177" v="29" actId="1076"/>
          <ac:picMkLst>
            <pc:docMk/>
            <pc:sldMk cId="2806979806" sldId="262"/>
            <ac:picMk id="7" creationId="{1CACE172-1607-4966-8E1D-A997A63CD4CA}"/>
          </ac:picMkLst>
        </pc:picChg>
        <pc:picChg chg="add del mod">
          <ac:chgData name="吉武 和敏" userId="e4825ba96748af9c" providerId="LiveId" clId="{535808C7-081B-4693-8F85-8231CF06CA29}" dt="2021-09-14T06:46:13.003" v="22" actId="478"/>
          <ac:picMkLst>
            <pc:docMk/>
            <pc:sldMk cId="2806979806" sldId="262"/>
            <ac:picMk id="9" creationId="{C4CB12EA-75AA-464F-A734-C60823C372F0}"/>
          </ac:picMkLst>
        </pc:picChg>
      </pc:sldChg>
      <pc:sldChg chg="add">
        <pc:chgData name="吉武 和敏" userId="e4825ba96748af9c" providerId="LiveId" clId="{535808C7-081B-4693-8F85-8231CF06CA29}" dt="2021-09-13T08:39:35.039" v="17"/>
        <pc:sldMkLst>
          <pc:docMk/>
          <pc:sldMk cId="2928055407" sldId="263"/>
        </pc:sldMkLst>
      </pc:sldChg>
      <pc:sldChg chg="add">
        <pc:chgData name="吉武 和敏" userId="e4825ba96748af9c" providerId="LiveId" clId="{535808C7-081B-4693-8F85-8231CF06CA29}" dt="2021-09-13T08:39:35.039" v="17"/>
        <pc:sldMkLst>
          <pc:docMk/>
          <pc:sldMk cId="1214924586" sldId="264"/>
        </pc:sldMkLst>
      </pc:sldChg>
      <pc:sldChg chg="add">
        <pc:chgData name="吉武 和敏" userId="e4825ba96748af9c" providerId="LiveId" clId="{535808C7-081B-4693-8F85-8231CF06CA29}" dt="2021-09-13T08:39:35.039" v="17"/>
        <pc:sldMkLst>
          <pc:docMk/>
          <pc:sldMk cId="3293758939" sldId="265"/>
        </pc:sldMkLst>
      </pc:sldChg>
      <pc:sldChg chg="del">
        <pc:chgData name="吉武 和敏" userId="e4825ba96748af9c" providerId="LiveId" clId="{535808C7-081B-4693-8F85-8231CF06CA29}" dt="2021-09-13T08:39:56.494" v="19" actId="47"/>
        <pc:sldMkLst>
          <pc:docMk/>
          <pc:sldMk cId="2704609531" sldId="268"/>
        </pc:sldMkLst>
      </pc:sldChg>
      <pc:sldChg chg="new">
        <pc:chgData name="吉武 和敏" userId="e4825ba96748af9c" providerId="LiveId" clId="{535808C7-081B-4693-8F85-8231CF06CA29}" dt="2021-09-13T08:30:51.007" v="2" actId="680"/>
        <pc:sldMkLst>
          <pc:docMk/>
          <pc:sldMk cId="2676106001" sldId="269"/>
        </pc:sldMkLst>
      </pc:sldChg>
      <pc:sldChg chg="del">
        <pc:chgData name="吉武 和敏" userId="e4825ba96748af9c" providerId="LiveId" clId="{535808C7-081B-4693-8F85-8231CF06CA29}" dt="2021-09-13T08:30:48.737" v="1" actId="47"/>
        <pc:sldMkLst>
          <pc:docMk/>
          <pc:sldMk cId="3600490621" sldId="269"/>
        </pc:sldMkLst>
      </pc:sldChg>
      <pc:sldChg chg="add">
        <pc:chgData name="吉武 和敏" userId="e4825ba96748af9c" providerId="LiveId" clId="{535808C7-081B-4693-8F85-8231CF06CA29}" dt="2021-09-13T08:30:51.806" v="3"/>
        <pc:sldMkLst>
          <pc:docMk/>
          <pc:sldMk cId="549526029" sldId="270"/>
        </pc:sldMkLst>
      </pc:sldChg>
      <pc:sldChg chg="add">
        <pc:chgData name="吉武 和敏" userId="e4825ba96748af9c" providerId="LiveId" clId="{535808C7-081B-4693-8F85-8231CF06CA29}" dt="2021-09-13T08:30:51.940" v="4"/>
        <pc:sldMkLst>
          <pc:docMk/>
          <pc:sldMk cId="3518054801" sldId="271"/>
        </pc:sldMkLst>
      </pc:sldChg>
      <pc:sldChg chg="add">
        <pc:chgData name="吉武 和敏" userId="e4825ba96748af9c" providerId="LiveId" clId="{535808C7-081B-4693-8F85-8231CF06CA29}" dt="2021-09-13T08:30:52.099" v="5"/>
        <pc:sldMkLst>
          <pc:docMk/>
          <pc:sldMk cId="2345565979" sldId="272"/>
        </pc:sldMkLst>
      </pc:sldChg>
      <pc:sldChg chg="add">
        <pc:chgData name="吉武 和敏" userId="e4825ba96748af9c" providerId="LiveId" clId="{535808C7-081B-4693-8F85-8231CF06CA29}" dt="2021-09-13T08:30:52.211" v="6"/>
        <pc:sldMkLst>
          <pc:docMk/>
          <pc:sldMk cId="1148990755" sldId="273"/>
        </pc:sldMkLst>
      </pc:sldChg>
      <pc:sldChg chg="add">
        <pc:chgData name="吉武 和敏" userId="e4825ba96748af9c" providerId="LiveId" clId="{535808C7-081B-4693-8F85-8231CF06CA29}" dt="2021-09-13T08:30:52.357" v="7"/>
        <pc:sldMkLst>
          <pc:docMk/>
          <pc:sldMk cId="3718634027" sldId="274"/>
        </pc:sldMkLst>
      </pc:sldChg>
      <pc:sldChg chg="add">
        <pc:chgData name="吉武 和敏" userId="e4825ba96748af9c" providerId="LiveId" clId="{535808C7-081B-4693-8F85-8231CF06CA29}" dt="2021-09-13T08:30:52.499" v="8"/>
        <pc:sldMkLst>
          <pc:docMk/>
          <pc:sldMk cId="3305646646" sldId="275"/>
        </pc:sldMkLst>
      </pc:sldChg>
      <pc:sldChg chg="modSp add mod">
        <pc:chgData name="吉武 和敏" userId="e4825ba96748af9c" providerId="LiveId" clId="{535808C7-081B-4693-8F85-8231CF06CA29}" dt="2021-10-19T09:28:26.923" v="51" actId="20577"/>
        <pc:sldMkLst>
          <pc:docMk/>
          <pc:sldMk cId="1801781158" sldId="276"/>
        </pc:sldMkLst>
        <pc:spChg chg="mod">
          <ac:chgData name="吉武 和敏" userId="e4825ba96748af9c" providerId="LiveId" clId="{535808C7-081B-4693-8F85-8231CF06CA29}" dt="2021-10-19T09:28:26.923" v="51" actId="20577"/>
          <ac:spMkLst>
            <pc:docMk/>
            <pc:sldMk cId="1801781158" sldId="276"/>
            <ac:spMk id="5" creationId="{1ABA4B7E-D139-4B4B-88DC-DA4AAAA73436}"/>
          </ac:spMkLst>
        </pc:spChg>
      </pc:sldChg>
      <pc:sldChg chg="addSp delSp modSp add mod">
        <pc:chgData name="吉武 和敏" userId="e4825ba96748af9c" providerId="LiveId" clId="{535808C7-081B-4693-8F85-8231CF06CA29}" dt="2021-10-19T09:39:21.934" v="52"/>
        <pc:sldMkLst>
          <pc:docMk/>
          <pc:sldMk cId="49459081" sldId="277"/>
        </pc:sldMkLst>
        <pc:spChg chg="mod">
          <ac:chgData name="吉武 和敏" userId="e4825ba96748af9c" providerId="LiveId" clId="{535808C7-081B-4693-8F85-8231CF06CA29}" dt="2021-10-19T09:39:21.934" v="52"/>
          <ac:spMkLst>
            <pc:docMk/>
            <pc:sldMk cId="49459081" sldId="277"/>
            <ac:spMk id="3" creationId="{D003F167-C51C-44A9-A479-4B8355C560B3}"/>
          </ac:spMkLst>
        </pc:spChg>
        <pc:cxnChg chg="add del mod">
          <ac:chgData name="吉武 和敏" userId="e4825ba96748af9c" providerId="LiveId" clId="{535808C7-081B-4693-8F85-8231CF06CA29}" dt="2021-10-19T08:59:54.354" v="37" actId="478"/>
          <ac:cxnSpMkLst>
            <pc:docMk/>
            <pc:sldMk cId="49459081" sldId="277"/>
            <ac:cxnSpMk id="11" creationId="{367DC935-7238-4094-9AFD-42672F5AC715}"/>
          </ac:cxnSpMkLst>
        </pc:cxnChg>
        <pc:cxnChg chg="add del mod">
          <ac:chgData name="吉武 和敏" userId="e4825ba96748af9c" providerId="LiveId" clId="{535808C7-081B-4693-8F85-8231CF06CA29}" dt="2021-10-19T08:59:54.354" v="37" actId="478"/>
          <ac:cxnSpMkLst>
            <pc:docMk/>
            <pc:sldMk cId="49459081" sldId="277"/>
            <ac:cxnSpMk id="16" creationId="{B214EECE-6962-4F61-B192-BC3B265AAAB2}"/>
          </ac:cxnSpMkLst>
        </pc:cxnChg>
      </pc:sldChg>
      <pc:sldChg chg="del">
        <pc:chgData name="吉武 和敏" userId="e4825ba96748af9c" providerId="LiveId" clId="{535808C7-081B-4693-8F85-8231CF06CA29}" dt="2021-09-13T08:30:44.898" v="0" actId="47"/>
        <pc:sldMkLst>
          <pc:docMk/>
          <pc:sldMk cId="664468651" sldId="277"/>
        </pc:sldMkLst>
      </pc:sldChg>
      <pc:sldChg chg="del">
        <pc:chgData name="吉武 和敏" userId="e4825ba96748af9c" providerId="LiveId" clId="{535808C7-081B-4693-8F85-8231CF06CA29}" dt="2021-09-13T08:30:44.898" v="0" actId="47"/>
        <pc:sldMkLst>
          <pc:docMk/>
          <pc:sldMk cId="370389737" sldId="278"/>
        </pc:sldMkLst>
      </pc:sldChg>
      <pc:sldChg chg="add">
        <pc:chgData name="吉武 和敏" userId="e4825ba96748af9c" providerId="LiveId" clId="{535808C7-081B-4693-8F85-8231CF06CA29}" dt="2021-09-13T08:38:28.154" v="11"/>
        <pc:sldMkLst>
          <pc:docMk/>
          <pc:sldMk cId="2753622518" sldId="278"/>
        </pc:sldMkLst>
      </pc:sldChg>
      <pc:sldChg chg="del">
        <pc:chgData name="吉武 和敏" userId="e4825ba96748af9c" providerId="LiveId" clId="{535808C7-081B-4693-8F85-8231CF06CA29}" dt="2021-09-13T08:30:44.898" v="0" actId="47"/>
        <pc:sldMkLst>
          <pc:docMk/>
          <pc:sldMk cId="3831337953" sldId="279"/>
        </pc:sldMkLst>
      </pc:sldChg>
      <pc:sldChg chg="add">
        <pc:chgData name="吉武 和敏" userId="e4825ba96748af9c" providerId="LiveId" clId="{535808C7-081B-4693-8F85-8231CF06CA29}" dt="2021-09-13T08:39:45.835" v="18"/>
        <pc:sldMkLst>
          <pc:docMk/>
          <pc:sldMk cId="1047350898" sldId="848"/>
        </pc:sldMkLst>
      </pc:sldChg>
      <pc:sldChg chg="add">
        <pc:chgData name="吉武 和敏" userId="e4825ba96748af9c" providerId="LiveId" clId="{535808C7-081B-4693-8F85-8231CF06CA29}" dt="2021-09-13T08:39:35.039" v="17"/>
        <pc:sldMkLst>
          <pc:docMk/>
          <pc:sldMk cId="731570627" sldId="849"/>
        </pc:sldMkLst>
      </pc:sldChg>
      <pc:sldChg chg="add">
        <pc:chgData name="吉武 和敏" userId="e4825ba96748af9c" providerId="LiveId" clId="{535808C7-081B-4693-8F85-8231CF06CA29}" dt="2021-09-13T08:39:35.039" v="17"/>
        <pc:sldMkLst>
          <pc:docMk/>
          <pc:sldMk cId="2300418936" sldId="850"/>
        </pc:sldMkLst>
      </pc:sldChg>
    </pc:docChg>
  </pc:docChgLst>
  <pc:docChgLst>
    <pc:chgData name="吉武 和敏" userId="e4825ba96748af9c" providerId="LiveId" clId="{7471937A-C170-42B0-9C6F-3DDC1BCC06B0}"/>
    <pc:docChg chg="undo redo custSel modSld sldOrd">
      <pc:chgData name="吉武 和敏" userId="e4825ba96748af9c" providerId="LiveId" clId="{7471937A-C170-42B0-9C6F-3DDC1BCC06B0}" dt="2022-08-31T09:35:12.731" v="2425" actId="1076"/>
      <pc:docMkLst>
        <pc:docMk/>
      </pc:docMkLst>
      <pc:sldChg chg="addSp delSp modSp mod">
        <pc:chgData name="吉武 和敏" userId="e4825ba96748af9c" providerId="LiveId" clId="{7471937A-C170-42B0-9C6F-3DDC1BCC06B0}" dt="2022-06-17T07:32:17.739" v="1760"/>
        <pc:sldMkLst>
          <pc:docMk/>
          <pc:sldMk cId="2737082793" sldId="257"/>
        </pc:sldMkLst>
        <pc:spChg chg="add mod">
          <ac:chgData name="吉武 和敏" userId="e4825ba96748af9c" providerId="LiveId" clId="{7471937A-C170-42B0-9C6F-3DDC1BCC06B0}" dt="2022-06-17T07:30:48.886" v="1751" actId="1076"/>
          <ac:spMkLst>
            <pc:docMk/>
            <pc:sldMk cId="2737082793" sldId="257"/>
            <ac:spMk id="6" creationId="{9B71010E-C53D-E719-AE80-F50BB9C887AB}"/>
          </ac:spMkLst>
        </pc:spChg>
        <pc:spChg chg="add mod">
          <ac:chgData name="吉武 和敏" userId="e4825ba96748af9c" providerId="LiveId" clId="{7471937A-C170-42B0-9C6F-3DDC1BCC06B0}" dt="2022-06-17T07:32:17.739" v="1760"/>
          <ac:spMkLst>
            <pc:docMk/>
            <pc:sldMk cId="2737082793" sldId="257"/>
            <ac:spMk id="7" creationId="{C82224E9-2399-839F-B27B-4D0914EC238D}"/>
          </ac:spMkLst>
        </pc:spChg>
        <pc:graphicFrameChg chg="add mod modGraphic">
          <ac:chgData name="吉武 和敏" userId="e4825ba96748af9c" providerId="LiveId" clId="{7471937A-C170-42B0-9C6F-3DDC1BCC06B0}" dt="2022-06-17T07:30:46.430" v="1750" actId="1076"/>
          <ac:graphicFrameMkLst>
            <pc:docMk/>
            <pc:sldMk cId="2737082793" sldId="257"/>
            <ac:graphicFrameMk id="2" creationId="{C63A816A-7065-B6FF-2CD4-416D7C9982E2}"/>
          </ac:graphicFrameMkLst>
        </pc:graphicFrameChg>
        <pc:picChg chg="del">
          <ac:chgData name="吉武 和敏" userId="e4825ba96748af9c" providerId="LiveId" clId="{7471937A-C170-42B0-9C6F-3DDC1BCC06B0}" dt="2022-06-17T07:27:37.321" v="1727" actId="478"/>
          <ac:picMkLst>
            <pc:docMk/>
            <pc:sldMk cId="2737082793" sldId="257"/>
            <ac:picMk id="5" creationId="{06AD9A8E-203A-469F-B75D-C2795674AA7A}"/>
          </ac:picMkLst>
        </pc:picChg>
      </pc:sldChg>
      <pc:sldChg chg="addSp delSp modSp mod ord">
        <pc:chgData name="吉武 和敏" userId="e4825ba96748af9c" providerId="LiveId" clId="{7471937A-C170-42B0-9C6F-3DDC1BCC06B0}" dt="2022-08-31T06:24:02.843" v="2054" actId="20577"/>
        <pc:sldMkLst>
          <pc:docMk/>
          <pc:sldMk cId="1542364386" sldId="260"/>
        </pc:sldMkLst>
        <pc:spChg chg="del mod">
          <ac:chgData name="吉武 和敏" userId="e4825ba96748af9c" providerId="LiveId" clId="{7471937A-C170-42B0-9C6F-3DDC1BCC06B0}" dt="2022-06-06T08:53:28.859" v="700"/>
          <ac:spMkLst>
            <pc:docMk/>
            <pc:sldMk cId="1542364386" sldId="260"/>
            <ac:spMk id="5" creationId="{75951465-0503-472E-9445-CAD3379E5728}"/>
          </ac:spMkLst>
        </pc:spChg>
        <pc:spChg chg="mod">
          <ac:chgData name="吉武 和敏" userId="e4825ba96748af9c" providerId="LiveId" clId="{7471937A-C170-42B0-9C6F-3DDC1BCC06B0}" dt="2022-06-06T08:56:14.484" v="751" actId="1076"/>
          <ac:spMkLst>
            <pc:docMk/>
            <pc:sldMk cId="1542364386" sldId="260"/>
            <ac:spMk id="6" creationId="{1D3E95CE-33DA-4724-A1BE-25F2BC2A0C1F}"/>
          </ac:spMkLst>
        </pc:spChg>
        <pc:spChg chg="del">
          <ac:chgData name="吉武 和敏" userId="e4825ba96748af9c" providerId="LiveId" clId="{7471937A-C170-42B0-9C6F-3DDC1BCC06B0}" dt="2022-06-06T08:53:28.857" v="698" actId="478"/>
          <ac:spMkLst>
            <pc:docMk/>
            <pc:sldMk cId="1542364386" sldId="260"/>
            <ac:spMk id="9" creationId="{3F83EC48-75A0-40D5-8CF1-ED089DD345B1}"/>
          </ac:spMkLst>
        </pc:spChg>
        <pc:spChg chg="mod">
          <ac:chgData name="吉武 和敏" userId="e4825ba96748af9c" providerId="LiveId" clId="{7471937A-C170-42B0-9C6F-3DDC1BCC06B0}" dt="2022-06-06T08:54:45.699" v="738" actId="1076"/>
          <ac:spMkLst>
            <pc:docMk/>
            <pc:sldMk cId="1542364386" sldId="260"/>
            <ac:spMk id="10" creationId="{8CD5E067-4B42-4F66-ABD5-719EB6575925}"/>
          </ac:spMkLst>
        </pc:spChg>
        <pc:spChg chg="mod">
          <ac:chgData name="吉武 和敏" userId="e4825ba96748af9c" providerId="LiveId" clId="{7471937A-C170-42B0-9C6F-3DDC1BCC06B0}" dt="2022-06-06T08:54:33.762" v="737" actId="5793"/>
          <ac:spMkLst>
            <pc:docMk/>
            <pc:sldMk cId="1542364386" sldId="260"/>
            <ac:spMk id="13" creationId="{0F2357CD-443B-4806-88D5-D0166B71DD8B}"/>
          </ac:spMkLst>
        </pc:spChg>
        <pc:spChg chg="mod">
          <ac:chgData name="吉武 和敏" userId="e4825ba96748af9c" providerId="LiveId" clId="{7471937A-C170-42B0-9C6F-3DDC1BCC06B0}" dt="2022-08-31T06:24:02.843" v="2054" actId="20577"/>
          <ac:spMkLst>
            <pc:docMk/>
            <pc:sldMk cId="1542364386" sldId="260"/>
            <ac:spMk id="14" creationId="{A75E551B-345E-4D00-A4F1-F961C99F3B6F}"/>
          </ac:spMkLst>
        </pc:spChg>
        <pc:picChg chg="mod">
          <ac:chgData name="吉武 和敏" userId="e4825ba96748af9c" providerId="LiveId" clId="{7471937A-C170-42B0-9C6F-3DDC1BCC06B0}" dt="2022-06-06T08:54:45.699" v="738" actId="1076"/>
          <ac:picMkLst>
            <pc:docMk/>
            <pc:sldMk cId="1542364386" sldId="260"/>
            <ac:picMk id="2050" creationId="{0D145C3E-C513-4184-AEFB-2200D276FBEB}"/>
          </ac:picMkLst>
        </pc:picChg>
        <pc:picChg chg="mod">
          <ac:chgData name="吉武 和敏" userId="e4825ba96748af9c" providerId="LiveId" clId="{7471937A-C170-42B0-9C6F-3DDC1BCC06B0}" dt="2022-06-06T08:54:45.699" v="738" actId="1076"/>
          <ac:picMkLst>
            <pc:docMk/>
            <pc:sldMk cId="1542364386" sldId="260"/>
            <ac:picMk id="2052" creationId="{B1E9D8DB-BBAD-4C27-81C0-BA12F669C270}"/>
          </ac:picMkLst>
        </pc:picChg>
        <pc:cxnChg chg="add mod">
          <ac:chgData name="吉武 和敏" userId="e4825ba96748af9c" providerId="LiveId" clId="{7471937A-C170-42B0-9C6F-3DDC1BCC06B0}" dt="2022-06-06T08:55:57.103" v="749" actId="14100"/>
          <ac:cxnSpMkLst>
            <pc:docMk/>
            <pc:sldMk cId="1542364386" sldId="260"/>
            <ac:cxnSpMk id="7" creationId="{5648B448-F8FC-BB68-ADAD-38FAEB79CA15}"/>
          </ac:cxnSpMkLst>
        </pc:cxnChg>
        <pc:cxnChg chg="add mod">
          <ac:chgData name="吉武 和敏" userId="e4825ba96748af9c" providerId="LiveId" clId="{7471937A-C170-42B0-9C6F-3DDC1BCC06B0}" dt="2022-06-06T08:55:24.045" v="742" actId="208"/>
          <ac:cxnSpMkLst>
            <pc:docMk/>
            <pc:sldMk cId="1542364386" sldId="260"/>
            <ac:cxnSpMk id="16" creationId="{409185A4-4824-49C4-0EAB-37BB04623831}"/>
          </ac:cxnSpMkLst>
        </pc:cxnChg>
        <pc:cxnChg chg="add mod">
          <ac:chgData name="吉武 和敏" userId="e4825ba96748af9c" providerId="LiveId" clId="{7471937A-C170-42B0-9C6F-3DDC1BCC06B0}" dt="2022-06-06T08:56:04.626" v="750" actId="14100"/>
          <ac:cxnSpMkLst>
            <pc:docMk/>
            <pc:sldMk cId="1542364386" sldId="260"/>
            <ac:cxnSpMk id="18" creationId="{8AC8581D-0811-C223-D955-8A3347294064}"/>
          </ac:cxnSpMkLst>
        </pc:cxnChg>
        <pc:cxnChg chg="add mod">
          <ac:chgData name="吉武 和敏" userId="e4825ba96748af9c" providerId="LiveId" clId="{7471937A-C170-42B0-9C6F-3DDC1BCC06B0}" dt="2022-06-06T08:55:47.890" v="748" actId="14100"/>
          <ac:cxnSpMkLst>
            <pc:docMk/>
            <pc:sldMk cId="1542364386" sldId="260"/>
            <ac:cxnSpMk id="20" creationId="{84D6E4F1-DD0F-0369-4E6A-CC3FAEBD5698}"/>
          </ac:cxnSpMkLst>
        </pc:cxnChg>
      </pc:sldChg>
      <pc:sldChg chg="modSp mod">
        <pc:chgData name="吉武 和敏" userId="e4825ba96748af9c" providerId="LiveId" clId="{7471937A-C170-42B0-9C6F-3DDC1BCC06B0}" dt="2022-08-31T07:33:26.583" v="2170" actId="14734"/>
        <pc:sldMkLst>
          <pc:docMk/>
          <pc:sldMk cId="2806979806" sldId="262"/>
        </pc:sldMkLst>
        <pc:spChg chg="mod">
          <ac:chgData name="吉武 和敏" userId="e4825ba96748af9c" providerId="LiveId" clId="{7471937A-C170-42B0-9C6F-3DDC1BCC06B0}" dt="2022-07-15T02:04:40.946" v="2044" actId="6549"/>
          <ac:spMkLst>
            <pc:docMk/>
            <pc:sldMk cId="2806979806" sldId="262"/>
            <ac:spMk id="4" creationId="{511C915F-66A0-D349-8612-850522C1B5EF}"/>
          </ac:spMkLst>
        </pc:spChg>
        <pc:graphicFrameChg chg="mod modGraphic">
          <ac:chgData name="吉武 和敏" userId="e4825ba96748af9c" providerId="LiveId" clId="{7471937A-C170-42B0-9C6F-3DDC1BCC06B0}" dt="2022-08-31T07:33:26.583" v="2170" actId="14734"/>
          <ac:graphicFrameMkLst>
            <pc:docMk/>
            <pc:sldMk cId="2806979806" sldId="262"/>
            <ac:graphicFrameMk id="8" creationId="{6EF45101-230B-4BC4-8CA5-FF20480C115F}"/>
          </ac:graphicFrameMkLst>
        </pc:graphicFrameChg>
      </pc:sldChg>
      <pc:sldChg chg="addSp delSp modSp mod">
        <pc:chgData name="吉武 和敏" userId="e4825ba96748af9c" providerId="LiveId" clId="{7471937A-C170-42B0-9C6F-3DDC1BCC06B0}" dt="2022-06-17T07:30:54.330" v="1754" actId="20577"/>
        <pc:sldMkLst>
          <pc:docMk/>
          <pc:sldMk cId="2928055407" sldId="263"/>
        </pc:sldMkLst>
        <pc:spChg chg="del">
          <ac:chgData name="吉武 和敏" userId="e4825ba96748af9c" providerId="LiveId" clId="{7471937A-C170-42B0-9C6F-3DDC1BCC06B0}" dt="2022-06-17T02:59:42.771" v="753" actId="478"/>
          <ac:spMkLst>
            <pc:docMk/>
            <pc:sldMk cId="2928055407" sldId="263"/>
            <ac:spMk id="2" creationId="{A71CE9E3-C1C9-405E-952D-742D18F77EC2}"/>
          </ac:spMkLst>
        </pc:spChg>
        <pc:spChg chg="mod">
          <ac:chgData name="吉武 和敏" userId="e4825ba96748af9c" providerId="LiveId" clId="{7471937A-C170-42B0-9C6F-3DDC1BCC06B0}" dt="2022-06-17T07:30:54.330" v="1754" actId="20577"/>
          <ac:spMkLst>
            <pc:docMk/>
            <pc:sldMk cId="2928055407" sldId="263"/>
            <ac:spMk id="3" creationId="{F0DE7B9D-5B30-4F9D-9BE9-33D3637F3139}"/>
          </ac:spMkLst>
        </pc:spChg>
        <pc:spChg chg="del">
          <ac:chgData name="吉武 和敏" userId="e4825ba96748af9c" providerId="LiveId" clId="{7471937A-C170-42B0-9C6F-3DDC1BCC06B0}" dt="2022-06-17T02:59:42.771" v="753" actId="478"/>
          <ac:spMkLst>
            <pc:docMk/>
            <pc:sldMk cId="2928055407" sldId="263"/>
            <ac:spMk id="5" creationId="{76C4D899-8D4C-4C16-A522-CB4174A3DE2D}"/>
          </ac:spMkLst>
        </pc:spChg>
        <pc:spChg chg="del">
          <ac:chgData name="吉武 和敏" userId="e4825ba96748af9c" providerId="LiveId" clId="{7471937A-C170-42B0-9C6F-3DDC1BCC06B0}" dt="2022-06-17T02:59:42.771" v="753" actId="478"/>
          <ac:spMkLst>
            <pc:docMk/>
            <pc:sldMk cId="2928055407" sldId="263"/>
            <ac:spMk id="6" creationId="{CD371A82-A652-4504-BD39-F6436E1B7E1F}"/>
          </ac:spMkLst>
        </pc:spChg>
        <pc:spChg chg="del">
          <ac:chgData name="吉武 和敏" userId="e4825ba96748af9c" providerId="LiveId" clId="{7471937A-C170-42B0-9C6F-3DDC1BCC06B0}" dt="2022-06-17T02:59:42.771" v="753" actId="478"/>
          <ac:spMkLst>
            <pc:docMk/>
            <pc:sldMk cId="2928055407" sldId="263"/>
            <ac:spMk id="7" creationId="{E6C0304A-D98F-49C1-AD05-EB86EA9CB082}"/>
          </ac:spMkLst>
        </pc:spChg>
        <pc:spChg chg="del">
          <ac:chgData name="吉武 和敏" userId="e4825ba96748af9c" providerId="LiveId" clId="{7471937A-C170-42B0-9C6F-3DDC1BCC06B0}" dt="2022-06-17T02:59:42.771" v="753" actId="478"/>
          <ac:spMkLst>
            <pc:docMk/>
            <pc:sldMk cId="2928055407" sldId="263"/>
            <ac:spMk id="8" creationId="{2D390167-42A6-4416-9015-5BC7CDFB5E42}"/>
          </ac:spMkLst>
        </pc:spChg>
        <pc:graphicFrameChg chg="add mod modGraphic">
          <ac:chgData name="吉武 和敏" userId="e4825ba96748af9c" providerId="LiveId" clId="{7471937A-C170-42B0-9C6F-3DDC1BCC06B0}" dt="2022-06-17T07:11:02.637" v="1457" actId="20577"/>
          <ac:graphicFrameMkLst>
            <pc:docMk/>
            <pc:sldMk cId="2928055407" sldId="263"/>
            <ac:graphicFrameMk id="4" creationId="{AF1B748C-0DC0-D457-310A-71EF007B6026}"/>
          </ac:graphicFrameMkLst>
        </pc:graphicFrameChg>
        <pc:picChg chg="del">
          <ac:chgData name="吉武 和敏" userId="e4825ba96748af9c" providerId="LiveId" clId="{7471937A-C170-42B0-9C6F-3DDC1BCC06B0}" dt="2022-06-17T06:39:01.826" v="840" actId="478"/>
          <ac:picMkLst>
            <pc:docMk/>
            <pc:sldMk cId="2928055407" sldId="263"/>
            <ac:picMk id="11" creationId="{40FA97A9-BE06-48A4-9536-EF3EB3889FA8}"/>
          </ac:picMkLst>
        </pc:picChg>
      </pc:sldChg>
      <pc:sldChg chg="addSp delSp modSp mod">
        <pc:chgData name="吉武 和敏" userId="e4825ba96748af9c" providerId="LiveId" clId="{7471937A-C170-42B0-9C6F-3DDC1BCC06B0}" dt="2022-06-17T07:30:57.789" v="1756" actId="20577"/>
        <pc:sldMkLst>
          <pc:docMk/>
          <pc:sldMk cId="1214924586" sldId="264"/>
        </pc:sldMkLst>
        <pc:spChg chg="mod">
          <ac:chgData name="吉武 和敏" userId="e4825ba96748af9c" providerId="LiveId" clId="{7471937A-C170-42B0-9C6F-3DDC1BCC06B0}" dt="2022-06-17T07:30:57.789" v="1756" actId="20577"/>
          <ac:spMkLst>
            <pc:docMk/>
            <pc:sldMk cId="1214924586" sldId="264"/>
            <ac:spMk id="3" creationId="{1C8D6076-5E91-4163-86D4-51A223E85E0C}"/>
          </ac:spMkLst>
        </pc:spChg>
        <pc:spChg chg="del">
          <ac:chgData name="吉武 和敏" userId="e4825ba96748af9c" providerId="LiveId" clId="{7471937A-C170-42B0-9C6F-3DDC1BCC06B0}" dt="2022-06-17T07:11:27.308" v="1458" actId="478"/>
          <ac:spMkLst>
            <pc:docMk/>
            <pc:sldMk cId="1214924586" sldId="264"/>
            <ac:spMk id="4" creationId="{E54DA8D1-AAC3-4ACC-BB1F-2D1E4252F610}"/>
          </ac:spMkLst>
        </pc:spChg>
        <pc:graphicFrameChg chg="add del mod">
          <ac:chgData name="吉武 和敏" userId="e4825ba96748af9c" providerId="LiveId" clId="{7471937A-C170-42B0-9C6F-3DDC1BCC06B0}" dt="2022-06-17T06:59:01.938" v="953" actId="478"/>
          <ac:graphicFrameMkLst>
            <pc:docMk/>
            <pc:sldMk cId="1214924586" sldId="264"/>
            <ac:graphicFrameMk id="5" creationId="{C5290AB8-AAEA-1779-7EFC-724F586AFFE9}"/>
          </ac:graphicFrameMkLst>
        </pc:graphicFrameChg>
        <pc:graphicFrameChg chg="add del mod">
          <ac:chgData name="吉武 和敏" userId="e4825ba96748af9c" providerId="LiveId" clId="{7471937A-C170-42B0-9C6F-3DDC1BCC06B0}" dt="2022-06-17T06:59:11.424" v="955"/>
          <ac:graphicFrameMkLst>
            <pc:docMk/>
            <pc:sldMk cId="1214924586" sldId="264"/>
            <ac:graphicFrameMk id="6" creationId="{C32D0A71-8EB7-3C14-97D6-9F7177AA7E32}"/>
          </ac:graphicFrameMkLst>
        </pc:graphicFrameChg>
        <pc:graphicFrameChg chg="add mod modGraphic">
          <ac:chgData name="吉武 和敏" userId="e4825ba96748af9c" providerId="LiveId" clId="{7471937A-C170-42B0-9C6F-3DDC1BCC06B0}" dt="2022-06-17T07:15:47.309" v="1516" actId="20577"/>
          <ac:graphicFrameMkLst>
            <pc:docMk/>
            <pc:sldMk cId="1214924586" sldId="264"/>
            <ac:graphicFrameMk id="7" creationId="{C23A32DD-B22A-165B-9054-4627C221577B}"/>
          </ac:graphicFrameMkLst>
        </pc:graphicFrameChg>
        <pc:picChg chg="del">
          <ac:chgData name="吉武 和敏" userId="e4825ba96748af9c" providerId="LiveId" clId="{7471937A-C170-42B0-9C6F-3DDC1BCC06B0}" dt="2022-06-17T06:58:54.431" v="951" actId="478"/>
          <ac:picMkLst>
            <pc:docMk/>
            <pc:sldMk cId="1214924586" sldId="264"/>
            <ac:picMk id="2" creationId="{02EAFE4D-99D8-5441-B25E-37E535389B32}"/>
          </ac:picMkLst>
        </pc:picChg>
      </pc:sldChg>
      <pc:sldChg chg="modSp mod ord">
        <pc:chgData name="吉武 和敏" userId="e4825ba96748af9c" providerId="LiveId" clId="{7471937A-C170-42B0-9C6F-3DDC1BCC06B0}" dt="2022-07-15T02:04:33.985" v="2043" actId="6549"/>
        <pc:sldMkLst>
          <pc:docMk/>
          <pc:sldMk cId="3293758939" sldId="265"/>
        </pc:sldMkLst>
        <pc:spChg chg="mod">
          <ac:chgData name="吉武 和敏" userId="e4825ba96748af9c" providerId="LiveId" clId="{7471937A-C170-42B0-9C6F-3DDC1BCC06B0}" dt="2022-07-15T02:04:33.985" v="2043" actId="6549"/>
          <ac:spMkLst>
            <pc:docMk/>
            <pc:sldMk cId="3293758939" sldId="265"/>
            <ac:spMk id="4" creationId="{C99C5266-8372-43B0-824A-843B04EA19DF}"/>
          </ac:spMkLst>
        </pc:spChg>
      </pc:sldChg>
      <pc:sldChg chg="modSp mod ord">
        <pc:chgData name="吉武 和敏" userId="e4825ba96748af9c" providerId="LiveId" clId="{7471937A-C170-42B0-9C6F-3DDC1BCC06B0}" dt="2022-08-31T07:22:51.501" v="2110" actId="20577"/>
        <pc:sldMkLst>
          <pc:docMk/>
          <pc:sldMk cId="549526029" sldId="270"/>
        </pc:sldMkLst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15" creationId="{14C90151-FE65-47E2-A011-A5ABC036A431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16" creationId="{BC9BBE92-BF58-4A10-81F0-B694204EAD9A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17" creationId="{4C7B0BD2-DAD4-4367-85B7-BC19BB77F192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18" creationId="{3312C2DC-7835-403C-A3C9-C0C31DDCA916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19" creationId="{49AF99EF-0ECE-4953-A58D-7586138946EC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20" creationId="{1CAA7D10-F6A7-4B50-A9D0-8072D220EE49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21" creationId="{55E6D484-0EE8-4FC9-AC52-300982BCF67A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29" creationId="{1C0D539E-DBB4-47F2-BC07-FC0E1DDDECA1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0" creationId="{D14FA8E3-B9E8-4FE8-A009-47D4C205766C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1" creationId="{5E5647CA-8E4C-4A70-BA57-7C7E5D2CE5D7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2" creationId="{D18E7BF0-E70D-48F1-B34B-6D39421DCACE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3" creationId="{2BF1A2DB-BFF5-43E0-BA14-FC601F79BEC8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4" creationId="{A954818D-EF86-4443-B00E-EEE3C46514CE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5" creationId="{CDCAAA5C-3D14-4FC4-A913-249A3471B53F}"/>
          </ac:spMkLst>
        </pc:spChg>
        <pc:spChg chg="mod">
          <ac:chgData name="吉武 和敏" userId="e4825ba96748af9c" providerId="LiveId" clId="{7471937A-C170-42B0-9C6F-3DDC1BCC06B0}" dt="2022-08-31T07:22:51.501" v="2110" actId="20577"/>
          <ac:spMkLst>
            <pc:docMk/>
            <pc:sldMk cId="549526029" sldId="270"/>
            <ac:spMk id="36" creationId="{9B68D934-5BD7-B74E-B7C8-1DEB66CE07C4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7" creationId="{D6133BAF-5153-457F-A4E1-591BDABB5F99}"/>
          </ac:spMkLst>
        </pc:spChg>
        <pc:spChg chg="mod">
          <ac:chgData name="吉武 和敏" userId="e4825ba96748af9c" providerId="LiveId" clId="{7471937A-C170-42B0-9C6F-3DDC1BCC06B0}" dt="2022-06-06T08:43:18.589" v="486" actId="1076"/>
          <ac:spMkLst>
            <pc:docMk/>
            <pc:sldMk cId="549526029" sldId="270"/>
            <ac:spMk id="38" creationId="{BC80D470-3D00-401A-BE04-F4E3B5EC0A75}"/>
          </ac:spMkLst>
        </pc:spChg>
        <pc:picChg chg="mod modCrop">
          <ac:chgData name="吉武 和敏" userId="e4825ba96748af9c" providerId="LiveId" clId="{7471937A-C170-42B0-9C6F-3DDC1BCC06B0}" dt="2022-06-23T08:11:24.014" v="2035" actId="732"/>
          <ac:picMkLst>
            <pc:docMk/>
            <pc:sldMk cId="549526029" sldId="270"/>
            <ac:picMk id="3" creationId="{412B2D32-B0C7-45ED-8587-7D4EE4FC5DCA}"/>
          </ac:picMkLst>
        </pc:picChg>
        <pc:picChg chg="mod modCrop">
          <ac:chgData name="吉武 和敏" userId="e4825ba96748af9c" providerId="LiveId" clId="{7471937A-C170-42B0-9C6F-3DDC1BCC06B0}" dt="2022-06-23T08:11:04.988" v="2031" actId="732"/>
          <ac:picMkLst>
            <pc:docMk/>
            <pc:sldMk cId="549526029" sldId="270"/>
            <ac:picMk id="4" creationId="{3E731FC4-5B4E-483A-B273-E32BAAC7EB3A}"/>
          </ac:picMkLst>
        </pc:pic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6" creationId="{75B6111D-3A68-4F7D-9B6B-EFC429EC7C47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9" creationId="{DDFDA90B-F622-45F8-90D0-41D389C85843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10" creationId="{C0E99A34-CE09-4E96-812C-1C3AD28E8F56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11" creationId="{9671955D-B1D3-4DA6-8856-C53C8F764057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12" creationId="{C2A54EB0-9C15-4C5D-818D-C04E04D3F4C3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13" creationId="{EDAF7941-A96E-4AA3-AE62-BE142EE3AB8C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14" creationId="{0119B606-FB1F-4911-820A-04C9E5F35252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2" creationId="{FF99138F-8B33-4C65-9D20-63595C38AA97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3" creationId="{0102FFD8-465A-44AF-989E-6D54A6A2F175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4" creationId="{80186D92-8A84-4496-AA6C-79012ACEBB69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5" creationId="{EDDB0627-B36D-4154-99F4-6CB70B34F7FD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6" creationId="{8241671F-B955-4EA2-B4CD-613F826A0F4B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7" creationId="{CAF98E57-D148-4A08-951B-63953576FC17}"/>
          </ac:cxnSpMkLst>
        </pc:cxnChg>
        <pc:cxnChg chg="mod">
          <ac:chgData name="吉武 和敏" userId="e4825ba96748af9c" providerId="LiveId" clId="{7471937A-C170-42B0-9C6F-3DDC1BCC06B0}" dt="2022-06-06T08:43:18.589" v="486" actId="1076"/>
          <ac:cxnSpMkLst>
            <pc:docMk/>
            <pc:sldMk cId="549526029" sldId="270"/>
            <ac:cxnSpMk id="28" creationId="{8165324B-E17D-4B45-9559-3281837264EE}"/>
          </ac:cxnSpMkLst>
        </pc:cxnChg>
      </pc:sldChg>
      <pc:sldChg chg="addSp delSp modSp mod">
        <pc:chgData name="吉武 和敏" userId="e4825ba96748af9c" providerId="LiveId" clId="{7471937A-C170-42B0-9C6F-3DDC1BCC06B0}" dt="2022-08-31T09:35:12.731" v="2425" actId="1076"/>
        <pc:sldMkLst>
          <pc:docMk/>
          <pc:sldMk cId="1801781158" sldId="276"/>
        </pc:sldMkLst>
        <pc:spChg chg="add mod">
          <ac:chgData name="吉武 和敏" userId="e4825ba96748af9c" providerId="LiveId" clId="{7471937A-C170-42B0-9C6F-3DDC1BCC06B0}" dt="2022-06-20T10:24:58.766" v="1805" actId="1076"/>
          <ac:spMkLst>
            <pc:docMk/>
            <pc:sldMk cId="1801781158" sldId="276"/>
            <ac:spMk id="2" creationId="{45894BA9-78EF-959C-E3D8-E99AA99786AE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5" creationId="{21A89A21-92E7-599D-FB07-3B199C2FDC46}"/>
          </ac:spMkLst>
        </pc:spChg>
        <pc:spChg chg="add mod">
          <ac:chgData name="吉武 和敏" userId="e4825ba96748af9c" providerId="LiveId" clId="{7471937A-C170-42B0-9C6F-3DDC1BCC06B0}" dt="2022-08-31T09:35:07.445" v="2424" actId="1076"/>
          <ac:spMkLst>
            <pc:docMk/>
            <pc:sldMk cId="1801781158" sldId="276"/>
            <ac:spMk id="6" creationId="{25A12343-9DF1-9C5D-B334-EF1C9600EF9F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7" creationId="{8F5CEA84-570A-82B9-D016-80816EE55A31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8" creationId="{49502DED-403B-73C9-D579-A17F95CF488C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9" creationId="{3F4C919D-3C18-A3FB-FCA9-42396029C275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0" creationId="{0418A991-AF34-C076-13EB-2F140B59A7A1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1" creationId="{D7DE08B4-DF1F-B069-D71E-5C218E87DA3D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2" creationId="{95AB2837-FF05-C2FA-F30D-051010E69DA8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4" creationId="{171E57AE-10F3-3860-0275-18CEA29C9033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5" creationId="{FEE612EF-85C5-2458-55EB-9810E5181771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6" creationId="{4A7A0DCA-BF33-880B-51F8-F29E18CDB6BD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7" creationId="{35C58560-B0FD-9A82-F003-4DC9DA99FD67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18" creationId="{D2705BB1-C03F-34AC-1C62-D1533F1EA12F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21" creationId="{7DF03E91-B8C6-ED0D-C276-DFEB226C3816}"/>
          </ac:spMkLst>
        </pc:spChg>
        <pc:spChg chg="add del">
          <ac:chgData name="吉武 和敏" userId="e4825ba96748af9c" providerId="LiveId" clId="{7471937A-C170-42B0-9C6F-3DDC1BCC06B0}" dt="2022-08-31T09:11:53.301" v="2348" actId="478"/>
          <ac:spMkLst>
            <pc:docMk/>
            <pc:sldMk cId="1801781158" sldId="276"/>
            <ac:spMk id="22" creationId="{790881C8-48F7-A9E5-9C90-A8F6AECA88B8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23" creationId="{DE30182B-DD0F-8D37-94ED-541C0197FDD5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25" creationId="{47B61525-6D15-DFF0-5BAD-0D2FE721E504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28" creationId="{7792F13B-3D29-826E-2F97-A50C9BAF3554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31" creationId="{86FB7000-D2DD-A2DC-476A-E6493663C12A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34" creationId="{8CF31A29-2443-C53C-7DE6-E8F58C3A07B5}"/>
          </ac:spMkLst>
        </pc:spChg>
        <pc:spChg chg="add del mod">
          <ac:chgData name="吉武 和敏" userId="e4825ba96748af9c" providerId="LiveId" clId="{7471937A-C170-42B0-9C6F-3DDC1BCC06B0}" dt="2022-08-31T08:43:46.016" v="2261" actId="1076"/>
          <ac:spMkLst>
            <pc:docMk/>
            <pc:sldMk cId="1801781158" sldId="276"/>
            <ac:spMk id="35" creationId="{12A1D832-D779-4DD2-818D-D1FC523A92FD}"/>
          </ac:spMkLst>
        </pc:spChg>
        <pc:spChg chg="add mod">
          <ac:chgData name="吉武 和敏" userId="e4825ba96748af9c" providerId="LiveId" clId="{7471937A-C170-42B0-9C6F-3DDC1BCC06B0}" dt="2022-08-31T09:35:12.731" v="2425" actId="1076"/>
          <ac:spMkLst>
            <pc:docMk/>
            <pc:sldMk cId="1801781158" sldId="276"/>
            <ac:spMk id="55" creationId="{76FFCAE9-6606-EDF2-5011-453DC217120C}"/>
          </ac:spMkLst>
        </pc:spChg>
        <pc:spChg chg="add mod">
          <ac:chgData name="吉武 和敏" userId="e4825ba96748af9c" providerId="LiveId" clId="{7471937A-C170-42B0-9C6F-3DDC1BCC06B0}" dt="2022-08-31T09:35:03.242" v="2423" actId="1076"/>
          <ac:spMkLst>
            <pc:docMk/>
            <pc:sldMk cId="1801781158" sldId="276"/>
            <ac:spMk id="56" creationId="{3723856C-A631-09C9-3312-6234E7B85381}"/>
          </ac:spMkLst>
        </pc:spChg>
        <pc:spChg chg="add mod">
          <ac:chgData name="吉武 和敏" userId="e4825ba96748af9c" providerId="LiveId" clId="{7471937A-C170-42B0-9C6F-3DDC1BCC06B0}" dt="2022-08-31T09:34:22.105" v="2421" actId="404"/>
          <ac:spMkLst>
            <pc:docMk/>
            <pc:sldMk cId="1801781158" sldId="276"/>
            <ac:spMk id="57" creationId="{D867FF48-CF37-158C-7F83-1B50325EB8BA}"/>
          </ac:spMkLst>
        </pc:spChg>
        <pc:spChg chg="add del mod">
          <ac:chgData name="吉武 和敏" userId="e4825ba96748af9c" providerId="LiveId" clId="{7471937A-C170-42B0-9C6F-3DDC1BCC06B0}" dt="2022-05-30T01:08:00.135" v="15" actId="478"/>
          <ac:spMkLst>
            <pc:docMk/>
            <pc:sldMk cId="1801781158" sldId="276"/>
            <ac:spMk id="64" creationId="{0DFC9FA2-1A30-0C72-6C90-334CF01F9083}"/>
          </ac:spMkLst>
        </pc:spChg>
        <pc:spChg chg="del">
          <ac:chgData name="吉武 和敏" userId="e4825ba96748af9c" providerId="LiveId" clId="{7471937A-C170-42B0-9C6F-3DDC1BCC06B0}" dt="2022-05-30T01:02:37.151" v="0" actId="478"/>
          <ac:spMkLst>
            <pc:docMk/>
            <pc:sldMk cId="1801781158" sldId="276"/>
            <ac:spMk id="133" creationId="{82FB00B5-D625-498B-900D-5C8608CC7104}"/>
          </ac:spMkLst>
        </pc:spChg>
        <pc:spChg chg="mod topLvl">
          <ac:chgData name="吉武 和敏" userId="e4825ba96748af9c" providerId="LiveId" clId="{7471937A-C170-42B0-9C6F-3DDC1BCC06B0}" dt="2022-06-20T14:47:27.045" v="1976" actId="1076"/>
          <ac:spMkLst>
            <pc:docMk/>
            <pc:sldMk cId="1801781158" sldId="276"/>
            <ac:spMk id="134" creationId="{F33D7786-894E-4336-AFE2-08A3AA577998}"/>
          </ac:spMkLst>
        </pc:spChg>
        <pc:spChg chg="del">
          <ac:chgData name="吉武 和敏" userId="e4825ba96748af9c" providerId="LiveId" clId="{7471937A-C170-42B0-9C6F-3DDC1BCC06B0}" dt="2022-05-30T01:02:37.151" v="0" actId="478"/>
          <ac:spMkLst>
            <pc:docMk/>
            <pc:sldMk cId="1801781158" sldId="276"/>
            <ac:spMk id="135" creationId="{1D0ABAEF-3984-454A-86F3-3B0DDB5E52F8}"/>
          </ac:spMkLst>
        </pc:spChg>
        <pc:spChg chg="del mod topLvl">
          <ac:chgData name="吉武 和敏" userId="e4825ba96748af9c" providerId="LiveId" clId="{7471937A-C170-42B0-9C6F-3DDC1BCC06B0}" dt="2022-06-20T14:47:47.665" v="1980" actId="478"/>
          <ac:spMkLst>
            <pc:docMk/>
            <pc:sldMk cId="1801781158" sldId="276"/>
            <ac:spMk id="136" creationId="{E2B5A034-0262-44CB-8BA7-E8B423E4F198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38" creationId="{11FF698B-F8DB-481B-9C59-6D72A00D9CF3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39" creationId="{BD96449B-A802-4954-A154-71AEECB96297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0" creationId="{95CE1A66-B7B5-4E5B-858F-925807FFAB90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1" creationId="{F45D0294-DE9B-49E5-BF52-CDCA73551EB6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3" creationId="{369BB812-9A24-4023-8CF8-ADB828FDC1C9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4" creationId="{EBF54CF1-8573-4D79-9BA5-8D564729C43F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5" creationId="{027E2719-8D8D-457E-9C19-79349C72F8DA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6" creationId="{6DCA375F-4019-4121-B77A-4EA9256C15D8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7" creationId="{47B0ADE1-3FE0-473D-82AC-CA44562D4DA8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8" creationId="{F3BA8252-3A97-4DDB-A721-A7BDC1263F67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49" creationId="{9E729119-C4F3-460A-BF04-09CF5256D902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0" creationId="{C183F0C1-2F17-4EAA-AF8A-DEA7640F336E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2" creationId="{219E8449-60F7-4ED5-A3A9-9014D25CC3AB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3" creationId="{0EB6F97B-5A89-41A0-AE74-FF89F3C70301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4" creationId="{9AB105F9-0F13-422A-94F7-EF8F7ECD2546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5" creationId="{D6423DE5-7E93-42A1-8F16-29380ADD8C31}"/>
          </ac:spMkLst>
        </pc:spChg>
        <pc:spChg chg="mod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6" creationId="{1ABF2F5D-9B0D-43F5-A8FA-042C625144CE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7" creationId="{B5D44FB6-2169-4D27-902B-0C82934A361D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8" creationId="{DF0A16DE-BBB7-4D01-8F51-6347D5624A4B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59" creationId="{BFF3B753-F377-4D4C-A21E-4ED05B7769DF}"/>
          </ac:spMkLst>
        </pc:spChg>
        <pc:spChg chg="del mod topLvl">
          <ac:chgData name="吉武 和敏" userId="e4825ba96748af9c" providerId="LiveId" clId="{7471937A-C170-42B0-9C6F-3DDC1BCC06B0}" dt="2022-05-30T01:02:54.040" v="2" actId="478"/>
          <ac:spMkLst>
            <pc:docMk/>
            <pc:sldMk cId="1801781158" sldId="276"/>
            <ac:spMk id="160" creationId="{921BD71D-083F-444D-A5B6-D16ADD355D4F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61" creationId="{456EDE17-0BEB-4FD6-B2BF-CBC644F484F6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1" creationId="{7FDDE4DF-38E3-469C-87AC-17F37EE6C4D9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2" creationId="{F445CC41-5451-4D89-AABA-47434DA86D0E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3" creationId="{2E062E6D-08E1-4C43-A281-F77015C3E22F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4" creationId="{6E5A503D-858D-4E02-8905-14636F362771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5" creationId="{C56DE13D-05A8-4605-A40D-6A7F550037CB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6" creationId="{3F69BF02-CB5C-47FF-9B94-60E977F94814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7" creationId="{EA15BA34-50B2-4189-BD6C-2DE711AEAA25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8" creationId="{23FDB3CA-67AA-47CB-A302-E0401DB80423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79" creationId="{6EB05808-F5A4-408D-96BC-86FB5BDC6223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80" creationId="{BB7C322D-A523-4888-A765-2CCCD2A43234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81" creationId="{28F79B98-6E6D-4E30-8EB6-4A2BC00E8D28}"/>
          </ac:spMkLst>
        </pc:spChg>
        <pc:spChg chg="mod topLvl">
          <ac:chgData name="吉武 和敏" userId="e4825ba96748af9c" providerId="LiveId" clId="{7471937A-C170-42B0-9C6F-3DDC1BCC06B0}" dt="2022-06-20T14:47:19.807" v="1975" actId="1076"/>
          <ac:spMkLst>
            <pc:docMk/>
            <pc:sldMk cId="1801781158" sldId="276"/>
            <ac:spMk id="187" creationId="{BAE869FB-CACC-4D1C-B781-89AA83F228B8}"/>
          </ac:spMkLst>
        </pc:spChg>
        <pc:grpChg chg="del">
          <ac:chgData name="吉武 和敏" userId="e4825ba96748af9c" providerId="LiveId" clId="{7471937A-C170-42B0-9C6F-3DDC1BCC06B0}" dt="2022-05-30T01:02:50.254" v="1" actId="165"/>
          <ac:grpSpMkLst>
            <pc:docMk/>
            <pc:sldMk cId="1801781158" sldId="276"/>
            <ac:grpSpMk id="23" creationId="{C46D59B5-E620-4190-AA70-9841255DFD95}"/>
          </ac:grpSpMkLst>
        </pc:grpChg>
        <pc:grpChg chg="mod topLvl">
          <ac:chgData name="吉武 和敏" userId="e4825ba96748af9c" providerId="LiveId" clId="{7471937A-C170-42B0-9C6F-3DDC1BCC06B0}" dt="2022-06-20T14:47:19.807" v="1975" actId="1076"/>
          <ac:grpSpMkLst>
            <pc:docMk/>
            <pc:sldMk cId="1801781158" sldId="276"/>
            <ac:grpSpMk id="142" creationId="{93E04830-B4C2-4EB7-9934-1D6440F064C1}"/>
          </ac:grpSpMkLst>
        </pc:grpChg>
        <pc:grpChg chg="mod topLvl">
          <ac:chgData name="吉武 和敏" userId="e4825ba96748af9c" providerId="LiveId" clId="{7471937A-C170-42B0-9C6F-3DDC1BCC06B0}" dt="2022-06-20T14:47:19.807" v="1975" actId="1076"/>
          <ac:grpSpMkLst>
            <pc:docMk/>
            <pc:sldMk cId="1801781158" sldId="276"/>
            <ac:grpSpMk id="151" creationId="{3CA8B676-31F6-4D16-B87D-241898043E57}"/>
          </ac:grpSpMkLst>
        </pc:grpChg>
        <pc:graphicFrameChg chg="add mod">
          <ac:chgData name="吉武 和敏" userId="e4825ba96748af9c" providerId="LiveId" clId="{7471937A-C170-42B0-9C6F-3DDC1BCC06B0}" dt="2022-08-31T08:39:24.353" v="2177"/>
          <ac:graphicFrameMkLst>
            <pc:docMk/>
            <pc:sldMk cId="1801781158" sldId="276"/>
            <ac:graphicFrameMk id="3" creationId="{6D99FD67-8F0D-1940-99E6-732CE047D441}"/>
          </ac:graphicFrameMkLst>
        </pc:graphicFrameChg>
        <pc:graphicFrameChg chg="add mod">
          <ac:chgData name="吉武 和敏" userId="e4825ba96748af9c" providerId="LiveId" clId="{7471937A-C170-42B0-9C6F-3DDC1BCC06B0}" dt="2022-08-31T09:34:59.844" v="2422" actId="14100"/>
          <ac:graphicFrameMkLst>
            <pc:docMk/>
            <pc:sldMk cId="1801781158" sldId="276"/>
            <ac:graphicFrameMk id="53" creationId="{EEA8E0FE-310C-04CF-5F10-40945D7F55B9}"/>
          </ac:graphicFrameMkLst>
        </pc:graphicFrameChg>
        <pc:picChg chg="add mod modCrop">
          <ac:chgData name="吉武 和敏" userId="e4825ba96748af9c" providerId="LiveId" clId="{7471937A-C170-42B0-9C6F-3DDC1BCC06B0}" dt="2022-08-31T09:35:12.731" v="2425" actId="1076"/>
          <ac:picMkLst>
            <pc:docMk/>
            <pc:sldMk cId="1801781158" sldId="276"/>
            <ac:picMk id="4" creationId="{E6542F90-93D8-881B-C6D2-B493A469142A}"/>
          </ac:picMkLst>
        </pc:picChg>
        <pc:picChg chg="mod topLvl">
          <ac:chgData name="吉武 和敏" userId="e4825ba96748af9c" providerId="LiveId" clId="{7471937A-C170-42B0-9C6F-3DDC1BCC06B0}" dt="2022-06-20T14:47:19.807" v="1975" actId="1076"/>
          <ac:picMkLst>
            <pc:docMk/>
            <pc:sldMk cId="1801781158" sldId="276"/>
            <ac:picMk id="162" creationId="{8136D439-923F-4F99-B500-ED11224E7908}"/>
          </ac:picMkLst>
        </pc:picChg>
        <pc:picChg chg="del mod topLvl">
          <ac:chgData name="吉武 和敏" userId="e4825ba96748af9c" providerId="LiveId" clId="{7471937A-C170-42B0-9C6F-3DDC1BCC06B0}" dt="2022-05-30T01:02:54.040" v="2" actId="478"/>
          <ac:picMkLst>
            <pc:docMk/>
            <pc:sldMk cId="1801781158" sldId="276"/>
            <ac:picMk id="163" creationId="{6224FAE0-03E6-4A57-802B-DBECA44C13FE}"/>
          </ac:picMkLst>
        </pc:picChg>
        <pc:picChg chg="mod topLvl">
          <ac:chgData name="吉武 和敏" userId="e4825ba96748af9c" providerId="LiveId" clId="{7471937A-C170-42B0-9C6F-3DDC1BCC06B0}" dt="2022-06-20T14:47:19.807" v="1975" actId="1076"/>
          <ac:picMkLst>
            <pc:docMk/>
            <pc:sldMk cId="1801781158" sldId="276"/>
            <ac:picMk id="164" creationId="{76E9F69D-64B1-4CD7-8AE4-EC35905D1BB9}"/>
          </ac:picMkLst>
        </pc:picChg>
        <pc:cxnChg chg="add mod">
          <ac:chgData name="吉武 和敏" userId="e4825ba96748af9c" providerId="LiveId" clId="{7471937A-C170-42B0-9C6F-3DDC1BCC06B0}" dt="2022-08-31T09:35:12.731" v="2425" actId="1076"/>
          <ac:cxnSpMkLst>
            <pc:docMk/>
            <pc:sldMk cId="1801781158" sldId="276"/>
            <ac:cxnSpMk id="20" creationId="{95B9B1AF-1246-7196-FEFE-158B6C3EE496}"/>
          </ac:cxnSpMkLst>
        </pc:cxnChg>
        <pc:cxnChg chg="add mod">
          <ac:chgData name="吉武 和敏" userId="e4825ba96748af9c" providerId="LiveId" clId="{7471937A-C170-42B0-9C6F-3DDC1BCC06B0}" dt="2022-08-31T09:35:12.731" v="2425" actId="1076"/>
          <ac:cxnSpMkLst>
            <pc:docMk/>
            <pc:sldMk cId="1801781158" sldId="276"/>
            <ac:cxnSpMk id="29" creationId="{326BB7F9-AC61-57B9-23F2-2EF46A06D6A3}"/>
          </ac:cxnSpMkLst>
        </pc:cxnChg>
        <pc:cxnChg chg="add mod">
          <ac:chgData name="吉武 和敏" userId="e4825ba96748af9c" providerId="LiveId" clId="{7471937A-C170-42B0-9C6F-3DDC1BCC06B0}" dt="2022-08-31T09:35:12.731" v="2425" actId="1076"/>
          <ac:cxnSpMkLst>
            <pc:docMk/>
            <pc:sldMk cId="1801781158" sldId="276"/>
            <ac:cxnSpMk id="32" creationId="{5905AF0C-5CBB-7CB5-96B1-F2FA3D0F4209}"/>
          </ac:cxnSpMkLst>
        </pc:cxnChg>
        <pc:cxnChg chg="del">
          <ac:chgData name="吉武 和敏" userId="e4825ba96748af9c" providerId="LiveId" clId="{7471937A-C170-42B0-9C6F-3DDC1BCC06B0}" dt="2022-05-30T01:02:37.151" v="0" actId="478"/>
          <ac:cxnSpMkLst>
            <pc:docMk/>
            <pc:sldMk cId="1801781158" sldId="276"/>
            <ac:cxnSpMk id="131" creationId="{8ACC601B-614A-464F-9927-DAB717E1B501}"/>
          </ac:cxnSpMkLst>
        </pc:cxnChg>
        <pc:cxnChg chg="mod topLvl">
          <ac:chgData name="吉武 和敏" userId="e4825ba96748af9c" providerId="LiveId" clId="{7471937A-C170-42B0-9C6F-3DDC1BCC06B0}" dt="2022-06-20T14:47:36.245" v="1978" actId="14100"/>
          <ac:cxnSpMkLst>
            <pc:docMk/>
            <pc:sldMk cId="1801781158" sldId="276"/>
            <ac:cxnSpMk id="132" creationId="{A7D99360-283D-428A-9BA6-AD866DED1EEC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37" creationId="{EB710813-8EFF-4F60-923A-ED5B477BBBB0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65" creationId="{4C951DB4-DA8B-4585-B945-1E356CF557A8}"/>
          </ac:cxnSpMkLst>
        </pc:cxnChg>
        <pc:cxnChg chg="del mod topLvl">
          <ac:chgData name="吉武 和敏" userId="e4825ba96748af9c" providerId="LiveId" clId="{7471937A-C170-42B0-9C6F-3DDC1BCC06B0}" dt="2022-05-30T01:02:54.040" v="2" actId="478"/>
          <ac:cxnSpMkLst>
            <pc:docMk/>
            <pc:sldMk cId="1801781158" sldId="276"/>
            <ac:cxnSpMk id="166" creationId="{475D3CBE-77FE-4813-A1F9-30C193C7B5EC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67" creationId="{A646F50F-EF52-4046-91F2-CECAA63C7773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68" creationId="{873548B1-576C-4100-8EA4-2695968FAD72}"/>
          </ac:cxnSpMkLst>
        </pc:cxnChg>
        <pc:cxnChg chg="del mod topLvl">
          <ac:chgData name="吉武 和敏" userId="e4825ba96748af9c" providerId="LiveId" clId="{7471937A-C170-42B0-9C6F-3DDC1BCC06B0}" dt="2022-05-30T01:02:55.063" v="3" actId="478"/>
          <ac:cxnSpMkLst>
            <pc:docMk/>
            <pc:sldMk cId="1801781158" sldId="276"/>
            <ac:cxnSpMk id="169" creationId="{224311A3-0252-49EA-9D58-57223911ABFC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70" creationId="{B340C186-43EE-4030-A088-FA72954C1675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82" creationId="{54685350-1355-47FA-869D-1B70B0C9F84A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83" creationId="{E7ACECF8-C8FB-4EEB-90D3-EB44109BE816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84" creationId="{0A0B0A57-EC80-444E-B46B-C8B7227F5CB2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85" creationId="{E5F47915-62CB-4307-9CF0-373C42B40C25}"/>
          </ac:cxnSpMkLst>
        </pc:cxnChg>
        <pc:cxnChg chg="mod topLvl">
          <ac:chgData name="吉武 和敏" userId="e4825ba96748af9c" providerId="LiveId" clId="{7471937A-C170-42B0-9C6F-3DDC1BCC06B0}" dt="2022-06-20T14:47:19.807" v="1975" actId="1076"/>
          <ac:cxnSpMkLst>
            <pc:docMk/>
            <pc:sldMk cId="1801781158" sldId="276"/>
            <ac:cxnSpMk id="186" creationId="{B8C1FB6C-1E06-4E59-95B1-3B206C4ADDB4}"/>
          </ac:cxnSpMkLst>
        </pc:cxnChg>
      </pc:sldChg>
      <pc:sldChg chg="addSp delSp modSp mod">
        <pc:chgData name="吉武 和敏" userId="e4825ba96748af9c" providerId="LiveId" clId="{7471937A-C170-42B0-9C6F-3DDC1BCC06B0}" dt="2022-08-31T06:51:49.940" v="2108" actId="478"/>
        <pc:sldMkLst>
          <pc:docMk/>
          <pc:sldMk cId="2753622518" sldId="278"/>
        </pc:sldMkLst>
        <pc:spChg chg="del mod">
          <ac:chgData name="吉武 和敏" userId="e4825ba96748af9c" providerId="LiveId" clId="{7471937A-C170-42B0-9C6F-3DDC1BCC06B0}" dt="2022-08-31T06:49:34.597" v="2100" actId="478"/>
          <ac:spMkLst>
            <pc:docMk/>
            <pc:sldMk cId="2753622518" sldId="278"/>
            <ac:spMk id="5" creationId="{7F157F4B-724B-4DC6-B394-EA4EB26E75A4}"/>
          </ac:spMkLst>
        </pc:spChg>
        <pc:spChg chg="mod">
          <ac:chgData name="吉武 和敏" userId="e4825ba96748af9c" providerId="LiveId" clId="{7471937A-C170-42B0-9C6F-3DDC1BCC06B0}" dt="2022-05-30T01:27:11.231" v="28" actId="58"/>
          <ac:spMkLst>
            <pc:docMk/>
            <pc:sldMk cId="2753622518" sldId="278"/>
            <ac:spMk id="7" creationId="{AA34A617-FB96-41A7-B2A0-6C317647BC5E}"/>
          </ac:spMkLst>
        </pc:spChg>
        <pc:spChg chg="del mod">
          <ac:chgData name="吉武 和敏" userId="e4825ba96748af9c" providerId="LiveId" clId="{7471937A-C170-42B0-9C6F-3DDC1BCC06B0}" dt="2022-08-31T06:51:49.940" v="2108" actId="478"/>
          <ac:spMkLst>
            <pc:docMk/>
            <pc:sldMk cId="2753622518" sldId="278"/>
            <ac:spMk id="12" creationId="{5C46EBBB-7E82-475B-A781-4CC2462613E0}"/>
          </ac:spMkLst>
        </pc:spChg>
        <pc:spChg chg="add del mod">
          <ac:chgData name="吉武 和敏" userId="e4825ba96748af9c" providerId="LiveId" clId="{7471937A-C170-42B0-9C6F-3DDC1BCC06B0}" dt="2022-08-31T06:41:26.648" v="2058" actId="22"/>
          <ac:spMkLst>
            <pc:docMk/>
            <pc:sldMk cId="2753622518" sldId="278"/>
            <ac:spMk id="13" creationId="{D2B87581-FBBC-08AD-D1E2-1F23D4AEFF39}"/>
          </ac:spMkLst>
        </pc:spChg>
        <pc:spChg chg="add del mod">
          <ac:chgData name="吉武 和敏" userId="e4825ba96748af9c" providerId="LiveId" clId="{7471937A-C170-42B0-9C6F-3DDC1BCC06B0}" dt="2022-08-31T06:41:26.648" v="2058" actId="22"/>
          <ac:spMkLst>
            <pc:docMk/>
            <pc:sldMk cId="2753622518" sldId="278"/>
            <ac:spMk id="15" creationId="{148C0B69-F7AB-6E87-ABA5-06F94ADC3942}"/>
          </ac:spMkLst>
        </pc:spChg>
        <pc:spChg chg="add del mod">
          <ac:chgData name="吉武 和敏" userId="e4825ba96748af9c" providerId="LiveId" clId="{7471937A-C170-42B0-9C6F-3DDC1BCC06B0}" dt="2022-08-31T06:41:26.648" v="2058" actId="22"/>
          <ac:spMkLst>
            <pc:docMk/>
            <pc:sldMk cId="2753622518" sldId="278"/>
            <ac:spMk id="17" creationId="{C44E7D13-07D4-9238-D2F0-53F19F053D4A}"/>
          </ac:spMkLst>
        </pc:spChg>
        <pc:spChg chg="add del mod">
          <ac:chgData name="吉武 和敏" userId="e4825ba96748af9c" providerId="LiveId" clId="{7471937A-C170-42B0-9C6F-3DDC1BCC06B0}" dt="2022-08-31T06:41:26.648" v="2058" actId="22"/>
          <ac:spMkLst>
            <pc:docMk/>
            <pc:sldMk cId="2753622518" sldId="278"/>
            <ac:spMk id="19" creationId="{E37168B7-2F55-6093-EA23-65F3630981B4}"/>
          </ac:spMkLst>
        </pc:spChg>
        <pc:spChg chg="add mod">
          <ac:chgData name="吉武 和敏" userId="e4825ba96748af9c" providerId="LiveId" clId="{7471937A-C170-42B0-9C6F-3DDC1BCC06B0}" dt="2022-08-31T06:49:44.040" v="2101" actId="1076"/>
          <ac:spMkLst>
            <pc:docMk/>
            <pc:sldMk cId="2753622518" sldId="278"/>
            <ac:spMk id="21" creationId="{F3B7A881-71CE-7058-C0FD-190F7BE2FE72}"/>
          </ac:spMkLst>
        </pc:spChg>
        <pc:spChg chg="add del mod">
          <ac:chgData name="吉武 和敏" userId="e4825ba96748af9c" providerId="LiveId" clId="{7471937A-C170-42B0-9C6F-3DDC1BCC06B0}" dt="2022-08-31T06:41:47.750" v="2061" actId="478"/>
          <ac:spMkLst>
            <pc:docMk/>
            <pc:sldMk cId="2753622518" sldId="278"/>
            <ac:spMk id="22" creationId="{01AB5992-A2C9-823F-F37E-245546194AEC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24" creationId="{1149C7D9-C0E3-D434-2C60-93FB143D9157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26" creationId="{2B0336D1-ECC9-E532-A4DE-4C012EE520FE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28" creationId="{BF5FDF79-4E81-480E-6B89-DDF9481DBAD4}"/>
          </ac:spMkLst>
        </pc:spChg>
        <pc:spChg chg="mod">
          <ac:chgData name="吉武 和敏" userId="e4825ba96748af9c" providerId="LiveId" clId="{7471937A-C170-42B0-9C6F-3DDC1BCC06B0}" dt="2022-08-31T06:50:05.158" v="2105" actId="1076"/>
          <ac:spMkLst>
            <pc:docMk/>
            <pc:sldMk cId="2753622518" sldId="278"/>
            <ac:spMk id="29" creationId="{29074086-7EA3-45F0-BE5A-BD91D2B98C1A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30" creationId="{353F2C99-3928-4272-C49D-AB2ACD12B606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32" creationId="{5B9659F6-D61A-6BB6-401E-17DBBCE485FB}"/>
          </ac:spMkLst>
        </pc:spChg>
        <pc:spChg chg="add mod">
          <ac:chgData name="吉武 和敏" userId="e4825ba96748af9c" providerId="LiveId" clId="{7471937A-C170-42B0-9C6F-3DDC1BCC06B0}" dt="2022-08-31T06:51:15.386" v="2107" actId="404"/>
          <ac:spMkLst>
            <pc:docMk/>
            <pc:sldMk cId="2753622518" sldId="278"/>
            <ac:spMk id="33" creationId="{754CA035-E314-A299-4D52-0A258182FD88}"/>
          </ac:spMkLst>
        </pc:spChg>
        <pc:spChg chg="add mod">
          <ac:chgData name="吉武 和敏" userId="e4825ba96748af9c" providerId="LiveId" clId="{7471937A-C170-42B0-9C6F-3DDC1BCC06B0}" dt="2022-08-31T06:51:15.386" v="2107" actId="404"/>
          <ac:spMkLst>
            <pc:docMk/>
            <pc:sldMk cId="2753622518" sldId="278"/>
            <ac:spMk id="34" creationId="{A0C844A6-1E13-D989-BEED-29C64C3F1181}"/>
          </ac:spMkLst>
        </pc:spChg>
        <pc:spChg chg="add del mod">
          <ac:chgData name="吉武 和敏" userId="e4825ba96748af9c" providerId="LiveId" clId="{7471937A-C170-42B0-9C6F-3DDC1BCC06B0}" dt="2022-08-31T06:46:08.485" v="2082" actId="478"/>
          <ac:spMkLst>
            <pc:docMk/>
            <pc:sldMk cId="2753622518" sldId="278"/>
            <ac:spMk id="35" creationId="{9751C1B1-91BF-A61A-E92E-237B04AA5CA3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37" creationId="{BF71E1CD-0980-B237-5E72-2A9D851F406A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38" creationId="{647B9A9F-8270-63FB-F70A-57FAD74DA6BA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39" creationId="{E1DAB826-F472-7463-C8B1-75D6B57B0264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40" creationId="{608D0E37-432F-33E9-3CD9-367C47C3FC28}"/>
          </ac:spMkLst>
        </pc:spChg>
        <pc:spChg chg="mod">
          <ac:chgData name="吉武 和敏" userId="e4825ba96748af9c" providerId="LiveId" clId="{7471937A-C170-42B0-9C6F-3DDC1BCC06B0}" dt="2022-08-31T06:41:42.891" v="2059"/>
          <ac:spMkLst>
            <pc:docMk/>
            <pc:sldMk cId="2753622518" sldId="278"/>
            <ac:spMk id="41" creationId="{EEDBBC71-0E41-7FCF-938E-22F4E0208047}"/>
          </ac:spMkLst>
        </pc:spChg>
        <pc:spChg chg="add mod">
          <ac:chgData name="吉武 和敏" userId="e4825ba96748af9c" providerId="LiveId" clId="{7471937A-C170-42B0-9C6F-3DDC1BCC06B0}" dt="2022-08-31T06:51:15.386" v="2107" actId="404"/>
          <ac:spMkLst>
            <pc:docMk/>
            <pc:sldMk cId="2753622518" sldId="278"/>
            <ac:spMk id="42" creationId="{A3270222-1BE2-BC9D-FDA6-3E7E6D326D61}"/>
          </ac:spMkLst>
        </pc:spChg>
        <pc:spChg chg="add del mod">
          <ac:chgData name="吉武 和敏" userId="e4825ba96748af9c" providerId="LiveId" clId="{7471937A-C170-42B0-9C6F-3DDC1BCC06B0}" dt="2022-08-31T06:48:51.493" v="2092" actId="478"/>
          <ac:spMkLst>
            <pc:docMk/>
            <pc:sldMk cId="2753622518" sldId="278"/>
            <ac:spMk id="43" creationId="{F662D6DF-A298-4330-C622-B63810958B25}"/>
          </ac:spMkLst>
        </pc:spChg>
        <pc:spChg chg="add mod">
          <ac:chgData name="吉武 和敏" userId="e4825ba96748af9c" providerId="LiveId" clId="{7471937A-C170-42B0-9C6F-3DDC1BCC06B0}" dt="2022-08-31T06:51:15.386" v="2107" actId="404"/>
          <ac:spMkLst>
            <pc:docMk/>
            <pc:sldMk cId="2753622518" sldId="278"/>
            <ac:spMk id="45" creationId="{679D4ECB-B9A1-FB37-B2FC-8C9F8B5048CE}"/>
          </ac:spMkLst>
        </pc:spChg>
        <pc:grpChg chg="add del mod">
          <ac:chgData name="吉武 和敏" userId="e4825ba96748af9c" providerId="LiveId" clId="{7471937A-C170-42B0-9C6F-3DDC1BCC06B0}" dt="2022-08-31T06:41:49.239" v="2062" actId="478"/>
          <ac:grpSpMkLst>
            <pc:docMk/>
            <pc:sldMk cId="2753622518" sldId="278"/>
            <ac:grpSpMk id="23" creationId="{16164F5D-92A2-553D-08B1-BA7F12FB19F0}"/>
          </ac:grpSpMkLst>
        </pc:grpChg>
        <pc:grpChg chg="add del mod">
          <ac:chgData name="吉武 和敏" userId="e4825ba96748af9c" providerId="LiveId" clId="{7471937A-C170-42B0-9C6F-3DDC1BCC06B0}" dt="2022-08-31T06:41:51.686" v="2063" actId="478"/>
          <ac:grpSpMkLst>
            <pc:docMk/>
            <pc:sldMk cId="2753622518" sldId="278"/>
            <ac:grpSpMk id="36" creationId="{01BA45C2-18AB-D790-76C8-CB0ED6B4D366}"/>
          </ac:grpSpMkLst>
        </pc:grpChg>
        <pc:cxnChg chg="add mod">
          <ac:chgData name="吉武 和敏" userId="e4825ba96748af9c" providerId="LiveId" clId="{7471937A-C170-42B0-9C6F-3DDC1BCC06B0}" dt="2022-08-31T06:50:17.936" v="2106" actId="14100"/>
          <ac:cxnSpMkLst>
            <pc:docMk/>
            <pc:sldMk cId="2753622518" sldId="278"/>
            <ac:cxnSpMk id="20" creationId="{043A4CB9-F3AD-DDA7-A308-E84FEF8EC369}"/>
          </ac:cxnSpMkLst>
        </pc:cxnChg>
      </pc:sldChg>
      <pc:sldChg chg="addSp delSp modSp mod delAnim">
        <pc:chgData name="吉武 和敏" userId="e4825ba96748af9c" providerId="LiveId" clId="{7471937A-C170-42B0-9C6F-3DDC1BCC06B0}" dt="2022-08-31T07:28:42.705" v="2147" actId="14100"/>
        <pc:sldMkLst>
          <pc:docMk/>
          <pc:sldMk cId="731570627" sldId="849"/>
        </pc:sldMkLst>
        <pc:spChg chg="add mod">
          <ac:chgData name="吉武 和敏" userId="e4825ba96748af9c" providerId="LiveId" clId="{7471937A-C170-42B0-9C6F-3DDC1BCC06B0}" dt="2022-08-31T07:28:23.229" v="2135" actId="20577"/>
          <ac:spMkLst>
            <pc:docMk/>
            <pc:sldMk cId="731570627" sldId="849"/>
            <ac:spMk id="11" creationId="{8F22E3BD-A3DA-BEF7-A0BF-0A12F33A76B3}"/>
          </ac:spMkLst>
        </pc:spChg>
        <pc:spChg chg="mod">
          <ac:chgData name="吉武 和敏" userId="e4825ba96748af9c" providerId="LiveId" clId="{7471937A-C170-42B0-9C6F-3DDC1BCC06B0}" dt="2022-08-31T07:26:58.789" v="2112" actId="21"/>
          <ac:spMkLst>
            <pc:docMk/>
            <pc:sldMk cId="731570627" sldId="849"/>
            <ac:spMk id="13" creationId="{58192918-1D3F-4432-8675-2210F8E4BEFD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14" creationId="{3A20B7D2-392E-4303-8F34-BF3EE5B76636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15" creationId="{72185980-969C-45D6-A755-E0F44EDD07E4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16" creationId="{E9A2BC1B-716E-402C-B184-D7FC59A5E1E7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17" creationId="{B0E096C1-C4BA-4D54-99FE-46E57F5CAC4F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18" creationId="{C862FE55-7F22-4E04-83CA-60F5D3679034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19" creationId="{CC651CF2-E12F-40D9-B03F-2D2B1E60F4FF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20" creationId="{004BBF05-7158-4EF6-B1BA-F2675548717A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21" creationId="{76AE29A8-F744-4B03-976E-4B68E3FC6903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22" creationId="{46BB1C3D-AE29-481A-87F3-14B6BDB58A50}"/>
          </ac:spMkLst>
        </pc:spChg>
        <pc:spChg chg="add mod">
          <ac:chgData name="吉武 和敏" userId="e4825ba96748af9c" providerId="LiveId" clId="{7471937A-C170-42B0-9C6F-3DDC1BCC06B0}" dt="2022-08-31T07:27:30.084" v="2121" actId="571"/>
          <ac:spMkLst>
            <pc:docMk/>
            <pc:sldMk cId="731570627" sldId="849"/>
            <ac:spMk id="23" creationId="{8C371165-CF52-2C8C-8309-B7FAD01EC663}"/>
          </ac:spMkLst>
        </pc:spChg>
        <pc:spChg chg="mod">
          <ac:chgData name="吉武 和敏" userId="e4825ba96748af9c" providerId="LiveId" clId="{7471937A-C170-42B0-9C6F-3DDC1BCC06B0}" dt="2022-06-17T06:02:55.932" v="759" actId="20577"/>
          <ac:spMkLst>
            <pc:docMk/>
            <pc:sldMk cId="731570627" sldId="849"/>
            <ac:spMk id="25" creationId="{7FC81EE4-1C66-44E1-AF05-A528AFD213DC}"/>
          </ac:spMkLst>
        </pc:spChg>
        <pc:spChg chg="mod">
          <ac:chgData name="吉武 和敏" userId="e4825ba96748af9c" providerId="LiveId" clId="{7471937A-C170-42B0-9C6F-3DDC1BCC06B0}" dt="2022-08-31T07:28:42.705" v="2147" actId="14100"/>
          <ac:spMkLst>
            <pc:docMk/>
            <pc:sldMk cId="731570627" sldId="849"/>
            <ac:spMk id="26" creationId="{BB32BB4D-729C-4957-969B-32107EB4D1E2}"/>
          </ac:spMkLst>
        </pc:spChg>
        <pc:spChg chg="mod">
          <ac:chgData name="吉武 和敏" userId="e4825ba96748af9c" providerId="LiveId" clId="{7471937A-C170-42B0-9C6F-3DDC1BCC06B0}" dt="2022-07-15T02:04:46.257" v="2045" actId="20577"/>
          <ac:spMkLst>
            <pc:docMk/>
            <pc:sldMk cId="731570627" sldId="849"/>
            <ac:spMk id="27" creationId="{B56048B9-A433-4A98-B8C4-403F245586F2}"/>
          </ac:spMkLst>
        </pc:spChg>
        <pc:spChg chg="add mod">
          <ac:chgData name="吉武 和敏" userId="e4825ba96748af9c" providerId="LiveId" clId="{7471937A-C170-42B0-9C6F-3DDC1BCC06B0}" dt="2022-08-31T07:28:10.173" v="2134" actId="1035"/>
          <ac:spMkLst>
            <pc:docMk/>
            <pc:sldMk cId="731570627" sldId="849"/>
            <ac:spMk id="28" creationId="{98837C13-3231-F151-87DE-A76D673E1AD6}"/>
          </ac:spMkLst>
        </pc:spChg>
        <pc:spChg chg="del">
          <ac:chgData name="吉武 和敏" userId="e4825ba96748af9c" providerId="LiveId" clId="{7471937A-C170-42B0-9C6F-3DDC1BCC06B0}" dt="2022-06-06T16:53:15.690" v="752" actId="478"/>
          <ac:spMkLst>
            <pc:docMk/>
            <pc:sldMk cId="731570627" sldId="849"/>
            <ac:spMk id="28" creationId="{9AB47BBD-DCCE-4D37-8151-6AD97F9917AA}"/>
          </ac:spMkLst>
        </pc:spChg>
        <pc:spChg chg="del">
          <ac:chgData name="吉武 和敏" userId="e4825ba96748af9c" providerId="LiveId" clId="{7471937A-C170-42B0-9C6F-3DDC1BCC06B0}" dt="2022-06-06T16:53:15.690" v="752" actId="478"/>
          <ac:spMkLst>
            <pc:docMk/>
            <pc:sldMk cId="731570627" sldId="849"/>
            <ac:spMk id="29" creationId="{E8985CD3-DF1A-4B67-BE45-57AC768A588D}"/>
          </ac:spMkLst>
        </pc:spChg>
        <pc:spChg chg="del">
          <ac:chgData name="吉武 和敏" userId="e4825ba96748af9c" providerId="LiveId" clId="{7471937A-C170-42B0-9C6F-3DDC1BCC06B0}" dt="2022-06-06T16:53:15.690" v="752" actId="478"/>
          <ac:spMkLst>
            <pc:docMk/>
            <pc:sldMk cId="731570627" sldId="849"/>
            <ac:spMk id="30" creationId="{A33342B1-37D8-4CDB-B660-40D486DB32C7}"/>
          </ac:spMkLst>
        </pc:spChg>
        <pc:spChg chg="del">
          <ac:chgData name="吉武 和敏" userId="e4825ba96748af9c" providerId="LiveId" clId="{7471937A-C170-42B0-9C6F-3DDC1BCC06B0}" dt="2022-06-06T16:53:15.690" v="752" actId="478"/>
          <ac:spMkLst>
            <pc:docMk/>
            <pc:sldMk cId="731570627" sldId="849"/>
            <ac:spMk id="31" creationId="{4BAE4256-DF19-4FEA-9303-1C59D608920B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32" creationId="{BF632E63-1009-4319-A02D-4DE7E4B511C7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33" creationId="{B35105A8-391C-4926-8F7C-FC34F1BE1AC4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34" creationId="{B3C0C293-42B2-4F35-9D6A-7C5C20BF4FA1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37" creationId="{A79AF4C4-063E-4D62-9A23-11AE238D34B4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38" creationId="{8992DB48-9963-4577-9A3B-0F1CAEEB8DC3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39" creationId="{036180F1-3608-4F45-B835-E322DAB0767E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41" creationId="{DB8F1385-3281-49E5-88A3-55C4E58C1404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42" creationId="{A8307465-822B-4E76-8842-B47A4713D478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43" creationId="{698FDE34-BFEE-4AE9-A729-C4F085740ABD}"/>
          </ac:spMkLst>
        </pc:spChg>
        <pc:spChg chg="del">
          <ac:chgData name="吉武 和敏" userId="e4825ba96748af9c" providerId="LiveId" clId="{7471937A-C170-42B0-9C6F-3DDC1BCC06B0}" dt="2022-06-06T16:53:15.690" v="752" actId="478"/>
          <ac:spMkLst>
            <pc:docMk/>
            <pc:sldMk cId="731570627" sldId="849"/>
            <ac:spMk id="44" creationId="{2F54EA21-64D5-4A6C-950D-ADA26AF7DD87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45" creationId="{3100CDE7-91FA-40A7-9DFE-65821B43A00D}"/>
          </ac:spMkLst>
        </pc:spChg>
        <pc:spChg chg="mod">
          <ac:chgData name="吉武 和敏" userId="e4825ba96748af9c" providerId="LiveId" clId="{7471937A-C170-42B0-9C6F-3DDC1BCC06B0}" dt="2022-08-31T07:26:53.784" v="2111" actId="1076"/>
          <ac:spMkLst>
            <pc:docMk/>
            <pc:sldMk cId="731570627" sldId="849"/>
            <ac:spMk id="46" creationId="{79DFFE87-2D56-4693-88C2-FDB43BEAC581}"/>
          </ac:spMkLst>
        </pc:spChg>
        <pc:grpChg chg="mod">
          <ac:chgData name="吉武 和敏" userId="e4825ba96748af9c" providerId="LiveId" clId="{7471937A-C170-42B0-9C6F-3DDC1BCC06B0}" dt="2022-08-31T07:26:53.784" v="2111" actId="1076"/>
          <ac:grpSpMkLst>
            <pc:docMk/>
            <pc:sldMk cId="731570627" sldId="849"/>
            <ac:grpSpMk id="50" creationId="{2E8573AE-45D0-40FF-A188-8DD4553EFF60}"/>
          </ac:grpSpMkLst>
        </pc:grpChg>
      </pc:sldChg>
    </pc:docChg>
  </pc:docChgLst>
  <pc:docChgLst>
    <pc:chgData name="吉武 和敏" userId="e4825ba96748af9c" providerId="LiveId" clId="{7D9BC6C3-ADD0-49E2-9986-EB182164A847}"/>
    <pc:docChg chg="undo custSel delSld modSld sldOrd">
      <pc:chgData name="吉武 和敏" userId="e4825ba96748af9c" providerId="LiveId" clId="{7D9BC6C3-ADD0-49E2-9986-EB182164A847}" dt="2022-03-18T09:41:25.905" v="1983" actId="22"/>
      <pc:docMkLst>
        <pc:docMk/>
      </pc:docMkLst>
      <pc:sldChg chg="addSp delSp mod">
        <pc:chgData name="吉武 和敏" userId="e4825ba96748af9c" providerId="LiveId" clId="{7D9BC6C3-ADD0-49E2-9986-EB182164A847}" dt="2022-03-18T09:41:25.905" v="1983" actId="22"/>
        <pc:sldMkLst>
          <pc:docMk/>
          <pc:sldMk cId="2737082793" sldId="257"/>
        </pc:sldMkLst>
        <pc:spChg chg="del">
          <ac:chgData name="吉武 和敏" userId="e4825ba96748af9c" providerId="LiveId" clId="{7D9BC6C3-ADD0-49E2-9986-EB182164A847}" dt="2022-03-18T09:41:25.561" v="1982" actId="478"/>
          <ac:spMkLst>
            <pc:docMk/>
            <pc:sldMk cId="2737082793" sldId="257"/>
            <ac:spMk id="4" creationId="{CEDEE7A9-479C-4974-BAA9-DD9A48AAD6AD}"/>
          </ac:spMkLst>
        </pc:spChg>
        <pc:picChg chg="del">
          <ac:chgData name="吉武 和敏" userId="e4825ba96748af9c" providerId="LiveId" clId="{7D9BC6C3-ADD0-49E2-9986-EB182164A847}" dt="2022-03-18T09:41:25.561" v="1982" actId="478"/>
          <ac:picMkLst>
            <pc:docMk/>
            <pc:sldMk cId="2737082793" sldId="257"/>
            <ac:picMk id="2" creationId="{AE7EDBB8-6C1C-944A-8348-6BAA9379288C}"/>
          </ac:picMkLst>
        </pc:picChg>
        <pc:picChg chg="add">
          <ac:chgData name="吉武 和敏" userId="e4825ba96748af9c" providerId="LiveId" clId="{7D9BC6C3-ADD0-49E2-9986-EB182164A847}" dt="2022-03-18T09:41:25.905" v="1983" actId="22"/>
          <ac:picMkLst>
            <pc:docMk/>
            <pc:sldMk cId="2737082793" sldId="257"/>
            <ac:picMk id="5" creationId="{06AD9A8E-203A-469F-B75D-C2795674AA7A}"/>
          </ac:picMkLst>
        </pc:picChg>
      </pc:sldChg>
      <pc:sldChg chg="addSp modSp mod ord">
        <pc:chgData name="吉武 和敏" userId="e4825ba96748af9c" providerId="LiveId" clId="{7D9BC6C3-ADD0-49E2-9986-EB182164A847}" dt="2022-03-18T08:16:08.201" v="1969" actId="20577"/>
        <pc:sldMkLst>
          <pc:docMk/>
          <pc:sldMk cId="1542364386" sldId="260"/>
        </pc:sldMkLst>
        <pc:spChg chg="add mod">
          <ac:chgData name="吉武 和敏" userId="e4825ba96748af9c" providerId="LiveId" clId="{7D9BC6C3-ADD0-49E2-9986-EB182164A847}" dt="2022-03-18T08:16:08.201" v="1969" actId="20577"/>
          <ac:spMkLst>
            <pc:docMk/>
            <pc:sldMk cId="1542364386" sldId="260"/>
            <ac:spMk id="14" creationId="{A75E551B-345E-4D00-A4F1-F961C99F3B6F}"/>
          </ac:spMkLst>
        </pc:spChg>
      </pc:sldChg>
      <pc:sldChg chg="modSp mod">
        <pc:chgData name="吉武 和敏" userId="e4825ba96748af9c" providerId="LiveId" clId="{7D9BC6C3-ADD0-49E2-9986-EB182164A847}" dt="2022-03-18T06:46:25.130" v="996" actId="1076"/>
        <pc:sldMkLst>
          <pc:docMk/>
          <pc:sldMk cId="2806979806" sldId="262"/>
        </pc:sldMkLst>
        <pc:graphicFrameChg chg="mod modGraphic">
          <ac:chgData name="吉武 和敏" userId="e4825ba96748af9c" providerId="LiveId" clId="{7D9BC6C3-ADD0-49E2-9986-EB182164A847}" dt="2022-03-18T06:46:25.130" v="996" actId="1076"/>
          <ac:graphicFrameMkLst>
            <pc:docMk/>
            <pc:sldMk cId="2806979806" sldId="262"/>
            <ac:graphicFrameMk id="8" creationId="{6EF45101-230B-4BC4-8CA5-FF20480C115F}"/>
          </ac:graphicFrameMkLst>
        </pc:graphicFrameChg>
        <pc:picChg chg="mod">
          <ac:chgData name="吉武 和敏" userId="e4825ba96748af9c" providerId="LiveId" clId="{7D9BC6C3-ADD0-49E2-9986-EB182164A847}" dt="2022-03-18T06:45:25.739" v="984" actId="1076"/>
          <ac:picMkLst>
            <pc:docMk/>
            <pc:sldMk cId="2806979806" sldId="262"/>
            <ac:picMk id="7" creationId="{1CACE172-1607-4966-8E1D-A997A63CD4CA}"/>
          </ac:picMkLst>
        </pc:picChg>
      </pc:sldChg>
      <pc:sldChg chg="addSp delSp modSp mod">
        <pc:chgData name="吉武 和敏" userId="e4825ba96748af9c" providerId="LiveId" clId="{7D9BC6C3-ADD0-49E2-9986-EB182164A847}" dt="2022-03-18T08:12:48.806" v="1946"/>
        <pc:sldMkLst>
          <pc:docMk/>
          <pc:sldMk cId="2928055407" sldId="263"/>
        </pc:sldMkLst>
        <pc:spChg chg="add del mod">
          <ac:chgData name="吉武 和敏" userId="e4825ba96748af9c" providerId="LiveId" clId="{7D9BC6C3-ADD0-49E2-9986-EB182164A847}" dt="2022-03-18T08:11:13.276" v="1856"/>
          <ac:spMkLst>
            <pc:docMk/>
            <pc:sldMk cId="2928055407" sldId="263"/>
            <ac:spMk id="4" creationId="{8CA147CB-14E6-4A23-957C-2DD1BA6002CE}"/>
          </ac:spMkLst>
        </pc:spChg>
        <pc:spChg chg="add del mod">
          <ac:chgData name="吉武 和敏" userId="e4825ba96748af9c" providerId="LiveId" clId="{7D9BC6C3-ADD0-49E2-9986-EB182164A847}" dt="2022-03-18T08:11:41.702" v="1881"/>
          <ac:spMkLst>
            <pc:docMk/>
            <pc:sldMk cId="2928055407" sldId="263"/>
            <ac:spMk id="9" creationId="{487C5349-E467-4999-8A6A-386F6BDE8850}"/>
          </ac:spMkLst>
        </pc:spChg>
        <pc:spChg chg="add del mod">
          <ac:chgData name="吉武 和敏" userId="e4825ba96748af9c" providerId="LiveId" clId="{7D9BC6C3-ADD0-49E2-9986-EB182164A847}" dt="2022-03-18T08:12:16.408" v="1917"/>
          <ac:spMkLst>
            <pc:docMk/>
            <pc:sldMk cId="2928055407" sldId="263"/>
            <ac:spMk id="10" creationId="{7FBCBCDD-77F0-4BD5-9953-388E98EEEB55}"/>
          </ac:spMkLst>
        </pc:spChg>
        <pc:spChg chg="add del mod">
          <ac:chgData name="吉武 和敏" userId="e4825ba96748af9c" providerId="LiveId" clId="{7D9BC6C3-ADD0-49E2-9986-EB182164A847}" dt="2022-03-18T08:12:48.806" v="1946"/>
          <ac:spMkLst>
            <pc:docMk/>
            <pc:sldMk cId="2928055407" sldId="263"/>
            <ac:spMk id="12" creationId="{473EC2E5-14B9-46F1-9786-121E3E1ECC1C}"/>
          </ac:spMkLst>
        </pc:spChg>
      </pc:sldChg>
      <pc:sldChg chg="addSp delSp modSp mod ord">
        <pc:chgData name="吉武 和敏" userId="e4825ba96748af9c" providerId="LiveId" clId="{7D9BC6C3-ADD0-49E2-9986-EB182164A847}" dt="2022-03-18T08:16:15.594" v="1981" actId="20577"/>
        <pc:sldMkLst>
          <pc:docMk/>
          <pc:sldMk cId="3293758939" sldId="265"/>
        </pc:sldMkLst>
        <pc:spChg chg="mod">
          <ac:chgData name="吉武 和敏" userId="e4825ba96748af9c" providerId="LiveId" clId="{7D9BC6C3-ADD0-49E2-9986-EB182164A847}" dt="2022-03-18T08:16:15.594" v="1981" actId="20577"/>
          <ac:spMkLst>
            <pc:docMk/>
            <pc:sldMk cId="3293758939" sldId="265"/>
            <ac:spMk id="4" creationId="{C99C5266-8372-43B0-824A-843B04EA19DF}"/>
          </ac:spMkLst>
        </pc:spChg>
        <pc:spChg chg="del">
          <ac:chgData name="吉武 和敏" userId="e4825ba96748af9c" providerId="LiveId" clId="{7D9BC6C3-ADD0-49E2-9986-EB182164A847}" dt="2022-03-18T08:13:19.769" v="1958" actId="478"/>
          <ac:spMkLst>
            <pc:docMk/>
            <pc:sldMk cId="3293758939" sldId="265"/>
            <ac:spMk id="7" creationId="{C415CAED-2931-4C0B-8441-6E649ED01476}"/>
          </ac:spMkLst>
        </pc:spChg>
        <pc:spChg chg="del">
          <ac:chgData name="吉武 和敏" userId="e4825ba96748af9c" providerId="LiveId" clId="{7D9BC6C3-ADD0-49E2-9986-EB182164A847}" dt="2022-03-18T08:13:19.769" v="1958" actId="478"/>
          <ac:spMkLst>
            <pc:docMk/>
            <pc:sldMk cId="3293758939" sldId="265"/>
            <ac:spMk id="9" creationId="{330C90D4-ADDD-49C0-AD40-8B081C8CB753}"/>
          </ac:spMkLst>
        </pc:spChg>
        <pc:spChg chg="del">
          <ac:chgData name="吉武 和敏" userId="e4825ba96748af9c" providerId="LiveId" clId="{7D9BC6C3-ADD0-49E2-9986-EB182164A847}" dt="2022-03-18T08:13:19.769" v="1958" actId="478"/>
          <ac:spMkLst>
            <pc:docMk/>
            <pc:sldMk cId="3293758939" sldId="265"/>
            <ac:spMk id="12" creationId="{A7DCEE08-4CC5-433C-B5E0-305C4A664D75}"/>
          </ac:spMkLst>
        </pc:spChg>
        <pc:spChg chg="del">
          <ac:chgData name="吉武 和敏" userId="e4825ba96748af9c" providerId="LiveId" clId="{7D9BC6C3-ADD0-49E2-9986-EB182164A847}" dt="2022-03-18T08:13:19.769" v="1958" actId="478"/>
          <ac:spMkLst>
            <pc:docMk/>
            <pc:sldMk cId="3293758939" sldId="265"/>
            <ac:spMk id="13" creationId="{93503832-CC26-4995-9980-B2C5748337F7}"/>
          </ac:spMkLst>
        </pc:spChg>
        <pc:spChg chg="add mod">
          <ac:chgData name="吉武 和敏" userId="e4825ba96748af9c" providerId="LiveId" clId="{7D9BC6C3-ADD0-49E2-9986-EB182164A847}" dt="2022-03-18T08:14:51.388" v="1963" actId="1076"/>
          <ac:spMkLst>
            <pc:docMk/>
            <pc:sldMk cId="3293758939" sldId="265"/>
            <ac:spMk id="17" creationId="{93619FF7-A2DF-4F49-8E65-7F93305DE065}"/>
          </ac:spMkLst>
        </pc:spChg>
        <pc:spChg chg="add mod">
          <ac:chgData name="吉武 和敏" userId="e4825ba96748af9c" providerId="LiveId" clId="{7D9BC6C3-ADD0-49E2-9986-EB182164A847}" dt="2022-03-18T08:14:54.889" v="1964" actId="1076"/>
          <ac:spMkLst>
            <pc:docMk/>
            <pc:sldMk cId="3293758939" sldId="265"/>
            <ac:spMk id="19" creationId="{7896DE3C-5779-446E-B512-4CCC8B0ABC73}"/>
          </ac:spMkLst>
        </pc:spChg>
        <pc:spChg chg="add mod">
          <ac:chgData name="吉武 和敏" userId="e4825ba96748af9c" providerId="LiveId" clId="{7D9BC6C3-ADD0-49E2-9986-EB182164A847}" dt="2022-03-18T08:15:03.316" v="1966" actId="1076"/>
          <ac:spMkLst>
            <pc:docMk/>
            <pc:sldMk cId="3293758939" sldId="265"/>
            <ac:spMk id="22" creationId="{91F0DFC2-2F64-47CB-93A7-EE558DDB137F}"/>
          </ac:spMkLst>
        </pc:spChg>
        <pc:spChg chg="add mod">
          <ac:chgData name="吉武 和敏" userId="e4825ba96748af9c" providerId="LiveId" clId="{7D9BC6C3-ADD0-49E2-9986-EB182164A847}" dt="2022-03-18T08:13:14.959" v="1956" actId="14100"/>
          <ac:spMkLst>
            <pc:docMk/>
            <pc:sldMk cId="3293758939" sldId="265"/>
            <ac:spMk id="27" creationId="{FBC99B85-F112-41D9-B028-ACC9A7639292}"/>
          </ac:spMkLst>
        </pc:spChg>
        <pc:picChg chg="del">
          <ac:chgData name="吉武 和敏" userId="e4825ba96748af9c" providerId="LiveId" clId="{7D9BC6C3-ADD0-49E2-9986-EB182164A847}" dt="2022-03-18T08:13:19.769" v="1958" actId="478"/>
          <ac:picMkLst>
            <pc:docMk/>
            <pc:sldMk cId="3293758939" sldId="265"/>
            <ac:picMk id="6" creationId="{12094DC7-4F8F-4992-866C-B15505920166}"/>
          </ac:picMkLst>
        </pc:picChg>
        <pc:cxnChg chg="mod">
          <ac:chgData name="吉武 和敏" userId="e4825ba96748af9c" providerId="LiveId" clId="{7D9BC6C3-ADD0-49E2-9986-EB182164A847}" dt="2022-03-18T08:15:00.473" v="1965" actId="14100"/>
          <ac:cxnSpMkLst>
            <pc:docMk/>
            <pc:sldMk cId="3293758939" sldId="265"/>
            <ac:cxnSpMk id="15" creationId="{EA2FE2F0-4A4D-42D5-BD5F-BE01DA2E39D2}"/>
          </ac:cxnSpMkLst>
        </pc:cxnChg>
        <pc:cxnChg chg="mod">
          <ac:chgData name="吉武 和敏" userId="e4825ba96748af9c" providerId="LiveId" clId="{7D9BC6C3-ADD0-49E2-9986-EB182164A847}" dt="2022-03-18T08:15:10.741" v="1968" actId="14100"/>
          <ac:cxnSpMkLst>
            <pc:docMk/>
            <pc:sldMk cId="3293758939" sldId="265"/>
            <ac:cxnSpMk id="16" creationId="{50F6F4E1-8B27-434E-95AB-0C25C9F1D91A}"/>
          </ac:cxnSpMkLst>
        </pc:cxnChg>
        <pc:cxnChg chg="mod">
          <ac:chgData name="吉武 和敏" userId="e4825ba96748af9c" providerId="LiveId" clId="{7D9BC6C3-ADD0-49E2-9986-EB182164A847}" dt="2022-03-18T08:13:03.176" v="1951" actId="14100"/>
          <ac:cxnSpMkLst>
            <pc:docMk/>
            <pc:sldMk cId="3293758939" sldId="265"/>
            <ac:cxnSpMk id="18" creationId="{A81AAF27-8248-4FCE-AFC4-86FEA3E6F9FD}"/>
          </ac:cxnSpMkLst>
        </pc:cxnChg>
        <pc:cxnChg chg="mod">
          <ac:chgData name="吉武 和敏" userId="e4825ba96748af9c" providerId="LiveId" clId="{7D9BC6C3-ADD0-49E2-9986-EB182164A847}" dt="2022-03-18T08:14:46.637" v="1962" actId="14100"/>
          <ac:cxnSpMkLst>
            <pc:docMk/>
            <pc:sldMk cId="3293758939" sldId="265"/>
            <ac:cxnSpMk id="25" creationId="{60E2E185-0E45-4E43-BE43-E4A64FB4A7C7}"/>
          </ac:cxnSpMkLst>
        </pc:cxnChg>
      </pc:sldChg>
      <pc:sldChg chg="addSp delSp modSp mod">
        <pc:chgData name="吉武 和敏" userId="e4825ba96748af9c" providerId="LiveId" clId="{7D9BC6C3-ADD0-49E2-9986-EB182164A847}" dt="2022-03-18T06:31:13.039" v="787" actId="1076"/>
        <pc:sldMkLst>
          <pc:docMk/>
          <pc:sldMk cId="1801781158" sldId="276"/>
        </pc:sldMkLst>
        <pc:spChg chg="mod">
          <ac:chgData name="吉武 和敏" userId="e4825ba96748af9c" providerId="LiveId" clId="{7D9BC6C3-ADD0-49E2-9986-EB182164A847}" dt="2021-12-13T08:13:23.527" v="25" actId="14100"/>
          <ac:spMkLst>
            <pc:docMk/>
            <pc:sldMk cId="1801781158" sldId="276"/>
            <ac:spMk id="3" creationId="{F8240C55-48B7-4F38-AF8C-2C987B10E89A}"/>
          </ac:spMkLst>
        </pc:spChg>
        <pc:spChg chg="mod">
          <ac:chgData name="吉武 和敏" userId="e4825ba96748af9c" providerId="LiveId" clId="{7D9BC6C3-ADD0-49E2-9986-EB182164A847}" dt="2021-12-13T08:13:48.357" v="27" actId="1076"/>
          <ac:spMkLst>
            <pc:docMk/>
            <pc:sldMk cId="1801781158" sldId="276"/>
            <ac:spMk id="4" creationId="{F33501D9-4A03-4976-A54E-BE855E935BBA}"/>
          </ac:spMkLst>
        </pc:spChg>
        <pc:spChg chg="mod">
          <ac:chgData name="吉武 和敏" userId="e4825ba96748af9c" providerId="LiveId" clId="{7D9BC6C3-ADD0-49E2-9986-EB182164A847}" dt="2022-03-14T10:09:33.471" v="154" actId="20577"/>
          <ac:spMkLst>
            <pc:docMk/>
            <pc:sldMk cId="1801781158" sldId="276"/>
            <ac:spMk id="5" creationId="{1ABA4B7E-D139-4B4B-88DC-DA4AAAA73436}"/>
          </ac:spMkLst>
        </pc:spChg>
        <pc:spChg chg="mod">
          <ac:chgData name="吉武 和敏" userId="e4825ba96748af9c" providerId="LiveId" clId="{7D9BC6C3-ADD0-49E2-9986-EB182164A847}" dt="2022-03-18T06:27:25.854" v="733" actId="20577"/>
          <ac:spMkLst>
            <pc:docMk/>
            <pc:sldMk cId="1801781158" sldId="276"/>
            <ac:spMk id="6" creationId="{21C3DACB-70B7-4A80-BBFD-84C2DCBA92E0}"/>
          </ac:spMkLst>
        </pc:spChg>
        <pc:spChg chg="mod">
          <ac:chgData name="吉武 和敏" userId="e4825ba96748af9c" providerId="LiveId" clId="{7D9BC6C3-ADD0-49E2-9986-EB182164A847}" dt="2022-03-14T10:14:05.914" v="157" actId="1076"/>
          <ac:spMkLst>
            <pc:docMk/>
            <pc:sldMk cId="1801781158" sldId="276"/>
            <ac:spMk id="13" creationId="{F85FFFF0-2103-4D3D-AFB0-C6DB98D86EAF}"/>
          </ac:spMkLst>
        </pc:spChg>
        <pc:spChg chg="mod">
          <ac:chgData name="吉武 和敏" userId="e4825ba96748af9c" providerId="LiveId" clId="{7D9BC6C3-ADD0-49E2-9986-EB182164A847}" dt="2021-12-13T08:13:41.022" v="26" actId="948"/>
          <ac:spMkLst>
            <pc:docMk/>
            <pc:sldMk cId="1801781158" sldId="276"/>
            <ac:spMk id="14" creationId="{7CB3ACA1-CF1C-4DD7-82EE-8D46BF98C232}"/>
          </ac:spMkLst>
        </pc:spChg>
        <pc:spChg chg="mod">
          <ac:chgData name="吉武 和敏" userId="e4825ba96748af9c" providerId="LiveId" clId="{7D9BC6C3-ADD0-49E2-9986-EB182164A847}" dt="2021-12-13T08:13:23.527" v="25" actId="14100"/>
          <ac:spMkLst>
            <pc:docMk/>
            <pc:sldMk cId="1801781158" sldId="276"/>
            <ac:spMk id="15" creationId="{CE03A854-A46C-48FE-AFA4-B36BB4BFA394}"/>
          </ac:spMkLst>
        </pc:spChg>
        <pc:spChg chg="add mod">
          <ac:chgData name="吉武 和敏" userId="e4825ba96748af9c" providerId="LiveId" clId="{7D9BC6C3-ADD0-49E2-9986-EB182164A847}" dt="2022-03-14T10:01:41.621" v="148" actId="1076"/>
          <ac:spMkLst>
            <pc:docMk/>
            <pc:sldMk cId="1801781158" sldId="276"/>
            <ac:spMk id="22" creationId="{672643A1-391C-4F61-9000-5A1EE34A4607}"/>
          </ac:spMkLst>
        </pc:spChg>
        <pc:spChg chg="del mod">
          <ac:chgData name="吉武 和敏" userId="e4825ba96748af9c" providerId="LiveId" clId="{7D9BC6C3-ADD0-49E2-9986-EB182164A847}" dt="2021-12-13T08:19:02.945" v="36" actId="478"/>
          <ac:spMkLst>
            <pc:docMk/>
            <pc:sldMk cId="1801781158" sldId="276"/>
            <ac:spMk id="22" creationId="{B3AF240D-5CC1-411F-8F0F-29FFDDEFBAC5}"/>
          </ac:spMkLst>
        </pc:spChg>
        <pc:spChg chg="del">
          <ac:chgData name="吉武 和敏" userId="e4825ba96748af9c" providerId="LiveId" clId="{7D9BC6C3-ADD0-49E2-9986-EB182164A847}" dt="2021-12-13T08:11:34.804" v="0" actId="478"/>
          <ac:spMkLst>
            <pc:docMk/>
            <pc:sldMk cId="1801781158" sldId="276"/>
            <ac:spMk id="23" creationId="{D3B651ED-92D3-4E20-9A46-78D782D06C96}"/>
          </ac:spMkLst>
        </pc:spChg>
        <pc:spChg chg="del mod">
          <ac:chgData name="吉武 和敏" userId="e4825ba96748af9c" providerId="LiveId" clId="{7D9BC6C3-ADD0-49E2-9986-EB182164A847}" dt="2021-12-13T08:19:02.945" v="36" actId="478"/>
          <ac:spMkLst>
            <pc:docMk/>
            <pc:sldMk cId="1801781158" sldId="276"/>
            <ac:spMk id="24" creationId="{406F8BF9-062E-4359-A420-F11A6B04DDB7}"/>
          </ac:spMkLst>
        </pc:spChg>
        <pc:spChg chg="del mod">
          <ac:chgData name="吉武 和敏" userId="e4825ba96748af9c" providerId="LiveId" clId="{7D9BC6C3-ADD0-49E2-9986-EB182164A847}" dt="2021-12-13T08:19:02.945" v="36" actId="478"/>
          <ac:spMkLst>
            <pc:docMk/>
            <pc:sldMk cId="1801781158" sldId="276"/>
            <ac:spMk id="28" creationId="{D47A8491-B6F3-4953-B859-846F62954DCC}"/>
          </ac:spMkLst>
        </pc:spChg>
        <pc:spChg chg="mod">
          <ac:chgData name="吉武 和敏" userId="e4825ba96748af9c" providerId="LiveId" clId="{7D9BC6C3-ADD0-49E2-9986-EB182164A847}" dt="2022-03-14T10:39:25.469" v="726" actId="20577"/>
          <ac:spMkLst>
            <pc:docMk/>
            <pc:sldMk cId="1801781158" sldId="276"/>
            <ac:spMk id="35" creationId="{12A1D832-D779-4DD2-818D-D1FC523A92FD}"/>
          </ac:spMkLst>
        </pc:spChg>
        <pc:spChg chg="add mod">
          <ac:chgData name="吉武 和敏" userId="e4825ba96748af9c" providerId="LiveId" clId="{7D9BC6C3-ADD0-49E2-9986-EB182164A847}" dt="2022-03-14T10:14:12.974" v="160" actId="20577"/>
          <ac:spMkLst>
            <pc:docMk/>
            <pc:sldMk cId="1801781158" sldId="276"/>
            <ac:spMk id="39" creationId="{1C0FEDCB-3362-489E-9782-2996FDD610AF}"/>
          </ac:spMkLst>
        </pc:spChg>
        <pc:spChg chg="add mod">
          <ac:chgData name="吉武 和敏" userId="e4825ba96748af9c" providerId="LiveId" clId="{7D9BC6C3-ADD0-49E2-9986-EB182164A847}" dt="2022-03-14T10:14:29.311" v="164" actId="20577"/>
          <ac:spMkLst>
            <pc:docMk/>
            <pc:sldMk cId="1801781158" sldId="276"/>
            <ac:spMk id="40" creationId="{40214D6C-801C-4CE1-A951-9280C580394B}"/>
          </ac:spMkLst>
        </pc:spChg>
        <pc:spChg chg="add mod">
          <ac:chgData name="吉武 和敏" userId="e4825ba96748af9c" providerId="LiveId" clId="{7D9BC6C3-ADD0-49E2-9986-EB182164A847}" dt="2022-03-14T10:18:27.518" v="167" actId="20577"/>
          <ac:spMkLst>
            <pc:docMk/>
            <pc:sldMk cId="1801781158" sldId="276"/>
            <ac:spMk id="41" creationId="{56901C6A-B8AD-4ED6-804C-3A1026EA8C9D}"/>
          </ac:spMkLst>
        </pc:spChg>
        <pc:spChg chg="add mod">
          <ac:chgData name="吉武 和敏" userId="e4825ba96748af9c" providerId="LiveId" clId="{7D9BC6C3-ADD0-49E2-9986-EB182164A847}" dt="2021-12-13T08:15:59.830" v="30" actId="14100"/>
          <ac:spMkLst>
            <pc:docMk/>
            <pc:sldMk cId="1801781158" sldId="276"/>
            <ac:spMk id="42" creationId="{7419A43C-7FC7-48BD-B4BB-E637C08E6974}"/>
          </ac:spMkLst>
        </pc:spChg>
        <pc:spChg chg="add mod">
          <ac:chgData name="吉武 和敏" userId="e4825ba96748af9c" providerId="LiveId" clId="{7D9BC6C3-ADD0-49E2-9986-EB182164A847}" dt="2022-03-14T10:26:48.684" v="176" actId="20577"/>
          <ac:spMkLst>
            <pc:docMk/>
            <pc:sldMk cId="1801781158" sldId="276"/>
            <ac:spMk id="43" creationId="{CD60431F-4837-4630-ABF0-6C5C7BAD1804}"/>
          </ac:spMkLst>
        </pc:spChg>
        <pc:spChg chg="add mod">
          <ac:chgData name="吉武 和敏" userId="e4825ba96748af9c" providerId="LiveId" clId="{7D9BC6C3-ADD0-49E2-9986-EB182164A847}" dt="2022-03-14T10:20:10.451" v="169" actId="1076"/>
          <ac:spMkLst>
            <pc:docMk/>
            <pc:sldMk cId="1801781158" sldId="276"/>
            <ac:spMk id="44" creationId="{0E00EF14-A266-4AA8-854F-32F153C631EC}"/>
          </ac:spMkLst>
        </pc:spChg>
        <pc:spChg chg="add mod">
          <ac:chgData name="吉武 和敏" userId="e4825ba96748af9c" providerId="LiveId" clId="{7D9BC6C3-ADD0-49E2-9986-EB182164A847}" dt="2021-12-13T08:19:06.969" v="38" actId="1076"/>
          <ac:spMkLst>
            <pc:docMk/>
            <pc:sldMk cId="1801781158" sldId="276"/>
            <ac:spMk id="45" creationId="{1A62A78B-355B-4376-827F-BB4E530798D2}"/>
          </ac:spMkLst>
        </pc:spChg>
        <pc:spChg chg="add mod">
          <ac:chgData name="吉武 和敏" userId="e4825ba96748af9c" providerId="LiveId" clId="{7D9BC6C3-ADD0-49E2-9986-EB182164A847}" dt="2021-12-13T08:19:06.969" v="38" actId="1076"/>
          <ac:spMkLst>
            <pc:docMk/>
            <pc:sldMk cId="1801781158" sldId="276"/>
            <ac:spMk id="46" creationId="{B79398A3-9F8D-455B-91FC-68D88DECEBEB}"/>
          </ac:spMkLst>
        </pc:spChg>
        <pc:spChg chg="add del mod">
          <ac:chgData name="吉武 和敏" userId="e4825ba96748af9c" providerId="LiveId" clId="{7D9BC6C3-ADD0-49E2-9986-EB182164A847}" dt="2022-03-18T06:27:33.739" v="734" actId="478"/>
          <ac:spMkLst>
            <pc:docMk/>
            <pc:sldMk cId="1801781158" sldId="276"/>
            <ac:spMk id="50" creationId="{83860497-88B6-455C-8440-9045BFED9E45}"/>
          </ac:spMkLst>
        </pc:spChg>
        <pc:spChg chg="add mod">
          <ac:chgData name="吉武 和敏" userId="e4825ba96748af9c" providerId="LiveId" clId="{7D9BC6C3-ADD0-49E2-9986-EB182164A847}" dt="2022-03-14T10:20:16.637" v="170" actId="20577"/>
          <ac:spMkLst>
            <pc:docMk/>
            <pc:sldMk cId="1801781158" sldId="276"/>
            <ac:spMk id="57" creationId="{A3D4012E-541D-4ACF-BB87-3882EDBCB796}"/>
          </ac:spMkLst>
        </pc:spChg>
        <pc:spChg chg="add mod">
          <ac:chgData name="吉武 和敏" userId="e4825ba96748af9c" providerId="LiveId" clId="{7D9BC6C3-ADD0-49E2-9986-EB182164A847}" dt="2022-03-14T10:20:38.813" v="174" actId="20577"/>
          <ac:spMkLst>
            <pc:docMk/>
            <pc:sldMk cId="1801781158" sldId="276"/>
            <ac:spMk id="58" creationId="{A0D6428E-E0A9-4F87-A810-F942DC2B3B9E}"/>
          </ac:spMkLst>
        </pc:spChg>
        <pc:spChg chg="add mod">
          <ac:chgData name="吉武 和敏" userId="e4825ba96748af9c" providerId="LiveId" clId="{7D9BC6C3-ADD0-49E2-9986-EB182164A847}" dt="2022-03-14T10:26:57.485" v="179" actId="20577"/>
          <ac:spMkLst>
            <pc:docMk/>
            <pc:sldMk cId="1801781158" sldId="276"/>
            <ac:spMk id="59" creationId="{64E18347-9B67-4CA1-BDE9-C7130653F6BF}"/>
          </ac:spMkLst>
        </pc:spChg>
        <pc:spChg chg="add mod">
          <ac:chgData name="吉武 和敏" userId="e4825ba96748af9c" providerId="LiveId" clId="{7D9BC6C3-ADD0-49E2-9986-EB182164A847}" dt="2022-03-14T10:38:27.291" v="578" actId="20577"/>
          <ac:spMkLst>
            <pc:docMk/>
            <pc:sldMk cId="1801781158" sldId="276"/>
            <ac:spMk id="60" creationId="{B9B4A422-335E-4B02-917D-C57977D0348A}"/>
          </ac:spMkLst>
        </pc:spChg>
        <pc:spChg chg="add mod">
          <ac:chgData name="吉武 和敏" userId="e4825ba96748af9c" providerId="LiveId" clId="{7D9BC6C3-ADD0-49E2-9986-EB182164A847}" dt="2022-03-14T10:38:34.186" v="580" actId="20577"/>
          <ac:spMkLst>
            <pc:docMk/>
            <pc:sldMk cId="1801781158" sldId="276"/>
            <ac:spMk id="61" creationId="{7E7EFE70-1534-4982-A21A-328251FBCE7F}"/>
          </ac:spMkLst>
        </pc:spChg>
        <pc:spChg chg="add mod">
          <ac:chgData name="吉武 和敏" userId="e4825ba96748af9c" providerId="LiveId" clId="{7D9BC6C3-ADD0-49E2-9986-EB182164A847}" dt="2022-03-18T06:26:16.621" v="730" actId="1038"/>
          <ac:spMkLst>
            <pc:docMk/>
            <pc:sldMk cId="1801781158" sldId="276"/>
            <ac:spMk id="65" creationId="{B94FC8F5-3559-4F17-9CB5-90007785C336}"/>
          </ac:spMkLst>
        </pc:spChg>
        <pc:spChg chg="add mod">
          <ac:chgData name="吉武 和敏" userId="e4825ba96748af9c" providerId="LiveId" clId="{7D9BC6C3-ADD0-49E2-9986-EB182164A847}" dt="2022-03-18T06:26:36.196" v="731" actId="571"/>
          <ac:spMkLst>
            <pc:docMk/>
            <pc:sldMk cId="1801781158" sldId="276"/>
            <ac:spMk id="66" creationId="{723970A6-CC40-420A-889E-2BC2F8274D76}"/>
          </ac:spMkLst>
        </pc:spChg>
        <pc:spChg chg="add mod">
          <ac:chgData name="吉武 和敏" userId="e4825ba96748af9c" providerId="LiveId" clId="{7D9BC6C3-ADD0-49E2-9986-EB182164A847}" dt="2022-03-18T06:31:13.039" v="787" actId="1076"/>
          <ac:spMkLst>
            <pc:docMk/>
            <pc:sldMk cId="1801781158" sldId="276"/>
            <ac:spMk id="67" creationId="{4470E73B-62A0-4BFC-B2AB-31AF50E28765}"/>
          </ac:spMkLst>
        </pc:spChg>
        <pc:spChg chg="add mod">
          <ac:chgData name="吉武 和敏" userId="e4825ba96748af9c" providerId="LiveId" clId="{7D9BC6C3-ADD0-49E2-9986-EB182164A847}" dt="2022-03-18T06:31:13.039" v="787" actId="1076"/>
          <ac:spMkLst>
            <pc:docMk/>
            <pc:sldMk cId="1801781158" sldId="276"/>
            <ac:spMk id="68" creationId="{04B94BC0-AAEF-4D5C-9562-F3FA61E7F5DB}"/>
          </ac:spMkLst>
        </pc:spChg>
        <pc:grpChg chg="mod">
          <ac:chgData name="吉武 和敏" userId="e4825ba96748af9c" providerId="LiveId" clId="{7D9BC6C3-ADD0-49E2-9986-EB182164A847}" dt="2022-03-14T10:14:05.914" v="157" actId="1076"/>
          <ac:grpSpMkLst>
            <pc:docMk/>
            <pc:sldMk cId="1801781158" sldId="276"/>
            <ac:grpSpMk id="7" creationId="{A966122F-78ED-4B9D-8C74-266BB20E1D84}"/>
          </ac:grpSpMkLst>
        </pc:grpChg>
        <pc:grpChg chg="mod">
          <ac:chgData name="吉武 和敏" userId="e4825ba96748af9c" providerId="LiveId" clId="{7D9BC6C3-ADD0-49E2-9986-EB182164A847}" dt="2021-12-13T08:13:23.527" v="25" actId="14100"/>
          <ac:grpSpMkLst>
            <pc:docMk/>
            <pc:sldMk cId="1801781158" sldId="276"/>
            <ac:grpSpMk id="16" creationId="{C5549054-6AEF-40F0-8D85-70D99D1E3DD7}"/>
          </ac:grpSpMkLst>
        </pc:grpChg>
        <pc:picChg chg="del mod">
          <ac:chgData name="吉武 和敏" userId="e4825ba96748af9c" providerId="LiveId" clId="{7D9BC6C3-ADD0-49E2-9986-EB182164A847}" dt="2021-12-13T08:19:02.945" v="36" actId="478"/>
          <ac:picMkLst>
            <pc:docMk/>
            <pc:sldMk cId="1801781158" sldId="276"/>
            <ac:picMk id="25" creationId="{B2CAD347-0D98-40AA-A22F-1F38583559FD}"/>
          </ac:picMkLst>
        </pc:picChg>
        <pc:picChg chg="del">
          <ac:chgData name="吉武 和敏" userId="e4825ba96748af9c" providerId="LiveId" clId="{7D9BC6C3-ADD0-49E2-9986-EB182164A847}" dt="2021-12-13T08:11:34.804" v="0" actId="478"/>
          <ac:picMkLst>
            <pc:docMk/>
            <pc:sldMk cId="1801781158" sldId="276"/>
            <ac:picMk id="26" creationId="{5B81E06E-8220-4D8A-9800-10CC3E634679}"/>
          </ac:picMkLst>
        </pc:picChg>
        <pc:picChg chg="del mod">
          <ac:chgData name="吉武 和敏" userId="e4825ba96748af9c" providerId="LiveId" clId="{7D9BC6C3-ADD0-49E2-9986-EB182164A847}" dt="2021-12-13T08:19:02.945" v="36" actId="478"/>
          <ac:picMkLst>
            <pc:docMk/>
            <pc:sldMk cId="1801781158" sldId="276"/>
            <ac:picMk id="27" creationId="{D7EA1D7C-FED7-4464-A8E8-F38A375B9461}"/>
          </ac:picMkLst>
        </pc:picChg>
        <pc:picChg chg="add mod">
          <ac:chgData name="吉武 和敏" userId="e4825ba96748af9c" providerId="LiveId" clId="{7D9BC6C3-ADD0-49E2-9986-EB182164A847}" dt="2022-03-14T10:20:10.451" v="169" actId="1076"/>
          <ac:picMkLst>
            <pc:docMk/>
            <pc:sldMk cId="1801781158" sldId="276"/>
            <ac:picMk id="47" creationId="{67417B17-7F98-4E54-BD6B-29FE9C9540FF}"/>
          </ac:picMkLst>
        </pc:picChg>
        <pc:picChg chg="add mod">
          <ac:chgData name="吉武 和敏" userId="e4825ba96748af9c" providerId="LiveId" clId="{7D9BC6C3-ADD0-49E2-9986-EB182164A847}" dt="2021-12-13T08:19:06.969" v="38" actId="1076"/>
          <ac:picMkLst>
            <pc:docMk/>
            <pc:sldMk cId="1801781158" sldId="276"/>
            <ac:picMk id="48" creationId="{20C1B741-9EA4-49DF-BB2F-3ACF3370A9D0}"/>
          </ac:picMkLst>
        </pc:picChg>
        <pc:picChg chg="add mod">
          <ac:chgData name="吉武 和敏" userId="e4825ba96748af9c" providerId="LiveId" clId="{7D9BC6C3-ADD0-49E2-9986-EB182164A847}" dt="2021-12-13T08:19:06.969" v="38" actId="1076"/>
          <ac:picMkLst>
            <pc:docMk/>
            <pc:sldMk cId="1801781158" sldId="276"/>
            <ac:picMk id="49" creationId="{7635A0AE-A756-4AC6-B66C-CEA0C815787E}"/>
          </ac:picMkLst>
        </pc:picChg>
        <pc:cxnChg chg="mod">
          <ac:chgData name="吉武 和敏" userId="e4825ba96748af9c" providerId="LiveId" clId="{7D9BC6C3-ADD0-49E2-9986-EB182164A847}" dt="2021-12-13T08:13:23.527" v="25" actId="14100"/>
          <ac:cxnSpMkLst>
            <pc:docMk/>
            <pc:sldMk cId="1801781158" sldId="276"/>
            <ac:cxnSpMk id="2" creationId="{F1DEAC02-A837-4C3B-B18E-9A965A909FC3}"/>
          </ac:cxnSpMkLst>
        </pc:cxnChg>
        <pc:cxnChg chg="del mod">
          <ac:chgData name="吉武 和敏" userId="e4825ba96748af9c" providerId="LiveId" clId="{7D9BC6C3-ADD0-49E2-9986-EB182164A847}" dt="2021-12-13T08:19:02.945" v="36" actId="478"/>
          <ac:cxnSpMkLst>
            <pc:docMk/>
            <pc:sldMk cId="1801781158" sldId="276"/>
            <ac:cxnSpMk id="29" creationId="{1A2EADD2-AF37-46B8-BFAA-9F3D1595B1E7}"/>
          </ac:cxnSpMkLst>
        </pc:cxnChg>
        <pc:cxnChg chg="del">
          <ac:chgData name="吉武 和敏" userId="e4825ba96748af9c" providerId="LiveId" clId="{7D9BC6C3-ADD0-49E2-9986-EB182164A847}" dt="2021-12-13T08:11:34.804" v="0" actId="478"/>
          <ac:cxnSpMkLst>
            <pc:docMk/>
            <pc:sldMk cId="1801781158" sldId="276"/>
            <ac:cxnSpMk id="30" creationId="{F1038B3B-E021-4971-916E-EFCB72E0C88C}"/>
          </ac:cxnSpMkLst>
        </pc:cxnChg>
        <pc:cxnChg chg="del mod">
          <ac:chgData name="吉武 和敏" userId="e4825ba96748af9c" providerId="LiveId" clId="{7D9BC6C3-ADD0-49E2-9986-EB182164A847}" dt="2021-12-13T08:19:02.945" v="36" actId="478"/>
          <ac:cxnSpMkLst>
            <pc:docMk/>
            <pc:sldMk cId="1801781158" sldId="276"/>
            <ac:cxnSpMk id="31" creationId="{CA5A2961-3DCF-4763-9C04-63E876A7DFCA}"/>
          </ac:cxnSpMkLst>
        </pc:cxnChg>
        <pc:cxnChg chg="del mod">
          <ac:chgData name="吉武 和敏" userId="e4825ba96748af9c" providerId="LiveId" clId="{7D9BC6C3-ADD0-49E2-9986-EB182164A847}" dt="2021-12-13T08:19:02.945" v="36" actId="478"/>
          <ac:cxnSpMkLst>
            <pc:docMk/>
            <pc:sldMk cId="1801781158" sldId="276"/>
            <ac:cxnSpMk id="32" creationId="{FEDF2F67-CA6B-4777-80ED-FDEB2B1C6A71}"/>
          </ac:cxnSpMkLst>
        </pc:cxnChg>
        <pc:cxnChg chg="del">
          <ac:chgData name="吉武 和敏" userId="e4825ba96748af9c" providerId="LiveId" clId="{7D9BC6C3-ADD0-49E2-9986-EB182164A847}" dt="2021-12-13T08:11:34.804" v="0" actId="478"/>
          <ac:cxnSpMkLst>
            <pc:docMk/>
            <pc:sldMk cId="1801781158" sldId="276"/>
            <ac:cxnSpMk id="33" creationId="{633D573B-BFB7-42BA-869E-F37378A9C6AB}"/>
          </ac:cxnSpMkLst>
        </pc:cxnChg>
        <pc:cxnChg chg="del mod">
          <ac:chgData name="吉武 和敏" userId="e4825ba96748af9c" providerId="LiveId" clId="{7D9BC6C3-ADD0-49E2-9986-EB182164A847}" dt="2021-12-13T08:19:02.945" v="36" actId="478"/>
          <ac:cxnSpMkLst>
            <pc:docMk/>
            <pc:sldMk cId="1801781158" sldId="276"/>
            <ac:cxnSpMk id="34" creationId="{68AB8D72-A136-4A67-8554-D60A7B256C59}"/>
          </ac:cxnSpMkLst>
        </pc:cxnChg>
        <pc:cxnChg chg="add mod">
          <ac:chgData name="吉武 和敏" userId="e4825ba96748af9c" providerId="LiveId" clId="{7D9BC6C3-ADD0-49E2-9986-EB182164A847}" dt="2022-03-14T10:20:10.451" v="169" actId="1076"/>
          <ac:cxnSpMkLst>
            <pc:docMk/>
            <pc:sldMk cId="1801781158" sldId="276"/>
            <ac:cxnSpMk id="51" creationId="{FADDA0DA-4332-4D2D-BA7A-DC71C678BA4C}"/>
          </ac:cxnSpMkLst>
        </pc:cxnChg>
        <pc:cxnChg chg="add mod">
          <ac:chgData name="吉武 和敏" userId="e4825ba96748af9c" providerId="LiveId" clId="{7D9BC6C3-ADD0-49E2-9986-EB182164A847}" dt="2021-12-13T08:19:06.969" v="38" actId="1076"/>
          <ac:cxnSpMkLst>
            <pc:docMk/>
            <pc:sldMk cId="1801781158" sldId="276"/>
            <ac:cxnSpMk id="52" creationId="{AD439C5F-7971-46C6-A2A1-9F747B0BC057}"/>
          </ac:cxnSpMkLst>
        </pc:cxnChg>
        <pc:cxnChg chg="add mod">
          <ac:chgData name="吉武 和敏" userId="e4825ba96748af9c" providerId="LiveId" clId="{7D9BC6C3-ADD0-49E2-9986-EB182164A847}" dt="2021-12-13T08:19:06.969" v="38" actId="1076"/>
          <ac:cxnSpMkLst>
            <pc:docMk/>
            <pc:sldMk cId="1801781158" sldId="276"/>
            <ac:cxnSpMk id="53" creationId="{AB51DDD2-91D0-40AE-8473-1EC7A3DA79B1}"/>
          </ac:cxnSpMkLst>
        </pc:cxnChg>
        <pc:cxnChg chg="add mod">
          <ac:chgData name="吉武 和敏" userId="e4825ba96748af9c" providerId="LiveId" clId="{7D9BC6C3-ADD0-49E2-9986-EB182164A847}" dt="2022-03-14T10:20:10.451" v="169" actId="1076"/>
          <ac:cxnSpMkLst>
            <pc:docMk/>
            <pc:sldMk cId="1801781158" sldId="276"/>
            <ac:cxnSpMk id="54" creationId="{99329787-9CB5-4F98-8B40-ACD91DEE0A39}"/>
          </ac:cxnSpMkLst>
        </pc:cxnChg>
        <pc:cxnChg chg="add mod">
          <ac:chgData name="吉武 和敏" userId="e4825ba96748af9c" providerId="LiveId" clId="{7D9BC6C3-ADD0-49E2-9986-EB182164A847}" dt="2021-12-13T08:19:06.969" v="38" actId="1076"/>
          <ac:cxnSpMkLst>
            <pc:docMk/>
            <pc:sldMk cId="1801781158" sldId="276"/>
            <ac:cxnSpMk id="55" creationId="{8D98788D-AA60-446A-A236-0754ED6903A5}"/>
          </ac:cxnSpMkLst>
        </pc:cxnChg>
        <pc:cxnChg chg="add mod">
          <ac:chgData name="吉武 和敏" userId="e4825ba96748af9c" providerId="LiveId" clId="{7D9BC6C3-ADD0-49E2-9986-EB182164A847}" dt="2021-12-13T08:19:06.969" v="38" actId="1076"/>
          <ac:cxnSpMkLst>
            <pc:docMk/>
            <pc:sldMk cId="1801781158" sldId="276"/>
            <ac:cxnSpMk id="56" creationId="{6CDA478C-687B-48D1-9EE0-526B92E23E40}"/>
          </ac:cxnSpMkLst>
        </pc:cxnChg>
      </pc:sldChg>
      <pc:sldChg chg="addSp delSp modSp mod">
        <pc:chgData name="吉武 和敏" userId="e4825ba96748af9c" providerId="LiveId" clId="{7D9BC6C3-ADD0-49E2-9986-EB182164A847}" dt="2022-03-18T08:09:53.933" v="1824" actId="20577"/>
        <pc:sldMkLst>
          <pc:docMk/>
          <pc:sldMk cId="2753622518" sldId="278"/>
        </pc:sldMkLst>
        <pc:spChg chg="mod">
          <ac:chgData name="吉武 和敏" userId="e4825ba96748af9c" providerId="LiveId" clId="{7D9BC6C3-ADD0-49E2-9986-EB182164A847}" dt="2022-03-18T06:30:41.208" v="780" actId="1076"/>
          <ac:spMkLst>
            <pc:docMk/>
            <pc:sldMk cId="2753622518" sldId="278"/>
            <ac:spMk id="2" creationId="{C97FCE43-EDAD-469F-B73A-A7E4578657E6}"/>
          </ac:spMkLst>
        </pc:spChg>
        <pc:spChg chg="mod">
          <ac:chgData name="吉武 和敏" userId="e4825ba96748af9c" providerId="LiveId" clId="{7D9BC6C3-ADD0-49E2-9986-EB182164A847}" dt="2022-03-18T08:09:53.933" v="1824" actId="20577"/>
          <ac:spMkLst>
            <pc:docMk/>
            <pc:sldMk cId="2753622518" sldId="278"/>
            <ac:spMk id="5" creationId="{7F157F4B-724B-4DC6-B394-EA4EB26E75A4}"/>
          </ac:spMkLst>
        </pc:spChg>
        <pc:spChg chg="mod">
          <ac:chgData name="吉武 和敏" userId="e4825ba96748af9c" providerId="LiveId" clId="{7D9BC6C3-ADD0-49E2-9986-EB182164A847}" dt="2022-03-18T06:30:41.208" v="780" actId="1076"/>
          <ac:spMkLst>
            <pc:docMk/>
            <pc:sldMk cId="2753622518" sldId="278"/>
            <ac:spMk id="6" creationId="{AF10BC8E-D93A-4A9E-A155-C85D90C16B8D}"/>
          </ac:spMkLst>
        </pc:spChg>
        <pc:spChg chg="mod">
          <ac:chgData name="吉武 和敏" userId="e4825ba96748af9c" providerId="LiveId" clId="{7D9BC6C3-ADD0-49E2-9986-EB182164A847}" dt="2022-03-18T06:30:41.208" v="780" actId="1076"/>
          <ac:spMkLst>
            <pc:docMk/>
            <pc:sldMk cId="2753622518" sldId="278"/>
            <ac:spMk id="7" creationId="{AA34A617-FB96-41A7-B2A0-6C317647BC5E}"/>
          </ac:spMkLst>
        </pc:spChg>
        <pc:spChg chg="mod">
          <ac:chgData name="吉武 和敏" userId="e4825ba96748af9c" providerId="LiveId" clId="{7D9BC6C3-ADD0-49E2-9986-EB182164A847}" dt="2022-03-18T06:30:41.208" v="780" actId="1076"/>
          <ac:spMkLst>
            <pc:docMk/>
            <pc:sldMk cId="2753622518" sldId="278"/>
            <ac:spMk id="8" creationId="{56555404-CC4A-4442-A2AA-693806D5A6A9}"/>
          </ac:spMkLst>
        </pc:spChg>
        <pc:spChg chg="add mod">
          <ac:chgData name="吉武 和敏" userId="e4825ba96748af9c" providerId="LiveId" clId="{7D9BC6C3-ADD0-49E2-9986-EB182164A847}" dt="2022-03-18T06:31:02.564" v="785" actId="1076"/>
          <ac:spMkLst>
            <pc:docMk/>
            <pc:sldMk cId="2753622518" sldId="278"/>
            <ac:spMk id="9" creationId="{92B9877E-5FCD-4573-AC4E-20B4617D3AAF}"/>
          </ac:spMkLst>
        </pc:spChg>
        <pc:spChg chg="add mod">
          <ac:chgData name="吉武 和敏" userId="e4825ba96748af9c" providerId="LiveId" clId="{7D9BC6C3-ADD0-49E2-9986-EB182164A847}" dt="2022-03-18T06:31:21.691" v="789" actId="20577"/>
          <ac:spMkLst>
            <pc:docMk/>
            <pc:sldMk cId="2753622518" sldId="278"/>
            <ac:spMk id="10" creationId="{1CA4C5B9-3DF6-484A-B18D-150276E560EC}"/>
          </ac:spMkLst>
        </pc:spChg>
        <pc:spChg chg="add mod ord">
          <ac:chgData name="吉武 和敏" userId="e4825ba96748af9c" providerId="LiveId" clId="{7D9BC6C3-ADD0-49E2-9986-EB182164A847}" dt="2022-03-18T06:38:32.824" v="845" actId="166"/>
          <ac:spMkLst>
            <pc:docMk/>
            <pc:sldMk cId="2753622518" sldId="278"/>
            <ac:spMk id="12" creationId="{5C46EBBB-7E82-475B-A781-4CC2462613E0}"/>
          </ac:spMkLst>
        </pc:spChg>
        <pc:spChg chg="add del mod">
          <ac:chgData name="吉武 和敏" userId="e4825ba96748af9c" providerId="LiveId" clId="{7D9BC6C3-ADD0-49E2-9986-EB182164A847}" dt="2022-03-18T06:32:02.077" v="793" actId="478"/>
          <ac:spMkLst>
            <pc:docMk/>
            <pc:sldMk cId="2753622518" sldId="278"/>
            <ac:spMk id="13" creationId="{8A31984E-E415-444D-BA39-ECE2183E7CC2}"/>
          </ac:spMkLst>
        </pc:spChg>
        <pc:spChg chg="add del mod">
          <ac:chgData name="吉武 和敏" userId="e4825ba96748af9c" providerId="LiveId" clId="{7D9BC6C3-ADD0-49E2-9986-EB182164A847}" dt="2022-03-18T06:32:03.258" v="794" actId="478"/>
          <ac:spMkLst>
            <pc:docMk/>
            <pc:sldMk cId="2753622518" sldId="278"/>
            <ac:spMk id="14" creationId="{0F920E79-7BE4-4ABA-A2B2-5BE390B9AF62}"/>
          </ac:spMkLst>
        </pc:spChg>
        <pc:spChg chg="add del mod">
          <ac:chgData name="吉武 和敏" userId="e4825ba96748af9c" providerId="LiveId" clId="{7D9BC6C3-ADD0-49E2-9986-EB182164A847}" dt="2022-03-18T06:32:03.258" v="794" actId="478"/>
          <ac:spMkLst>
            <pc:docMk/>
            <pc:sldMk cId="2753622518" sldId="278"/>
            <ac:spMk id="15" creationId="{BB76351D-CFAE-4B8C-9970-1FE1CD0A3877}"/>
          </ac:spMkLst>
        </pc:spChg>
        <pc:spChg chg="mod">
          <ac:chgData name="吉武 和敏" userId="e4825ba96748af9c" providerId="LiveId" clId="{7D9BC6C3-ADD0-49E2-9986-EB182164A847}" dt="2022-03-18T06:31:34.432" v="790"/>
          <ac:spMkLst>
            <pc:docMk/>
            <pc:sldMk cId="2753622518" sldId="278"/>
            <ac:spMk id="17" creationId="{D3FDE44D-C054-462B-A454-74578B5A916A}"/>
          </ac:spMkLst>
        </pc:spChg>
        <pc:spChg chg="mod">
          <ac:chgData name="吉武 和敏" userId="e4825ba96748af9c" providerId="LiveId" clId="{7D9BC6C3-ADD0-49E2-9986-EB182164A847}" dt="2022-03-18T06:31:34.432" v="790"/>
          <ac:spMkLst>
            <pc:docMk/>
            <pc:sldMk cId="2753622518" sldId="278"/>
            <ac:spMk id="18" creationId="{38BD0363-0683-48E3-9151-90070385E019}"/>
          </ac:spMkLst>
        </pc:spChg>
        <pc:spChg chg="mod">
          <ac:chgData name="吉武 和敏" userId="e4825ba96748af9c" providerId="LiveId" clId="{7D9BC6C3-ADD0-49E2-9986-EB182164A847}" dt="2022-03-18T06:31:34.432" v="790"/>
          <ac:spMkLst>
            <pc:docMk/>
            <pc:sldMk cId="2753622518" sldId="278"/>
            <ac:spMk id="19" creationId="{7571F168-1D84-44A9-9EF0-FB0CCCE7FE93}"/>
          </ac:spMkLst>
        </pc:spChg>
        <pc:spChg chg="mod">
          <ac:chgData name="吉武 和敏" userId="e4825ba96748af9c" providerId="LiveId" clId="{7D9BC6C3-ADD0-49E2-9986-EB182164A847}" dt="2022-03-18T06:31:34.432" v="790"/>
          <ac:spMkLst>
            <pc:docMk/>
            <pc:sldMk cId="2753622518" sldId="278"/>
            <ac:spMk id="20" creationId="{BF218479-D4FE-4389-8B4D-BAEDF13194B5}"/>
          </ac:spMkLst>
        </pc:spChg>
        <pc:spChg chg="mod">
          <ac:chgData name="吉武 和敏" userId="e4825ba96748af9c" providerId="LiveId" clId="{7D9BC6C3-ADD0-49E2-9986-EB182164A847}" dt="2022-03-18T06:31:34.432" v="790"/>
          <ac:spMkLst>
            <pc:docMk/>
            <pc:sldMk cId="2753622518" sldId="278"/>
            <ac:spMk id="21" creationId="{3CB0DC90-BE0D-4934-B8D7-3974AA6B3874}"/>
          </ac:spMkLst>
        </pc:spChg>
        <pc:spChg chg="add del mod">
          <ac:chgData name="吉武 和敏" userId="e4825ba96748af9c" providerId="LiveId" clId="{7D9BC6C3-ADD0-49E2-9986-EB182164A847}" dt="2022-03-18T06:32:02.077" v="793" actId="478"/>
          <ac:spMkLst>
            <pc:docMk/>
            <pc:sldMk cId="2753622518" sldId="278"/>
            <ac:spMk id="22" creationId="{0C83AFCA-A425-4399-AC85-2077C60218A0}"/>
          </ac:spMkLst>
        </pc:spChg>
        <pc:spChg chg="add del mod">
          <ac:chgData name="吉武 和敏" userId="e4825ba96748af9c" providerId="LiveId" clId="{7D9BC6C3-ADD0-49E2-9986-EB182164A847}" dt="2022-03-18T06:38:06.814" v="840" actId="478"/>
          <ac:spMkLst>
            <pc:docMk/>
            <pc:sldMk cId="2753622518" sldId="278"/>
            <ac:spMk id="25" creationId="{D5D187B8-C1F0-4D5F-BC59-324B22D15405}"/>
          </ac:spMkLst>
        </pc:spChg>
        <pc:spChg chg="add del mod">
          <ac:chgData name="吉武 和敏" userId="e4825ba96748af9c" providerId="LiveId" clId="{7D9BC6C3-ADD0-49E2-9986-EB182164A847}" dt="2022-03-18T06:35:28.380" v="818"/>
          <ac:spMkLst>
            <pc:docMk/>
            <pc:sldMk cId="2753622518" sldId="278"/>
            <ac:spMk id="26" creationId="{F0056E00-81F3-4FFF-8BAD-3A92F26EF03C}"/>
          </ac:spMkLst>
        </pc:spChg>
        <pc:spChg chg="add mod">
          <ac:chgData name="吉武 和敏" userId="e4825ba96748af9c" providerId="LiveId" clId="{7D9BC6C3-ADD0-49E2-9986-EB182164A847}" dt="2022-03-18T06:36:55.356" v="835" actId="1076"/>
          <ac:spMkLst>
            <pc:docMk/>
            <pc:sldMk cId="2753622518" sldId="278"/>
            <ac:spMk id="27" creationId="{87CA274D-562B-49B2-BE1A-960A52AA8CDA}"/>
          </ac:spMkLst>
        </pc:spChg>
        <pc:spChg chg="add del">
          <ac:chgData name="吉武 和敏" userId="e4825ba96748af9c" providerId="LiveId" clId="{7D9BC6C3-ADD0-49E2-9986-EB182164A847}" dt="2022-03-18T06:38:11.577" v="843" actId="478"/>
          <ac:spMkLst>
            <pc:docMk/>
            <pc:sldMk cId="2753622518" sldId="278"/>
            <ac:spMk id="28" creationId="{EE96A5C4-2650-44EB-98DC-A202561252A1}"/>
          </ac:spMkLst>
        </pc:spChg>
        <pc:spChg chg="add">
          <ac:chgData name="吉武 和敏" userId="e4825ba96748af9c" providerId="LiveId" clId="{7D9BC6C3-ADD0-49E2-9986-EB182164A847}" dt="2022-03-18T06:37:54.638" v="838" actId="11529"/>
          <ac:spMkLst>
            <pc:docMk/>
            <pc:sldMk cId="2753622518" sldId="278"/>
            <ac:spMk id="29" creationId="{29074086-7EA3-45F0-BE5A-BD91D2B98C1A}"/>
          </ac:spMkLst>
        </pc:spChg>
        <pc:spChg chg="add del">
          <ac:chgData name="吉武 和敏" userId="e4825ba96748af9c" providerId="LiveId" clId="{7D9BC6C3-ADD0-49E2-9986-EB182164A847}" dt="2022-03-18T06:38:10.425" v="842" actId="478"/>
          <ac:spMkLst>
            <pc:docMk/>
            <pc:sldMk cId="2753622518" sldId="278"/>
            <ac:spMk id="30" creationId="{D83E8FF4-6EB9-4016-AB07-D807ED34904A}"/>
          </ac:spMkLst>
        </pc:spChg>
        <pc:spChg chg="add">
          <ac:chgData name="吉武 和敏" userId="e4825ba96748af9c" providerId="LiveId" clId="{7D9BC6C3-ADD0-49E2-9986-EB182164A847}" dt="2022-03-18T06:38:29.173" v="844" actId="11529"/>
          <ac:spMkLst>
            <pc:docMk/>
            <pc:sldMk cId="2753622518" sldId="278"/>
            <ac:spMk id="31" creationId="{513679D1-DEB3-496E-863D-C6B6D3628555}"/>
          </ac:spMkLst>
        </pc:spChg>
        <pc:grpChg chg="add del mod">
          <ac:chgData name="吉武 和敏" userId="e4825ba96748af9c" providerId="LiveId" clId="{7D9BC6C3-ADD0-49E2-9986-EB182164A847}" dt="2022-03-18T06:32:03.258" v="794" actId="478"/>
          <ac:grpSpMkLst>
            <pc:docMk/>
            <pc:sldMk cId="2753622518" sldId="278"/>
            <ac:grpSpMk id="16" creationId="{54A48B4E-DD36-4FC4-960A-9F9DCA8CF854}"/>
          </ac:grpSpMkLst>
        </pc:grpChg>
        <pc:graphicFrameChg chg="mod modGraphic">
          <ac:chgData name="吉武 和敏" userId="e4825ba96748af9c" providerId="LiveId" clId="{7D9BC6C3-ADD0-49E2-9986-EB182164A847}" dt="2022-03-18T06:35:28.011" v="816" actId="207"/>
          <ac:graphicFrameMkLst>
            <pc:docMk/>
            <pc:sldMk cId="2753622518" sldId="278"/>
            <ac:graphicFrameMk id="3" creationId="{6E67CC4C-4DEC-4F4E-9314-8265D0985035}"/>
          </ac:graphicFrameMkLst>
        </pc:graphicFrameChg>
        <pc:graphicFrameChg chg="mod">
          <ac:chgData name="吉武 和敏" userId="e4825ba96748af9c" providerId="LiveId" clId="{7D9BC6C3-ADD0-49E2-9986-EB182164A847}" dt="2022-03-18T06:30:41.208" v="780" actId="1076"/>
          <ac:graphicFrameMkLst>
            <pc:docMk/>
            <pc:sldMk cId="2753622518" sldId="278"/>
            <ac:graphicFrameMk id="4" creationId="{2241D1E8-1A15-469D-8B1F-2C574C5FF7FA}"/>
          </ac:graphicFrameMkLst>
        </pc:graphicFrameChg>
        <pc:cxnChg chg="add del mod">
          <ac:chgData name="吉武 和敏" userId="e4825ba96748af9c" providerId="LiveId" clId="{7D9BC6C3-ADD0-49E2-9986-EB182164A847}" dt="2022-03-18T06:37:26.568" v="837" actId="478"/>
          <ac:cxnSpMkLst>
            <pc:docMk/>
            <pc:sldMk cId="2753622518" sldId="278"/>
            <ac:cxnSpMk id="11" creationId="{6F44B182-5022-497B-B3EF-2EEF73414092}"/>
          </ac:cxnSpMkLst>
        </pc:cxnChg>
      </pc:sldChg>
      <pc:sldChg chg="del">
        <pc:chgData name="吉武 和敏" userId="e4825ba96748af9c" providerId="LiveId" clId="{7D9BC6C3-ADD0-49E2-9986-EB182164A847}" dt="2022-03-18T08:03:06.196" v="1822" actId="47"/>
        <pc:sldMkLst>
          <pc:docMk/>
          <pc:sldMk cId="1047350898" sldId="848"/>
        </pc:sldMkLst>
      </pc:sldChg>
      <pc:sldChg chg="addSp delSp modSp mod modAnim">
        <pc:chgData name="吉武 和敏" userId="e4825ba96748af9c" providerId="LiveId" clId="{7D9BC6C3-ADD0-49E2-9986-EB182164A847}" dt="2022-03-18T08:01:14.955" v="1787" actId="20577"/>
        <pc:sldMkLst>
          <pc:docMk/>
          <pc:sldMk cId="731570627" sldId="849"/>
        </pc:sldMkLst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2" creationId="{86A720CB-688F-44AD-93B9-21725394B9F5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3" creationId="{18DA21D4-12DA-40A0-B413-F4B558A4AE8A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4" creationId="{41D95B17-756A-4585-B280-1098ECF3D936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5" creationId="{8A63F1E4-64F2-44F1-946F-4FD68E3C67E9}"/>
          </ac:spMkLst>
        </pc:spChg>
        <pc:spChg chg="add mod">
          <ac:chgData name="吉武 和敏" userId="e4825ba96748af9c" providerId="LiveId" clId="{7D9BC6C3-ADD0-49E2-9986-EB182164A847}" dt="2022-03-18T07:27:37.826" v="1170" actId="164"/>
          <ac:spMkLst>
            <pc:docMk/>
            <pc:sldMk cId="731570627" sldId="849"/>
            <ac:spMk id="6" creationId="{03EBDB8B-1E40-4B04-8B5B-AD75DF492D63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7" creationId="{41C1A4FB-B4B0-498E-82D3-CD0615C86A82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8" creationId="{12A4CC10-4D84-4F33-AF5F-7BD3ACC72EA7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9" creationId="{CFA5A6C2-0C98-464D-A4D6-58CB252258F4}"/>
          </ac:spMkLst>
        </pc:spChg>
        <pc:spChg chg="del mod">
          <ac:chgData name="吉武 和敏" userId="e4825ba96748af9c" providerId="LiveId" clId="{7D9BC6C3-ADD0-49E2-9986-EB182164A847}" dt="2022-03-18T07:08:55.395" v="1148" actId="478"/>
          <ac:spMkLst>
            <pc:docMk/>
            <pc:sldMk cId="731570627" sldId="849"/>
            <ac:spMk id="10" creationId="{53FE06AD-F4A6-4357-90C1-0C6374FCDBDF}"/>
          </ac:spMkLst>
        </pc:spChg>
        <pc:spChg chg="del mod">
          <ac:chgData name="吉武 和敏" userId="e4825ba96748af9c" providerId="LiveId" clId="{7D9BC6C3-ADD0-49E2-9986-EB182164A847}" dt="2022-03-18T07:08:52.580" v="1147" actId="478"/>
          <ac:spMkLst>
            <pc:docMk/>
            <pc:sldMk cId="731570627" sldId="849"/>
            <ac:spMk id="11" creationId="{A31B3470-C369-49B8-8D8E-575E6EF6EF17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12" creationId="{2EF3C249-9CA1-4AB1-B4A1-E9AC456FA64D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13" creationId="{58192918-1D3F-4432-8675-2210F8E4BEFD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14" creationId="{3A20B7D2-392E-4303-8F34-BF3EE5B76636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15" creationId="{72185980-969C-45D6-A755-E0F44EDD07E4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16" creationId="{E9A2BC1B-716E-402C-B184-D7FC59A5E1E7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17" creationId="{B0E096C1-C4BA-4D54-99FE-46E57F5CAC4F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18" creationId="{C862FE55-7F22-4E04-83CA-60F5D3679034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19" creationId="{CC651CF2-E12F-40D9-B03F-2D2B1E60F4FF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20" creationId="{004BBF05-7158-4EF6-B1BA-F2675548717A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21" creationId="{76AE29A8-F744-4B03-976E-4B68E3FC6903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22" creationId="{46BB1C3D-AE29-481A-87F3-14B6BDB58A50}"/>
          </ac:spMkLst>
        </pc:spChg>
        <pc:spChg chg="del mod">
          <ac:chgData name="吉武 和敏" userId="e4825ba96748af9c" providerId="LiveId" clId="{7D9BC6C3-ADD0-49E2-9986-EB182164A847}" dt="2022-03-18T07:28:33.590" v="1173" actId="21"/>
          <ac:spMkLst>
            <pc:docMk/>
            <pc:sldMk cId="731570627" sldId="849"/>
            <ac:spMk id="23" creationId="{B0FAB632-2895-447B-9AAB-3EA5841196FE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24" creationId="{31711E34-5E5F-44A5-B03E-F1D053AB8ABA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25" creationId="{7FC81EE4-1C66-44E1-AF05-A528AFD213DC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26" creationId="{BB32BB4D-729C-4957-969B-32107EB4D1E2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27" creationId="{B56048B9-A433-4A98-B8C4-403F245586F2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28" creationId="{9AB47BBD-DCCE-4D37-8151-6AD97F9917AA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29" creationId="{E8985CD3-DF1A-4B67-BE45-57AC768A588D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30" creationId="{A33342B1-37D8-4CDB-B660-40D486DB32C7}"/>
          </ac:spMkLst>
        </pc:spChg>
        <pc:spChg chg="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31" creationId="{4BAE4256-DF19-4FEA-9303-1C59D608920B}"/>
          </ac:spMkLst>
        </pc:spChg>
        <pc:spChg chg="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32" creationId="{BF632E63-1009-4319-A02D-4DE7E4B511C7}"/>
          </ac:spMkLst>
        </pc:spChg>
        <pc:spChg chg="add mod">
          <ac:chgData name="吉武 和敏" userId="e4825ba96748af9c" providerId="LiveId" clId="{7D9BC6C3-ADD0-49E2-9986-EB182164A847}" dt="2022-03-18T07:58:56.143" v="1768" actId="20577"/>
          <ac:spMkLst>
            <pc:docMk/>
            <pc:sldMk cId="731570627" sldId="849"/>
            <ac:spMk id="33" creationId="{B35105A8-391C-4926-8F7C-FC34F1BE1AC4}"/>
          </ac:spMkLst>
        </pc:spChg>
        <pc:spChg chg="add mod">
          <ac:chgData name="吉武 和敏" userId="e4825ba96748af9c" providerId="LiveId" clId="{7D9BC6C3-ADD0-49E2-9986-EB182164A847}" dt="2022-03-18T08:01:14.955" v="1787" actId="20577"/>
          <ac:spMkLst>
            <pc:docMk/>
            <pc:sldMk cId="731570627" sldId="849"/>
            <ac:spMk id="34" creationId="{B3C0C293-42B2-4F35-9D6A-7C5C20BF4FA1}"/>
          </ac:spMkLst>
        </pc:spChg>
        <pc:spChg chg="add del mod">
          <ac:chgData name="吉武 和敏" userId="e4825ba96748af9c" providerId="LiveId" clId="{7D9BC6C3-ADD0-49E2-9986-EB182164A847}" dt="2022-03-18T07:37:02.271" v="1345" actId="478"/>
          <ac:spMkLst>
            <pc:docMk/>
            <pc:sldMk cId="731570627" sldId="849"/>
            <ac:spMk id="35" creationId="{A0A2FA7F-F3A7-4914-896A-716B5EB6F74D}"/>
          </ac:spMkLst>
        </pc:spChg>
        <pc:spChg chg="add del mod">
          <ac:chgData name="吉武 和敏" userId="e4825ba96748af9c" providerId="LiveId" clId="{7D9BC6C3-ADD0-49E2-9986-EB182164A847}" dt="2022-03-18T07:28:37.104" v="1174" actId="478"/>
          <ac:spMkLst>
            <pc:docMk/>
            <pc:sldMk cId="731570627" sldId="849"/>
            <ac:spMk id="36" creationId="{8F2BB1A7-D242-4830-9425-2F4222EBD06D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37" creationId="{A79AF4C4-063E-4D62-9A23-11AE238D34B4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38" creationId="{8992DB48-9963-4577-9A3B-0F1CAEEB8DC3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39" creationId="{036180F1-3608-4F45-B835-E322DAB0767E}"/>
          </ac:spMkLst>
        </pc:spChg>
        <pc:spChg chg="add del mod">
          <ac:chgData name="吉武 和敏" userId="e4825ba96748af9c" providerId="LiveId" clId="{7D9BC6C3-ADD0-49E2-9986-EB182164A847}" dt="2022-03-18T07:36:58.703" v="1344" actId="478"/>
          <ac:spMkLst>
            <pc:docMk/>
            <pc:sldMk cId="731570627" sldId="849"/>
            <ac:spMk id="40" creationId="{85941801-89F3-42BF-B9C1-CD0267156B6B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41" creationId="{DB8F1385-3281-49E5-88A3-55C4E58C1404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42" creationId="{A8307465-822B-4E76-8842-B47A4713D478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43" creationId="{698FDE34-BFEE-4AE9-A729-C4F085740ABD}"/>
          </ac:spMkLst>
        </pc:spChg>
        <pc:spChg chg="add mod">
          <ac:chgData name="吉武 和敏" userId="e4825ba96748af9c" providerId="LiveId" clId="{7D9BC6C3-ADD0-49E2-9986-EB182164A847}" dt="2022-03-18T07:46:01.063" v="1435" actId="1076"/>
          <ac:spMkLst>
            <pc:docMk/>
            <pc:sldMk cId="731570627" sldId="849"/>
            <ac:spMk id="44" creationId="{2F54EA21-64D5-4A6C-950D-ADA26AF7DD87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45" creationId="{3100CDE7-91FA-40A7-9DFE-65821B43A00D}"/>
          </ac:spMkLst>
        </pc:spChg>
        <pc:spChg chg="add mod">
          <ac:chgData name="吉武 和敏" userId="e4825ba96748af9c" providerId="LiveId" clId="{7D9BC6C3-ADD0-49E2-9986-EB182164A847}" dt="2022-03-18T07:46:28.465" v="1437" actId="1076"/>
          <ac:spMkLst>
            <pc:docMk/>
            <pc:sldMk cId="731570627" sldId="849"/>
            <ac:spMk id="46" creationId="{79DFFE87-2D56-4693-88C2-FDB43BEAC581}"/>
          </ac:spMkLst>
        </pc:spChg>
        <pc:spChg chg="add del mod">
          <ac:chgData name="吉武 和敏" userId="e4825ba96748af9c" providerId="LiveId" clId="{7D9BC6C3-ADD0-49E2-9986-EB182164A847}" dt="2022-03-18T06:51:23.143" v="1028" actId="478"/>
          <ac:spMkLst>
            <pc:docMk/>
            <pc:sldMk cId="731570627" sldId="849"/>
            <ac:spMk id="47" creationId="{06FF4D90-F2C9-4357-9245-6D6EBFE94DAC}"/>
          </ac:spMkLst>
        </pc:spChg>
        <pc:spChg chg="add mod">
          <ac:chgData name="吉武 和敏" userId="e4825ba96748af9c" providerId="LiveId" clId="{7D9BC6C3-ADD0-49E2-9986-EB182164A847}" dt="2022-03-18T07:27:37.826" v="1170" actId="164"/>
          <ac:spMkLst>
            <pc:docMk/>
            <pc:sldMk cId="731570627" sldId="849"/>
            <ac:spMk id="48" creationId="{7CC711CD-FF96-409C-9059-F846D3AA3C4B}"/>
          </ac:spMkLst>
        </pc:spChg>
        <pc:spChg chg="add mod">
          <ac:chgData name="吉武 和敏" userId="e4825ba96748af9c" providerId="LiveId" clId="{7D9BC6C3-ADD0-49E2-9986-EB182164A847}" dt="2022-03-18T07:27:37.826" v="1170" actId="164"/>
          <ac:spMkLst>
            <pc:docMk/>
            <pc:sldMk cId="731570627" sldId="849"/>
            <ac:spMk id="49" creationId="{C81F6121-807A-4080-9BEA-0D47FBFAFED0}"/>
          </ac:spMkLst>
        </pc:spChg>
        <pc:grpChg chg="add mod">
          <ac:chgData name="吉武 和敏" userId="e4825ba96748af9c" providerId="LiveId" clId="{7D9BC6C3-ADD0-49E2-9986-EB182164A847}" dt="2022-03-18T07:46:28.465" v="1437" actId="1076"/>
          <ac:grpSpMkLst>
            <pc:docMk/>
            <pc:sldMk cId="731570627" sldId="849"/>
            <ac:grpSpMk id="50" creationId="{2E8573AE-45D0-40FF-A188-8DD4553EFF60}"/>
          </ac:grpSpMkLst>
        </pc:grpChg>
        <pc:picChg chg="del">
          <ac:chgData name="吉武 和敏" userId="e4825ba96748af9c" providerId="LiveId" clId="{7D9BC6C3-ADD0-49E2-9986-EB182164A847}" dt="2022-03-18T06:46:39.401" v="997" actId="478"/>
          <ac:picMkLst>
            <pc:docMk/>
            <pc:sldMk cId="731570627" sldId="849"/>
            <ac:picMk id="5122" creationId="{708902DD-6FB6-4B34-954E-3F0987209E69}"/>
          </ac:picMkLst>
        </pc:picChg>
      </pc:sldChg>
      <pc:sldChg chg="delSp del mod">
        <pc:chgData name="吉武 和敏" userId="e4825ba96748af9c" providerId="LiveId" clId="{7D9BC6C3-ADD0-49E2-9986-EB182164A847}" dt="2022-03-18T08:01:38.492" v="1788" actId="47"/>
        <pc:sldMkLst>
          <pc:docMk/>
          <pc:sldMk cId="2300418936" sldId="850"/>
        </pc:sldMkLst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2" creationId="{FB0962DD-C6E1-425E-97A9-DAA42BFB7ECA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3" creationId="{67CFCD4B-6FD7-4716-A0C3-F1C32D24CA79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4" creationId="{3F4C895A-02A3-4123-BA2E-F76865753029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5" creationId="{1F9FDE14-8429-4F26-B5E6-20754F354E21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7" creationId="{74D71D79-9532-437B-9BB8-72422682C55C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8" creationId="{6D35DE78-1EC5-4FC0-9534-DFC4CD334604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9" creationId="{9C20F8E7-0909-464D-BFD8-7ED7A9D17A7D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0" creationId="{73EFC6C7-DCC0-42C1-A9AB-F52F30FBAA9F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1" creationId="{0FB8AD3D-7BDE-4846-9079-9F0728EC30FD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2" creationId="{7DA75BF2-3DE5-4BD6-8BA2-C5777EF8FC7F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3" creationId="{26DE3C7D-0E1F-4C80-B103-2DAF98C44875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4" creationId="{39A7A274-B3DC-4B5C-BAC0-850E35DB3977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5" creationId="{72BC3E60-6777-4E53-BB93-70B40B47F4F7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6" creationId="{F4C4B0EC-80E4-4C1A-9C3C-CBE5DEFABB8F}"/>
          </ac:spMkLst>
        </pc:spChg>
        <pc:spChg chg="del">
          <ac:chgData name="吉武 和敏" userId="e4825ba96748af9c" providerId="LiveId" clId="{7D9BC6C3-ADD0-49E2-9986-EB182164A847}" dt="2022-03-18T06:47:29.007" v="1003" actId="21"/>
          <ac:spMkLst>
            <pc:docMk/>
            <pc:sldMk cId="2300418936" sldId="850"/>
            <ac:spMk id="17" creationId="{FFCD9738-A8BA-4C9D-904D-19A0C2C23FF1}"/>
          </ac:spMkLst>
        </pc:spChg>
      </pc:sldChg>
    </pc:docChg>
  </pc:docChgLst>
  <pc:docChgLst>
    <pc:chgData name="吉武 和敏" userId="e4825ba96748af9c" providerId="LiveId" clId="{15FD9FA1-5CB1-411D-9C30-AFAF7EA2C5F4}"/>
    <pc:docChg chg="undo custSel delSld modSld">
      <pc:chgData name="吉武 和敏" userId="e4825ba96748af9c" providerId="LiveId" clId="{15FD9FA1-5CB1-411D-9C30-AFAF7EA2C5F4}" dt="2022-09-15T07:21:31.513" v="12" actId="47"/>
      <pc:docMkLst>
        <pc:docMk/>
      </pc:docMkLst>
      <pc:sldChg chg="modSp del mod">
        <pc:chgData name="吉武 和敏" userId="e4825ba96748af9c" providerId="LiveId" clId="{15FD9FA1-5CB1-411D-9C30-AFAF7EA2C5F4}" dt="2022-09-15T07:21:31.513" v="12" actId="47"/>
        <pc:sldMkLst>
          <pc:docMk/>
          <pc:sldMk cId="2737082793" sldId="257"/>
        </pc:sldMkLst>
        <pc:spChg chg="mod">
          <ac:chgData name="吉武 和敏" userId="e4825ba96748af9c" providerId="LiveId" clId="{15FD9FA1-5CB1-411D-9C30-AFAF7EA2C5F4}" dt="2022-09-15T07:06:47.207" v="2" actId="1076"/>
          <ac:spMkLst>
            <pc:docMk/>
            <pc:sldMk cId="2737082793" sldId="257"/>
            <ac:spMk id="6" creationId="{9B71010E-C53D-E719-AE80-F50BB9C887AB}"/>
          </ac:spMkLst>
        </pc:spChg>
        <pc:spChg chg="mod">
          <ac:chgData name="吉武 和敏" userId="e4825ba96748af9c" providerId="LiveId" clId="{15FD9FA1-5CB1-411D-9C30-AFAF7EA2C5F4}" dt="2022-09-15T07:14:12.768" v="9" actId="6549"/>
          <ac:spMkLst>
            <pc:docMk/>
            <pc:sldMk cId="2737082793" sldId="257"/>
            <ac:spMk id="7" creationId="{C82224E9-2399-839F-B27B-4D0914EC238D}"/>
          </ac:spMkLst>
        </pc:spChg>
        <pc:graphicFrameChg chg="modGraphic">
          <ac:chgData name="吉武 和敏" userId="e4825ba96748af9c" providerId="LiveId" clId="{15FD9FA1-5CB1-411D-9C30-AFAF7EA2C5F4}" dt="2022-09-15T07:06:43.638" v="1" actId="21"/>
          <ac:graphicFrameMkLst>
            <pc:docMk/>
            <pc:sldMk cId="2737082793" sldId="257"/>
            <ac:graphicFrameMk id="2" creationId="{C63A816A-7065-B6FF-2CD4-416D7C9982E2}"/>
          </ac:graphicFrameMkLst>
        </pc:graphicFrameChg>
      </pc:sldChg>
      <pc:sldChg chg="modSp del mod">
        <pc:chgData name="吉武 和敏" userId="e4825ba96748af9c" providerId="LiveId" clId="{15FD9FA1-5CB1-411D-9C30-AFAF7EA2C5F4}" dt="2022-09-15T07:21:31.513" v="12" actId="47"/>
        <pc:sldMkLst>
          <pc:docMk/>
          <pc:sldMk cId="2928055407" sldId="263"/>
        </pc:sldMkLst>
        <pc:spChg chg="mod">
          <ac:chgData name="吉武 和敏" userId="e4825ba96748af9c" providerId="LiveId" clId="{15FD9FA1-5CB1-411D-9C30-AFAF7EA2C5F4}" dt="2022-09-15T07:14:16.563" v="10" actId="20577"/>
          <ac:spMkLst>
            <pc:docMk/>
            <pc:sldMk cId="2928055407" sldId="263"/>
            <ac:spMk id="3" creationId="{F0DE7B9D-5B30-4F9D-9BE9-33D3637F3139}"/>
          </ac:spMkLst>
        </pc:spChg>
      </pc:sldChg>
      <pc:sldChg chg="modSp del mod">
        <pc:chgData name="吉武 和敏" userId="e4825ba96748af9c" providerId="LiveId" clId="{15FD9FA1-5CB1-411D-9C30-AFAF7EA2C5F4}" dt="2022-09-15T07:21:31.513" v="12" actId="47"/>
        <pc:sldMkLst>
          <pc:docMk/>
          <pc:sldMk cId="1214924586" sldId="264"/>
        </pc:sldMkLst>
        <pc:spChg chg="mod">
          <ac:chgData name="吉武 和敏" userId="e4825ba96748af9c" providerId="LiveId" clId="{15FD9FA1-5CB1-411D-9C30-AFAF7EA2C5F4}" dt="2022-09-15T07:14:20.244" v="11" actId="20577"/>
          <ac:spMkLst>
            <pc:docMk/>
            <pc:sldMk cId="1214924586" sldId="264"/>
            <ac:spMk id="3" creationId="{1C8D6076-5E91-4163-86D4-51A223E85E0C}"/>
          </ac:spMkLst>
        </pc:spChg>
      </pc:sldChg>
      <pc:sldChg chg="del">
        <pc:chgData name="吉武 和敏" userId="e4825ba96748af9c" providerId="LiveId" clId="{15FD9FA1-5CB1-411D-9C30-AFAF7EA2C5F4}" dt="2022-09-15T07:21:31.513" v="12" actId="47"/>
        <pc:sldMkLst>
          <pc:docMk/>
          <pc:sldMk cId="3518054801" sldId="271"/>
        </pc:sldMkLst>
      </pc:sldChg>
      <pc:sldChg chg="del">
        <pc:chgData name="吉武 和敏" userId="e4825ba96748af9c" providerId="LiveId" clId="{15FD9FA1-5CB1-411D-9C30-AFAF7EA2C5F4}" dt="2022-09-15T07:21:31.513" v="12" actId="47"/>
        <pc:sldMkLst>
          <pc:docMk/>
          <pc:sldMk cId="1148990755" sldId="273"/>
        </pc:sldMkLst>
      </pc:sldChg>
      <pc:sldChg chg="del">
        <pc:chgData name="吉武 和敏" userId="e4825ba96748af9c" providerId="LiveId" clId="{15FD9FA1-5CB1-411D-9C30-AFAF7EA2C5F4}" dt="2022-09-15T07:21:31.513" v="12" actId="47"/>
        <pc:sldMkLst>
          <pc:docMk/>
          <pc:sldMk cId="3718634027" sldId="274"/>
        </pc:sldMkLst>
      </pc:sldChg>
      <pc:sldChg chg="del">
        <pc:chgData name="吉武 和敏" userId="e4825ba96748af9c" providerId="LiveId" clId="{15FD9FA1-5CB1-411D-9C30-AFAF7EA2C5F4}" dt="2022-09-15T07:21:31.513" v="12" actId="47"/>
        <pc:sldMkLst>
          <pc:docMk/>
          <pc:sldMk cId="3305646646" sldId="275"/>
        </pc:sldMkLst>
      </pc:sldChg>
    </pc:docChg>
  </pc:docChgLst>
  <pc:docChgLst>
    <pc:chgData name="吉武 和敏" userId="e4825ba96748af9c" providerId="LiveId" clId="{D8F8C96C-8CA0-429B-86BE-3F66D77F7287}"/>
    <pc:docChg chg="delSld">
      <pc:chgData name="吉武 和敏" userId="e4825ba96748af9c" providerId="LiveId" clId="{D8F8C96C-8CA0-429B-86BE-3F66D77F7287}" dt="2022-09-15T07:22:21.155" v="0" actId="47"/>
      <pc:docMkLst>
        <pc:docMk/>
      </pc:docMkLst>
      <pc:sldChg chg="del">
        <pc:chgData name="吉武 和敏" userId="e4825ba96748af9c" providerId="LiveId" clId="{D8F8C96C-8CA0-429B-86BE-3F66D77F7287}" dt="2022-09-15T07:22:21.155" v="0" actId="47"/>
        <pc:sldMkLst>
          <pc:docMk/>
          <pc:sldMk cId="2806979806" sldId="262"/>
        </pc:sldMkLst>
      </pc:sldChg>
      <pc:sldChg chg="del">
        <pc:chgData name="吉武 和敏" userId="e4825ba96748af9c" providerId="LiveId" clId="{D8F8C96C-8CA0-429B-86BE-3F66D77F7287}" dt="2022-09-15T07:22:21.155" v="0" actId="47"/>
        <pc:sldMkLst>
          <pc:docMk/>
          <pc:sldMk cId="3293758939" sldId="265"/>
        </pc:sldMkLst>
      </pc:sldChg>
      <pc:sldChg chg="del">
        <pc:chgData name="吉武 和敏" userId="e4825ba96748af9c" providerId="LiveId" clId="{D8F8C96C-8CA0-429B-86BE-3F66D77F7287}" dt="2022-09-15T07:22:21.155" v="0" actId="47"/>
        <pc:sldMkLst>
          <pc:docMk/>
          <pc:sldMk cId="1801781158" sldId="276"/>
        </pc:sldMkLst>
      </pc:sldChg>
      <pc:sldChg chg="del">
        <pc:chgData name="吉武 和敏" userId="e4825ba96748af9c" providerId="LiveId" clId="{D8F8C96C-8CA0-429B-86BE-3F66D77F7287}" dt="2022-09-15T07:22:21.155" v="0" actId="47"/>
        <pc:sldMkLst>
          <pc:docMk/>
          <pc:sldMk cId="2753622518" sldId="278"/>
        </pc:sldMkLst>
      </pc:sldChg>
      <pc:sldChg chg="del">
        <pc:chgData name="吉武 和敏" userId="e4825ba96748af9c" providerId="LiveId" clId="{D8F8C96C-8CA0-429B-86BE-3F66D77F7287}" dt="2022-09-15T07:22:21.155" v="0" actId="47"/>
        <pc:sldMkLst>
          <pc:docMk/>
          <pc:sldMk cId="731570627" sldId="849"/>
        </pc:sldMkLst>
      </pc:sldChg>
    </pc:docChg>
  </pc:docChgLst>
  <pc:docChgLst>
    <pc:chgData name="吉武 和敏" userId="e4825ba96748af9c" providerId="LiveId" clId="{07C93B19-CA14-42D4-A579-56BF69355786}"/>
    <pc:docChg chg="custSel addSld delSld modSld sldOrd">
      <pc:chgData name="吉武 和敏" userId="e4825ba96748af9c" providerId="LiveId" clId="{07C93B19-CA14-42D4-A579-56BF69355786}" dt="2020-09-03T07:53:12.567" v="429" actId="6549"/>
      <pc:docMkLst>
        <pc:docMk/>
      </pc:docMkLst>
      <pc:sldChg chg="modSp mod">
        <pc:chgData name="吉武 和敏" userId="e4825ba96748af9c" providerId="LiveId" clId="{07C93B19-CA14-42D4-A579-56BF69355786}" dt="2020-09-03T07:37:26.556" v="253" actId="20577"/>
        <pc:sldMkLst>
          <pc:docMk/>
          <pc:sldMk cId="1744819178" sldId="257"/>
        </pc:sldMkLst>
        <pc:spChg chg="mod">
          <ac:chgData name="吉武 和敏" userId="e4825ba96748af9c" providerId="LiveId" clId="{07C93B19-CA14-42D4-A579-56BF69355786}" dt="2020-09-03T07:37:26.556" v="253" actId="20577"/>
          <ac:spMkLst>
            <pc:docMk/>
            <pc:sldMk cId="1744819178" sldId="257"/>
            <ac:spMk id="11" creationId="{00000000-0000-0000-0000-000000000000}"/>
          </ac:spMkLst>
        </pc:spChg>
      </pc:sldChg>
      <pc:sldChg chg="modSp mod">
        <pc:chgData name="吉武 和敏" userId="e4825ba96748af9c" providerId="LiveId" clId="{07C93B19-CA14-42D4-A579-56BF69355786}" dt="2020-09-03T07:45:12.402" v="255" actId="20577"/>
        <pc:sldMkLst>
          <pc:docMk/>
          <pc:sldMk cId="1279635173" sldId="258"/>
        </pc:sldMkLst>
        <pc:spChg chg="mod">
          <ac:chgData name="吉武 和敏" userId="e4825ba96748af9c" providerId="LiveId" clId="{07C93B19-CA14-42D4-A579-56BF69355786}" dt="2020-09-03T07:45:12.402" v="255" actId="20577"/>
          <ac:spMkLst>
            <pc:docMk/>
            <pc:sldMk cId="1279635173" sldId="258"/>
            <ac:spMk id="17" creationId="{B2D68AC7-1A9E-486E-8E8C-4E418A7A418D}"/>
          </ac:spMkLst>
        </pc:spChg>
        <pc:graphicFrameChg chg="mod">
          <ac:chgData name="吉武 和敏" userId="e4825ba96748af9c" providerId="LiveId" clId="{07C93B19-CA14-42D4-A579-56BF69355786}" dt="2020-09-03T07:37:47.769" v="254" actId="207"/>
          <ac:graphicFrameMkLst>
            <pc:docMk/>
            <pc:sldMk cId="1279635173" sldId="258"/>
            <ac:graphicFrameMk id="15" creationId="{00000000-0008-0000-0000-000003000000}"/>
          </ac:graphicFrameMkLst>
        </pc:graphicFrameChg>
      </pc:sldChg>
      <pc:sldChg chg="modSp mod">
        <pc:chgData name="吉武 和敏" userId="e4825ba96748af9c" providerId="LiveId" clId="{07C93B19-CA14-42D4-A579-56BF69355786}" dt="2020-09-03T06:27:01.757" v="224" actId="1076"/>
        <pc:sldMkLst>
          <pc:docMk/>
          <pc:sldMk cId="2704609531" sldId="268"/>
        </pc:sldMkLst>
        <pc:spChg chg="mod">
          <ac:chgData name="吉武 和敏" userId="e4825ba96748af9c" providerId="LiveId" clId="{07C93B19-CA14-42D4-A579-56BF69355786}" dt="2020-09-03T06:27:01.757" v="224" actId="1076"/>
          <ac:spMkLst>
            <pc:docMk/>
            <pc:sldMk cId="2704609531" sldId="268"/>
            <ac:spMk id="464" creationId="{34EBC69B-984F-4718-B389-24BE132528C5}"/>
          </ac:spMkLst>
        </pc:spChg>
      </pc:sldChg>
      <pc:sldChg chg="modSp mod">
        <pc:chgData name="吉武 和敏" userId="e4825ba96748af9c" providerId="LiveId" clId="{07C93B19-CA14-42D4-A579-56BF69355786}" dt="2020-09-03T07:32:51.110" v="252" actId="20577"/>
        <pc:sldMkLst>
          <pc:docMk/>
          <pc:sldMk cId="3600490621" sldId="269"/>
        </pc:sldMkLst>
        <pc:spChg chg="mod">
          <ac:chgData name="吉武 和敏" userId="e4825ba96748af9c" providerId="LiveId" clId="{07C93B19-CA14-42D4-A579-56BF69355786}" dt="2020-09-03T07:32:25.717" v="242" actId="20577"/>
          <ac:spMkLst>
            <pc:docMk/>
            <pc:sldMk cId="3600490621" sldId="269"/>
            <ac:spMk id="43" creationId="{EBFA25FB-F771-48F4-813D-7C618FB7AD47}"/>
          </ac:spMkLst>
        </pc:spChg>
        <pc:spChg chg="mod">
          <ac:chgData name="吉武 和敏" userId="e4825ba96748af9c" providerId="LiveId" clId="{07C93B19-CA14-42D4-A579-56BF69355786}" dt="2020-09-03T07:32:29.622" v="244" actId="20577"/>
          <ac:spMkLst>
            <pc:docMk/>
            <pc:sldMk cId="3600490621" sldId="269"/>
            <ac:spMk id="54" creationId="{F58C9D88-1738-43D0-91BA-E680AE232662}"/>
          </ac:spMkLst>
        </pc:spChg>
        <pc:spChg chg="mod">
          <ac:chgData name="吉武 和敏" userId="e4825ba96748af9c" providerId="LiveId" clId="{07C93B19-CA14-42D4-A579-56BF69355786}" dt="2020-09-03T07:32:33.031" v="246" actId="20577"/>
          <ac:spMkLst>
            <pc:docMk/>
            <pc:sldMk cId="3600490621" sldId="269"/>
            <ac:spMk id="55" creationId="{74BA2DED-2485-4D8E-8D8A-60208E47CBFF}"/>
          </ac:spMkLst>
        </pc:spChg>
        <pc:spChg chg="mod">
          <ac:chgData name="吉武 和敏" userId="e4825ba96748af9c" providerId="LiveId" clId="{07C93B19-CA14-42D4-A579-56BF69355786}" dt="2020-09-03T07:32:51.110" v="252" actId="20577"/>
          <ac:spMkLst>
            <pc:docMk/>
            <pc:sldMk cId="3600490621" sldId="269"/>
            <ac:spMk id="58" creationId="{843EBD7F-F4CE-442D-9EA6-E84F9F778925}"/>
          </ac:spMkLst>
        </pc:spChg>
        <pc:spChg chg="mod">
          <ac:chgData name="吉武 和敏" userId="e4825ba96748af9c" providerId="LiveId" clId="{07C93B19-CA14-42D4-A579-56BF69355786}" dt="2020-09-03T07:32:48.149" v="250" actId="20577"/>
          <ac:spMkLst>
            <pc:docMk/>
            <pc:sldMk cId="3600490621" sldId="269"/>
            <ac:spMk id="59" creationId="{B27533F2-3389-4C70-8282-9031981DC756}"/>
          </ac:spMkLst>
        </pc:spChg>
        <pc:spChg chg="mod">
          <ac:chgData name="吉武 和敏" userId="e4825ba96748af9c" providerId="LiveId" clId="{07C93B19-CA14-42D4-A579-56BF69355786}" dt="2020-09-03T07:32:44.821" v="248" actId="20577"/>
          <ac:spMkLst>
            <pc:docMk/>
            <pc:sldMk cId="3600490621" sldId="269"/>
            <ac:spMk id="60" creationId="{DA35C147-B146-4D3E-9594-DF7CCA1C7041}"/>
          </ac:spMkLst>
        </pc:spChg>
        <pc:spChg chg="mod">
          <ac:chgData name="吉武 和敏" userId="e4825ba96748af9c" providerId="LiveId" clId="{07C93B19-CA14-42D4-A579-56BF69355786}" dt="2020-09-03T06:29:07.305" v="237" actId="20577"/>
          <ac:spMkLst>
            <pc:docMk/>
            <pc:sldMk cId="3600490621" sldId="269"/>
            <ac:spMk id="148" creationId="{8EA9CF68-ACDA-455B-97C7-59AF4AF6EAD8}"/>
          </ac:spMkLst>
        </pc:spChg>
      </pc:sldChg>
      <pc:sldChg chg="modSp mod ord">
        <pc:chgData name="吉武 和敏" userId="e4825ba96748af9c" providerId="LiveId" clId="{07C93B19-CA14-42D4-A579-56BF69355786}" dt="2020-09-03T07:53:12.567" v="429" actId="6549"/>
        <pc:sldMkLst>
          <pc:docMk/>
          <pc:sldMk cId="664468651" sldId="277"/>
        </pc:sldMkLst>
        <pc:spChg chg="mod">
          <ac:chgData name="吉武 和敏" userId="e4825ba96748af9c" providerId="LiveId" clId="{07C93B19-CA14-42D4-A579-56BF69355786}" dt="2020-09-03T07:53:12.567" v="429" actId="6549"/>
          <ac:spMkLst>
            <pc:docMk/>
            <pc:sldMk cId="664468651" sldId="277"/>
            <ac:spMk id="7" creationId="{F72334D3-2C6D-4958-B3FA-0EE2C20DE506}"/>
          </ac:spMkLst>
        </pc:spChg>
      </pc:sldChg>
      <pc:sldChg chg="modSp mod">
        <pc:chgData name="吉武 和敏" userId="e4825ba96748af9c" providerId="LiveId" clId="{07C93B19-CA14-42D4-A579-56BF69355786}" dt="2020-09-03T06:45:47.411" v="238" actId="6549"/>
        <pc:sldMkLst>
          <pc:docMk/>
          <pc:sldMk cId="370389737" sldId="278"/>
        </pc:sldMkLst>
        <pc:spChg chg="mod">
          <ac:chgData name="吉武 和敏" userId="e4825ba96748af9c" providerId="LiveId" clId="{07C93B19-CA14-42D4-A579-56BF69355786}" dt="2020-09-03T06:45:47.411" v="238" actId="6549"/>
          <ac:spMkLst>
            <pc:docMk/>
            <pc:sldMk cId="370389737" sldId="278"/>
            <ac:spMk id="10" creationId="{03EB489A-2754-4EF8-B046-85DE05011559}"/>
          </ac:spMkLst>
        </pc:spChg>
      </pc:sldChg>
      <pc:sldChg chg="addSp delSp modSp add mod">
        <pc:chgData name="吉武 和敏" userId="e4825ba96748af9c" providerId="LiveId" clId="{07C93B19-CA14-42D4-A579-56BF69355786}" dt="2020-09-03T07:50:49.514" v="307" actId="20577"/>
        <pc:sldMkLst>
          <pc:docMk/>
          <pc:sldMk cId="3831337953" sldId="279"/>
        </pc:sldMkLst>
        <pc:spChg chg="add mod ord">
          <ac:chgData name="吉武 和敏" userId="e4825ba96748af9c" providerId="LiveId" clId="{07C93B19-CA14-42D4-A579-56BF69355786}" dt="2020-08-24T15:45:09.610" v="40" actId="166"/>
          <ac:spMkLst>
            <pc:docMk/>
            <pc:sldMk cId="3831337953" sldId="279"/>
            <ac:spMk id="4" creationId="{50AD6A44-8C47-4D00-AC64-82CF3915729E}"/>
          </ac:spMkLst>
        </pc:spChg>
        <pc:spChg chg="add mod">
          <ac:chgData name="吉武 和敏" userId="e4825ba96748af9c" providerId="LiveId" clId="{07C93B19-CA14-42D4-A579-56BF69355786}" dt="2020-08-24T15:45:04.739" v="39" actId="14100"/>
          <ac:spMkLst>
            <pc:docMk/>
            <pc:sldMk cId="3831337953" sldId="279"/>
            <ac:spMk id="5" creationId="{4330C9F9-A1A5-4F62-8CBC-67F1B7740ACE}"/>
          </ac:spMkLst>
        </pc:spChg>
        <pc:spChg chg="add del">
          <ac:chgData name="吉武 和敏" userId="e4825ba96748af9c" providerId="LiveId" clId="{07C93B19-CA14-42D4-A579-56BF69355786}" dt="2020-08-24T15:46:14.230" v="159"/>
          <ac:spMkLst>
            <pc:docMk/>
            <pc:sldMk cId="3831337953" sldId="279"/>
            <ac:spMk id="6" creationId="{A906B463-8FA9-46E4-8ED6-CB3238985C5F}"/>
          </ac:spMkLst>
        </pc:spChg>
        <pc:spChg chg="add del">
          <ac:chgData name="吉武 和敏" userId="e4825ba96748af9c" providerId="LiveId" clId="{07C93B19-CA14-42D4-A579-56BF69355786}" dt="2020-08-24T15:46:16.564" v="161"/>
          <ac:spMkLst>
            <pc:docMk/>
            <pc:sldMk cId="3831337953" sldId="279"/>
            <ac:spMk id="7" creationId="{B0FA28B8-B7E2-4C9A-A750-7D6B46D7E740}"/>
          </ac:spMkLst>
        </pc:spChg>
        <pc:spChg chg="mod">
          <ac:chgData name="吉武 和敏" userId="e4825ba96748af9c" providerId="LiveId" clId="{07C93B19-CA14-42D4-A579-56BF69355786}" dt="2020-09-03T07:50:49.514" v="307" actId="20577"/>
          <ac:spMkLst>
            <pc:docMk/>
            <pc:sldMk cId="3831337953" sldId="279"/>
            <ac:spMk id="17" creationId="{B2D68AC7-1A9E-486E-8E8C-4E418A7A418D}"/>
          </ac:spMkLst>
        </pc:spChg>
        <pc:graphicFrameChg chg="del">
          <ac:chgData name="吉武 和敏" userId="e4825ba96748af9c" providerId="LiveId" clId="{07C93B19-CA14-42D4-A579-56BF69355786}" dt="2020-08-24T15:44:10.841" v="6" actId="478"/>
          <ac:graphicFrameMkLst>
            <pc:docMk/>
            <pc:sldMk cId="3831337953" sldId="279"/>
            <ac:graphicFrameMk id="15" creationId="{00000000-0008-0000-0000-000003000000}"/>
          </ac:graphicFrameMkLst>
        </pc:graphicFrameChg>
        <pc:picChg chg="add mod modCrop">
          <ac:chgData name="吉武 和敏" userId="e4825ba96748af9c" providerId="LiveId" clId="{07C93B19-CA14-42D4-A579-56BF69355786}" dt="2020-09-03T07:45:42.391" v="256" actId="732"/>
          <ac:picMkLst>
            <pc:docMk/>
            <pc:sldMk cId="3831337953" sldId="279"/>
            <ac:picMk id="3" creationId="{801D9538-80D8-4F72-84B2-D79724EBAF29}"/>
          </ac:picMkLst>
        </pc:picChg>
      </pc:sldChg>
      <pc:sldChg chg="add del">
        <pc:chgData name="吉武 和敏" userId="e4825ba96748af9c" providerId="LiveId" clId="{07C93B19-CA14-42D4-A579-56BF69355786}" dt="2020-08-27T07:04:37.008" v="219"/>
        <pc:sldMkLst>
          <pc:docMk/>
          <pc:sldMk cId="1505998649" sldId="280"/>
        </pc:sldMkLst>
      </pc:sldChg>
    </pc:docChg>
  </pc:docChgLst>
  <pc:docChgLst>
    <pc:chgData name="吉武 和敏" userId="e4825ba96748af9c" providerId="LiveId" clId="{4D8F1663-5CB1-9F45-8567-16737C5B335A}"/>
    <pc:docChg chg="modSld">
      <pc:chgData name="吉武 和敏" userId="e4825ba96748af9c" providerId="LiveId" clId="{4D8F1663-5CB1-9F45-8567-16737C5B335A}" dt="2021-09-14T00:25:33.538" v="15" actId="1076"/>
      <pc:docMkLst>
        <pc:docMk/>
      </pc:docMkLst>
      <pc:sldChg chg="addSp delSp modSp mod">
        <pc:chgData name="吉武 和敏" userId="e4825ba96748af9c" providerId="LiveId" clId="{4D8F1663-5CB1-9F45-8567-16737C5B335A}" dt="2021-09-14T00:25:33.538" v="15" actId="1076"/>
        <pc:sldMkLst>
          <pc:docMk/>
          <pc:sldMk cId="2806979806" sldId="262"/>
        </pc:sldMkLst>
        <pc:spChg chg="add del">
          <ac:chgData name="吉武 和敏" userId="e4825ba96748af9c" providerId="LiveId" clId="{4D8F1663-5CB1-9F45-8567-16737C5B335A}" dt="2021-09-14T00:20:17.810" v="3" actId="478"/>
          <ac:spMkLst>
            <pc:docMk/>
            <pc:sldMk cId="2806979806" sldId="262"/>
            <ac:spMk id="4" creationId="{63B3A729-530B-DB47-8D4C-82B1F4317325}"/>
          </ac:spMkLst>
        </pc:spChg>
        <pc:spChg chg="add del mod">
          <ac:chgData name="吉武 和敏" userId="e4825ba96748af9c" providerId="LiveId" clId="{4D8F1663-5CB1-9F45-8567-16737C5B335A}" dt="2021-09-14T00:20:17.810" v="3" actId="478"/>
          <ac:spMkLst>
            <pc:docMk/>
            <pc:sldMk cId="2806979806" sldId="262"/>
            <ac:spMk id="6" creationId="{BB79D1E7-B7AB-B041-AA57-74E958DF8846}"/>
          </ac:spMkLst>
        </pc:spChg>
        <pc:spChg chg="add del mod">
          <ac:chgData name="吉武 和敏" userId="e4825ba96748af9c" providerId="LiveId" clId="{4D8F1663-5CB1-9F45-8567-16737C5B335A}" dt="2021-09-14T00:20:17.810" v="3" actId="478"/>
          <ac:spMkLst>
            <pc:docMk/>
            <pc:sldMk cId="2806979806" sldId="262"/>
            <ac:spMk id="7" creationId="{8A5CA284-E244-B44E-9C2B-0D5CEC170BD9}"/>
          </ac:spMkLst>
        </pc:spChg>
        <pc:graphicFrameChg chg="add mod">
          <ac:chgData name="吉武 和敏" userId="e4825ba96748af9c" providerId="LiveId" clId="{4D8F1663-5CB1-9F45-8567-16737C5B335A}" dt="2021-09-14T00:25:33.538" v="15" actId="1076"/>
          <ac:graphicFrameMkLst>
            <pc:docMk/>
            <pc:sldMk cId="2806979806" sldId="262"/>
            <ac:graphicFrameMk id="10" creationId="{24F41B01-3CD9-8148-801D-F56737EC36F4}"/>
          </ac:graphicFrameMkLst>
        </pc:graphicFrameChg>
        <pc:picChg chg="add mod">
          <ac:chgData name="吉武 和敏" userId="e4825ba96748af9c" providerId="LiveId" clId="{4D8F1663-5CB1-9F45-8567-16737C5B335A}" dt="2021-09-14T00:25:05.552" v="14" actId="1076"/>
          <ac:picMkLst>
            <pc:docMk/>
            <pc:sldMk cId="2806979806" sldId="262"/>
            <ac:picMk id="9" creationId="{C4CB12EA-75AA-464F-A734-C60823C372F0}"/>
          </ac:picMkLst>
        </pc:picChg>
      </pc:sldChg>
    </pc:docChg>
  </pc:docChgLst>
  <pc:docChgLst>
    <pc:chgData name="吉武 和敏" userId="e4825ba96748af9c" providerId="LiveId" clId="{59840E0E-A079-47E9-9879-A3EAF0DD7017}"/>
    <pc:docChg chg="modSld">
      <pc:chgData name="吉武 和敏" userId="e4825ba96748af9c" providerId="LiveId" clId="{59840E0E-A079-47E9-9879-A3EAF0DD7017}" dt="2022-08-08T08:17:03.094" v="15" actId="14100"/>
      <pc:docMkLst>
        <pc:docMk/>
      </pc:docMkLst>
      <pc:sldChg chg="modSp mod">
        <pc:chgData name="吉武 和敏" userId="e4825ba96748af9c" providerId="LiveId" clId="{59840E0E-A079-47E9-9879-A3EAF0DD7017}" dt="2022-08-08T08:17:03.094" v="15" actId="14100"/>
        <pc:sldMkLst>
          <pc:docMk/>
          <pc:sldMk cId="731570627" sldId="849"/>
        </pc:sldMkLst>
        <pc:spChg chg="mod">
          <ac:chgData name="吉武 和敏" userId="e4825ba96748af9c" providerId="LiveId" clId="{59840E0E-A079-47E9-9879-A3EAF0DD7017}" dt="2022-08-08T08:16:31.237" v="8" actId="14100"/>
          <ac:spMkLst>
            <pc:docMk/>
            <pc:sldMk cId="731570627" sldId="849"/>
            <ac:spMk id="25" creationId="{7FC81EE4-1C66-44E1-AF05-A528AFD213DC}"/>
          </ac:spMkLst>
        </pc:spChg>
        <pc:spChg chg="mod">
          <ac:chgData name="吉武 和敏" userId="e4825ba96748af9c" providerId="LiveId" clId="{59840E0E-A079-47E9-9879-A3EAF0DD7017}" dt="2022-08-08T08:17:03.094" v="15" actId="14100"/>
          <ac:spMkLst>
            <pc:docMk/>
            <pc:sldMk cId="731570627" sldId="849"/>
            <ac:spMk id="26" creationId="{BB32BB4D-729C-4957-969B-32107EB4D1E2}"/>
          </ac:spMkLst>
        </pc:spChg>
      </pc:sldChg>
    </pc:docChg>
  </pc:docChgLst>
  <pc:docChgLst>
    <pc:chgData name="吉武 和敏" userId="e4825ba96748af9c" providerId="LiveId" clId="{F03051E2-2AE0-48D6-8219-1D10DE8504FE}"/>
    <pc:docChg chg="modSld">
      <pc:chgData name="吉武 和敏" userId="e4825ba96748af9c" providerId="LiveId" clId="{F03051E2-2AE0-48D6-8219-1D10DE8504FE}" dt="2019-09-13T01:40:06.615" v="3"/>
      <pc:docMkLst>
        <pc:docMk/>
      </pc:docMkLst>
      <pc:sldChg chg="modSp">
        <pc:chgData name="吉武 和敏" userId="e4825ba96748af9c" providerId="LiveId" clId="{F03051E2-2AE0-48D6-8219-1D10DE8504FE}" dt="2019-09-13T01:40:06.615" v="3"/>
        <pc:sldMkLst>
          <pc:docMk/>
          <pc:sldMk cId="3696140831" sldId="261"/>
        </pc:sldMkLst>
        <pc:graphicFrameChg chg="mod">
          <ac:chgData name="吉武 和敏" userId="e4825ba96748af9c" providerId="LiveId" clId="{F03051E2-2AE0-48D6-8219-1D10DE8504FE}" dt="2019-09-13T01:40:06.615" v="3"/>
          <ac:graphicFrameMkLst>
            <pc:docMk/>
            <pc:sldMk cId="3696140831" sldId="261"/>
            <ac:graphicFrameMk id="4" creationId="{00000000-0000-0000-0000-000000000000}"/>
          </ac:graphicFrameMkLst>
        </pc:graphicFrameChg>
      </pc:sldChg>
    </pc:docChg>
  </pc:docChgLst>
  <pc:docChgLst>
    <pc:chgData name="吉武 和敏" userId="e4825ba96748af9c" providerId="LiveId" clId="{B117E4CF-70EB-4DD9-86C8-E35E5FF3BEDE}"/>
    <pc:docChg chg="addSld modSld">
      <pc:chgData name="吉武 和敏" userId="e4825ba96748af9c" providerId="LiveId" clId="{B117E4CF-70EB-4DD9-86C8-E35E5FF3BEDE}" dt="2020-03-09T05:19:10.541" v="0"/>
      <pc:docMkLst>
        <pc:docMk/>
      </pc:docMkLst>
      <pc:sldChg chg="add">
        <pc:chgData name="吉武 和敏" userId="e4825ba96748af9c" providerId="LiveId" clId="{B117E4CF-70EB-4DD9-86C8-E35E5FF3BEDE}" dt="2020-03-09T05:19:10.541" v="0"/>
        <pc:sldMkLst>
          <pc:docMk/>
          <pc:sldMk cId="1744819178" sldId="257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1279635173" sldId="258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182183821" sldId="264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1485698774" sldId="265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626345740" sldId="267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2704609531" sldId="268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3600490621" sldId="269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15316528" sldId="270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3159242479" sldId="271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2987232527" sldId="272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3371264791" sldId="273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1287841559" sldId="274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1920743463" sldId="275"/>
        </pc:sldMkLst>
      </pc:sldChg>
      <pc:sldChg chg="add">
        <pc:chgData name="吉武 和敏" userId="e4825ba96748af9c" providerId="LiveId" clId="{B117E4CF-70EB-4DD9-86C8-E35E5FF3BEDE}" dt="2020-03-09T05:19:10.541" v="0"/>
        <pc:sldMkLst>
          <pc:docMk/>
          <pc:sldMk cId="491749897" sldId="27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F17C42-5453-4C64-A57D-3CA58DBADF4A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A8D4E0-5A17-424B-BBD5-0037BEFF9F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6444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490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110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056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8520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1106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301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024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7595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6559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8668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3404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05A12-FEF5-4027-8D93-6466A6FE893F}" type="datetimeFigureOut">
              <a:rPr kumimoji="1" lang="ja-JP" altLang="en-US" smtClean="0"/>
              <a:t>2022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7ED0B-D4A5-4D97-9FE6-DC7B451754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483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9606A9F-6B2C-8C4E-A7EE-18BA463D2A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706"/>
          <a:stretch/>
        </p:blipFill>
        <p:spPr>
          <a:xfrm>
            <a:off x="6059764" y="1106861"/>
            <a:ext cx="2772869" cy="4644278"/>
          </a:xfrm>
          <a:prstGeom prst="rect">
            <a:avLst/>
          </a:prstGeom>
        </p:spPr>
      </p:pic>
      <p:pic>
        <p:nvPicPr>
          <p:cNvPr id="4" name="図 3" descr="設計図&#10;&#10;自動的に生成された説明">
            <a:extLst>
              <a:ext uri="{FF2B5EF4-FFF2-40B4-BE49-F238E27FC236}">
                <a16:creationId xmlns:a16="http://schemas.microsoft.com/office/drawing/2014/main" id="{CDDB7AB1-FEB7-4894-9CFD-2CC46E1A45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4563" y="1191716"/>
            <a:ext cx="2770103" cy="1889067"/>
          </a:xfrm>
          <a:prstGeom prst="rect">
            <a:avLst/>
          </a:prstGeom>
        </p:spPr>
      </p:pic>
      <p:pic>
        <p:nvPicPr>
          <p:cNvPr id="2050" name="Picture 2">
            <a:extLst>
              <a:ext uri="{FF2B5EF4-FFF2-40B4-BE49-F238E27FC236}">
                <a16:creationId xmlns:a16="http://schemas.microsoft.com/office/drawing/2014/main" id="{0D145C3E-C513-4184-AEFB-2200D276FB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9048" y="3262613"/>
            <a:ext cx="1458777" cy="28554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B1E9D8DB-BBAD-4C27-81C0-BA12F669C2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6451" y="3923475"/>
            <a:ext cx="618978" cy="21945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D3E95CE-33DA-4724-A1BE-25F2BC2A0C1F}"/>
              </a:ext>
            </a:extLst>
          </p:cNvPr>
          <p:cNvSpPr txBox="1"/>
          <p:nvPr/>
        </p:nvSpPr>
        <p:spPr>
          <a:xfrm>
            <a:off x="3876120" y="3691177"/>
            <a:ext cx="134440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Two pencil leads</a:t>
            </a:r>
          </a:p>
        </p:txBody>
      </p:sp>
      <p:pic>
        <p:nvPicPr>
          <p:cNvPr id="2054" name="Picture 6">
            <a:extLst>
              <a:ext uri="{FF2B5EF4-FFF2-40B4-BE49-F238E27FC236}">
                <a16:creationId xmlns:a16="http://schemas.microsoft.com/office/drawing/2014/main" id="{9B592C42-476F-4B6A-8ECF-54759EBF1C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7348" y="1334651"/>
            <a:ext cx="818084" cy="1599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F2357CD-443B-4806-88D5-D0166B71DD8B}"/>
              </a:ext>
            </a:extLst>
          </p:cNvPr>
          <p:cNvSpPr txBox="1"/>
          <p:nvPr/>
        </p:nvSpPr>
        <p:spPr>
          <a:xfrm>
            <a:off x="182898" y="1788340"/>
            <a:ext cx="122904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A 3D</a:t>
            </a:r>
            <a:r>
              <a:rPr lang="ja-JP" altLang="en-US" sz="1350" dirty="0"/>
              <a:t> </a:t>
            </a:r>
            <a:r>
              <a:rPr lang="en-US" altLang="ja-JP" sz="1350" dirty="0"/>
              <a:t>Printer</a:t>
            </a:r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id="{626B4F67-00DA-43BF-B7D3-E8909403A4FF}"/>
              </a:ext>
            </a:extLst>
          </p:cNvPr>
          <p:cNvSpPr/>
          <p:nvPr/>
        </p:nvSpPr>
        <p:spPr>
          <a:xfrm>
            <a:off x="2319619" y="1991845"/>
            <a:ext cx="519392" cy="32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CD5E067-4B42-4F66-ABD5-719EB6575925}"/>
              </a:ext>
            </a:extLst>
          </p:cNvPr>
          <p:cNvSpPr txBox="1"/>
          <p:nvPr/>
        </p:nvSpPr>
        <p:spPr>
          <a:xfrm>
            <a:off x="1411941" y="3048474"/>
            <a:ext cx="148649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A silicon lunch cup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75E551B-345E-4D00-A4F1-F961C99F3B6F}"/>
              </a:ext>
            </a:extLst>
          </p:cNvPr>
          <p:cNvSpPr txBox="1"/>
          <p:nvPr/>
        </p:nvSpPr>
        <p:spPr>
          <a:xfrm>
            <a:off x="88311" y="6523342"/>
            <a:ext cx="360220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Sup. Fig. 1. Disposable electrophoresis chambers</a:t>
            </a:r>
            <a:endParaRPr lang="ja-JP" altLang="en-US" sz="1350" dirty="0"/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5648B448-F8FC-BB68-ADAD-38FAEB79CA15}"/>
              </a:ext>
            </a:extLst>
          </p:cNvPr>
          <p:cNvCxnSpPr>
            <a:cxnSpLocks/>
          </p:cNvCxnSpPr>
          <p:nvPr/>
        </p:nvCxnSpPr>
        <p:spPr>
          <a:xfrm>
            <a:off x="5060515" y="2517732"/>
            <a:ext cx="2148214" cy="237368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409185A4-4824-49C4-0EAB-37BB04623831}"/>
              </a:ext>
            </a:extLst>
          </p:cNvPr>
          <p:cNvCxnSpPr>
            <a:cxnSpLocks/>
          </p:cNvCxnSpPr>
          <p:nvPr/>
        </p:nvCxnSpPr>
        <p:spPr>
          <a:xfrm>
            <a:off x="2985919" y="4547265"/>
            <a:ext cx="4028656" cy="30008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8AC8581D-0811-C223-D955-8A3347294064}"/>
              </a:ext>
            </a:extLst>
          </p:cNvPr>
          <p:cNvCxnSpPr>
            <a:cxnSpLocks/>
          </p:cNvCxnSpPr>
          <p:nvPr/>
        </p:nvCxnSpPr>
        <p:spPr>
          <a:xfrm flipV="1">
            <a:off x="4393033" y="5185010"/>
            <a:ext cx="3053165" cy="4285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84D6E4F1-DD0F-0369-4E6A-CC3FAEBD5698}"/>
              </a:ext>
            </a:extLst>
          </p:cNvPr>
          <p:cNvCxnSpPr>
            <a:cxnSpLocks/>
          </p:cNvCxnSpPr>
          <p:nvPr/>
        </p:nvCxnSpPr>
        <p:spPr>
          <a:xfrm flipV="1">
            <a:off x="4393033" y="4816720"/>
            <a:ext cx="3183820" cy="79679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8DB3D441-48C5-FE38-D1A7-DF5960F71C07}"/>
              </a:ext>
            </a:extLst>
          </p:cNvPr>
          <p:cNvCxnSpPr/>
          <p:nvPr/>
        </p:nvCxnSpPr>
        <p:spPr>
          <a:xfrm>
            <a:off x="3572933" y="804333"/>
            <a:ext cx="0" cy="5926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02FF8B9-7044-43E5-D9BD-33B729BA46A0}"/>
              </a:ext>
            </a:extLst>
          </p:cNvPr>
          <p:cNvSpPr txBox="1"/>
          <p:nvPr/>
        </p:nvSpPr>
        <p:spPr>
          <a:xfrm>
            <a:off x="3163990" y="547223"/>
            <a:ext cx="205653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Gel maker stand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F2E27DF-9EE9-2804-3871-6D6EEACA8C88}"/>
              </a:ext>
            </a:extLst>
          </p:cNvPr>
          <p:cNvSpPr txBox="1"/>
          <p:nvPr/>
        </p:nvSpPr>
        <p:spPr>
          <a:xfrm>
            <a:off x="3171214" y="2709587"/>
            <a:ext cx="7797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Comb</a:t>
            </a: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D6896F92-6BCC-5126-2988-7850C728775A}"/>
              </a:ext>
            </a:extLst>
          </p:cNvPr>
          <p:cNvCxnSpPr>
            <a:cxnSpLocks/>
          </p:cNvCxnSpPr>
          <p:nvPr/>
        </p:nvCxnSpPr>
        <p:spPr>
          <a:xfrm flipV="1">
            <a:off x="3707449" y="2692400"/>
            <a:ext cx="297284" cy="9204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7DD54C5C-E5B8-3431-A0F3-04C7A8C221E3}"/>
              </a:ext>
            </a:extLst>
          </p:cNvPr>
          <p:cNvCxnSpPr/>
          <p:nvPr/>
        </p:nvCxnSpPr>
        <p:spPr>
          <a:xfrm>
            <a:off x="4766733" y="1642047"/>
            <a:ext cx="0" cy="5926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0D7ABE3-4059-B4BC-EBCA-2387421283DF}"/>
              </a:ext>
            </a:extLst>
          </p:cNvPr>
          <p:cNvSpPr txBox="1"/>
          <p:nvPr/>
        </p:nvSpPr>
        <p:spPr>
          <a:xfrm>
            <a:off x="4460414" y="1341872"/>
            <a:ext cx="84453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Gel tray</a:t>
            </a:r>
          </a:p>
        </p:txBody>
      </p:sp>
    </p:spTree>
    <p:extLst>
      <p:ext uri="{BB962C8B-B14F-4D97-AF65-F5344CB8AC3E}">
        <p14:creationId xmlns:p14="http://schemas.microsoft.com/office/powerpoint/2010/main" val="1542364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夜に光っている電子&#10;&#10;自動的に生成された説明">
            <a:extLst>
              <a:ext uri="{FF2B5EF4-FFF2-40B4-BE49-F238E27FC236}">
                <a16:creationId xmlns:a16="http://schemas.microsoft.com/office/drawing/2014/main" id="{412B2D32-B0C7-45ED-8587-7D4EE4FC5D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84" t="15630" r="42062" b="2874"/>
          <a:stretch/>
        </p:blipFill>
        <p:spPr>
          <a:xfrm>
            <a:off x="1706252" y="619400"/>
            <a:ext cx="1385740" cy="5269583"/>
          </a:xfrm>
          <a:prstGeom prst="rect">
            <a:avLst/>
          </a:prstGeom>
        </p:spPr>
      </p:pic>
      <p:pic>
        <p:nvPicPr>
          <p:cNvPr id="4" name="図 3" descr="コンピューターの画面&#10;&#10;自動的に生成された説明">
            <a:extLst>
              <a:ext uri="{FF2B5EF4-FFF2-40B4-BE49-F238E27FC236}">
                <a16:creationId xmlns:a16="http://schemas.microsoft.com/office/drawing/2014/main" id="{3E731FC4-5B4E-483A-B273-E32BAAC7EB3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14" t="13333" r="44859" b="9828"/>
          <a:stretch/>
        </p:blipFill>
        <p:spPr>
          <a:xfrm>
            <a:off x="4572001" y="619400"/>
            <a:ext cx="1131218" cy="5269583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75B6111D-3A68-4F7D-9B6B-EFC429EC7C47}"/>
              </a:ext>
            </a:extLst>
          </p:cNvPr>
          <p:cNvCxnSpPr>
            <a:cxnSpLocks/>
          </p:cNvCxnSpPr>
          <p:nvPr/>
        </p:nvCxnSpPr>
        <p:spPr>
          <a:xfrm>
            <a:off x="1480009" y="1948578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DDFDA90B-F622-45F8-90D0-41D389C85843}"/>
              </a:ext>
            </a:extLst>
          </p:cNvPr>
          <p:cNvCxnSpPr>
            <a:cxnSpLocks/>
          </p:cNvCxnSpPr>
          <p:nvPr/>
        </p:nvCxnSpPr>
        <p:spPr>
          <a:xfrm>
            <a:off x="1480009" y="2061700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C0E99A34-CE09-4E96-812C-1C3AD28E8F56}"/>
              </a:ext>
            </a:extLst>
          </p:cNvPr>
          <p:cNvCxnSpPr>
            <a:cxnSpLocks/>
          </p:cNvCxnSpPr>
          <p:nvPr/>
        </p:nvCxnSpPr>
        <p:spPr>
          <a:xfrm>
            <a:off x="1480009" y="2155968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9671955D-B1D3-4DA6-8856-C53C8F764057}"/>
              </a:ext>
            </a:extLst>
          </p:cNvPr>
          <p:cNvCxnSpPr>
            <a:cxnSpLocks/>
          </p:cNvCxnSpPr>
          <p:nvPr/>
        </p:nvCxnSpPr>
        <p:spPr>
          <a:xfrm>
            <a:off x="1480009" y="2269089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C2A54EB0-9C15-4C5D-818D-C04E04D3F4C3}"/>
              </a:ext>
            </a:extLst>
          </p:cNvPr>
          <p:cNvCxnSpPr>
            <a:cxnSpLocks/>
          </p:cNvCxnSpPr>
          <p:nvPr/>
        </p:nvCxnSpPr>
        <p:spPr>
          <a:xfrm>
            <a:off x="1480009" y="2485906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EDAF7941-A96E-4AA3-AE62-BE142EE3AB8C}"/>
              </a:ext>
            </a:extLst>
          </p:cNvPr>
          <p:cNvCxnSpPr>
            <a:cxnSpLocks/>
          </p:cNvCxnSpPr>
          <p:nvPr/>
        </p:nvCxnSpPr>
        <p:spPr>
          <a:xfrm>
            <a:off x="1480009" y="1816603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119B606-FB1F-4911-820A-04C9E5F35252}"/>
              </a:ext>
            </a:extLst>
          </p:cNvPr>
          <p:cNvCxnSpPr>
            <a:cxnSpLocks/>
          </p:cNvCxnSpPr>
          <p:nvPr/>
        </p:nvCxnSpPr>
        <p:spPr>
          <a:xfrm>
            <a:off x="1480009" y="2655589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4C90151-FE65-47E2-A011-A5ABC036A431}"/>
              </a:ext>
            </a:extLst>
          </p:cNvPr>
          <p:cNvSpPr txBox="1"/>
          <p:nvPr/>
        </p:nvSpPr>
        <p:spPr>
          <a:xfrm>
            <a:off x="971536" y="1686968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3,0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C9BBE92-BF58-4A10-81F0-B694204EAD9A}"/>
              </a:ext>
            </a:extLst>
          </p:cNvPr>
          <p:cNvSpPr txBox="1"/>
          <p:nvPr/>
        </p:nvSpPr>
        <p:spPr>
          <a:xfrm>
            <a:off x="971536" y="1820114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>
                <a:solidFill>
                  <a:srgbClr val="FF0000"/>
                </a:solidFill>
              </a:rPr>
              <a:t>2</a:t>
            </a:r>
            <a:r>
              <a:rPr kumimoji="1" lang="en-US" altLang="ja-JP" sz="1100">
                <a:solidFill>
                  <a:srgbClr val="FF0000"/>
                </a:solidFill>
              </a:rPr>
              <a:t>,0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C7B0BD2-DAD4-4367-85B7-BC19BB77F192}"/>
              </a:ext>
            </a:extLst>
          </p:cNvPr>
          <p:cNvSpPr txBox="1"/>
          <p:nvPr/>
        </p:nvSpPr>
        <p:spPr>
          <a:xfrm>
            <a:off x="971536" y="1921468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1,5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312C2DC-7835-403C-A3C9-C0C31DDCA916}"/>
              </a:ext>
            </a:extLst>
          </p:cNvPr>
          <p:cNvSpPr txBox="1"/>
          <p:nvPr/>
        </p:nvSpPr>
        <p:spPr>
          <a:xfrm>
            <a:off x="971536" y="2049932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1,</a:t>
            </a:r>
            <a:r>
              <a:rPr lang="en-US" altLang="ja-JP" sz="1100">
                <a:solidFill>
                  <a:srgbClr val="FF0000"/>
                </a:solidFill>
              </a:rPr>
              <a:t>3</a:t>
            </a:r>
            <a:r>
              <a:rPr kumimoji="1" lang="en-US" altLang="ja-JP" sz="1100">
                <a:solidFill>
                  <a:srgbClr val="FF0000"/>
                </a:solidFill>
              </a:rPr>
              <a:t>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9AF99EF-0ECE-4953-A58D-7586138946EC}"/>
              </a:ext>
            </a:extLst>
          </p:cNvPr>
          <p:cNvSpPr txBox="1"/>
          <p:nvPr/>
        </p:nvSpPr>
        <p:spPr>
          <a:xfrm>
            <a:off x="971536" y="2154796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1,0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CAA7D10-F6A7-4B50-A9D0-8072D220EE49}"/>
              </a:ext>
            </a:extLst>
          </p:cNvPr>
          <p:cNvSpPr txBox="1"/>
          <p:nvPr/>
        </p:nvSpPr>
        <p:spPr>
          <a:xfrm>
            <a:off x="1075233" y="2342161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>
                <a:solidFill>
                  <a:srgbClr val="FF0000"/>
                </a:solidFill>
              </a:rPr>
              <a:t>7</a:t>
            </a:r>
            <a:r>
              <a:rPr kumimoji="1" lang="en-US" altLang="ja-JP" sz="1100">
                <a:solidFill>
                  <a:srgbClr val="FF0000"/>
                </a:solidFill>
              </a:rPr>
              <a:t>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5E6D484-0EE8-4FC9-AC52-300982BCF67A}"/>
              </a:ext>
            </a:extLst>
          </p:cNvPr>
          <p:cNvSpPr txBox="1"/>
          <p:nvPr/>
        </p:nvSpPr>
        <p:spPr>
          <a:xfrm>
            <a:off x="1075233" y="2524784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5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FF99138F-8B33-4C65-9D20-63595C38AA97}"/>
              </a:ext>
            </a:extLst>
          </p:cNvPr>
          <p:cNvCxnSpPr>
            <a:cxnSpLocks/>
          </p:cNvCxnSpPr>
          <p:nvPr/>
        </p:nvCxnSpPr>
        <p:spPr>
          <a:xfrm>
            <a:off x="4262487" y="2298505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0102FFD8-465A-44AF-989E-6D54A6A2F175}"/>
              </a:ext>
            </a:extLst>
          </p:cNvPr>
          <p:cNvCxnSpPr>
            <a:cxnSpLocks/>
          </p:cNvCxnSpPr>
          <p:nvPr/>
        </p:nvCxnSpPr>
        <p:spPr>
          <a:xfrm>
            <a:off x="4262487" y="2449816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0186D92-8A84-4496-AA6C-79012ACEBB69}"/>
              </a:ext>
            </a:extLst>
          </p:cNvPr>
          <p:cNvCxnSpPr>
            <a:cxnSpLocks/>
          </p:cNvCxnSpPr>
          <p:nvPr/>
        </p:nvCxnSpPr>
        <p:spPr>
          <a:xfrm>
            <a:off x="4262487" y="2575908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EDDB0627-B36D-4154-99F4-6CB70B34F7FD}"/>
              </a:ext>
            </a:extLst>
          </p:cNvPr>
          <p:cNvCxnSpPr>
            <a:cxnSpLocks/>
          </p:cNvCxnSpPr>
          <p:nvPr/>
        </p:nvCxnSpPr>
        <p:spPr>
          <a:xfrm>
            <a:off x="4262487" y="2727218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8241671F-B955-4EA2-B4CD-613F826A0F4B}"/>
              </a:ext>
            </a:extLst>
          </p:cNvPr>
          <p:cNvCxnSpPr>
            <a:cxnSpLocks/>
          </p:cNvCxnSpPr>
          <p:nvPr/>
        </p:nvCxnSpPr>
        <p:spPr>
          <a:xfrm>
            <a:off x="4262487" y="3017230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CAF98E57-D148-4A08-951B-63953576FC17}"/>
              </a:ext>
            </a:extLst>
          </p:cNvPr>
          <p:cNvCxnSpPr>
            <a:cxnSpLocks/>
          </p:cNvCxnSpPr>
          <p:nvPr/>
        </p:nvCxnSpPr>
        <p:spPr>
          <a:xfrm>
            <a:off x="4262487" y="2121977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8165324B-E17D-4B45-9559-3281837264EE}"/>
              </a:ext>
            </a:extLst>
          </p:cNvPr>
          <p:cNvCxnSpPr>
            <a:cxnSpLocks/>
          </p:cNvCxnSpPr>
          <p:nvPr/>
        </p:nvCxnSpPr>
        <p:spPr>
          <a:xfrm>
            <a:off x="4262487" y="3244197"/>
            <a:ext cx="42420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C0D539E-DBB4-47F2-BC07-FC0E1DDDECA1}"/>
              </a:ext>
            </a:extLst>
          </p:cNvPr>
          <p:cNvSpPr txBox="1"/>
          <p:nvPr/>
        </p:nvSpPr>
        <p:spPr>
          <a:xfrm>
            <a:off x="3754014" y="1948578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3,0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14FA8E3-B9E8-4FE8-A009-47D4C205766C}"/>
              </a:ext>
            </a:extLst>
          </p:cNvPr>
          <p:cNvSpPr txBox="1"/>
          <p:nvPr/>
        </p:nvSpPr>
        <p:spPr>
          <a:xfrm>
            <a:off x="3754014" y="2126673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>
                <a:solidFill>
                  <a:srgbClr val="FF0000"/>
                </a:solidFill>
              </a:rPr>
              <a:t>2</a:t>
            </a:r>
            <a:r>
              <a:rPr kumimoji="1" lang="en-US" altLang="ja-JP" sz="1100">
                <a:solidFill>
                  <a:srgbClr val="FF0000"/>
                </a:solidFill>
              </a:rPr>
              <a:t>,0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E5647CA-8E4C-4A70-BA57-7C7E5D2CE5D7}"/>
              </a:ext>
            </a:extLst>
          </p:cNvPr>
          <p:cNvSpPr txBox="1"/>
          <p:nvPr/>
        </p:nvSpPr>
        <p:spPr>
          <a:xfrm>
            <a:off x="3754014" y="2262243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1,5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18E7BF0-E70D-48F1-B34B-6D39421DCACE}"/>
              </a:ext>
            </a:extLst>
          </p:cNvPr>
          <p:cNvSpPr txBox="1"/>
          <p:nvPr/>
        </p:nvSpPr>
        <p:spPr>
          <a:xfrm>
            <a:off x="3754014" y="2434075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1,</a:t>
            </a:r>
            <a:r>
              <a:rPr lang="en-US" altLang="ja-JP" sz="1100">
                <a:solidFill>
                  <a:srgbClr val="FF0000"/>
                </a:solidFill>
              </a:rPr>
              <a:t>3</a:t>
            </a:r>
            <a:r>
              <a:rPr kumimoji="1" lang="en-US" altLang="ja-JP" sz="1100">
                <a:solidFill>
                  <a:srgbClr val="FF0000"/>
                </a:solidFill>
              </a:rPr>
              <a:t>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BF1A2DB-BFF5-43E0-BA14-FC601F79BEC8}"/>
              </a:ext>
            </a:extLst>
          </p:cNvPr>
          <p:cNvSpPr txBox="1"/>
          <p:nvPr/>
        </p:nvSpPr>
        <p:spPr>
          <a:xfrm>
            <a:off x="3754014" y="2574340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1,0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954818D-EF86-4443-B00E-EEE3C46514CE}"/>
              </a:ext>
            </a:extLst>
          </p:cNvPr>
          <p:cNvSpPr txBox="1"/>
          <p:nvPr/>
        </p:nvSpPr>
        <p:spPr>
          <a:xfrm>
            <a:off x="3857711" y="2824958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>
                <a:solidFill>
                  <a:srgbClr val="FF0000"/>
                </a:solidFill>
              </a:rPr>
              <a:t>7</a:t>
            </a:r>
            <a:r>
              <a:rPr kumimoji="1" lang="en-US" altLang="ja-JP" sz="1100">
                <a:solidFill>
                  <a:srgbClr val="FF0000"/>
                </a:solidFill>
              </a:rPr>
              <a:t>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DCAAA5C-3D14-4FC4-A913-249A3471B53F}"/>
              </a:ext>
            </a:extLst>
          </p:cNvPr>
          <p:cNvSpPr txBox="1"/>
          <p:nvPr/>
        </p:nvSpPr>
        <p:spPr>
          <a:xfrm>
            <a:off x="3857711" y="3069233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solidFill>
                  <a:srgbClr val="FF0000"/>
                </a:solidFill>
              </a:rPr>
              <a:t>500</a:t>
            </a:r>
            <a:endParaRPr kumimoji="1" lang="ja-JP" altLang="en-US" sz="1100">
              <a:solidFill>
                <a:srgbClr val="FF0000"/>
              </a:solidFill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6133BAF-5153-457F-A4E1-591BDABB5F99}"/>
              </a:ext>
            </a:extLst>
          </p:cNvPr>
          <p:cNvSpPr txBox="1"/>
          <p:nvPr/>
        </p:nvSpPr>
        <p:spPr>
          <a:xfrm>
            <a:off x="971536" y="0"/>
            <a:ext cx="2742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) 2 step PCR for Nanopore</a:t>
            </a:r>
            <a:endParaRPr kumimoji="1" lang="ja-JP" altLang="en-US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C80D470-3D00-401A-BE04-F4E3B5EC0A75}"/>
              </a:ext>
            </a:extLst>
          </p:cNvPr>
          <p:cNvSpPr txBox="1"/>
          <p:nvPr/>
        </p:nvSpPr>
        <p:spPr>
          <a:xfrm>
            <a:off x="4148369" y="0"/>
            <a:ext cx="2601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) 1 step PCR for </a:t>
            </a:r>
            <a:r>
              <a:rPr kumimoji="1" lang="en-US" altLang="ja-JP" dirty="0" err="1"/>
              <a:t>LoopSeq</a:t>
            </a:r>
            <a:endParaRPr kumimoji="1" lang="ja-JP" altLang="en-US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B68D934-5BD7-B74E-B7C8-1DEB66CE07C4}"/>
              </a:ext>
            </a:extLst>
          </p:cNvPr>
          <p:cNvSpPr txBox="1"/>
          <p:nvPr/>
        </p:nvSpPr>
        <p:spPr>
          <a:xfrm>
            <a:off x="318458" y="5905065"/>
            <a:ext cx="805498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Sup. Fig. 2. PCR with UMI tag</a:t>
            </a:r>
          </a:p>
          <a:p>
            <a:r>
              <a:rPr lang="en-US" altLang="ja-JP" sz="1350" dirty="0"/>
              <a:t>A) 2 step PCR for Nanopore sequencing with UMI tags, B) 1 step PCR for </a:t>
            </a:r>
            <a:r>
              <a:rPr lang="en-US" altLang="ja-JP" sz="1350" dirty="0" err="1"/>
              <a:t>LoopSeq</a:t>
            </a:r>
            <a:r>
              <a:rPr lang="en-US" altLang="ja-JP" sz="1350" dirty="0"/>
              <a:t> sequencing without UMI tags</a:t>
            </a:r>
            <a:endParaRPr lang="ja-JP" altLang="en-US" sz="1350" dirty="0"/>
          </a:p>
        </p:txBody>
      </p:sp>
    </p:spTree>
    <p:extLst>
      <p:ext uri="{BB962C8B-B14F-4D97-AF65-F5344CB8AC3E}">
        <p14:creationId xmlns:p14="http://schemas.microsoft.com/office/powerpoint/2010/main" val="549526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76</TotalTime>
  <Words>86</Words>
  <Application>Microsoft Office PowerPoint</Application>
  <PresentationFormat>画面に合わせる (4:3)</PresentationFormat>
  <Paragraphs>2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武和敏</dc:creator>
  <cp:lastModifiedBy>Kazutoshi Yoshitake</cp:lastModifiedBy>
  <cp:revision>1</cp:revision>
  <dcterms:created xsi:type="dcterms:W3CDTF">2017-12-27T03:46:23Z</dcterms:created>
  <dcterms:modified xsi:type="dcterms:W3CDTF">2022-09-15T07:22:26Z</dcterms:modified>
</cp:coreProperties>
</file>